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4">
  <p:sldMasterIdLst>
    <p:sldMasterId id="2147483660" r:id="rId1"/>
  </p:sldMasterIdLst>
  <p:notesMasterIdLst>
    <p:notesMasterId r:id="rId19"/>
  </p:notesMasterIdLst>
  <p:sldIdLst>
    <p:sldId id="2022" r:id="rId2"/>
    <p:sldId id="2011" r:id="rId3"/>
    <p:sldId id="2012" r:id="rId4"/>
    <p:sldId id="2007" r:id="rId5"/>
    <p:sldId id="2013" r:id="rId6"/>
    <p:sldId id="2018" r:id="rId7"/>
    <p:sldId id="2019" r:id="rId8"/>
    <p:sldId id="2000" r:id="rId9"/>
    <p:sldId id="1998" r:id="rId10"/>
    <p:sldId id="2015" r:id="rId11"/>
    <p:sldId id="2020" r:id="rId12"/>
    <p:sldId id="2026" r:id="rId13"/>
    <p:sldId id="2028" r:id="rId14"/>
    <p:sldId id="2005" r:id="rId15"/>
    <p:sldId id="2004" r:id="rId16"/>
    <p:sldId id="2008" r:id="rId17"/>
    <p:sldId id="2023" r:id="rId18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88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  <a:srgbClr val="F0EDEC"/>
    <a:srgbClr val="E1D9D7"/>
    <a:srgbClr val="E6DBD2"/>
    <a:srgbClr val="FCDCBC"/>
    <a:srgbClr val="F8F200"/>
    <a:srgbClr val="B80000"/>
    <a:srgbClr val="FFCC66"/>
    <a:srgbClr val="FFFFFF"/>
    <a:srgbClr val="039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D82ED02-7E44-4D90-AA80-85DAE28EF6E0}" v="11" dt="2025-05-23T00:21:50.59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116" y="-972"/>
      </p:cViewPr>
      <p:guideLst>
        <p:guide orient="horz" pos="4088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6/11/relationships/changesInfo" Target="changesInfos/changesInfo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n Ge" userId="b8e2f334ff6b24d1" providerId="LiveId" clId="{E541C54D-80C8-4FBC-802B-F04B92A715F8}"/>
    <pc:docChg chg="undo custSel modSld">
      <pc:chgData name="Jun Ge" userId="b8e2f334ff6b24d1" providerId="LiveId" clId="{E541C54D-80C8-4FBC-802B-F04B92A715F8}" dt="2025-05-15T13:48:27.624" v="3" actId="13926"/>
      <pc:docMkLst>
        <pc:docMk/>
      </pc:docMkLst>
      <pc:sldChg chg="modSp mod">
        <pc:chgData name="Jun Ge" userId="b8e2f334ff6b24d1" providerId="LiveId" clId="{E541C54D-80C8-4FBC-802B-F04B92A715F8}" dt="2025-05-15T13:48:27.624" v="3" actId="13926"/>
        <pc:sldMkLst>
          <pc:docMk/>
          <pc:sldMk cId="1082031398" sldId="2022"/>
        </pc:sldMkLst>
        <pc:graphicFrameChg chg="mod modGraphic">
          <ac:chgData name="Jun Ge" userId="b8e2f334ff6b24d1" providerId="LiveId" clId="{E541C54D-80C8-4FBC-802B-F04B92A715F8}" dt="2025-05-15T13:48:27.624" v="3" actId="13926"/>
          <ac:graphicFrameMkLst>
            <pc:docMk/>
            <pc:sldMk cId="1082031398" sldId="2022"/>
            <ac:graphicFrameMk id="7" creationId="{8C18C645-16B0-3614-5CD9-14BA3E973DD7}"/>
          </ac:graphicFrameMkLst>
        </pc:graphicFrameChg>
      </pc:sldChg>
    </pc:docChg>
  </pc:docChgLst>
  <pc:docChgLst>
    <pc:chgData name="Jun Ge" userId="b8e2f334ff6b24d1" providerId="LiveId" clId="{27BBD27F-DAD9-48F7-9CAB-0BA8756FCF49}"/>
    <pc:docChg chg="custSel addSld modSld">
      <pc:chgData name="Jun Ge" userId="b8e2f334ff6b24d1" providerId="LiveId" clId="{27BBD27F-DAD9-48F7-9CAB-0BA8756FCF49}" dt="2025-05-06T13:11:18.694" v="182" actId="20577"/>
      <pc:docMkLst>
        <pc:docMk/>
      </pc:docMkLst>
      <pc:sldChg chg="addSp delSp modSp mod">
        <pc:chgData name="Jun Ge" userId="b8e2f334ff6b24d1" providerId="LiveId" clId="{27BBD27F-DAD9-48F7-9CAB-0BA8756FCF49}" dt="2025-05-06T13:00:03.594" v="154" actId="1036"/>
        <pc:sldMkLst>
          <pc:docMk/>
          <pc:sldMk cId="2097586221" sldId="2016"/>
        </pc:sldMkLst>
      </pc:sldChg>
      <pc:sldChg chg="addSp modSp new mod">
        <pc:chgData name="Jun Ge" userId="b8e2f334ff6b24d1" providerId="LiveId" clId="{27BBD27F-DAD9-48F7-9CAB-0BA8756FCF49}" dt="2025-05-06T13:11:18.694" v="182" actId="20577"/>
        <pc:sldMkLst>
          <pc:docMk/>
          <pc:sldMk cId="736711877" sldId="2020"/>
        </pc:sldMkLst>
      </pc:sldChg>
    </pc:docChg>
  </pc:docChgLst>
  <pc:docChgLst>
    <pc:chgData name="Jun Ge" userId="b8e2f334ff6b24d1" providerId="LiveId" clId="{825995D3-08DA-4B58-8974-CEEA835AA63A}"/>
    <pc:docChg chg="custSel addSld modSld">
      <pc:chgData name="Jun Ge" userId="b8e2f334ff6b24d1" providerId="LiveId" clId="{825995D3-08DA-4B58-8974-CEEA835AA63A}" dt="2025-04-30T06:08:51.398" v="42" actId="20577"/>
      <pc:docMkLst>
        <pc:docMk/>
      </pc:docMkLst>
      <pc:sldChg chg="add">
        <pc:chgData name="Jun Ge" userId="b8e2f334ff6b24d1" providerId="LiveId" clId="{825995D3-08DA-4B58-8974-CEEA835AA63A}" dt="2025-04-30T05:38:09.860" v="1"/>
        <pc:sldMkLst>
          <pc:docMk/>
          <pc:sldMk cId="27041322" sldId="1998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3540714721" sldId="2000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2645669267" sldId="2004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1997357976" sldId="2005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2950916666" sldId="2007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3613101676" sldId="2008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1294620802" sldId="2011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3927637345" sldId="2012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1010496936" sldId="2013"/>
        </pc:sldMkLst>
      </pc:sldChg>
      <pc:sldChg chg="addSp delSp modSp add mod">
        <pc:chgData name="Jun Ge" userId="b8e2f334ff6b24d1" providerId="LiveId" clId="{825995D3-08DA-4B58-8974-CEEA835AA63A}" dt="2025-04-30T06:08:51.398" v="42" actId="20577"/>
        <pc:sldMkLst>
          <pc:docMk/>
          <pc:sldMk cId="3682301007" sldId="2015"/>
        </pc:sldMkLst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6" creationId="{22F635C3-6459-2673-AC77-F4617B59FC4D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1" creationId="{99E0D76C-277A-A1C3-0B02-6AE8B920A445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2" creationId="{B688B260-AA42-1768-5CC0-DB91ECCA8E92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3" creationId="{CF03B69B-1CE4-5D78-297C-58517D494DF5}"/>
          </ac:spMkLst>
        </pc:spChg>
        <pc:spChg chg="mod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5" creationId="{FABF467D-C420-540A-A1CB-0D77C3FC8AB5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6" creationId="{F0BD5D86-C541-00A6-BB15-96900B56E88C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19" creationId="{9FC26628-9DC2-5EAC-DA58-9BC405A18E9F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20" creationId="{CB8C969C-F2EE-4EC5-01E1-0DC2CE776C1B}"/>
          </ac:spMkLst>
        </pc:spChg>
        <pc:spChg chg="mod topLvl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21" creationId="{1E9F67F4-BB1D-61EE-C91A-A32FED6DE3F2}"/>
          </ac:spMkLst>
        </pc:spChg>
        <pc:spChg chg="mod">
          <ac:chgData name="Jun Ge" userId="b8e2f334ff6b24d1" providerId="LiveId" clId="{825995D3-08DA-4B58-8974-CEEA835AA63A}" dt="2025-04-30T05:38:57.265" v="40" actId="164"/>
          <ac:spMkLst>
            <pc:docMk/>
            <pc:sldMk cId="3682301007" sldId="2015"/>
            <ac:spMk id="22" creationId="{0AFDF182-2742-265B-5961-8F28CE61EB93}"/>
          </ac:spMkLst>
        </pc:spChg>
        <pc:spChg chg="mod">
          <ac:chgData name="Jun Ge" userId="b8e2f334ff6b24d1" providerId="LiveId" clId="{825995D3-08DA-4B58-8974-CEEA835AA63A}" dt="2025-04-30T06:08:51.398" v="42" actId="20577"/>
          <ac:spMkLst>
            <pc:docMk/>
            <pc:sldMk cId="3682301007" sldId="2015"/>
            <ac:spMk id="29" creationId="{238251D4-08E8-AB92-9823-7837288781AC}"/>
          </ac:spMkLst>
        </pc:spChg>
      </pc:sldChg>
      <pc:sldChg chg="new">
        <pc:chgData name="Jun Ge" userId="b8e2f334ff6b24d1" providerId="LiveId" clId="{825995D3-08DA-4B58-8974-CEEA835AA63A}" dt="2025-04-30T05:38:09.007" v="0" actId="680"/>
        <pc:sldMkLst>
          <pc:docMk/>
          <pc:sldMk cId="35473581" sldId="2017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1135461668" sldId="2018"/>
        </pc:sldMkLst>
      </pc:sldChg>
      <pc:sldChg chg="add">
        <pc:chgData name="Jun Ge" userId="b8e2f334ff6b24d1" providerId="LiveId" clId="{825995D3-08DA-4B58-8974-CEEA835AA63A}" dt="2025-04-30T05:38:09.860" v="1"/>
        <pc:sldMkLst>
          <pc:docMk/>
          <pc:sldMk cId="1948246596" sldId="2019"/>
        </pc:sldMkLst>
      </pc:sldChg>
    </pc:docChg>
  </pc:docChgLst>
  <pc:docChgLst>
    <pc:chgData name="Jun Ge" userId="b8e2f334ff6b24d1" providerId="LiveId" clId="{0D82ED02-7E44-4D90-AA80-85DAE28EF6E0}"/>
    <pc:docChg chg="undo redo custSel addSld delSld modSld sldOrd">
      <pc:chgData name="Jun Ge" userId="b8e2f334ff6b24d1" providerId="LiveId" clId="{0D82ED02-7E44-4D90-AA80-85DAE28EF6E0}" dt="2025-05-23T00:35:07.289" v="2657" actId="114"/>
      <pc:docMkLst>
        <pc:docMk/>
      </pc:docMkLst>
      <pc:sldChg chg="del">
        <pc:chgData name="Jun Ge" userId="b8e2f334ff6b24d1" providerId="LiveId" clId="{0D82ED02-7E44-4D90-AA80-85DAE28EF6E0}" dt="2025-05-07T07:08:40.047" v="0" actId="47"/>
        <pc:sldMkLst>
          <pc:docMk/>
          <pc:sldMk cId="2018852456" sldId="259"/>
        </pc:sldMkLst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2623619644" sldId="1971"/>
        </pc:sldMkLst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1636927533" sldId="1985"/>
        </pc:sldMkLst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3163861480" sldId="1990"/>
        </pc:sldMkLst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2642223838" sldId="1994"/>
        </pc:sldMkLst>
      </pc:sldChg>
      <pc:sldChg chg="addSp delSp modSp mod chgLayout">
        <pc:chgData name="Jun Ge" userId="b8e2f334ff6b24d1" providerId="LiveId" clId="{0D82ED02-7E44-4D90-AA80-85DAE28EF6E0}" dt="2025-05-13T09:29:47.984" v="2421" actId="2710"/>
        <pc:sldMkLst>
          <pc:docMk/>
          <pc:sldMk cId="27041322" sldId="1998"/>
        </pc:sldMkLst>
        <pc:spChg chg="mod">
          <ac:chgData name="Jun Ge" userId="b8e2f334ff6b24d1" providerId="LiveId" clId="{0D82ED02-7E44-4D90-AA80-85DAE28EF6E0}" dt="2025-05-13T09:29:47.984" v="2421" actId="2710"/>
          <ac:spMkLst>
            <pc:docMk/>
            <pc:sldMk cId="27041322" sldId="1998"/>
            <ac:spMk id="4" creationId="{A1CA2BD4-D252-654F-BB3B-46156A64F2D3}"/>
          </ac:spMkLst>
        </pc:spChg>
      </pc:sldChg>
      <pc:sldChg chg="modSp mod">
        <pc:chgData name="Jun Ge" userId="b8e2f334ff6b24d1" providerId="LiveId" clId="{0D82ED02-7E44-4D90-AA80-85DAE28EF6E0}" dt="2025-05-23T00:25:44.305" v="2644" actId="20577"/>
        <pc:sldMkLst>
          <pc:docMk/>
          <pc:sldMk cId="3540714721" sldId="2000"/>
        </pc:sldMkLst>
        <pc:spChg chg="mod">
          <ac:chgData name="Jun Ge" userId="b8e2f334ff6b24d1" providerId="LiveId" clId="{0D82ED02-7E44-4D90-AA80-85DAE28EF6E0}" dt="2025-05-23T00:25:44.305" v="2644" actId="20577"/>
          <ac:spMkLst>
            <pc:docMk/>
            <pc:sldMk cId="3540714721" sldId="2000"/>
            <ac:spMk id="2" creationId="{12579D72-C2F3-2410-4C4D-4CFB43ED32A6}"/>
          </ac:spMkLst>
        </pc:spChg>
        <pc:spChg chg="mod">
          <ac:chgData name="Jun Ge" userId="b8e2f334ff6b24d1" providerId="LiveId" clId="{0D82ED02-7E44-4D90-AA80-85DAE28EF6E0}" dt="2025-05-22T23:40:27.566" v="2563" actId="20577"/>
          <ac:spMkLst>
            <pc:docMk/>
            <pc:sldMk cId="3540714721" sldId="2000"/>
            <ac:spMk id="13" creationId="{8ACDE1A8-6181-29B5-0278-8804384EC2BC}"/>
          </ac:spMkLst>
        </pc:spChg>
        <pc:spChg chg="mod">
          <ac:chgData name="Jun Ge" userId="b8e2f334ff6b24d1" providerId="LiveId" clId="{0D82ED02-7E44-4D90-AA80-85DAE28EF6E0}" dt="2025-05-22T23:40:29.315" v="2564" actId="20577"/>
          <ac:spMkLst>
            <pc:docMk/>
            <pc:sldMk cId="3540714721" sldId="2000"/>
            <ac:spMk id="14" creationId="{8B1AD08E-0425-5C96-654A-DB475A29349D}"/>
          </ac:spMkLst>
        </pc:spChg>
        <pc:spChg chg="mod">
          <ac:chgData name="Jun Ge" userId="b8e2f334ff6b24d1" providerId="LiveId" clId="{0D82ED02-7E44-4D90-AA80-85DAE28EF6E0}" dt="2025-05-22T23:40:30.780" v="2565" actId="20577"/>
          <ac:spMkLst>
            <pc:docMk/>
            <pc:sldMk cId="3540714721" sldId="2000"/>
            <ac:spMk id="15" creationId="{32AEFE3A-E702-BB9D-8B0A-C1EF1DA17C92}"/>
          </ac:spMkLst>
        </pc:spChg>
      </pc:sldChg>
      <pc:sldChg chg="addSp delSp modSp mod">
        <pc:chgData name="Jun Ge" userId="b8e2f334ff6b24d1" providerId="LiveId" clId="{0D82ED02-7E44-4D90-AA80-85DAE28EF6E0}" dt="2025-05-23T00:26:56.571" v="2652" actId="20577"/>
        <pc:sldMkLst>
          <pc:docMk/>
          <pc:sldMk cId="2645669267" sldId="2004"/>
        </pc:sldMkLst>
        <pc:spChg chg="mod">
          <ac:chgData name="Jun Ge" userId="b8e2f334ff6b24d1" providerId="LiveId" clId="{0D82ED02-7E44-4D90-AA80-85DAE28EF6E0}" dt="2025-05-22T23:41:47.178" v="2591" actId="20577"/>
          <ac:spMkLst>
            <pc:docMk/>
            <pc:sldMk cId="2645669267" sldId="2004"/>
            <ac:spMk id="11" creationId="{2C0529D5-D538-8937-DDEB-F1E65C1B5E96}"/>
          </ac:spMkLst>
        </pc:spChg>
        <pc:spChg chg="mod topLvl">
          <ac:chgData name="Jun Ge" userId="b8e2f334ff6b24d1" providerId="LiveId" clId="{0D82ED02-7E44-4D90-AA80-85DAE28EF6E0}" dt="2025-05-22T23:41:48.814" v="2593" actId="20577"/>
          <ac:spMkLst>
            <pc:docMk/>
            <pc:sldMk cId="2645669267" sldId="2004"/>
            <ac:spMk id="12" creationId="{D7860481-ABA4-A926-C48C-24A7F90F26C0}"/>
          </ac:spMkLst>
        </pc:spChg>
        <pc:spChg chg="mod">
          <ac:chgData name="Jun Ge" userId="b8e2f334ff6b24d1" providerId="LiveId" clId="{0D82ED02-7E44-4D90-AA80-85DAE28EF6E0}" dt="2025-05-22T23:41:50.690" v="2595" actId="20577"/>
          <ac:spMkLst>
            <pc:docMk/>
            <pc:sldMk cId="2645669267" sldId="2004"/>
            <ac:spMk id="13" creationId="{8D7C34D6-CD87-897E-5586-C1193DA15CA9}"/>
          </ac:spMkLst>
        </pc:spChg>
        <pc:spChg chg="mod topLvl">
          <ac:chgData name="Jun Ge" userId="b8e2f334ff6b24d1" providerId="LiveId" clId="{0D82ED02-7E44-4D90-AA80-85DAE28EF6E0}" dt="2025-05-22T23:41:52.990" v="2596" actId="20577"/>
          <ac:spMkLst>
            <pc:docMk/>
            <pc:sldMk cId="2645669267" sldId="2004"/>
            <ac:spMk id="14" creationId="{C2118672-3F23-C03C-00C8-3B3664CA5C42}"/>
          </ac:spMkLst>
        </pc:spChg>
        <pc:spChg chg="mod topLvl">
          <ac:chgData name="Jun Ge" userId="b8e2f334ff6b24d1" providerId="LiveId" clId="{0D82ED02-7E44-4D90-AA80-85DAE28EF6E0}" dt="2025-05-22T23:41:54.455" v="2597" actId="20577"/>
          <ac:spMkLst>
            <pc:docMk/>
            <pc:sldMk cId="2645669267" sldId="2004"/>
            <ac:spMk id="15" creationId="{6005BD6F-206B-BE0A-8A16-F12FB5701D32}"/>
          </ac:spMkLst>
        </pc:spChg>
        <pc:spChg chg="mod">
          <ac:chgData name="Jun Ge" userId="b8e2f334ff6b24d1" providerId="LiveId" clId="{0D82ED02-7E44-4D90-AA80-85DAE28EF6E0}" dt="2025-05-22T23:41:58.586" v="2599" actId="20577"/>
          <ac:spMkLst>
            <pc:docMk/>
            <pc:sldMk cId="2645669267" sldId="2004"/>
            <ac:spMk id="16" creationId="{5D65F8AB-EC32-8311-FC12-119C9CC2F88A}"/>
          </ac:spMkLst>
        </pc:spChg>
        <pc:spChg chg="mod">
          <ac:chgData name="Jun Ge" userId="b8e2f334ff6b24d1" providerId="LiveId" clId="{0D82ED02-7E44-4D90-AA80-85DAE28EF6E0}" dt="2025-05-22T23:42:00.595" v="2601" actId="20577"/>
          <ac:spMkLst>
            <pc:docMk/>
            <pc:sldMk cId="2645669267" sldId="2004"/>
            <ac:spMk id="17" creationId="{A883D369-F644-2CF3-D889-8D66B3FF2C5D}"/>
          </ac:spMkLst>
        </pc:spChg>
        <pc:spChg chg="add mod">
          <ac:chgData name="Jun Ge" userId="b8e2f334ff6b24d1" providerId="LiveId" clId="{0D82ED02-7E44-4D90-AA80-85DAE28EF6E0}" dt="2025-05-23T00:26:56.571" v="2652" actId="20577"/>
          <ac:spMkLst>
            <pc:docMk/>
            <pc:sldMk cId="2645669267" sldId="2004"/>
            <ac:spMk id="21" creationId="{3E17923C-6528-88A8-14E7-E5F054F6F197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86" creationId="{06DF3F1A-78BB-7768-895F-F0C6BBADC408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90" creationId="{AEF90F8A-4E6C-0277-06EB-2696FB06303B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95" creationId="{FC7FD9BC-3578-9920-E4F4-6E664F08EE7F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98" creationId="{DB7F2CF1-BF7E-05D9-4555-735843071357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107" creationId="{17E744E6-7246-820B-A06B-4063718CC7C7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109" creationId="{86AA50F2-239C-D60C-9960-A7294520040C}"/>
          </ac:spMkLst>
        </pc:spChg>
        <pc:spChg chg="mod">
          <ac:chgData name="Jun Ge" userId="b8e2f334ff6b24d1" providerId="LiveId" clId="{0D82ED02-7E44-4D90-AA80-85DAE28EF6E0}" dt="2025-05-10T02:05:31.454" v="2191" actId="165"/>
          <ac:spMkLst>
            <pc:docMk/>
            <pc:sldMk cId="2645669267" sldId="2004"/>
            <ac:spMk id="111" creationId="{3D19CF76-EDC3-07BB-899E-BCC554A2B892}"/>
          </ac:spMkLst>
        </pc:spChg>
        <pc:grpChg chg="mod">
          <ac:chgData name="Jun Ge" userId="b8e2f334ff6b24d1" providerId="LiveId" clId="{0D82ED02-7E44-4D90-AA80-85DAE28EF6E0}" dt="2025-05-10T02:06:44.802" v="2272" actId="1037"/>
          <ac:grpSpMkLst>
            <pc:docMk/>
            <pc:sldMk cId="2645669267" sldId="2004"/>
            <ac:grpSpMk id="3" creationId="{9CD2F699-4012-18A2-B180-BC0D2B81765B}"/>
          </ac:grpSpMkLst>
        </pc:grpChg>
        <pc:grpChg chg="mod">
          <ac:chgData name="Jun Ge" userId="b8e2f334ff6b24d1" providerId="LiveId" clId="{0D82ED02-7E44-4D90-AA80-85DAE28EF6E0}" dt="2025-05-10T02:06:13.056" v="2255" actId="1037"/>
          <ac:grpSpMkLst>
            <pc:docMk/>
            <pc:sldMk cId="2645669267" sldId="2004"/>
            <ac:grpSpMk id="4" creationId="{1358D61F-167D-114B-C1B3-0FEB392A8011}"/>
          </ac:grpSpMkLst>
        </pc:grpChg>
        <pc:grpChg chg="mod">
          <ac:chgData name="Jun Ge" userId="b8e2f334ff6b24d1" providerId="LiveId" clId="{0D82ED02-7E44-4D90-AA80-85DAE28EF6E0}" dt="2025-05-10T02:06:59.266" v="2287" actId="164"/>
          <ac:grpSpMkLst>
            <pc:docMk/>
            <pc:sldMk cId="2645669267" sldId="2004"/>
            <ac:grpSpMk id="5" creationId="{AE687C38-84DE-7B61-B319-59031EC9B2EB}"/>
          </ac:grpSpMkLst>
        </pc:grpChg>
        <pc:grpChg chg="mod">
          <ac:chgData name="Jun Ge" userId="b8e2f334ff6b24d1" providerId="LiveId" clId="{0D82ED02-7E44-4D90-AA80-85DAE28EF6E0}" dt="2025-05-10T02:06:59.266" v="2287" actId="164"/>
          <ac:grpSpMkLst>
            <pc:docMk/>
            <pc:sldMk cId="2645669267" sldId="2004"/>
            <ac:grpSpMk id="6" creationId="{3F77F583-867A-5229-5DCC-8E60AB47D18F}"/>
          </ac:grpSpMkLst>
        </pc:grpChg>
        <pc:grpChg chg="mod">
          <ac:chgData name="Jun Ge" userId="b8e2f334ff6b24d1" providerId="LiveId" clId="{0D82ED02-7E44-4D90-AA80-85DAE28EF6E0}" dt="2025-05-10T02:06:55.176" v="2286" actId="1035"/>
          <ac:grpSpMkLst>
            <pc:docMk/>
            <pc:sldMk cId="2645669267" sldId="2004"/>
            <ac:grpSpMk id="7" creationId="{799E305A-6040-E28D-D758-F267A6B297B2}"/>
          </ac:grpSpMkLst>
        </pc:grpChg>
        <pc:grpChg chg="mod">
          <ac:chgData name="Jun Ge" userId="b8e2f334ff6b24d1" providerId="LiveId" clId="{0D82ED02-7E44-4D90-AA80-85DAE28EF6E0}" dt="2025-05-10T02:06:55.176" v="2286" actId="1035"/>
          <ac:grpSpMkLst>
            <pc:docMk/>
            <pc:sldMk cId="2645669267" sldId="2004"/>
            <ac:grpSpMk id="8" creationId="{48727D59-5610-D6E5-B202-0B74677A20D8}"/>
          </ac:grpSpMkLst>
        </pc:grpChg>
        <pc:grpChg chg="mod">
          <ac:chgData name="Jun Ge" userId="b8e2f334ff6b24d1" providerId="LiveId" clId="{0D82ED02-7E44-4D90-AA80-85DAE28EF6E0}" dt="2025-05-10T02:06:55.176" v="2286" actId="1035"/>
          <ac:grpSpMkLst>
            <pc:docMk/>
            <pc:sldMk cId="2645669267" sldId="2004"/>
            <ac:grpSpMk id="9" creationId="{0432618C-05EA-D300-B81A-006E90CE702C}"/>
          </ac:grpSpMkLst>
        </pc:grpChg>
        <pc:grpChg chg="add mod">
          <ac:chgData name="Jun Ge" userId="b8e2f334ff6b24d1" providerId="LiveId" clId="{0D82ED02-7E44-4D90-AA80-85DAE28EF6E0}" dt="2025-05-10T02:24:22.655" v="2348" actId="1036"/>
          <ac:grpSpMkLst>
            <pc:docMk/>
            <pc:sldMk cId="2645669267" sldId="2004"/>
            <ac:grpSpMk id="20" creationId="{AC94F770-76F3-CD82-C40D-42CA45A19D78}"/>
          </ac:grpSpMkLst>
        </pc:grpChg>
      </pc:sldChg>
      <pc:sldChg chg="modSp mod">
        <pc:chgData name="Jun Ge" userId="b8e2f334ff6b24d1" providerId="LiveId" clId="{0D82ED02-7E44-4D90-AA80-85DAE28EF6E0}" dt="2025-05-23T00:26:48.111" v="2649" actId="20577"/>
        <pc:sldMkLst>
          <pc:docMk/>
          <pc:sldMk cId="1997357976" sldId="2005"/>
        </pc:sldMkLst>
        <pc:spChg chg="mod">
          <ac:chgData name="Jun Ge" userId="b8e2f334ff6b24d1" providerId="LiveId" clId="{0D82ED02-7E44-4D90-AA80-85DAE28EF6E0}" dt="2025-05-22T23:41:32.560" v="2585" actId="20577"/>
          <ac:spMkLst>
            <pc:docMk/>
            <pc:sldMk cId="1997357976" sldId="2005"/>
            <ac:spMk id="14" creationId="{EA33387F-B3FE-5E82-6E65-6C8877FEED41}"/>
          </ac:spMkLst>
        </pc:spChg>
        <pc:spChg chg="mod">
          <ac:chgData name="Jun Ge" userId="b8e2f334ff6b24d1" providerId="LiveId" clId="{0D82ED02-7E44-4D90-AA80-85DAE28EF6E0}" dt="2025-05-22T23:41:33.889" v="2586" actId="20577"/>
          <ac:spMkLst>
            <pc:docMk/>
            <pc:sldMk cId="1997357976" sldId="2005"/>
            <ac:spMk id="15" creationId="{03991227-1849-6C62-F9B8-6CFAAED2D75C}"/>
          </ac:spMkLst>
        </pc:spChg>
        <pc:spChg chg="mod">
          <ac:chgData name="Jun Ge" userId="b8e2f334ff6b24d1" providerId="LiveId" clId="{0D82ED02-7E44-4D90-AA80-85DAE28EF6E0}" dt="2025-05-23T00:26:48.111" v="2649" actId="20577"/>
          <ac:spMkLst>
            <pc:docMk/>
            <pc:sldMk cId="1997357976" sldId="2005"/>
            <ac:spMk id="16" creationId="{7E7742CD-2B28-CFC8-E9D3-A831EFD23A85}"/>
          </ac:spMkLst>
        </pc:spChg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2834156885" sldId="2006"/>
        </pc:sldMkLst>
      </pc:sldChg>
      <pc:sldChg chg="addSp delSp modSp mod">
        <pc:chgData name="Jun Ge" userId="b8e2f334ff6b24d1" providerId="LiveId" clId="{0D82ED02-7E44-4D90-AA80-85DAE28EF6E0}" dt="2025-05-23T00:24:49.121" v="2632" actId="20577"/>
        <pc:sldMkLst>
          <pc:docMk/>
          <pc:sldMk cId="2950916666" sldId="2007"/>
        </pc:sldMkLst>
        <pc:spChg chg="mod">
          <ac:chgData name="Jun Ge" userId="b8e2f334ff6b24d1" providerId="LiveId" clId="{0D82ED02-7E44-4D90-AA80-85DAE28EF6E0}" dt="2025-05-23T00:24:49.121" v="2632" actId="20577"/>
          <ac:spMkLst>
            <pc:docMk/>
            <pc:sldMk cId="2950916666" sldId="2007"/>
            <ac:spMk id="10" creationId="{BF0F2345-9415-21C9-E045-24D5A13E0A98}"/>
          </ac:spMkLst>
        </pc:spChg>
        <pc:spChg chg="mod">
          <ac:chgData name="Jun Ge" userId="b8e2f334ff6b24d1" providerId="LiveId" clId="{0D82ED02-7E44-4D90-AA80-85DAE28EF6E0}" dt="2025-05-22T23:39:37.153" v="2522" actId="20577"/>
          <ac:spMkLst>
            <pc:docMk/>
            <pc:sldMk cId="2950916666" sldId="2007"/>
            <ac:spMk id="18" creationId="{B05C1EAF-C30C-D26A-00CD-F2AB76F3276A}"/>
          </ac:spMkLst>
        </pc:spChg>
        <pc:spChg chg="mod">
          <ac:chgData name="Jun Ge" userId="b8e2f334ff6b24d1" providerId="LiveId" clId="{0D82ED02-7E44-4D90-AA80-85DAE28EF6E0}" dt="2025-05-22T23:39:38.831" v="2524" actId="20577"/>
          <ac:spMkLst>
            <pc:docMk/>
            <pc:sldMk cId="2950916666" sldId="2007"/>
            <ac:spMk id="20" creationId="{2E1584AA-52E6-A0FD-70F4-5FDAF8A3EFD7}"/>
          </ac:spMkLst>
        </pc:spChg>
        <pc:spChg chg="mod">
          <ac:chgData name="Jun Ge" userId="b8e2f334ff6b24d1" providerId="LiveId" clId="{0D82ED02-7E44-4D90-AA80-85DAE28EF6E0}" dt="2025-05-22T23:39:41.467" v="2526" actId="20577"/>
          <ac:spMkLst>
            <pc:docMk/>
            <pc:sldMk cId="2950916666" sldId="2007"/>
            <ac:spMk id="21" creationId="{912229D4-ADA4-23E5-CE2E-256B309C1836}"/>
          </ac:spMkLst>
        </pc:spChg>
        <pc:spChg chg="mod ord">
          <ac:chgData name="Jun Ge" userId="b8e2f334ff6b24d1" providerId="LiveId" clId="{0D82ED02-7E44-4D90-AA80-85DAE28EF6E0}" dt="2025-05-22T23:39:44.131" v="2528" actId="20577"/>
          <ac:spMkLst>
            <pc:docMk/>
            <pc:sldMk cId="2950916666" sldId="2007"/>
            <ac:spMk id="22" creationId="{C494F37F-CC94-BFBC-6CBA-ED4F1E2C9247}"/>
          </ac:spMkLst>
        </pc:spChg>
        <pc:spChg chg="mod ord topLvl">
          <ac:chgData name="Jun Ge" userId="b8e2f334ff6b24d1" providerId="LiveId" clId="{0D82ED02-7E44-4D90-AA80-85DAE28EF6E0}" dt="2025-05-22T23:39:45.715" v="2530" actId="20577"/>
          <ac:spMkLst>
            <pc:docMk/>
            <pc:sldMk cId="2950916666" sldId="2007"/>
            <ac:spMk id="23" creationId="{4C78BF46-E024-4610-4E94-363BCCFFCB93}"/>
          </ac:spMkLst>
        </pc:spChg>
        <pc:spChg chg="mod ord">
          <ac:chgData name="Jun Ge" userId="b8e2f334ff6b24d1" providerId="LiveId" clId="{0D82ED02-7E44-4D90-AA80-85DAE28EF6E0}" dt="2025-05-22T23:39:48.029" v="2532" actId="20577"/>
          <ac:spMkLst>
            <pc:docMk/>
            <pc:sldMk cId="2950916666" sldId="2007"/>
            <ac:spMk id="24" creationId="{18B7E778-615A-FCCC-A6A0-6F04088943F2}"/>
          </ac:spMkLst>
        </pc:spChg>
        <pc:spChg chg="mod">
          <ac:chgData name="Jun Ge" userId="b8e2f334ff6b24d1" providerId="LiveId" clId="{0D82ED02-7E44-4D90-AA80-85DAE28EF6E0}" dt="2025-05-22T23:39:50.250" v="2534" actId="20577"/>
          <ac:spMkLst>
            <pc:docMk/>
            <pc:sldMk cId="2950916666" sldId="2007"/>
            <ac:spMk id="32" creationId="{3768A870-198A-8295-17B2-336AA6F04959}"/>
          </ac:spMkLst>
        </pc:spChg>
        <pc:spChg chg="mod">
          <ac:chgData name="Jun Ge" userId="b8e2f334ff6b24d1" providerId="LiveId" clId="{0D82ED02-7E44-4D90-AA80-85DAE28EF6E0}" dt="2025-05-10T01:36:23.558" v="1376" actId="1038"/>
          <ac:spMkLst>
            <pc:docMk/>
            <pc:sldMk cId="2950916666" sldId="2007"/>
            <ac:spMk id="33" creationId="{710CAEFD-2663-F3D1-8E6F-E44B29980210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34" creationId="{BCE7DBF8-CCC8-EBED-E15A-5AFD576D1EF9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35" creationId="{ABC1E357-BC68-2984-10E9-1F86962BE05A}"/>
          </ac:spMkLst>
        </pc:spChg>
        <pc:spChg chg="mod">
          <ac:chgData name="Jun Ge" userId="b8e2f334ff6b24d1" providerId="LiveId" clId="{0D82ED02-7E44-4D90-AA80-85DAE28EF6E0}" dt="2025-05-10T01:33:15.334" v="1290" actId="164"/>
          <ac:spMkLst>
            <pc:docMk/>
            <pc:sldMk cId="2950916666" sldId="2007"/>
            <ac:spMk id="36" creationId="{BF7FC62D-0DA3-3A21-89E9-F59D1E826099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37" creationId="{A9693803-4C4E-0632-A1A9-13E5639F6329}"/>
          </ac:spMkLst>
        </pc:spChg>
        <pc:spChg chg="mod">
          <ac:chgData name="Jun Ge" userId="b8e2f334ff6b24d1" providerId="LiveId" clId="{0D82ED02-7E44-4D90-AA80-85DAE28EF6E0}" dt="2025-05-10T01:33:15.334" v="1290" actId="164"/>
          <ac:spMkLst>
            <pc:docMk/>
            <pc:sldMk cId="2950916666" sldId="2007"/>
            <ac:spMk id="38" creationId="{D18890DB-CF76-68FA-8ABF-B75CF1FFA9ED}"/>
          </ac:spMkLst>
        </pc:spChg>
        <pc:spChg chg="mod">
          <ac:chgData name="Jun Ge" userId="b8e2f334ff6b24d1" providerId="LiveId" clId="{0D82ED02-7E44-4D90-AA80-85DAE28EF6E0}" dt="2025-05-10T01:36:39.577" v="1394" actId="1037"/>
          <ac:spMkLst>
            <pc:docMk/>
            <pc:sldMk cId="2950916666" sldId="2007"/>
            <ac:spMk id="39" creationId="{C7C2B6CA-725B-4899-E782-926FFE261AD3}"/>
          </ac:spMkLst>
        </pc:spChg>
        <pc:spChg chg="mod">
          <ac:chgData name="Jun Ge" userId="b8e2f334ff6b24d1" providerId="LiveId" clId="{0D82ED02-7E44-4D90-AA80-85DAE28EF6E0}" dt="2025-05-10T01:36:58.397" v="1397" actId="1038"/>
          <ac:spMkLst>
            <pc:docMk/>
            <pc:sldMk cId="2950916666" sldId="2007"/>
            <ac:spMk id="40" creationId="{29FA4A7F-0D84-4B31-D6C1-EA9E8E33CFCE}"/>
          </ac:spMkLst>
        </pc:spChg>
        <pc:spChg chg="mod">
          <ac:chgData name="Jun Ge" userId="b8e2f334ff6b24d1" providerId="LiveId" clId="{0D82ED02-7E44-4D90-AA80-85DAE28EF6E0}" dt="2025-05-10T01:36:30.817" v="1387" actId="1035"/>
          <ac:spMkLst>
            <pc:docMk/>
            <pc:sldMk cId="2950916666" sldId="2007"/>
            <ac:spMk id="41" creationId="{1BDA3937-F4FA-B4EC-4C1B-DA7AF1B3AE59}"/>
          </ac:spMkLst>
        </pc:spChg>
        <pc:spChg chg="mod">
          <ac:chgData name="Jun Ge" userId="b8e2f334ff6b24d1" providerId="LiveId" clId="{0D82ED02-7E44-4D90-AA80-85DAE28EF6E0}" dt="2025-05-10T01:36:32.036" v="1389" actId="1035"/>
          <ac:spMkLst>
            <pc:docMk/>
            <pc:sldMk cId="2950916666" sldId="2007"/>
            <ac:spMk id="42" creationId="{662867B5-0E79-1E99-B264-638ADC8175DA}"/>
          </ac:spMkLst>
        </pc:spChg>
        <pc:spChg chg="mod ord">
          <ac:chgData name="Jun Ge" userId="b8e2f334ff6b24d1" providerId="LiveId" clId="{0D82ED02-7E44-4D90-AA80-85DAE28EF6E0}" dt="2025-05-10T01:39:31.206" v="1592" actId="1035"/>
          <ac:spMkLst>
            <pc:docMk/>
            <pc:sldMk cId="2950916666" sldId="2007"/>
            <ac:spMk id="43" creationId="{5DE8BA59-8427-2192-81E2-299CB4182125}"/>
          </ac:spMkLst>
        </pc:spChg>
        <pc:spChg chg="mod ord">
          <ac:chgData name="Jun Ge" userId="b8e2f334ff6b24d1" providerId="LiveId" clId="{0D82ED02-7E44-4D90-AA80-85DAE28EF6E0}" dt="2025-05-10T01:37:04" v="1402" actId="1035"/>
          <ac:spMkLst>
            <pc:docMk/>
            <pc:sldMk cId="2950916666" sldId="2007"/>
            <ac:spMk id="44" creationId="{18E9DF80-B4F3-BC28-CFA8-AC47DEB1B620}"/>
          </ac:spMkLst>
        </pc:spChg>
        <pc:spChg chg="mod ord">
          <ac:chgData name="Jun Ge" userId="b8e2f334ff6b24d1" providerId="LiveId" clId="{0D82ED02-7E44-4D90-AA80-85DAE28EF6E0}" dt="2025-05-10T01:37:06.044" v="1405" actId="1038"/>
          <ac:spMkLst>
            <pc:docMk/>
            <pc:sldMk cId="2950916666" sldId="2007"/>
            <ac:spMk id="45" creationId="{4852BDBF-68DE-AD59-5B05-129C1A2CB2F7}"/>
          </ac:spMkLst>
        </pc:spChg>
        <pc:spChg chg="mod ord">
          <ac:chgData name="Jun Ge" userId="b8e2f334ff6b24d1" providerId="LiveId" clId="{0D82ED02-7E44-4D90-AA80-85DAE28EF6E0}" dt="2025-05-10T01:37:07.352" v="1408" actId="1035"/>
          <ac:spMkLst>
            <pc:docMk/>
            <pc:sldMk cId="2950916666" sldId="2007"/>
            <ac:spMk id="46" creationId="{85D7709D-B2BE-B507-19A2-BE32862A9A23}"/>
          </ac:spMkLst>
        </pc:spChg>
        <pc:spChg chg="mod ord">
          <ac:chgData name="Jun Ge" userId="b8e2f334ff6b24d1" providerId="LiveId" clId="{0D82ED02-7E44-4D90-AA80-85DAE28EF6E0}" dt="2025-05-10T01:37:08.148" v="1410" actId="1035"/>
          <ac:spMkLst>
            <pc:docMk/>
            <pc:sldMk cId="2950916666" sldId="2007"/>
            <ac:spMk id="47" creationId="{DF4ACAAE-E8A1-92B3-5E6C-888188DF586A}"/>
          </ac:spMkLst>
        </pc:spChg>
        <pc:spChg chg="mod ord">
          <ac:chgData name="Jun Ge" userId="b8e2f334ff6b24d1" providerId="LiveId" clId="{0D82ED02-7E44-4D90-AA80-85DAE28EF6E0}" dt="2025-05-10T01:37:09.661" v="1412" actId="1035"/>
          <ac:spMkLst>
            <pc:docMk/>
            <pc:sldMk cId="2950916666" sldId="2007"/>
            <ac:spMk id="48" creationId="{165A40AA-2093-4D75-D0BE-F063D22E3131}"/>
          </ac:spMkLst>
        </pc:spChg>
        <pc:spChg chg="mod ord">
          <ac:chgData name="Jun Ge" userId="b8e2f334ff6b24d1" providerId="LiveId" clId="{0D82ED02-7E44-4D90-AA80-85DAE28EF6E0}" dt="2025-05-10T01:37:10.640" v="1414" actId="1035"/>
          <ac:spMkLst>
            <pc:docMk/>
            <pc:sldMk cId="2950916666" sldId="2007"/>
            <ac:spMk id="49" creationId="{F344B4FC-29CF-2003-D5F8-4A402CF53159}"/>
          </ac:spMkLst>
        </pc:spChg>
        <pc:spChg chg="mod ord">
          <ac:chgData name="Jun Ge" userId="b8e2f334ff6b24d1" providerId="LiveId" clId="{0D82ED02-7E44-4D90-AA80-85DAE28EF6E0}" dt="2025-05-10T01:37:11.795" v="1416" actId="1035"/>
          <ac:spMkLst>
            <pc:docMk/>
            <pc:sldMk cId="2950916666" sldId="2007"/>
            <ac:spMk id="50" creationId="{6768FDA9-9F01-93C6-683D-A740694CC50F}"/>
          </ac:spMkLst>
        </pc:spChg>
        <pc:spChg chg="mod ord">
          <ac:chgData name="Jun Ge" userId="b8e2f334ff6b24d1" providerId="LiveId" clId="{0D82ED02-7E44-4D90-AA80-85DAE28EF6E0}" dt="2025-05-10T01:37:13.738" v="1421" actId="1037"/>
          <ac:spMkLst>
            <pc:docMk/>
            <pc:sldMk cId="2950916666" sldId="2007"/>
            <ac:spMk id="51" creationId="{43D3C77A-5B86-E543-072E-9F2F315ACDFE}"/>
          </ac:spMkLst>
        </pc:spChg>
        <pc:spChg chg="mod ord">
          <ac:chgData name="Jun Ge" userId="b8e2f334ff6b24d1" providerId="LiveId" clId="{0D82ED02-7E44-4D90-AA80-85DAE28EF6E0}" dt="2025-05-10T01:37:15.350" v="1424" actId="1038"/>
          <ac:spMkLst>
            <pc:docMk/>
            <pc:sldMk cId="2950916666" sldId="2007"/>
            <ac:spMk id="52" creationId="{DBC6A1D1-B70D-738D-4DB7-39F3A081A789}"/>
          </ac:spMkLst>
        </pc:spChg>
        <pc:spChg chg="mod">
          <ac:chgData name="Jun Ge" userId="b8e2f334ff6b24d1" providerId="LiveId" clId="{0D82ED02-7E44-4D90-AA80-85DAE28EF6E0}" dt="2025-05-10T01:37:16.916" v="1427" actId="1035"/>
          <ac:spMkLst>
            <pc:docMk/>
            <pc:sldMk cId="2950916666" sldId="2007"/>
            <ac:spMk id="54" creationId="{E02B138F-291A-E0E7-0935-6CAD9EBC538D}"/>
          </ac:spMkLst>
        </pc:spChg>
        <pc:spChg chg="mod">
          <ac:chgData name="Jun Ge" userId="b8e2f334ff6b24d1" providerId="LiveId" clId="{0D82ED02-7E44-4D90-AA80-85DAE28EF6E0}" dt="2025-05-10T01:37:22.130" v="1436" actId="1035"/>
          <ac:spMkLst>
            <pc:docMk/>
            <pc:sldMk cId="2950916666" sldId="2007"/>
            <ac:spMk id="55" creationId="{5A01C2AD-912E-67EC-F48A-98734BE6EBC0}"/>
          </ac:spMkLst>
        </pc:spChg>
        <pc:spChg chg="mod">
          <ac:chgData name="Jun Ge" userId="b8e2f334ff6b24d1" providerId="LiveId" clId="{0D82ED02-7E44-4D90-AA80-85DAE28EF6E0}" dt="2025-05-10T01:37:25.841" v="1448" actId="1037"/>
          <ac:spMkLst>
            <pc:docMk/>
            <pc:sldMk cId="2950916666" sldId="2007"/>
            <ac:spMk id="56" creationId="{97FCCEB6-4A1D-41BF-A9D7-DB2BD1126FAE}"/>
          </ac:spMkLst>
        </pc:spChg>
        <pc:spChg chg="mod">
          <ac:chgData name="Jun Ge" userId="b8e2f334ff6b24d1" providerId="LiveId" clId="{0D82ED02-7E44-4D90-AA80-85DAE28EF6E0}" dt="2025-05-10T01:37:32.324" v="1456" actId="1035"/>
          <ac:spMkLst>
            <pc:docMk/>
            <pc:sldMk cId="2950916666" sldId="2007"/>
            <ac:spMk id="57" creationId="{E88CCCD5-1D54-D3AD-01E2-12E45CA18922}"/>
          </ac:spMkLst>
        </pc:spChg>
        <pc:spChg chg="mod">
          <ac:chgData name="Jun Ge" userId="b8e2f334ff6b24d1" providerId="LiveId" clId="{0D82ED02-7E44-4D90-AA80-85DAE28EF6E0}" dt="2025-05-10T01:37:38.631" v="1463" actId="1035"/>
          <ac:spMkLst>
            <pc:docMk/>
            <pc:sldMk cId="2950916666" sldId="2007"/>
            <ac:spMk id="58" creationId="{BF142120-F894-3EB6-6E42-8BDD1A3BD9A5}"/>
          </ac:spMkLst>
        </pc:spChg>
        <pc:spChg chg="mod">
          <ac:chgData name="Jun Ge" userId="b8e2f334ff6b24d1" providerId="LiveId" clId="{0D82ED02-7E44-4D90-AA80-85DAE28EF6E0}" dt="2025-05-10T01:37:18.492" v="1430" actId="1037"/>
          <ac:spMkLst>
            <pc:docMk/>
            <pc:sldMk cId="2950916666" sldId="2007"/>
            <ac:spMk id="59" creationId="{EDD6F072-D7E9-F2EF-23E2-D20992285378}"/>
          </ac:spMkLst>
        </pc:spChg>
        <pc:spChg chg="mod">
          <ac:chgData name="Jun Ge" userId="b8e2f334ff6b24d1" providerId="LiveId" clId="{0D82ED02-7E44-4D90-AA80-85DAE28EF6E0}" dt="2025-05-10T01:37:23.886" v="1442" actId="1035"/>
          <ac:spMkLst>
            <pc:docMk/>
            <pc:sldMk cId="2950916666" sldId="2007"/>
            <ac:spMk id="60" creationId="{338FF72E-FEE0-F46C-C0AA-DB3D17A61F9B}"/>
          </ac:spMkLst>
        </pc:spChg>
        <pc:spChg chg="mod">
          <ac:chgData name="Jun Ge" userId="b8e2f334ff6b24d1" providerId="LiveId" clId="{0D82ED02-7E44-4D90-AA80-85DAE28EF6E0}" dt="2025-05-10T01:37:27.687" v="1451" actId="1035"/>
          <ac:spMkLst>
            <pc:docMk/>
            <pc:sldMk cId="2950916666" sldId="2007"/>
            <ac:spMk id="61" creationId="{CF8A4458-AF13-0DE0-FCC8-4247964B36D3}"/>
          </ac:spMkLst>
        </pc:spChg>
        <pc:spChg chg="mod">
          <ac:chgData name="Jun Ge" userId="b8e2f334ff6b24d1" providerId="LiveId" clId="{0D82ED02-7E44-4D90-AA80-85DAE28EF6E0}" dt="2025-05-10T01:37:35.298" v="1460" actId="1037"/>
          <ac:spMkLst>
            <pc:docMk/>
            <pc:sldMk cId="2950916666" sldId="2007"/>
            <ac:spMk id="62" creationId="{94C66713-88DF-C845-27ED-92921E7B6B9C}"/>
          </ac:spMkLst>
        </pc:spChg>
        <pc:spChg chg="mod">
          <ac:chgData name="Jun Ge" userId="b8e2f334ff6b24d1" providerId="LiveId" clId="{0D82ED02-7E44-4D90-AA80-85DAE28EF6E0}" dt="2025-05-10T01:33:26.857" v="1293" actId="164"/>
          <ac:spMkLst>
            <pc:docMk/>
            <pc:sldMk cId="2950916666" sldId="2007"/>
            <ac:spMk id="63" creationId="{8852B8D5-CBA2-C20E-31D2-90ACD6C151C2}"/>
          </ac:spMkLst>
        </pc:spChg>
        <pc:spChg chg="mod">
          <ac:chgData name="Jun Ge" userId="b8e2f334ff6b24d1" providerId="LiveId" clId="{0D82ED02-7E44-4D90-AA80-85DAE28EF6E0}" dt="2025-05-10T01:38:01.025" v="1479" actId="1035"/>
          <ac:spMkLst>
            <pc:docMk/>
            <pc:sldMk cId="2950916666" sldId="2007"/>
            <ac:spMk id="64" creationId="{A54146F9-7AF4-B192-1359-C9B37370F51E}"/>
          </ac:spMkLst>
        </pc:spChg>
        <pc:spChg chg="mod">
          <ac:chgData name="Jun Ge" userId="b8e2f334ff6b24d1" providerId="LiveId" clId="{0D82ED02-7E44-4D90-AA80-85DAE28EF6E0}" dt="2025-05-10T01:37:59.562" v="1478" actId="1035"/>
          <ac:spMkLst>
            <pc:docMk/>
            <pc:sldMk cId="2950916666" sldId="2007"/>
            <ac:spMk id="65" creationId="{E19AD876-483D-399B-FA2E-A997BDD1F874}"/>
          </ac:spMkLst>
        </pc:spChg>
        <pc:spChg chg="mod">
          <ac:chgData name="Jun Ge" userId="b8e2f334ff6b24d1" providerId="LiveId" clId="{0D82ED02-7E44-4D90-AA80-85DAE28EF6E0}" dt="2025-05-10T01:38:06.069" v="1481" actId="1036"/>
          <ac:spMkLst>
            <pc:docMk/>
            <pc:sldMk cId="2950916666" sldId="2007"/>
            <ac:spMk id="66" creationId="{74BB6492-2E8C-38B1-2315-8E336810D76D}"/>
          </ac:spMkLst>
        </pc:spChg>
        <pc:spChg chg="mod">
          <ac:chgData name="Jun Ge" userId="b8e2f334ff6b24d1" providerId="LiveId" clId="{0D82ED02-7E44-4D90-AA80-85DAE28EF6E0}" dt="2025-05-10T01:33:32.762" v="1294" actId="164"/>
          <ac:spMkLst>
            <pc:docMk/>
            <pc:sldMk cId="2950916666" sldId="2007"/>
            <ac:spMk id="67" creationId="{C2A3228C-92B5-F75B-06C8-55F7EF9D2564}"/>
          </ac:spMkLst>
        </pc:spChg>
        <pc:spChg chg="mod">
          <ac:chgData name="Jun Ge" userId="b8e2f334ff6b24d1" providerId="LiveId" clId="{0D82ED02-7E44-4D90-AA80-85DAE28EF6E0}" dt="2025-05-10T01:37:50.572" v="1470" actId="1035"/>
          <ac:spMkLst>
            <pc:docMk/>
            <pc:sldMk cId="2950916666" sldId="2007"/>
            <ac:spMk id="68" creationId="{8C6CE3C5-111C-FC3C-A0C2-A89661A4F892}"/>
          </ac:spMkLst>
        </pc:spChg>
        <pc:spChg chg="mod">
          <ac:chgData name="Jun Ge" userId="b8e2f334ff6b24d1" providerId="LiveId" clId="{0D82ED02-7E44-4D90-AA80-85DAE28EF6E0}" dt="2025-05-10T01:37:44.944" v="1468" actId="1037"/>
          <ac:spMkLst>
            <pc:docMk/>
            <pc:sldMk cId="2950916666" sldId="2007"/>
            <ac:spMk id="69" creationId="{4CC77D03-BA55-09BE-6A2A-96D28ABB2EC3}"/>
          </ac:spMkLst>
        </pc:spChg>
        <pc:spChg chg="mod">
          <ac:chgData name="Jun Ge" userId="b8e2f334ff6b24d1" providerId="LiveId" clId="{0D82ED02-7E44-4D90-AA80-85DAE28EF6E0}" dt="2025-05-10T01:33:32.762" v="1294" actId="164"/>
          <ac:spMkLst>
            <pc:docMk/>
            <pc:sldMk cId="2950916666" sldId="2007"/>
            <ac:spMk id="70" creationId="{4DA9A1AB-BA30-AB1F-6FC5-F022111AB887}"/>
          </ac:spMkLst>
        </pc:spChg>
        <pc:spChg chg="mod topLvl">
          <ac:chgData name="Jun Ge" userId="b8e2f334ff6b24d1" providerId="LiveId" clId="{0D82ED02-7E44-4D90-AA80-85DAE28EF6E0}" dt="2025-05-10T01:36:48.253" v="1395" actId="165"/>
          <ac:spMkLst>
            <pc:docMk/>
            <pc:sldMk cId="2950916666" sldId="2007"/>
            <ac:spMk id="71" creationId="{488CA966-5582-11C8-467B-E54600D221E4}"/>
          </ac:spMkLst>
        </pc:spChg>
        <pc:spChg chg="mod">
          <ac:chgData name="Jun Ge" userId="b8e2f334ff6b24d1" providerId="LiveId" clId="{0D82ED02-7E44-4D90-AA80-85DAE28EF6E0}" dt="2025-05-10T01:33:32.762" v="1294" actId="164"/>
          <ac:spMkLst>
            <pc:docMk/>
            <pc:sldMk cId="2950916666" sldId="2007"/>
            <ac:spMk id="72" creationId="{C18D8B66-86A0-DD7B-7354-C894E9C2EB82}"/>
          </ac:spMkLst>
        </pc:spChg>
        <pc:spChg chg="mod">
          <ac:chgData name="Jun Ge" userId="b8e2f334ff6b24d1" providerId="LiveId" clId="{0D82ED02-7E44-4D90-AA80-85DAE28EF6E0}" dt="2025-05-10T01:33:32.762" v="1294" actId="164"/>
          <ac:spMkLst>
            <pc:docMk/>
            <pc:sldMk cId="2950916666" sldId="2007"/>
            <ac:spMk id="73" creationId="{5BF22B0A-BFC8-24EF-BE2C-08DEE4EB7BA4}"/>
          </ac:spMkLst>
        </pc:spChg>
        <pc:spChg chg="mod">
          <ac:chgData name="Jun Ge" userId="b8e2f334ff6b24d1" providerId="LiveId" clId="{0D82ED02-7E44-4D90-AA80-85DAE28EF6E0}" dt="2025-05-10T01:38:09.435" v="1484" actId="1035"/>
          <ac:spMkLst>
            <pc:docMk/>
            <pc:sldMk cId="2950916666" sldId="2007"/>
            <ac:spMk id="74" creationId="{E1F6A4A5-5A95-8C87-609F-5F1322CF77A4}"/>
          </ac:spMkLst>
        </pc:spChg>
        <pc:spChg chg="mod">
          <ac:chgData name="Jun Ge" userId="b8e2f334ff6b24d1" providerId="LiveId" clId="{0D82ED02-7E44-4D90-AA80-85DAE28EF6E0}" dt="2025-05-10T01:38:20.745" v="1507" actId="1035"/>
          <ac:spMkLst>
            <pc:docMk/>
            <pc:sldMk cId="2950916666" sldId="2007"/>
            <ac:spMk id="75" creationId="{BC64C1CC-C7CA-9EE2-27B7-F264BD15D438}"/>
          </ac:spMkLst>
        </pc:spChg>
        <pc:spChg chg="mod">
          <ac:chgData name="Jun Ge" userId="b8e2f334ff6b24d1" providerId="LiveId" clId="{0D82ED02-7E44-4D90-AA80-85DAE28EF6E0}" dt="2025-05-10T01:38:11.736" v="1491" actId="1035"/>
          <ac:spMkLst>
            <pc:docMk/>
            <pc:sldMk cId="2950916666" sldId="2007"/>
            <ac:spMk id="76" creationId="{BCA7B75D-F407-5B05-3A58-803DF4591F9E}"/>
          </ac:spMkLst>
        </pc:spChg>
        <pc:spChg chg="mod">
          <ac:chgData name="Jun Ge" userId="b8e2f334ff6b24d1" providerId="LiveId" clId="{0D82ED02-7E44-4D90-AA80-85DAE28EF6E0}" dt="2025-05-10T01:33:41.538" v="1295" actId="164"/>
          <ac:spMkLst>
            <pc:docMk/>
            <pc:sldMk cId="2950916666" sldId="2007"/>
            <ac:spMk id="77" creationId="{A7BD6F0F-A41D-6304-EDC4-5235D329FC45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78" creationId="{AE27A52B-BB06-F675-37EC-416A3DE172A6}"/>
          </ac:spMkLst>
        </pc:spChg>
        <pc:spChg chg="mod">
          <ac:chgData name="Jun Ge" userId="b8e2f334ff6b24d1" providerId="LiveId" clId="{0D82ED02-7E44-4D90-AA80-85DAE28EF6E0}" dt="2025-05-10T01:33:41.538" v="1295" actId="164"/>
          <ac:spMkLst>
            <pc:docMk/>
            <pc:sldMk cId="2950916666" sldId="2007"/>
            <ac:spMk id="79" creationId="{0A4127D3-355C-4D47-F2B1-94AA7387B265}"/>
          </ac:spMkLst>
        </pc:spChg>
        <pc:spChg chg="mod">
          <ac:chgData name="Jun Ge" userId="b8e2f334ff6b24d1" providerId="LiveId" clId="{0D82ED02-7E44-4D90-AA80-85DAE28EF6E0}" dt="2025-05-10T01:38:14.545" v="1498" actId="1035"/>
          <ac:spMkLst>
            <pc:docMk/>
            <pc:sldMk cId="2950916666" sldId="2007"/>
            <ac:spMk id="80" creationId="{70AA06FA-8F28-D271-E58F-85413A85FAD3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81" creationId="{5CC48CF7-10AF-A3AD-5775-A6088480C2BA}"/>
          </ac:spMkLst>
        </pc:spChg>
        <pc:spChg chg="mod">
          <ac:chgData name="Jun Ge" userId="b8e2f334ff6b24d1" providerId="LiveId" clId="{0D82ED02-7E44-4D90-AA80-85DAE28EF6E0}" dt="2025-05-10T01:38:16.848" v="1502" actId="1035"/>
          <ac:spMkLst>
            <pc:docMk/>
            <pc:sldMk cId="2950916666" sldId="2007"/>
            <ac:spMk id="82" creationId="{20BE4FD8-C771-82C2-66E5-B30CBE6C779D}"/>
          </ac:spMkLst>
        </pc:spChg>
        <pc:spChg chg="mod">
          <ac:chgData name="Jun Ge" userId="b8e2f334ff6b24d1" providerId="LiveId" clId="{0D82ED02-7E44-4D90-AA80-85DAE28EF6E0}" dt="2025-05-10T01:33:41.538" v="1295" actId="164"/>
          <ac:spMkLst>
            <pc:docMk/>
            <pc:sldMk cId="2950916666" sldId="2007"/>
            <ac:spMk id="83" creationId="{5A5D19C7-99CB-61F5-04C1-8E3B5E37FFC2}"/>
          </ac:spMkLst>
        </pc:spChg>
        <pc:spChg chg="mod">
          <ac:chgData name="Jun Ge" userId="b8e2f334ff6b24d1" providerId="LiveId" clId="{0D82ED02-7E44-4D90-AA80-85DAE28EF6E0}" dt="2025-05-10T01:38:30.993" v="1528" actId="1035"/>
          <ac:spMkLst>
            <pc:docMk/>
            <pc:sldMk cId="2950916666" sldId="2007"/>
            <ac:spMk id="84" creationId="{69E171E6-087D-2414-9F35-4BC8C2FD7661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85" creationId="{3A2C0332-E85C-9CB3-6115-C2A67446AD33}"/>
          </ac:spMkLst>
        </pc:spChg>
        <pc:spChg chg="mod">
          <ac:chgData name="Jun Ge" userId="b8e2f334ff6b24d1" providerId="LiveId" clId="{0D82ED02-7E44-4D90-AA80-85DAE28EF6E0}" dt="2025-05-10T01:38:34.190" v="1537" actId="1038"/>
          <ac:spMkLst>
            <pc:docMk/>
            <pc:sldMk cId="2950916666" sldId="2007"/>
            <ac:spMk id="86" creationId="{319F092C-B8C9-B6CE-0CA7-880A22CF4076}"/>
          </ac:spMkLst>
        </pc:spChg>
        <pc:spChg chg="mod">
          <ac:chgData name="Jun Ge" userId="b8e2f334ff6b24d1" providerId="LiveId" clId="{0D82ED02-7E44-4D90-AA80-85DAE28EF6E0}" dt="2025-05-10T01:38:35.456" v="1539" actId="1038"/>
          <ac:spMkLst>
            <pc:docMk/>
            <pc:sldMk cId="2950916666" sldId="2007"/>
            <ac:spMk id="87" creationId="{468F059E-E643-7A46-C2C8-19B07FE6B7B6}"/>
          </ac:spMkLst>
        </pc:spChg>
        <pc:spChg chg="mod">
          <ac:chgData name="Jun Ge" userId="b8e2f334ff6b24d1" providerId="LiveId" clId="{0D82ED02-7E44-4D90-AA80-85DAE28EF6E0}" dt="2025-05-10T01:38:37.821" v="1546" actId="1035"/>
          <ac:spMkLst>
            <pc:docMk/>
            <pc:sldMk cId="2950916666" sldId="2007"/>
            <ac:spMk id="88" creationId="{F3BE4764-B84F-F906-538A-7A1B9853824B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89" creationId="{517BB582-9626-57D5-6D84-A326FA3EE251}"/>
          </ac:spMkLst>
        </pc:spChg>
        <pc:spChg chg="mod">
          <ac:chgData name="Jun Ge" userId="b8e2f334ff6b24d1" providerId="LiveId" clId="{0D82ED02-7E44-4D90-AA80-85DAE28EF6E0}" dt="2025-05-10T01:38:44.273" v="1554" actId="1035"/>
          <ac:spMkLst>
            <pc:docMk/>
            <pc:sldMk cId="2950916666" sldId="2007"/>
            <ac:spMk id="90" creationId="{A4B973D4-A5ED-3DE7-8570-6DBDABFB1FC5}"/>
          </ac:spMkLst>
        </pc:spChg>
        <pc:spChg chg="mod">
          <ac:chgData name="Jun Ge" userId="b8e2f334ff6b24d1" providerId="LiveId" clId="{0D82ED02-7E44-4D90-AA80-85DAE28EF6E0}" dt="2025-05-10T01:38:45.658" v="1556" actId="1038"/>
          <ac:spMkLst>
            <pc:docMk/>
            <pc:sldMk cId="2950916666" sldId="2007"/>
            <ac:spMk id="91" creationId="{263124FD-2330-3EBB-4BE0-18813A8A8E55}"/>
          </ac:spMkLst>
        </pc:spChg>
        <pc:spChg chg="mod">
          <ac:chgData name="Jun Ge" userId="b8e2f334ff6b24d1" providerId="LiveId" clId="{0D82ED02-7E44-4D90-AA80-85DAE28EF6E0}" dt="2025-05-10T01:38:47.401" v="1561" actId="1035"/>
          <ac:spMkLst>
            <pc:docMk/>
            <pc:sldMk cId="2950916666" sldId="2007"/>
            <ac:spMk id="92" creationId="{E3DAE8FB-C759-AD8F-CBF9-8F7FD4F23A2C}"/>
          </ac:spMkLst>
        </pc:spChg>
        <pc:spChg chg="mod">
          <ac:chgData name="Jun Ge" userId="b8e2f334ff6b24d1" providerId="LiveId" clId="{0D82ED02-7E44-4D90-AA80-85DAE28EF6E0}" dt="2025-05-10T01:38:48.852" v="1564" actId="1035"/>
          <ac:spMkLst>
            <pc:docMk/>
            <pc:sldMk cId="2950916666" sldId="2007"/>
            <ac:spMk id="93" creationId="{1DCF3315-9C21-0C30-8781-1CC1F1A5D14A}"/>
          </ac:spMkLst>
        </pc:spChg>
        <pc:spChg chg="mod">
          <ac:chgData name="Jun Ge" userId="b8e2f334ff6b24d1" providerId="LiveId" clId="{0D82ED02-7E44-4D90-AA80-85DAE28EF6E0}" dt="2025-05-10T01:39:10.160" v="1587" actId="1035"/>
          <ac:spMkLst>
            <pc:docMk/>
            <pc:sldMk cId="2950916666" sldId="2007"/>
            <ac:spMk id="94" creationId="{5DAAFB83-1A30-A860-0F87-EE5273DC79E4}"/>
          </ac:spMkLst>
        </pc:spChg>
        <pc:spChg chg="mod">
          <ac:chgData name="Jun Ge" userId="b8e2f334ff6b24d1" providerId="LiveId" clId="{0D82ED02-7E44-4D90-AA80-85DAE28EF6E0}" dt="2025-05-10T01:39:10.160" v="1587" actId="1035"/>
          <ac:spMkLst>
            <pc:docMk/>
            <pc:sldMk cId="2950916666" sldId="2007"/>
            <ac:spMk id="95" creationId="{91622166-030C-2CDB-4849-606B06EB26BC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96" creationId="{11FE771E-021C-A43A-A7FF-9CF0201F96BC}"/>
          </ac:spMkLst>
        </pc:spChg>
        <pc:spChg chg="mod">
          <ac:chgData name="Jun Ge" userId="b8e2f334ff6b24d1" providerId="LiveId" clId="{0D82ED02-7E44-4D90-AA80-85DAE28EF6E0}" dt="2025-05-10T01:39:10.160" v="1587" actId="1035"/>
          <ac:spMkLst>
            <pc:docMk/>
            <pc:sldMk cId="2950916666" sldId="2007"/>
            <ac:spMk id="97" creationId="{87E50522-8CFF-0AB8-6CF1-E6B153E9BD0F}"/>
          </ac:spMkLst>
        </pc:spChg>
        <pc:spChg chg="mod">
          <ac:chgData name="Jun Ge" userId="b8e2f334ff6b24d1" providerId="LiveId" clId="{0D82ED02-7E44-4D90-AA80-85DAE28EF6E0}" dt="2025-05-10T01:39:10.160" v="1587" actId="1035"/>
          <ac:spMkLst>
            <pc:docMk/>
            <pc:sldMk cId="2950916666" sldId="2007"/>
            <ac:spMk id="98" creationId="{53C98B89-21CC-77D3-D734-8BCFA07568A3}"/>
          </ac:spMkLst>
        </pc:spChg>
        <pc:spChg chg="mod">
          <ac:chgData name="Jun Ge" userId="b8e2f334ff6b24d1" providerId="LiveId" clId="{0D82ED02-7E44-4D90-AA80-85DAE28EF6E0}" dt="2025-05-10T01:39:01.901" v="1579" actId="1035"/>
          <ac:spMkLst>
            <pc:docMk/>
            <pc:sldMk cId="2950916666" sldId="2007"/>
            <ac:spMk id="99" creationId="{94C0B9AE-1EC7-0E85-34F2-119CD53BFA3D}"/>
          </ac:spMkLst>
        </pc:spChg>
        <pc:spChg chg="mod">
          <ac:chgData name="Jun Ge" userId="b8e2f334ff6b24d1" providerId="LiveId" clId="{0D82ED02-7E44-4D90-AA80-85DAE28EF6E0}" dt="2025-05-10T01:39:01.901" v="1579" actId="1035"/>
          <ac:spMkLst>
            <pc:docMk/>
            <pc:sldMk cId="2950916666" sldId="2007"/>
            <ac:spMk id="100" creationId="{D4B74611-D5D1-DE55-9453-BDBE1D4F41EF}"/>
          </ac:spMkLst>
        </pc:spChg>
        <pc:spChg chg="mod">
          <ac:chgData name="Jun Ge" userId="b8e2f334ff6b24d1" providerId="LiveId" clId="{0D82ED02-7E44-4D90-AA80-85DAE28EF6E0}" dt="2025-05-10T01:39:01.901" v="1579" actId="1035"/>
          <ac:spMkLst>
            <pc:docMk/>
            <pc:sldMk cId="2950916666" sldId="2007"/>
            <ac:spMk id="101" creationId="{E5942BDA-514C-AEB5-C572-17147CB0D547}"/>
          </ac:spMkLst>
        </pc:spChg>
        <pc:spChg chg="mod">
          <ac:chgData name="Jun Ge" userId="b8e2f334ff6b24d1" providerId="LiveId" clId="{0D82ED02-7E44-4D90-AA80-85DAE28EF6E0}" dt="2025-05-10T01:39:01.901" v="1579" actId="1035"/>
          <ac:spMkLst>
            <pc:docMk/>
            <pc:sldMk cId="2950916666" sldId="2007"/>
            <ac:spMk id="102" creationId="{6684E2F7-50E2-3A3E-AFB6-D0BD4311B1ED}"/>
          </ac:spMkLst>
        </pc:spChg>
        <pc:spChg chg="mod topLvl">
          <ac:chgData name="Jun Ge" userId="b8e2f334ff6b24d1" providerId="LiveId" clId="{0D82ED02-7E44-4D90-AA80-85DAE28EF6E0}" dt="2025-05-10T01:39:22.412" v="1590" actId="164"/>
          <ac:spMkLst>
            <pc:docMk/>
            <pc:sldMk cId="2950916666" sldId="2007"/>
            <ac:spMk id="103" creationId="{94274DAC-3910-CD76-1492-6DEB79FE63C6}"/>
          </ac:spMkLst>
        </pc:spChg>
        <pc:picChg chg="mod">
          <ac:chgData name="Jun Ge" userId="b8e2f334ff6b24d1" providerId="LiveId" clId="{0D82ED02-7E44-4D90-AA80-85DAE28EF6E0}" dt="2025-05-10T01:35:23.048" v="1330" actId="1035"/>
          <ac:picMkLst>
            <pc:docMk/>
            <pc:sldMk cId="2950916666" sldId="2007"/>
            <ac:picMk id="11" creationId="{4269D400-B4F3-95A7-E145-CAEF00E59EDB}"/>
          </ac:picMkLst>
        </pc:picChg>
        <pc:picChg chg="mod">
          <ac:chgData name="Jun Ge" userId="b8e2f334ff6b24d1" providerId="LiveId" clId="{0D82ED02-7E44-4D90-AA80-85DAE28EF6E0}" dt="2025-05-10T01:35:51.007" v="1349" actId="164"/>
          <ac:picMkLst>
            <pc:docMk/>
            <pc:sldMk cId="2950916666" sldId="2007"/>
            <ac:picMk id="12" creationId="{1D5DFC55-B369-E01B-8DF5-09C0F5FAC497}"/>
          </ac:picMkLst>
        </pc:picChg>
        <pc:picChg chg="mod">
          <ac:chgData name="Jun Ge" userId="b8e2f334ff6b24d1" providerId="LiveId" clId="{0D82ED02-7E44-4D90-AA80-85DAE28EF6E0}" dt="2025-05-10T01:37:30.755" v="1454" actId="1035"/>
          <ac:picMkLst>
            <pc:docMk/>
            <pc:sldMk cId="2950916666" sldId="2007"/>
            <ac:picMk id="15" creationId="{7A69F65B-32CF-4589-468A-A68825CA48AC}"/>
          </ac:picMkLst>
        </pc:picChg>
        <pc:picChg chg="mod">
          <ac:chgData name="Jun Ge" userId="b8e2f334ff6b24d1" providerId="LiveId" clId="{0D82ED02-7E44-4D90-AA80-85DAE28EF6E0}" dt="2025-05-10T01:36:27.781" v="1383" actId="1038"/>
          <ac:picMkLst>
            <pc:docMk/>
            <pc:sldMk cId="2950916666" sldId="2007"/>
            <ac:picMk id="31" creationId="{959BCFA5-8B9A-881C-50F4-41E1C60D2243}"/>
          </ac:picMkLst>
        </pc:picChg>
      </pc:sldChg>
      <pc:sldChg chg="addSp delSp modSp mod">
        <pc:chgData name="Jun Ge" userId="b8e2f334ff6b24d1" providerId="LiveId" clId="{0D82ED02-7E44-4D90-AA80-85DAE28EF6E0}" dt="2025-05-23T00:27:00.310" v="2655" actId="20577"/>
        <pc:sldMkLst>
          <pc:docMk/>
          <pc:sldMk cId="3613101676" sldId="2008"/>
        </pc:sldMkLst>
        <pc:spChg chg="mod">
          <ac:chgData name="Jun Ge" userId="b8e2f334ff6b24d1" providerId="LiveId" clId="{0D82ED02-7E44-4D90-AA80-85DAE28EF6E0}" dt="2025-05-23T00:27:00.310" v="2655" actId="20577"/>
          <ac:spMkLst>
            <pc:docMk/>
            <pc:sldMk cId="3613101676" sldId="2008"/>
            <ac:spMk id="12" creationId="{20E29743-C3CF-318D-42F2-7B206212A56E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35" creationId="{7105A7EA-515C-FE10-C061-F6575DED0882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36" creationId="{8C31071F-9CF7-E8E2-305C-49657B040FA7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42" creationId="{A7CD4B46-67B2-E346-A2AD-6ABC4B26704F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51" creationId="{AA162EBF-9EE9-0B4A-E557-09CBC32B792C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61" creationId="{13621A7C-3D05-0AB4-67C8-B24BB163AB1D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65" creationId="{9FFBF20D-18B9-55ED-5305-7A86105D9BEF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67" creationId="{2413BB83-B940-9F9F-1F5D-9E4809B23539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70" creationId="{8CE6294D-27E3-3AAE-15B9-17F191D6D9EB}"/>
          </ac:spMkLst>
        </pc:spChg>
        <pc:spChg chg="mod">
          <ac:chgData name="Jun Ge" userId="b8e2f334ff6b24d1" providerId="LiveId" clId="{0D82ED02-7E44-4D90-AA80-85DAE28EF6E0}" dt="2025-05-22T23:42:29.957" v="2616" actId="20577"/>
          <ac:spMkLst>
            <pc:docMk/>
            <pc:sldMk cId="3613101676" sldId="2008"/>
            <ac:spMk id="71" creationId="{11FBF21F-E3F1-9164-459E-CA28AAF2071F}"/>
          </ac:spMkLst>
        </pc:spChg>
        <pc:spChg chg="mod">
          <ac:chgData name="Jun Ge" userId="b8e2f334ff6b24d1" providerId="LiveId" clId="{0D82ED02-7E44-4D90-AA80-85DAE28EF6E0}" dt="2025-05-22T23:42:31.052" v="2617" actId="20577"/>
          <ac:spMkLst>
            <pc:docMk/>
            <pc:sldMk cId="3613101676" sldId="2008"/>
            <ac:spMk id="72" creationId="{8D274D0D-3AEB-5C2E-BE75-D981F52815F1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74" creationId="{E46B9B09-BA66-F0AB-4F85-F556C104C6A4}"/>
          </ac:spMkLst>
        </pc:spChg>
        <pc:spChg chg="mod">
          <ac:chgData name="Jun Ge" userId="b8e2f334ff6b24d1" providerId="LiveId" clId="{0D82ED02-7E44-4D90-AA80-85DAE28EF6E0}" dt="2025-05-10T02:05:18.578" v="2190" actId="165"/>
          <ac:spMkLst>
            <pc:docMk/>
            <pc:sldMk cId="3613101676" sldId="2008"/>
            <ac:spMk id="77" creationId="{AC3C384F-2254-0796-DDDF-EF7D3FE6947E}"/>
          </ac:spMkLst>
        </pc:spChg>
        <pc:spChg chg="mod">
          <ac:chgData name="Jun Ge" userId="b8e2f334ff6b24d1" providerId="LiveId" clId="{0D82ED02-7E44-4D90-AA80-85DAE28EF6E0}" dt="2025-05-22T23:42:32.641" v="2618" actId="20577"/>
          <ac:spMkLst>
            <pc:docMk/>
            <pc:sldMk cId="3613101676" sldId="2008"/>
            <ac:spMk id="79" creationId="{8CD9A29A-3069-6DA1-1628-FE0DCEB6B815}"/>
          </ac:spMkLst>
        </pc:spChg>
        <pc:spChg chg="mod">
          <ac:chgData name="Jun Ge" userId="b8e2f334ff6b24d1" providerId="LiveId" clId="{0D82ED02-7E44-4D90-AA80-85DAE28EF6E0}" dt="2025-05-22T23:42:34.120" v="2619" actId="20577"/>
          <ac:spMkLst>
            <pc:docMk/>
            <pc:sldMk cId="3613101676" sldId="2008"/>
            <ac:spMk id="80" creationId="{2B167E9F-0438-E350-D76A-0615C9D64CF0}"/>
          </ac:spMkLst>
        </pc:spChg>
        <pc:spChg chg="mod">
          <ac:chgData name="Jun Ge" userId="b8e2f334ff6b24d1" providerId="LiveId" clId="{0D82ED02-7E44-4D90-AA80-85DAE28EF6E0}" dt="2025-05-22T23:42:35.499" v="2620" actId="20577"/>
          <ac:spMkLst>
            <pc:docMk/>
            <pc:sldMk cId="3613101676" sldId="2008"/>
            <ac:spMk id="81" creationId="{053A79B3-F8EE-CD09-D942-7DB88967C012}"/>
          </ac:spMkLst>
        </pc:spChg>
        <pc:spChg chg="mod">
          <ac:chgData name="Jun Ge" userId="b8e2f334ff6b24d1" providerId="LiveId" clId="{0D82ED02-7E44-4D90-AA80-85DAE28EF6E0}" dt="2025-05-22T23:42:37.267" v="2621" actId="20577"/>
          <ac:spMkLst>
            <pc:docMk/>
            <pc:sldMk cId="3613101676" sldId="2008"/>
            <ac:spMk id="82" creationId="{72E61E01-6609-CB7A-CCA7-FC5F58AB7640}"/>
          </ac:spMkLst>
        </pc:spChg>
        <pc:spChg chg="mod">
          <ac:chgData name="Jun Ge" userId="b8e2f334ff6b24d1" providerId="LiveId" clId="{0D82ED02-7E44-4D90-AA80-85DAE28EF6E0}" dt="2025-05-22T23:42:38.741" v="2622" actId="20577"/>
          <ac:spMkLst>
            <pc:docMk/>
            <pc:sldMk cId="3613101676" sldId="2008"/>
            <ac:spMk id="83" creationId="{B9C59564-F675-9FA4-58CE-6E0C6C9AECC1}"/>
          </ac:spMkLst>
        </pc:spChg>
        <pc:grpChg chg="mod">
          <ac:chgData name="Jun Ge" userId="b8e2f334ff6b24d1" providerId="LiveId" clId="{0D82ED02-7E44-4D90-AA80-85DAE28EF6E0}" dt="2025-05-13T07:36:53.527" v="2393" actId="1036"/>
          <ac:grpSpMkLst>
            <pc:docMk/>
            <pc:sldMk cId="3613101676" sldId="2008"/>
            <ac:grpSpMk id="2" creationId="{0278F5C0-0722-7A20-A250-4084BAE0F3EB}"/>
          </ac:grpSpMkLst>
        </pc:grpChg>
        <pc:grpChg chg="mod">
          <ac:chgData name="Jun Ge" userId="b8e2f334ff6b24d1" providerId="LiveId" clId="{0D82ED02-7E44-4D90-AA80-85DAE28EF6E0}" dt="2025-05-10T02:07:26.448" v="2293" actId="164"/>
          <ac:grpSpMkLst>
            <pc:docMk/>
            <pc:sldMk cId="3613101676" sldId="2008"/>
            <ac:grpSpMk id="6" creationId="{3A2049D3-3E97-18A7-562F-979BE921450C}"/>
          </ac:grpSpMkLst>
        </pc:grpChg>
        <pc:grpChg chg="mod">
          <ac:chgData name="Jun Ge" userId="b8e2f334ff6b24d1" providerId="LiveId" clId="{0D82ED02-7E44-4D90-AA80-85DAE28EF6E0}" dt="2025-05-10T02:07:26.448" v="2293" actId="164"/>
          <ac:grpSpMkLst>
            <pc:docMk/>
            <pc:sldMk cId="3613101676" sldId="2008"/>
            <ac:grpSpMk id="7" creationId="{26B97364-F3C1-7806-185C-6DBBE35AEAB1}"/>
          </ac:grpSpMkLst>
        </pc:grpChg>
        <pc:grpChg chg="mod">
          <ac:chgData name="Jun Ge" userId="b8e2f334ff6b24d1" providerId="LiveId" clId="{0D82ED02-7E44-4D90-AA80-85DAE28EF6E0}" dt="2025-05-10T02:07:26.448" v="2293" actId="164"/>
          <ac:grpSpMkLst>
            <pc:docMk/>
            <pc:sldMk cId="3613101676" sldId="2008"/>
            <ac:grpSpMk id="8" creationId="{DB6A0B16-C9C2-18E3-8268-AA9C195C36B4}"/>
          </ac:grpSpMkLst>
        </pc:grpChg>
      </pc:sldChg>
      <pc:sldChg chg="modSp mod">
        <pc:chgData name="Jun Ge" userId="b8e2f334ff6b24d1" providerId="LiveId" clId="{0D82ED02-7E44-4D90-AA80-85DAE28EF6E0}" dt="2025-05-23T00:21:50.825" v="2629" actId="20577"/>
        <pc:sldMkLst>
          <pc:docMk/>
          <pc:sldMk cId="1294620802" sldId="2011"/>
        </pc:sldMkLst>
        <pc:spChg chg="mod">
          <ac:chgData name="Jun Ge" userId="b8e2f334ff6b24d1" providerId="LiveId" clId="{0D82ED02-7E44-4D90-AA80-85DAE28EF6E0}" dt="2025-05-23T00:21:50.825" v="2629" actId="20577"/>
          <ac:spMkLst>
            <pc:docMk/>
            <pc:sldMk cId="1294620802" sldId="2011"/>
            <ac:spMk id="4" creationId="{D950673E-A140-94AF-7077-3A50F58A780A}"/>
          </ac:spMkLst>
        </pc:spChg>
        <pc:spChg chg="mod">
          <ac:chgData name="Jun Ge" userId="b8e2f334ff6b24d1" providerId="LiveId" clId="{0D82ED02-7E44-4D90-AA80-85DAE28EF6E0}" dt="2025-05-22T23:37:07.229" v="2453" actId="20577"/>
          <ac:spMkLst>
            <pc:docMk/>
            <pc:sldMk cId="1294620802" sldId="2011"/>
            <ac:spMk id="8" creationId="{F4D71C03-088C-67D7-2514-C2B96D44C258}"/>
          </ac:spMkLst>
        </pc:spChg>
        <pc:spChg chg="mod">
          <ac:chgData name="Jun Ge" userId="b8e2f334ff6b24d1" providerId="LiveId" clId="{0D82ED02-7E44-4D90-AA80-85DAE28EF6E0}" dt="2025-05-22T23:37:10.510" v="2454" actId="20577"/>
          <ac:spMkLst>
            <pc:docMk/>
            <pc:sldMk cId="1294620802" sldId="2011"/>
            <ac:spMk id="10" creationId="{C07E77E7-1E9B-06EF-7F0C-8AEF68E90FAA}"/>
          </ac:spMkLst>
        </pc:spChg>
      </pc:sldChg>
      <pc:sldChg chg="addSp delSp modSp mod">
        <pc:chgData name="Jun Ge" userId="b8e2f334ff6b24d1" providerId="LiveId" clId="{0D82ED02-7E44-4D90-AA80-85DAE28EF6E0}" dt="2025-05-22T23:38:18.838" v="2477" actId="20577"/>
        <pc:sldMkLst>
          <pc:docMk/>
          <pc:sldMk cId="3927637345" sldId="2012"/>
        </pc:sldMkLst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12" creationId="{2BE08D64-874A-DB89-65BF-2825A0860C04}"/>
          </ac:spMkLst>
        </pc:spChg>
        <pc:spChg chg="mod topLvl">
          <ac:chgData name="Jun Ge" userId="b8e2f334ff6b24d1" providerId="LiveId" clId="{0D82ED02-7E44-4D90-AA80-85DAE28EF6E0}" dt="2025-05-10T01:32:43.139" v="1286" actId="404"/>
          <ac:spMkLst>
            <pc:docMk/>
            <pc:sldMk cId="3927637345" sldId="2012"/>
            <ac:spMk id="23" creationId="{5B470E50-9D94-11B3-9DD2-9C4AD8EFAEA2}"/>
          </ac:spMkLst>
        </pc:spChg>
        <pc:spChg chg="mod topLvl">
          <ac:chgData name="Jun Ge" userId="b8e2f334ff6b24d1" providerId="LiveId" clId="{0D82ED02-7E44-4D90-AA80-85DAE28EF6E0}" dt="2025-05-10T01:33:00.068" v="1287" actId="164"/>
          <ac:spMkLst>
            <pc:docMk/>
            <pc:sldMk cId="3927637345" sldId="2012"/>
            <ac:spMk id="24" creationId="{B6030661-F39D-DFAA-C05B-EDA5BC40FA2A}"/>
          </ac:spMkLst>
        </pc:spChg>
        <pc:spChg chg="mod topLvl">
          <ac:chgData name="Jun Ge" userId="b8e2f334ff6b24d1" providerId="LiveId" clId="{0D82ED02-7E44-4D90-AA80-85DAE28EF6E0}" dt="2025-05-10T01:33:00.068" v="1287" actId="164"/>
          <ac:spMkLst>
            <pc:docMk/>
            <pc:sldMk cId="3927637345" sldId="2012"/>
            <ac:spMk id="25" creationId="{BCB7F137-F033-5ECC-7878-377F912DF301}"/>
          </ac:spMkLst>
        </pc:spChg>
        <pc:spChg chg="mod topLvl">
          <ac:chgData name="Jun Ge" userId="b8e2f334ff6b24d1" providerId="LiveId" clId="{0D82ED02-7E44-4D90-AA80-85DAE28EF6E0}" dt="2025-05-10T01:32:43.139" v="1286" actId="404"/>
          <ac:spMkLst>
            <pc:docMk/>
            <pc:sldMk cId="3927637345" sldId="2012"/>
            <ac:spMk id="26" creationId="{53D8E3FF-19CB-FDE9-E5D4-77E0DF6BD155}"/>
          </ac:spMkLst>
        </pc:spChg>
        <pc:spChg chg="mod topLvl">
          <ac:chgData name="Jun Ge" userId="b8e2f334ff6b24d1" providerId="LiveId" clId="{0D82ED02-7E44-4D90-AA80-85DAE28EF6E0}" dt="2025-05-10T01:32:43.139" v="1286" actId="404"/>
          <ac:spMkLst>
            <pc:docMk/>
            <pc:sldMk cId="3927637345" sldId="2012"/>
            <ac:spMk id="28" creationId="{26FCB5A6-077D-C56E-DA31-CC628CCB31C5}"/>
          </ac:spMkLst>
        </pc:spChg>
        <pc:spChg chg="mod topLvl">
          <ac:chgData name="Jun Ge" userId="b8e2f334ff6b24d1" providerId="LiveId" clId="{0D82ED02-7E44-4D90-AA80-85DAE28EF6E0}" dt="2025-05-10T01:33:00.068" v="1287" actId="164"/>
          <ac:spMkLst>
            <pc:docMk/>
            <pc:sldMk cId="3927637345" sldId="2012"/>
            <ac:spMk id="30" creationId="{5DCD7342-3390-AD85-782F-6E6D1CAB6169}"/>
          </ac:spMkLst>
        </pc:spChg>
        <pc:spChg chg="mod topLvl">
          <ac:chgData name="Jun Ge" userId="b8e2f334ff6b24d1" providerId="LiveId" clId="{0D82ED02-7E44-4D90-AA80-85DAE28EF6E0}" dt="2025-05-10T01:33:00.068" v="1287" actId="164"/>
          <ac:spMkLst>
            <pc:docMk/>
            <pc:sldMk cId="3927637345" sldId="2012"/>
            <ac:spMk id="31" creationId="{5DD4E2F7-7CFC-1676-5617-794180260B21}"/>
          </ac:spMkLst>
        </pc:spChg>
        <pc:spChg chg="mod topLvl">
          <ac:chgData name="Jun Ge" userId="b8e2f334ff6b24d1" providerId="LiveId" clId="{0D82ED02-7E44-4D90-AA80-85DAE28EF6E0}" dt="2025-05-10T01:33:00.068" v="1287" actId="164"/>
          <ac:spMkLst>
            <pc:docMk/>
            <pc:sldMk cId="3927637345" sldId="2012"/>
            <ac:spMk id="32" creationId="{F658A455-1F42-1069-7576-61DEC34C4B49}"/>
          </ac:spMkLst>
        </pc:spChg>
        <pc:spChg chg="mod topLvl">
          <ac:chgData name="Jun Ge" userId="b8e2f334ff6b24d1" providerId="LiveId" clId="{0D82ED02-7E44-4D90-AA80-85DAE28EF6E0}" dt="2025-05-10T01:32:43.139" v="1286" actId="404"/>
          <ac:spMkLst>
            <pc:docMk/>
            <pc:sldMk cId="3927637345" sldId="2012"/>
            <ac:spMk id="33" creationId="{16DFF568-0A91-5491-1B3B-17DDE6BB3353}"/>
          </ac:spMkLst>
        </pc:spChg>
        <pc:spChg chg="mod">
          <ac:chgData name="Jun Ge" userId="b8e2f334ff6b24d1" providerId="LiveId" clId="{0D82ED02-7E44-4D90-AA80-85DAE28EF6E0}" dt="2025-05-22T23:38:18.838" v="2477" actId="20577"/>
          <ac:spMkLst>
            <pc:docMk/>
            <pc:sldMk cId="3927637345" sldId="2012"/>
            <ac:spMk id="36" creationId="{8630C500-F622-1EE2-F2D1-EA0F091186DC}"/>
          </ac:spMkLst>
        </pc:spChg>
        <pc:spChg chg="mod topLvl">
          <ac:chgData name="Jun Ge" userId="b8e2f334ff6b24d1" providerId="LiveId" clId="{0D82ED02-7E44-4D90-AA80-85DAE28EF6E0}" dt="2025-05-10T01:32:43.139" v="1286" actId="404"/>
          <ac:spMkLst>
            <pc:docMk/>
            <pc:sldMk cId="3927637345" sldId="2012"/>
            <ac:spMk id="38" creationId="{CF8EF4B4-F902-60CF-98D8-FB79B7340E0A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46" creationId="{972D40E8-BB41-A941-5B44-8B9A945B8583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47" creationId="{35F73A9D-5A15-880E-AB0F-02AD79A548FD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50" creationId="{47DB6B0E-037A-052F-E01B-0BEB8A357A7C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54" creationId="{8AD05BF0-1232-20C5-4936-9B29D45B935A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57" creationId="{2BC61F1A-E349-AA11-F788-13294666C006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60" creationId="{04722FDB-2539-59BF-E72A-EC3EB924F7F6}"/>
          </ac:spMkLst>
        </pc:spChg>
        <pc:spChg chg="mod">
          <ac:chgData name="Jun Ge" userId="b8e2f334ff6b24d1" providerId="LiveId" clId="{0D82ED02-7E44-4D90-AA80-85DAE28EF6E0}" dt="2025-05-10T01:32:35.974" v="1283" actId="165"/>
          <ac:spMkLst>
            <pc:docMk/>
            <pc:sldMk cId="3927637345" sldId="2012"/>
            <ac:spMk id="72" creationId="{FB944488-14FC-28BA-79A1-0435729145E4}"/>
          </ac:spMkLst>
        </pc:spChg>
        <pc:spChg chg="mod">
          <ac:chgData name="Jun Ge" userId="b8e2f334ff6b24d1" providerId="LiveId" clId="{0D82ED02-7E44-4D90-AA80-85DAE28EF6E0}" dt="2025-05-22T23:37:47.512" v="2457" actId="20577"/>
          <ac:spMkLst>
            <pc:docMk/>
            <pc:sldMk cId="3927637345" sldId="2012"/>
            <ac:spMk id="91" creationId="{666F45FB-308B-CFBE-280E-61E319A6B9AD}"/>
          </ac:spMkLst>
        </pc:spChg>
        <pc:spChg chg="mod">
          <ac:chgData name="Jun Ge" userId="b8e2f334ff6b24d1" providerId="LiveId" clId="{0D82ED02-7E44-4D90-AA80-85DAE28EF6E0}" dt="2025-05-22T23:37:48.806" v="2458" actId="20577"/>
          <ac:spMkLst>
            <pc:docMk/>
            <pc:sldMk cId="3927637345" sldId="2012"/>
            <ac:spMk id="92" creationId="{B885AB24-3BFC-93B7-C5FB-0F1F0FFCCA55}"/>
          </ac:spMkLst>
        </pc:spChg>
        <pc:spChg chg="mod">
          <ac:chgData name="Jun Ge" userId="b8e2f334ff6b24d1" providerId="LiveId" clId="{0D82ED02-7E44-4D90-AA80-85DAE28EF6E0}" dt="2025-05-22T23:37:50.718" v="2459" actId="20577"/>
          <ac:spMkLst>
            <pc:docMk/>
            <pc:sldMk cId="3927637345" sldId="2012"/>
            <ac:spMk id="93" creationId="{92656B68-661F-15D9-DEB5-4C98DACA4BBA}"/>
          </ac:spMkLst>
        </pc:spChg>
        <pc:spChg chg="mod topLvl">
          <ac:chgData name="Jun Ge" userId="b8e2f334ff6b24d1" providerId="LiveId" clId="{0D82ED02-7E44-4D90-AA80-85DAE28EF6E0}" dt="2025-05-22T23:37:52.567" v="2460" actId="20577"/>
          <ac:spMkLst>
            <pc:docMk/>
            <pc:sldMk cId="3927637345" sldId="2012"/>
            <ac:spMk id="94" creationId="{5787BCB1-BBA0-0BE9-A0BE-CCDE07C85C06}"/>
          </ac:spMkLst>
        </pc:spChg>
        <pc:spChg chg="mod">
          <ac:chgData name="Jun Ge" userId="b8e2f334ff6b24d1" providerId="LiveId" clId="{0D82ED02-7E44-4D90-AA80-85DAE28EF6E0}" dt="2025-05-22T23:37:54.005" v="2461" actId="20577"/>
          <ac:spMkLst>
            <pc:docMk/>
            <pc:sldMk cId="3927637345" sldId="2012"/>
            <ac:spMk id="95" creationId="{7B8E41CD-4772-EF79-F0E7-E6F2B0B23ED6}"/>
          </ac:spMkLst>
        </pc:spChg>
        <pc:spChg chg="mod">
          <ac:chgData name="Jun Ge" userId="b8e2f334ff6b24d1" providerId="LiveId" clId="{0D82ED02-7E44-4D90-AA80-85DAE28EF6E0}" dt="2025-05-22T23:37:55.306" v="2462" actId="20577"/>
          <ac:spMkLst>
            <pc:docMk/>
            <pc:sldMk cId="3927637345" sldId="2012"/>
            <ac:spMk id="97" creationId="{D7007142-A09E-264E-B700-7F7B83BAE17A}"/>
          </ac:spMkLst>
        </pc:spChg>
        <pc:spChg chg="mod">
          <ac:chgData name="Jun Ge" userId="b8e2f334ff6b24d1" providerId="LiveId" clId="{0D82ED02-7E44-4D90-AA80-85DAE28EF6E0}" dt="2025-05-22T23:37:57.720" v="2463" actId="20577"/>
          <ac:spMkLst>
            <pc:docMk/>
            <pc:sldMk cId="3927637345" sldId="2012"/>
            <ac:spMk id="98" creationId="{0FC5B015-0B86-D2C8-2A02-415C895C5AFA}"/>
          </ac:spMkLst>
        </pc:spChg>
        <pc:grpChg chg="mod">
          <ac:chgData name="Jun Ge" userId="b8e2f334ff6b24d1" providerId="LiveId" clId="{0D82ED02-7E44-4D90-AA80-85DAE28EF6E0}" dt="2025-05-10T01:31:25.553" v="1273" actId="164"/>
          <ac:grpSpMkLst>
            <pc:docMk/>
            <pc:sldMk cId="3927637345" sldId="2012"/>
            <ac:grpSpMk id="18" creationId="{66975222-9EE1-9F36-537F-AA77556044BF}"/>
          </ac:grpSpMkLst>
        </pc:grpChg>
        <pc:grpChg chg="mod">
          <ac:chgData name="Jun Ge" userId="b8e2f334ff6b24d1" providerId="LiveId" clId="{0D82ED02-7E44-4D90-AA80-85DAE28EF6E0}" dt="2025-05-10T01:31:25.553" v="1273" actId="164"/>
          <ac:grpSpMkLst>
            <pc:docMk/>
            <pc:sldMk cId="3927637345" sldId="2012"/>
            <ac:grpSpMk id="19" creationId="{D66CBDD7-5B95-89A0-7752-69D26A03E1A8}"/>
          </ac:grpSpMkLst>
        </pc:grpChg>
        <pc:grpChg chg="mod">
          <ac:chgData name="Jun Ge" userId="b8e2f334ff6b24d1" providerId="LiveId" clId="{0D82ED02-7E44-4D90-AA80-85DAE28EF6E0}" dt="2025-05-10T01:30:02.818" v="1254" actId="1035"/>
          <ac:grpSpMkLst>
            <pc:docMk/>
            <pc:sldMk cId="3927637345" sldId="2012"/>
            <ac:grpSpMk id="20" creationId="{326367EC-871C-1338-6478-920E33C47C81}"/>
          </ac:grpSpMkLst>
        </pc:grpChg>
        <pc:grpChg chg="mod">
          <ac:chgData name="Jun Ge" userId="b8e2f334ff6b24d1" providerId="LiveId" clId="{0D82ED02-7E44-4D90-AA80-85DAE28EF6E0}" dt="2025-05-10T01:31:23.653" v="1272"/>
          <ac:grpSpMkLst>
            <pc:docMk/>
            <pc:sldMk cId="3927637345" sldId="2012"/>
            <ac:grpSpMk id="22" creationId="{1A79EDB4-A6C4-4AFE-C580-59411FEC1AB9}"/>
          </ac:grpSpMkLst>
        </pc:grpChg>
        <pc:grpChg chg="mod">
          <ac:chgData name="Jun Ge" userId="b8e2f334ff6b24d1" providerId="LiveId" clId="{0D82ED02-7E44-4D90-AA80-85DAE28EF6E0}" dt="2025-05-10T01:29:46.178" v="1233" actId="1037"/>
          <ac:grpSpMkLst>
            <pc:docMk/>
            <pc:sldMk cId="3927637345" sldId="2012"/>
            <ac:grpSpMk id="34" creationId="{C5ED0C81-E723-0F23-D04F-9F3E97180E6D}"/>
          </ac:grpSpMkLst>
        </pc:grpChg>
        <pc:grpChg chg="mod">
          <ac:chgData name="Jun Ge" userId="b8e2f334ff6b24d1" providerId="LiveId" clId="{0D82ED02-7E44-4D90-AA80-85DAE28EF6E0}" dt="2025-05-10T01:30:02.818" v="1254" actId="1035"/>
          <ac:grpSpMkLst>
            <pc:docMk/>
            <pc:sldMk cId="3927637345" sldId="2012"/>
            <ac:grpSpMk id="35" creationId="{F5E338CE-1BB7-E37B-C733-116482574268}"/>
          </ac:grpSpMkLst>
        </pc:grpChg>
      </pc:sldChg>
      <pc:sldChg chg="addSp delSp modSp mod">
        <pc:chgData name="Jun Ge" userId="b8e2f334ff6b24d1" providerId="LiveId" clId="{0D82ED02-7E44-4D90-AA80-85DAE28EF6E0}" dt="2025-05-23T00:34:53.752" v="2656" actId="114"/>
        <pc:sldMkLst>
          <pc:docMk/>
          <pc:sldMk cId="1010496936" sldId="2013"/>
        </pc:sldMkLst>
        <pc:spChg chg="mod">
          <ac:chgData name="Jun Ge" userId="b8e2f334ff6b24d1" providerId="LiveId" clId="{0D82ED02-7E44-4D90-AA80-85DAE28EF6E0}" dt="2025-05-22T23:39:52.952" v="2536" actId="20577"/>
          <ac:spMkLst>
            <pc:docMk/>
            <pc:sldMk cId="1010496936" sldId="2013"/>
            <ac:spMk id="2" creationId="{4D2AF7A5-E4B2-47FB-17EF-BF88DE9F7816}"/>
          </ac:spMkLst>
        </pc:spChg>
        <pc:spChg chg="mod">
          <ac:chgData name="Jun Ge" userId="b8e2f334ff6b24d1" providerId="LiveId" clId="{0D82ED02-7E44-4D90-AA80-85DAE28EF6E0}" dt="2025-05-22T23:39:54.705" v="2538" actId="20577"/>
          <ac:spMkLst>
            <pc:docMk/>
            <pc:sldMk cId="1010496936" sldId="2013"/>
            <ac:spMk id="4" creationId="{8E81E31B-BDC5-57A2-591F-4EBEE2911CBE}"/>
          </ac:spMkLst>
        </pc:spChg>
        <pc:spChg chg="mod">
          <ac:chgData name="Jun Ge" userId="b8e2f334ff6b24d1" providerId="LiveId" clId="{0D82ED02-7E44-4D90-AA80-85DAE28EF6E0}" dt="2025-05-22T23:39:56.999" v="2540" actId="20577"/>
          <ac:spMkLst>
            <pc:docMk/>
            <pc:sldMk cId="1010496936" sldId="2013"/>
            <ac:spMk id="6" creationId="{4A8D26A8-D8BD-0F13-694D-2404CFEB1298}"/>
          </ac:spMkLst>
        </pc:spChg>
        <pc:spChg chg="mod">
          <ac:chgData name="Jun Ge" userId="b8e2f334ff6b24d1" providerId="LiveId" clId="{0D82ED02-7E44-4D90-AA80-85DAE28EF6E0}" dt="2025-05-22T23:39:58.773" v="2542" actId="20577"/>
          <ac:spMkLst>
            <pc:docMk/>
            <pc:sldMk cId="1010496936" sldId="2013"/>
            <ac:spMk id="8" creationId="{DB8DEA8E-4A0B-5B02-680A-7CB662AD4A50}"/>
          </ac:spMkLst>
        </pc:spChg>
        <pc:spChg chg="mod topLvl">
          <ac:chgData name="Jun Ge" userId="b8e2f334ff6b24d1" providerId="LiveId" clId="{0D82ED02-7E44-4D90-AA80-85DAE28EF6E0}" dt="2025-05-22T23:40:00.422" v="2544" actId="20577"/>
          <ac:spMkLst>
            <pc:docMk/>
            <pc:sldMk cId="1010496936" sldId="2013"/>
            <ac:spMk id="10" creationId="{8162D21B-B755-7B11-8AEB-93287BAF5D80}"/>
          </ac:spMkLst>
        </pc:spChg>
        <pc:spChg chg="mod topLvl">
          <ac:chgData name="Jun Ge" userId="b8e2f334ff6b24d1" providerId="LiveId" clId="{0D82ED02-7E44-4D90-AA80-85DAE28EF6E0}" dt="2025-05-22T23:40:02.671" v="2546" actId="20577"/>
          <ac:spMkLst>
            <pc:docMk/>
            <pc:sldMk cId="1010496936" sldId="2013"/>
            <ac:spMk id="12" creationId="{F2E33EFD-6049-8165-C77C-6A246ABB170A}"/>
          </ac:spMkLst>
        </pc:spChg>
        <pc:spChg chg="mod">
          <ac:chgData name="Jun Ge" userId="b8e2f334ff6b24d1" providerId="LiveId" clId="{0D82ED02-7E44-4D90-AA80-85DAE28EF6E0}" dt="2025-05-22T23:40:04.705" v="2548" actId="20577"/>
          <ac:spMkLst>
            <pc:docMk/>
            <pc:sldMk cId="1010496936" sldId="2013"/>
            <ac:spMk id="14" creationId="{C69E793E-313C-5665-72D6-9D39A6829233}"/>
          </ac:spMkLst>
        </pc:spChg>
        <pc:spChg chg="mod">
          <ac:chgData name="Jun Ge" userId="b8e2f334ff6b24d1" providerId="LiveId" clId="{0D82ED02-7E44-4D90-AA80-85DAE28EF6E0}" dt="2025-05-23T00:34:53.752" v="2656" actId="114"/>
          <ac:spMkLst>
            <pc:docMk/>
            <pc:sldMk cId="1010496936" sldId="2013"/>
            <ac:spMk id="18" creationId="{2DD5AEA8-9809-7E1D-5A79-34F5F48A6573}"/>
          </ac:spMkLst>
        </pc:spChg>
        <pc:spChg chg="mod">
          <ac:chgData name="Jun Ge" userId="b8e2f334ff6b24d1" providerId="LiveId" clId="{0D82ED02-7E44-4D90-AA80-85DAE28EF6E0}" dt="2025-05-10T01:43:46.015" v="1740" actId="164"/>
          <ac:spMkLst>
            <pc:docMk/>
            <pc:sldMk cId="1010496936" sldId="2013"/>
            <ac:spMk id="19" creationId="{7959CEAB-5591-B44F-0503-2FF445B115AA}"/>
          </ac:spMkLst>
        </pc:spChg>
        <pc:spChg chg="mod">
          <ac:chgData name="Jun Ge" userId="b8e2f334ff6b24d1" providerId="LiveId" clId="{0D82ED02-7E44-4D90-AA80-85DAE28EF6E0}" dt="2025-05-10T01:43:50.769" v="1741" actId="164"/>
          <ac:spMkLst>
            <pc:docMk/>
            <pc:sldMk cId="1010496936" sldId="2013"/>
            <ac:spMk id="20" creationId="{75EA06B9-1CB9-91D4-6874-4A999E12DD75}"/>
          </ac:spMkLst>
        </pc:spChg>
        <pc:spChg chg="mod topLvl">
          <ac:chgData name="Jun Ge" userId="b8e2f334ff6b24d1" providerId="LiveId" clId="{0D82ED02-7E44-4D90-AA80-85DAE28EF6E0}" dt="2025-05-10T01:43:53.397" v="1742" actId="164"/>
          <ac:spMkLst>
            <pc:docMk/>
            <pc:sldMk cId="1010496936" sldId="2013"/>
            <ac:spMk id="21" creationId="{6F2BFAD3-BE10-23A7-B236-D094C1237953}"/>
          </ac:spMkLst>
        </pc:spChg>
        <pc:spChg chg="mod topLvl">
          <ac:chgData name="Jun Ge" userId="b8e2f334ff6b24d1" providerId="LiveId" clId="{0D82ED02-7E44-4D90-AA80-85DAE28EF6E0}" dt="2025-05-10T01:44:05.292" v="1745" actId="164"/>
          <ac:spMkLst>
            <pc:docMk/>
            <pc:sldMk cId="1010496936" sldId="2013"/>
            <ac:spMk id="22" creationId="{AE8CC783-8991-7A73-2403-026CF36BD8D0}"/>
          </ac:spMkLst>
        </pc:spChg>
        <pc:spChg chg="mod">
          <ac:chgData name="Jun Ge" userId="b8e2f334ff6b24d1" providerId="LiveId" clId="{0D82ED02-7E44-4D90-AA80-85DAE28EF6E0}" dt="2025-05-10T01:44:02.207" v="1744" actId="164"/>
          <ac:spMkLst>
            <pc:docMk/>
            <pc:sldMk cId="1010496936" sldId="2013"/>
            <ac:spMk id="23" creationId="{FAAC0F3D-4C9C-B8D9-48BE-49259C92B8C8}"/>
          </ac:spMkLst>
        </pc:spChg>
        <pc:spChg chg="mod topLvl">
          <ac:chgData name="Jun Ge" userId="b8e2f334ff6b24d1" providerId="LiveId" clId="{0D82ED02-7E44-4D90-AA80-85DAE28EF6E0}" dt="2025-05-10T01:43:58.553" v="1743" actId="164"/>
          <ac:spMkLst>
            <pc:docMk/>
            <pc:sldMk cId="1010496936" sldId="2013"/>
            <ac:spMk id="24" creationId="{A2153B20-EB75-9EEE-0AEF-D5FB75719F16}"/>
          </ac:spMkLst>
        </pc:spChg>
        <pc:spChg chg="mod">
          <ac:chgData name="Jun Ge" userId="b8e2f334ff6b24d1" providerId="LiveId" clId="{0D82ED02-7E44-4D90-AA80-85DAE28EF6E0}" dt="2025-05-10T01:44:08.504" v="1746" actId="164"/>
          <ac:spMkLst>
            <pc:docMk/>
            <pc:sldMk cId="1010496936" sldId="2013"/>
            <ac:spMk id="25" creationId="{4FCDD127-4C42-6423-A02D-A4178CEA70D2}"/>
          </ac:spMkLst>
        </pc:spChg>
        <pc:spChg chg="mod topLvl">
          <ac:chgData name="Jun Ge" userId="b8e2f334ff6b24d1" providerId="LiveId" clId="{0D82ED02-7E44-4D90-AA80-85DAE28EF6E0}" dt="2025-05-10T01:43:46.015" v="1740" actId="164"/>
          <ac:spMkLst>
            <pc:docMk/>
            <pc:sldMk cId="1010496936" sldId="2013"/>
            <ac:spMk id="26" creationId="{2B20E1AF-0B2C-688E-5BAB-99FF3914BC87}"/>
          </ac:spMkLst>
        </pc:spChg>
        <pc:spChg chg="mod topLvl">
          <ac:chgData name="Jun Ge" userId="b8e2f334ff6b24d1" providerId="LiveId" clId="{0D82ED02-7E44-4D90-AA80-85DAE28EF6E0}" dt="2025-05-10T01:43:50.769" v="1741" actId="164"/>
          <ac:spMkLst>
            <pc:docMk/>
            <pc:sldMk cId="1010496936" sldId="2013"/>
            <ac:spMk id="27" creationId="{1C5FB127-8DF3-85C2-F9DD-11E9FD400EED}"/>
          </ac:spMkLst>
        </pc:spChg>
        <pc:spChg chg="mod topLvl">
          <ac:chgData name="Jun Ge" userId="b8e2f334ff6b24d1" providerId="LiveId" clId="{0D82ED02-7E44-4D90-AA80-85DAE28EF6E0}" dt="2025-05-10T01:43:53.397" v="1742" actId="164"/>
          <ac:spMkLst>
            <pc:docMk/>
            <pc:sldMk cId="1010496936" sldId="2013"/>
            <ac:spMk id="28" creationId="{7EB765FB-04CA-B096-BB37-9B36D85DB72D}"/>
          </ac:spMkLst>
        </pc:spChg>
        <pc:spChg chg="mod">
          <ac:chgData name="Jun Ge" userId="b8e2f334ff6b24d1" providerId="LiveId" clId="{0D82ED02-7E44-4D90-AA80-85DAE28EF6E0}" dt="2025-05-10T01:44:05.292" v="1745" actId="164"/>
          <ac:spMkLst>
            <pc:docMk/>
            <pc:sldMk cId="1010496936" sldId="2013"/>
            <ac:spMk id="29" creationId="{DD475C22-FF2A-4657-9F0C-1EC6B7AD69B3}"/>
          </ac:spMkLst>
        </pc:spChg>
        <pc:spChg chg="mod topLvl">
          <ac:chgData name="Jun Ge" userId="b8e2f334ff6b24d1" providerId="LiveId" clId="{0D82ED02-7E44-4D90-AA80-85DAE28EF6E0}" dt="2025-05-10T01:44:02.207" v="1744" actId="164"/>
          <ac:spMkLst>
            <pc:docMk/>
            <pc:sldMk cId="1010496936" sldId="2013"/>
            <ac:spMk id="30" creationId="{20CE1419-36FE-F78B-CEC3-1795182AC2A1}"/>
          </ac:spMkLst>
        </pc:spChg>
        <pc:spChg chg="mod topLvl">
          <ac:chgData name="Jun Ge" userId="b8e2f334ff6b24d1" providerId="LiveId" clId="{0D82ED02-7E44-4D90-AA80-85DAE28EF6E0}" dt="2025-05-10T01:43:58.553" v="1743" actId="164"/>
          <ac:spMkLst>
            <pc:docMk/>
            <pc:sldMk cId="1010496936" sldId="2013"/>
            <ac:spMk id="31" creationId="{E7E911AD-EF68-920D-3A04-BE1FA7A782DB}"/>
          </ac:spMkLst>
        </pc:spChg>
        <pc:spChg chg="mod topLvl">
          <ac:chgData name="Jun Ge" userId="b8e2f334ff6b24d1" providerId="LiveId" clId="{0D82ED02-7E44-4D90-AA80-85DAE28EF6E0}" dt="2025-05-10T01:44:08.504" v="1746" actId="164"/>
          <ac:spMkLst>
            <pc:docMk/>
            <pc:sldMk cId="1010496936" sldId="2013"/>
            <ac:spMk id="32" creationId="{4DE3205E-3B94-35CF-D3CB-2E98244B57FC}"/>
          </ac:spMkLst>
        </pc:spChg>
        <pc:spChg chg="mod">
          <ac:chgData name="Jun Ge" userId="b8e2f334ff6b24d1" providerId="LiveId" clId="{0D82ED02-7E44-4D90-AA80-85DAE28EF6E0}" dt="2025-05-10T01:43:46.015" v="1740" actId="164"/>
          <ac:spMkLst>
            <pc:docMk/>
            <pc:sldMk cId="1010496936" sldId="2013"/>
            <ac:spMk id="33" creationId="{2FDEC03D-FCAA-1B7E-B4F7-4F4B55C11D0A}"/>
          </ac:spMkLst>
        </pc:spChg>
        <pc:spChg chg="mod">
          <ac:chgData name="Jun Ge" userId="b8e2f334ff6b24d1" providerId="LiveId" clId="{0D82ED02-7E44-4D90-AA80-85DAE28EF6E0}" dt="2025-05-10T01:43:50.769" v="1741" actId="164"/>
          <ac:spMkLst>
            <pc:docMk/>
            <pc:sldMk cId="1010496936" sldId="2013"/>
            <ac:spMk id="34" creationId="{E492D282-91DE-E52B-0022-30E648FB4F66}"/>
          </ac:spMkLst>
        </pc:spChg>
        <pc:spChg chg="mod topLvl">
          <ac:chgData name="Jun Ge" userId="b8e2f334ff6b24d1" providerId="LiveId" clId="{0D82ED02-7E44-4D90-AA80-85DAE28EF6E0}" dt="2025-05-10T01:43:53.397" v="1742" actId="164"/>
          <ac:spMkLst>
            <pc:docMk/>
            <pc:sldMk cId="1010496936" sldId="2013"/>
            <ac:spMk id="35" creationId="{32200E3F-AEC8-76DE-73B4-9BE52C4606A7}"/>
          </ac:spMkLst>
        </pc:spChg>
        <pc:spChg chg="mod topLvl">
          <ac:chgData name="Jun Ge" userId="b8e2f334ff6b24d1" providerId="LiveId" clId="{0D82ED02-7E44-4D90-AA80-85DAE28EF6E0}" dt="2025-05-10T01:44:05.292" v="1745" actId="164"/>
          <ac:spMkLst>
            <pc:docMk/>
            <pc:sldMk cId="1010496936" sldId="2013"/>
            <ac:spMk id="36" creationId="{6FED08C9-D262-10A9-0359-33DC188848D4}"/>
          </ac:spMkLst>
        </pc:spChg>
        <pc:spChg chg="mod topLvl">
          <ac:chgData name="Jun Ge" userId="b8e2f334ff6b24d1" providerId="LiveId" clId="{0D82ED02-7E44-4D90-AA80-85DAE28EF6E0}" dt="2025-05-10T01:44:02.207" v="1744" actId="164"/>
          <ac:spMkLst>
            <pc:docMk/>
            <pc:sldMk cId="1010496936" sldId="2013"/>
            <ac:spMk id="37" creationId="{28E4FB74-B4E5-5301-EEB2-5572A590C873}"/>
          </ac:spMkLst>
        </pc:spChg>
        <pc:spChg chg="mod topLvl">
          <ac:chgData name="Jun Ge" userId="b8e2f334ff6b24d1" providerId="LiveId" clId="{0D82ED02-7E44-4D90-AA80-85DAE28EF6E0}" dt="2025-05-10T01:43:58.553" v="1743" actId="164"/>
          <ac:spMkLst>
            <pc:docMk/>
            <pc:sldMk cId="1010496936" sldId="2013"/>
            <ac:spMk id="38" creationId="{396259ED-76AD-591E-B502-DFC23AB76DC6}"/>
          </ac:spMkLst>
        </pc:spChg>
        <pc:spChg chg="mod">
          <ac:chgData name="Jun Ge" userId="b8e2f334ff6b24d1" providerId="LiveId" clId="{0D82ED02-7E44-4D90-AA80-85DAE28EF6E0}" dt="2025-05-10T01:44:08.504" v="1746" actId="164"/>
          <ac:spMkLst>
            <pc:docMk/>
            <pc:sldMk cId="1010496936" sldId="2013"/>
            <ac:spMk id="39" creationId="{8D5ABB3F-17BB-07BD-C0A1-3A2FB0E5D87B}"/>
          </ac:spMkLst>
        </pc:spChg>
        <pc:grpChg chg="add mod">
          <ac:chgData name="Jun Ge" userId="b8e2f334ff6b24d1" providerId="LiveId" clId="{0D82ED02-7E44-4D90-AA80-85DAE28EF6E0}" dt="2025-05-10T01:44:12.936" v="1747" actId="12788"/>
          <ac:grpSpMkLst>
            <pc:docMk/>
            <pc:sldMk cId="1010496936" sldId="2013"/>
            <ac:grpSpMk id="48" creationId="{B354379E-D363-D1BA-CACA-DAEBFBBCC753}"/>
          </ac:grpSpMkLst>
        </pc:grpChg>
        <pc:grpChg chg="add mod">
          <ac:chgData name="Jun Ge" userId="b8e2f334ff6b24d1" providerId="LiveId" clId="{0D82ED02-7E44-4D90-AA80-85DAE28EF6E0}" dt="2025-05-10T01:44:31.769" v="1754" actId="164"/>
          <ac:grpSpMkLst>
            <pc:docMk/>
            <pc:sldMk cId="1010496936" sldId="2013"/>
            <ac:grpSpMk id="49" creationId="{B8E7908D-C234-60EE-8982-8BB1229D8FA8}"/>
          </ac:grpSpMkLst>
        </pc:grpChg>
        <pc:grpChg chg="add mod">
          <ac:chgData name="Jun Ge" userId="b8e2f334ff6b24d1" providerId="LiveId" clId="{0D82ED02-7E44-4D90-AA80-85DAE28EF6E0}" dt="2025-05-10T01:44:21.399" v="1753" actId="1038"/>
          <ac:grpSpMkLst>
            <pc:docMk/>
            <pc:sldMk cId="1010496936" sldId="2013"/>
            <ac:grpSpMk id="50" creationId="{FF3F314B-FDC0-5258-14C5-9B889F0F3F9B}"/>
          </ac:grpSpMkLst>
        </pc:grpChg>
        <pc:grpChg chg="add mod">
          <ac:chgData name="Jun Ge" userId="b8e2f334ff6b24d1" providerId="LiveId" clId="{0D82ED02-7E44-4D90-AA80-85DAE28EF6E0}" dt="2025-05-10T01:44:21.399" v="1753" actId="1038"/>
          <ac:grpSpMkLst>
            <pc:docMk/>
            <pc:sldMk cId="1010496936" sldId="2013"/>
            <ac:grpSpMk id="51" creationId="{9E4B20FB-9B01-FC29-36A1-A771C92319EC}"/>
          </ac:grpSpMkLst>
        </pc:grpChg>
        <pc:grpChg chg="add mod">
          <ac:chgData name="Jun Ge" userId="b8e2f334ff6b24d1" providerId="LiveId" clId="{0D82ED02-7E44-4D90-AA80-85DAE28EF6E0}" dt="2025-05-10T01:44:16.150" v="1748" actId="12788"/>
          <ac:grpSpMkLst>
            <pc:docMk/>
            <pc:sldMk cId="1010496936" sldId="2013"/>
            <ac:grpSpMk id="52" creationId="{763BF225-C5C1-2F30-41A7-BA21ADAE0197}"/>
          </ac:grpSpMkLst>
        </pc:grpChg>
        <pc:grpChg chg="add mod">
          <ac:chgData name="Jun Ge" userId="b8e2f334ff6b24d1" providerId="LiveId" clId="{0D82ED02-7E44-4D90-AA80-85DAE28EF6E0}" dt="2025-05-10T01:44:31.769" v="1754" actId="164"/>
          <ac:grpSpMkLst>
            <pc:docMk/>
            <pc:sldMk cId="1010496936" sldId="2013"/>
            <ac:grpSpMk id="53" creationId="{6A17986D-4C64-A876-B52B-A4AF78D5233D}"/>
          </ac:grpSpMkLst>
        </pc:grpChg>
        <pc:grpChg chg="add mod">
          <ac:chgData name="Jun Ge" userId="b8e2f334ff6b24d1" providerId="LiveId" clId="{0D82ED02-7E44-4D90-AA80-85DAE28EF6E0}" dt="2025-05-10T01:44:12.936" v="1747" actId="12788"/>
          <ac:grpSpMkLst>
            <pc:docMk/>
            <pc:sldMk cId="1010496936" sldId="2013"/>
            <ac:grpSpMk id="54" creationId="{252E37D7-751F-FC71-0F8C-3771FCB9836E}"/>
          </ac:grpSpMkLst>
        </pc:grpChg>
        <pc:grpChg chg="add mod">
          <ac:chgData name="Jun Ge" userId="b8e2f334ff6b24d1" providerId="LiveId" clId="{0D82ED02-7E44-4D90-AA80-85DAE28EF6E0}" dt="2025-05-10T02:09:28.726" v="2307" actId="14100"/>
          <ac:grpSpMkLst>
            <pc:docMk/>
            <pc:sldMk cId="1010496936" sldId="2013"/>
            <ac:grpSpMk id="55" creationId="{46372908-CDE1-D474-5709-595848A9FE90}"/>
          </ac:grpSpMkLst>
        </pc:grpChg>
        <pc:picChg chg="mod">
          <ac:chgData name="Jun Ge" userId="b8e2f334ff6b24d1" providerId="LiveId" clId="{0D82ED02-7E44-4D90-AA80-85DAE28EF6E0}" dt="2025-05-10T01:44:08.504" v="1746" actId="164"/>
          <ac:picMkLst>
            <pc:docMk/>
            <pc:sldMk cId="1010496936" sldId="2013"/>
            <ac:picMk id="3" creationId="{EE706733-81DB-E5EF-1743-1E1D69668FB5}"/>
          </ac:picMkLst>
        </pc:picChg>
        <pc:picChg chg="mod">
          <ac:chgData name="Jun Ge" userId="b8e2f334ff6b24d1" providerId="LiveId" clId="{0D82ED02-7E44-4D90-AA80-85DAE28EF6E0}" dt="2025-05-10T01:44:05.292" v="1745" actId="164"/>
          <ac:picMkLst>
            <pc:docMk/>
            <pc:sldMk cId="1010496936" sldId="2013"/>
            <ac:picMk id="5" creationId="{65FAF42A-FFA0-A33C-A9D9-4656FCE03F53}"/>
          </ac:picMkLst>
        </pc:picChg>
        <pc:picChg chg="mod">
          <ac:chgData name="Jun Ge" userId="b8e2f334ff6b24d1" providerId="LiveId" clId="{0D82ED02-7E44-4D90-AA80-85DAE28EF6E0}" dt="2025-05-10T01:43:58.553" v="1743" actId="164"/>
          <ac:picMkLst>
            <pc:docMk/>
            <pc:sldMk cId="1010496936" sldId="2013"/>
            <ac:picMk id="7" creationId="{F16475B8-A1F4-DC9C-7E52-53D1B2C40E5B}"/>
          </ac:picMkLst>
        </pc:picChg>
        <pc:picChg chg="mod">
          <ac:chgData name="Jun Ge" userId="b8e2f334ff6b24d1" providerId="LiveId" clId="{0D82ED02-7E44-4D90-AA80-85DAE28EF6E0}" dt="2025-05-10T01:44:02.207" v="1744" actId="164"/>
          <ac:picMkLst>
            <pc:docMk/>
            <pc:sldMk cId="1010496936" sldId="2013"/>
            <ac:picMk id="9" creationId="{EC42EB87-ACDE-A563-B580-9DB401D2302F}"/>
          </ac:picMkLst>
        </pc:picChg>
        <pc:picChg chg="mod">
          <ac:chgData name="Jun Ge" userId="b8e2f334ff6b24d1" providerId="LiveId" clId="{0D82ED02-7E44-4D90-AA80-85DAE28EF6E0}" dt="2025-05-10T01:43:53.397" v="1742" actId="164"/>
          <ac:picMkLst>
            <pc:docMk/>
            <pc:sldMk cId="1010496936" sldId="2013"/>
            <ac:picMk id="11" creationId="{A13F1C26-AA03-DEE3-68E8-4652ED751E1C}"/>
          </ac:picMkLst>
        </pc:picChg>
        <pc:picChg chg="mod">
          <ac:chgData name="Jun Ge" userId="b8e2f334ff6b24d1" providerId="LiveId" clId="{0D82ED02-7E44-4D90-AA80-85DAE28EF6E0}" dt="2025-05-10T01:43:46.015" v="1740" actId="164"/>
          <ac:picMkLst>
            <pc:docMk/>
            <pc:sldMk cId="1010496936" sldId="2013"/>
            <ac:picMk id="13" creationId="{20C88D9E-F4EF-E36D-FA51-996524E236E6}"/>
          </ac:picMkLst>
        </pc:picChg>
        <pc:picChg chg="mod">
          <ac:chgData name="Jun Ge" userId="b8e2f334ff6b24d1" providerId="LiveId" clId="{0D82ED02-7E44-4D90-AA80-85DAE28EF6E0}" dt="2025-05-10T01:43:50.769" v="1741" actId="164"/>
          <ac:picMkLst>
            <pc:docMk/>
            <pc:sldMk cId="1010496936" sldId="2013"/>
            <ac:picMk id="17" creationId="{E385F3B5-9F47-8753-F40F-DF5A63E4B26B}"/>
          </ac:picMkLst>
        </pc:picChg>
      </pc:sldChg>
      <pc:sldChg chg="addSp delSp modSp mod">
        <pc:chgData name="Jun Ge" userId="b8e2f334ff6b24d1" providerId="LiveId" clId="{0D82ED02-7E44-4D90-AA80-85DAE28EF6E0}" dt="2025-05-22T23:41:23.795" v="2584" actId="20577"/>
        <pc:sldMkLst>
          <pc:docMk/>
          <pc:sldMk cId="3682301007" sldId="2015"/>
        </pc:sldMkLst>
        <pc:spChg chg="mod">
          <ac:chgData name="Jun Ge" userId="b8e2f334ff6b24d1" providerId="LiveId" clId="{0D82ED02-7E44-4D90-AA80-85DAE28EF6E0}" dt="2025-05-22T23:41:11.231" v="2577" actId="20577"/>
          <ac:spMkLst>
            <pc:docMk/>
            <pc:sldMk cId="3682301007" sldId="2015"/>
            <ac:spMk id="5" creationId="{8A40FA5B-702D-5465-6CC3-147436072560}"/>
          </ac:spMkLst>
        </pc:spChg>
        <pc:spChg chg="mod">
          <ac:chgData name="Jun Ge" userId="b8e2f334ff6b24d1" providerId="LiveId" clId="{0D82ED02-7E44-4D90-AA80-85DAE28EF6E0}" dt="2025-05-22T23:41:17.025" v="2580" actId="14100"/>
          <ac:spMkLst>
            <pc:docMk/>
            <pc:sldMk cId="3682301007" sldId="2015"/>
            <ac:spMk id="6" creationId="{22F635C3-6459-2673-AC77-F4617B59FC4D}"/>
          </ac:spMkLst>
        </pc:spChg>
        <pc:spChg chg="mod">
          <ac:chgData name="Jun Ge" userId="b8e2f334ff6b24d1" providerId="LiveId" clId="{0D82ED02-7E44-4D90-AA80-85DAE28EF6E0}" dt="2025-05-22T23:41:23.795" v="2584" actId="20577"/>
          <ac:spMkLst>
            <pc:docMk/>
            <pc:sldMk cId="3682301007" sldId="2015"/>
            <ac:spMk id="29" creationId="{238251D4-08E8-AB92-9823-7837288781AC}"/>
          </ac:spMkLst>
        </pc:spChg>
      </pc:sldChg>
      <pc:sldChg chg="add del">
        <pc:chgData name="Jun Ge" userId="b8e2f334ff6b24d1" providerId="LiveId" clId="{0D82ED02-7E44-4D90-AA80-85DAE28EF6E0}" dt="2025-05-12T07:18:07.753" v="2358" actId="2696"/>
        <pc:sldMkLst>
          <pc:docMk/>
          <pc:sldMk cId="2097586221" sldId="2016"/>
        </pc:sldMkLst>
      </pc:sldChg>
      <pc:sldChg chg="del">
        <pc:chgData name="Jun Ge" userId="b8e2f334ff6b24d1" providerId="LiveId" clId="{0D82ED02-7E44-4D90-AA80-85DAE28EF6E0}" dt="2025-05-07T07:08:40.047" v="0" actId="47"/>
        <pc:sldMkLst>
          <pc:docMk/>
          <pc:sldMk cId="35473581" sldId="2017"/>
        </pc:sldMkLst>
      </pc:sldChg>
      <pc:sldChg chg="addSp delSp modSp mod">
        <pc:chgData name="Jun Ge" userId="b8e2f334ff6b24d1" providerId="LiveId" clId="{0D82ED02-7E44-4D90-AA80-85DAE28EF6E0}" dt="2025-05-23T00:35:07.289" v="2657" actId="114"/>
        <pc:sldMkLst>
          <pc:docMk/>
          <pc:sldMk cId="1135461668" sldId="2018"/>
        </pc:sldMkLst>
        <pc:spChg chg="mod ord topLvl">
          <ac:chgData name="Jun Ge" userId="b8e2f334ff6b24d1" providerId="LiveId" clId="{0D82ED02-7E44-4D90-AA80-85DAE28EF6E0}" dt="2025-05-22T23:40:09.369" v="2550" actId="20577"/>
          <ac:spMkLst>
            <pc:docMk/>
            <pc:sldMk cId="1135461668" sldId="2018"/>
            <ac:spMk id="2" creationId="{23ECA110-D907-7BF6-FAB3-CCE6D5FACF98}"/>
          </ac:spMkLst>
        </pc:spChg>
        <pc:spChg chg="mod ord topLvl">
          <ac:chgData name="Jun Ge" userId="b8e2f334ff6b24d1" providerId="LiveId" clId="{0D82ED02-7E44-4D90-AA80-85DAE28EF6E0}" dt="2025-05-22T23:40:11.747" v="2552" actId="20577"/>
          <ac:spMkLst>
            <pc:docMk/>
            <pc:sldMk cId="1135461668" sldId="2018"/>
            <ac:spMk id="3" creationId="{D9E7A4B3-42B1-C5F7-780A-74BE7A261A54}"/>
          </ac:spMkLst>
        </pc:spChg>
        <pc:spChg chg="mod ord topLvl">
          <ac:chgData name="Jun Ge" userId="b8e2f334ff6b24d1" providerId="LiveId" clId="{0D82ED02-7E44-4D90-AA80-85DAE28EF6E0}" dt="2025-05-22T23:40:13.632" v="2554" actId="20577"/>
          <ac:spMkLst>
            <pc:docMk/>
            <pc:sldMk cId="1135461668" sldId="2018"/>
            <ac:spMk id="4" creationId="{52AA5CEF-E2B7-64ED-BBEC-7A38BA738E57}"/>
          </ac:spMkLst>
        </pc:spChg>
        <pc:spChg chg="mod ord topLvl">
          <ac:chgData name="Jun Ge" userId="b8e2f334ff6b24d1" providerId="LiveId" clId="{0D82ED02-7E44-4D90-AA80-85DAE28EF6E0}" dt="2025-05-22T23:40:15.755" v="2556" actId="20577"/>
          <ac:spMkLst>
            <pc:docMk/>
            <pc:sldMk cId="1135461668" sldId="2018"/>
            <ac:spMk id="5" creationId="{97B999A9-B1B4-0D5C-9D47-D5BE67169F95}"/>
          </ac:spMkLst>
        </pc:spChg>
        <pc:spChg chg="mod ord">
          <ac:chgData name="Jun Ge" userId="b8e2f334ff6b24d1" providerId="LiveId" clId="{0D82ED02-7E44-4D90-AA80-85DAE28EF6E0}" dt="2025-05-22T23:40:17.429" v="2558" actId="20577"/>
          <ac:spMkLst>
            <pc:docMk/>
            <pc:sldMk cId="1135461668" sldId="2018"/>
            <ac:spMk id="6" creationId="{E2554957-FB96-68AB-4D80-8C3F643F2843}"/>
          </ac:spMkLst>
        </pc:spChg>
        <pc:spChg chg="mod ord">
          <ac:chgData name="Jun Ge" userId="b8e2f334ff6b24d1" providerId="LiveId" clId="{0D82ED02-7E44-4D90-AA80-85DAE28EF6E0}" dt="2025-05-22T23:40:20.332" v="2560" actId="20577"/>
          <ac:spMkLst>
            <pc:docMk/>
            <pc:sldMk cId="1135461668" sldId="2018"/>
            <ac:spMk id="7" creationId="{99649809-F358-DAC5-A667-B4A591433BCD}"/>
          </ac:spMkLst>
        </pc:spChg>
        <pc:spChg chg="mod ord topLvl">
          <ac:chgData name="Jun Ge" userId="b8e2f334ff6b24d1" providerId="LiveId" clId="{0D82ED02-7E44-4D90-AA80-85DAE28EF6E0}" dt="2025-05-22T23:40:22.587" v="2562" actId="20577"/>
          <ac:spMkLst>
            <pc:docMk/>
            <pc:sldMk cId="1135461668" sldId="2018"/>
            <ac:spMk id="8" creationId="{2CC6FEC1-E896-652A-2C3B-E5D6336E576B}"/>
          </ac:spMkLst>
        </pc:spChg>
        <pc:spChg chg="mod">
          <ac:chgData name="Jun Ge" userId="b8e2f334ff6b24d1" providerId="LiveId" clId="{0D82ED02-7E44-4D90-AA80-85DAE28EF6E0}" dt="2025-05-10T01:52:54.419" v="2072" actId="1036"/>
          <ac:spMkLst>
            <pc:docMk/>
            <pc:sldMk cId="1135461668" sldId="2018"/>
            <ac:spMk id="20" creationId="{4EB3B764-FC1A-B476-886B-C18AD8BDA8FD}"/>
          </ac:spMkLst>
        </pc:spChg>
        <pc:spChg chg="mod">
          <ac:chgData name="Jun Ge" userId="b8e2f334ff6b24d1" providerId="LiveId" clId="{0D82ED02-7E44-4D90-AA80-85DAE28EF6E0}" dt="2025-05-23T00:35:07.289" v="2657" actId="114"/>
          <ac:spMkLst>
            <pc:docMk/>
            <pc:sldMk cId="1135461668" sldId="2018"/>
            <ac:spMk id="21" creationId="{784D353F-2AC5-618D-8A63-BC05FB46DD96}"/>
          </ac:spMkLst>
        </pc:spChg>
        <pc:spChg chg="mod">
          <ac:chgData name="Jun Ge" userId="b8e2f334ff6b24d1" providerId="LiveId" clId="{0D82ED02-7E44-4D90-AA80-85DAE28EF6E0}" dt="2025-05-10T01:52:42.300" v="2067" actId="1035"/>
          <ac:spMkLst>
            <pc:docMk/>
            <pc:sldMk cId="1135461668" sldId="2018"/>
            <ac:spMk id="22" creationId="{EBAC1FBD-03F4-F515-A28E-C9F1CD0D86D3}"/>
          </ac:spMkLst>
        </pc:spChg>
        <pc:spChg chg="mod">
          <ac:chgData name="Jun Ge" userId="b8e2f334ff6b24d1" providerId="LiveId" clId="{0D82ED02-7E44-4D90-AA80-85DAE28EF6E0}" dt="2025-05-10T01:48:22.367" v="1863" actId="1036"/>
          <ac:spMkLst>
            <pc:docMk/>
            <pc:sldMk cId="1135461668" sldId="2018"/>
            <ac:spMk id="23" creationId="{B38F02EB-8D3C-FEA4-9732-A15A6007454E}"/>
          </ac:spMkLst>
        </pc:spChg>
        <pc:spChg chg="mod">
          <ac:chgData name="Jun Ge" userId="b8e2f334ff6b24d1" providerId="LiveId" clId="{0D82ED02-7E44-4D90-AA80-85DAE28EF6E0}" dt="2025-05-10T01:53:01.549" v="2077" actId="1036"/>
          <ac:spMkLst>
            <pc:docMk/>
            <pc:sldMk cId="1135461668" sldId="2018"/>
            <ac:spMk id="24" creationId="{857D95A6-D247-1CAD-F822-5C0821CCD9BC}"/>
          </ac:spMkLst>
        </pc:spChg>
        <pc:spChg chg="mod">
          <ac:chgData name="Jun Ge" userId="b8e2f334ff6b24d1" providerId="LiveId" clId="{0D82ED02-7E44-4D90-AA80-85DAE28EF6E0}" dt="2025-05-10T01:52:26.675" v="2051" actId="1036"/>
          <ac:spMkLst>
            <pc:docMk/>
            <pc:sldMk cId="1135461668" sldId="2018"/>
            <ac:spMk id="27" creationId="{886593AD-EAC2-F226-CDC9-40B7726D3F6C}"/>
          </ac:spMkLst>
        </pc:spChg>
        <pc:spChg chg="mod">
          <ac:chgData name="Jun Ge" userId="b8e2f334ff6b24d1" providerId="LiveId" clId="{0D82ED02-7E44-4D90-AA80-85DAE28EF6E0}" dt="2025-05-10T01:52:30.644" v="2054" actId="1036"/>
          <ac:spMkLst>
            <pc:docMk/>
            <pc:sldMk cId="1135461668" sldId="2018"/>
            <ac:spMk id="28" creationId="{02ECA340-C33F-85BB-4FBF-A21A0E966482}"/>
          </ac:spMkLst>
        </pc:spChg>
        <pc:spChg chg="mod">
          <ac:chgData name="Jun Ge" userId="b8e2f334ff6b24d1" providerId="LiveId" clId="{0D82ED02-7E44-4D90-AA80-85DAE28EF6E0}" dt="2025-05-10T01:52:21.024" v="2047" actId="1036"/>
          <ac:spMkLst>
            <pc:docMk/>
            <pc:sldMk cId="1135461668" sldId="2018"/>
            <ac:spMk id="29" creationId="{45766127-3E89-9E4C-77B2-52EF921A4CFE}"/>
          </ac:spMkLst>
        </pc:spChg>
        <pc:spChg chg="mod ord">
          <ac:chgData name="Jun Ge" userId="b8e2f334ff6b24d1" providerId="LiveId" clId="{0D82ED02-7E44-4D90-AA80-85DAE28EF6E0}" dt="2025-05-10T01:52:54.419" v="2072" actId="1036"/>
          <ac:spMkLst>
            <pc:docMk/>
            <pc:sldMk cId="1135461668" sldId="2018"/>
            <ac:spMk id="30" creationId="{FDD1F94F-810A-A0C4-4640-007070819080}"/>
          </ac:spMkLst>
        </pc:spChg>
        <pc:spChg chg="mod">
          <ac:chgData name="Jun Ge" userId="b8e2f334ff6b24d1" providerId="LiveId" clId="{0D82ED02-7E44-4D90-AA80-85DAE28EF6E0}" dt="2025-05-10T01:52:35.066" v="2059" actId="1036"/>
          <ac:spMkLst>
            <pc:docMk/>
            <pc:sldMk cId="1135461668" sldId="2018"/>
            <ac:spMk id="31" creationId="{F291916A-4736-CCF8-EE72-EE3E5DAAB503}"/>
          </ac:spMkLst>
        </pc:spChg>
        <pc:spChg chg="mod">
          <ac:chgData name="Jun Ge" userId="b8e2f334ff6b24d1" providerId="LiveId" clId="{0D82ED02-7E44-4D90-AA80-85DAE28EF6E0}" dt="2025-05-10T01:50:40.438" v="1935" actId="165"/>
          <ac:spMkLst>
            <pc:docMk/>
            <pc:sldMk cId="1135461668" sldId="2018"/>
            <ac:spMk id="32" creationId="{D47883A1-82FF-E371-1F7D-041B025F3937}"/>
          </ac:spMkLst>
        </pc:spChg>
        <pc:spChg chg="mod">
          <ac:chgData name="Jun Ge" userId="b8e2f334ff6b24d1" providerId="LiveId" clId="{0D82ED02-7E44-4D90-AA80-85DAE28EF6E0}" dt="2025-05-10T01:53:01.549" v="2077" actId="1036"/>
          <ac:spMkLst>
            <pc:docMk/>
            <pc:sldMk cId="1135461668" sldId="2018"/>
            <ac:spMk id="33" creationId="{472A39D7-D04C-91B8-7AC4-612292210E1D}"/>
          </ac:spMkLst>
        </pc:spChg>
        <pc:spChg chg="mod">
          <ac:chgData name="Jun Ge" userId="b8e2f334ff6b24d1" providerId="LiveId" clId="{0D82ED02-7E44-4D90-AA80-85DAE28EF6E0}" dt="2025-05-10T01:52:26.675" v="2051" actId="1036"/>
          <ac:spMkLst>
            <pc:docMk/>
            <pc:sldMk cId="1135461668" sldId="2018"/>
            <ac:spMk id="34" creationId="{AE665D8C-574B-3A38-CC04-B23B6611DD4D}"/>
          </ac:spMkLst>
        </pc:spChg>
        <pc:spChg chg="mod">
          <ac:chgData name="Jun Ge" userId="b8e2f334ff6b24d1" providerId="LiveId" clId="{0D82ED02-7E44-4D90-AA80-85DAE28EF6E0}" dt="2025-05-10T01:50:40.438" v="1935" actId="165"/>
          <ac:spMkLst>
            <pc:docMk/>
            <pc:sldMk cId="1135461668" sldId="2018"/>
            <ac:spMk id="35" creationId="{5E13F4E9-D189-6675-3DEF-B67F6F1B26FF}"/>
          </ac:spMkLst>
        </pc:spChg>
        <pc:spChg chg="mod">
          <ac:chgData name="Jun Ge" userId="b8e2f334ff6b24d1" providerId="LiveId" clId="{0D82ED02-7E44-4D90-AA80-85DAE28EF6E0}" dt="2025-05-10T01:52:21.024" v="2047" actId="1036"/>
          <ac:spMkLst>
            <pc:docMk/>
            <pc:sldMk cId="1135461668" sldId="2018"/>
            <ac:spMk id="36" creationId="{0D12FAEA-0DB9-5949-3C4A-2F4E564BF8C1}"/>
          </ac:spMkLst>
        </pc:spChg>
        <pc:spChg chg="mod">
          <ac:chgData name="Jun Ge" userId="b8e2f334ff6b24d1" providerId="LiveId" clId="{0D82ED02-7E44-4D90-AA80-85DAE28EF6E0}" dt="2025-05-10T01:52:54.419" v="2072" actId="1036"/>
          <ac:spMkLst>
            <pc:docMk/>
            <pc:sldMk cId="1135461668" sldId="2018"/>
            <ac:spMk id="37" creationId="{35DDB3EA-B130-A130-D00C-9B5484A84DBE}"/>
          </ac:spMkLst>
        </pc:spChg>
        <pc:spChg chg="mod">
          <ac:chgData name="Jun Ge" userId="b8e2f334ff6b24d1" providerId="LiveId" clId="{0D82ED02-7E44-4D90-AA80-85DAE28EF6E0}" dt="2025-05-10T01:52:45.247" v="2070" actId="1035"/>
          <ac:spMkLst>
            <pc:docMk/>
            <pc:sldMk cId="1135461668" sldId="2018"/>
            <ac:spMk id="38" creationId="{1C66E24F-E2FF-E9E2-6E47-821ECCAC1DAB}"/>
          </ac:spMkLst>
        </pc:spChg>
        <pc:spChg chg="mod topLvl">
          <ac:chgData name="Jun Ge" userId="b8e2f334ff6b24d1" providerId="LiveId" clId="{0D82ED02-7E44-4D90-AA80-85DAE28EF6E0}" dt="2025-05-10T01:50:40.438" v="1935" actId="165"/>
          <ac:spMkLst>
            <pc:docMk/>
            <pc:sldMk cId="1135461668" sldId="2018"/>
            <ac:spMk id="39" creationId="{DEFFC85A-E52D-E47D-6899-584DCEB32C37}"/>
          </ac:spMkLst>
        </pc:spChg>
        <pc:spChg chg="mod">
          <ac:chgData name="Jun Ge" userId="b8e2f334ff6b24d1" providerId="LiveId" clId="{0D82ED02-7E44-4D90-AA80-85DAE28EF6E0}" dt="2025-05-10T01:53:01.549" v="2077" actId="1036"/>
          <ac:spMkLst>
            <pc:docMk/>
            <pc:sldMk cId="1135461668" sldId="2018"/>
            <ac:spMk id="40" creationId="{1885ED03-51AE-25D6-70A1-572BE38C3670}"/>
          </ac:spMkLst>
        </pc:spChg>
        <pc:spChg chg="mod">
          <ac:chgData name="Jun Ge" userId="b8e2f334ff6b24d1" providerId="LiveId" clId="{0D82ED02-7E44-4D90-AA80-85DAE28EF6E0}" dt="2025-05-10T01:52:26.675" v="2051" actId="1036"/>
          <ac:spMkLst>
            <pc:docMk/>
            <pc:sldMk cId="1135461668" sldId="2018"/>
            <ac:spMk id="41" creationId="{FB91A2CC-BC45-F6C4-625A-1C327A622CA7}"/>
          </ac:spMkLst>
        </pc:spChg>
        <pc:spChg chg="mod">
          <ac:chgData name="Jun Ge" userId="b8e2f334ff6b24d1" providerId="LiveId" clId="{0D82ED02-7E44-4D90-AA80-85DAE28EF6E0}" dt="2025-05-10T01:52:30.644" v="2054" actId="1036"/>
          <ac:spMkLst>
            <pc:docMk/>
            <pc:sldMk cId="1135461668" sldId="2018"/>
            <ac:spMk id="42" creationId="{9416594D-FEC1-16C4-4436-14A71614C1AE}"/>
          </ac:spMkLst>
        </pc:spChg>
        <pc:spChg chg="mod">
          <ac:chgData name="Jun Ge" userId="b8e2f334ff6b24d1" providerId="LiveId" clId="{0D82ED02-7E44-4D90-AA80-85DAE28EF6E0}" dt="2025-05-10T01:52:21.024" v="2047" actId="1036"/>
          <ac:spMkLst>
            <pc:docMk/>
            <pc:sldMk cId="1135461668" sldId="2018"/>
            <ac:spMk id="43" creationId="{E959DB5C-52DD-7700-1CD6-FB0AAF8B7CDB}"/>
          </ac:spMkLst>
        </pc:spChg>
        <pc:grpChg chg="add mod">
          <ac:chgData name="Jun Ge" userId="b8e2f334ff6b24d1" providerId="LiveId" clId="{0D82ED02-7E44-4D90-AA80-85DAE28EF6E0}" dt="2025-05-10T01:51:31.925" v="1992" actId="164"/>
          <ac:grpSpMkLst>
            <pc:docMk/>
            <pc:sldMk cId="1135461668" sldId="2018"/>
            <ac:grpSpMk id="14" creationId="{1995019C-D610-2AFA-58A1-8EA16096CE86}"/>
          </ac:grpSpMkLst>
        </pc:grpChg>
        <pc:grpChg chg="add mod">
          <ac:chgData name="Jun Ge" userId="b8e2f334ff6b24d1" providerId="LiveId" clId="{0D82ED02-7E44-4D90-AA80-85DAE28EF6E0}" dt="2025-05-10T01:50:47.144" v="1948" actId="1037"/>
          <ac:grpSpMkLst>
            <pc:docMk/>
            <pc:sldMk cId="1135461668" sldId="2018"/>
            <ac:grpSpMk id="15" creationId="{5134C7FE-72A5-4892-04A5-75BAA49FDE68}"/>
          </ac:grpSpMkLst>
        </pc:grpChg>
        <pc:grpChg chg="add mod">
          <ac:chgData name="Jun Ge" userId="b8e2f334ff6b24d1" providerId="LiveId" clId="{0D82ED02-7E44-4D90-AA80-85DAE28EF6E0}" dt="2025-05-10T01:50:50.124" v="1953" actId="1037"/>
          <ac:grpSpMkLst>
            <pc:docMk/>
            <pc:sldMk cId="1135461668" sldId="2018"/>
            <ac:grpSpMk id="16" creationId="{5F0B9638-C8D7-0A07-B9F6-C88BA31BD44D}"/>
          </ac:grpSpMkLst>
        </pc:grpChg>
        <pc:grpChg chg="add mod">
          <ac:chgData name="Jun Ge" userId="b8e2f334ff6b24d1" providerId="LiveId" clId="{0D82ED02-7E44-4D90-AA80-85DAE28EF6E0}" dt="2025-05-10T01:51:31.925" v="1992" actId="164"/>
          <ac:grpSpMkLst>
            <pc:docMk/>
            <pc:sldMk cId="1135461668" sldId="2018"/>
            <ac:grpSpMk id="17" creationId="{0223FB7A-29B7-7BD7-6967-F17F004151D7}"/>
          </ac:grpSpMkLst>
        </pc:grpChg>
        <pc:grpChg chg="add mod">
          <ac:chgData name="Jun Ge" userId="b8e2f334ff6b24d1" providerId="LiveId" clId="{0D82ED02-7E44-4D90-AA80-85DAE28EF6E0}" dt="2025-05-10T02:09:53.866" v="2321" actId="1035"/>
          <ac:grpSpMkLst>
            <pc:docMk/>
            <pc:sldMk cId="1135461668" sldId="2018"/>
            <ac:grpSpMk id="25" creationId="{85928596-F12A-8FE4-4961-86119D97DD27}"/>
          </ac:grpSpMkLst>
        </pc:grpChg>
        <pc:grpChg chg="mod">
          <ac:chgData name="Jun Ge" userId="b8e2f334ff6b24d1" providerId="LiveId" clId="{0D82ED02-7E44-4D90-AA80-85DAE28EF6E0}" dt="2025-05-10T01:51:16.442" v="1987" actId="1036"/>
          <ac:grpSpMkLst>
            <pc:docMk/>
            <pc:sldMk cId="1135461668" sldId="2018"/>
            <ac:grpSpMk id="87" creationId="{2C92D940-072F-2C8E-5D05-7D3002CDB6AA}"/>
          </ac:grpSpMkLst>
        </pc:grpChg>
        <pc:grpChg chg="mod">
          <ac:chgData name="Jun Ge" userId="b8e2f334ff6b24d1" providerId="LiveId" clId="{0D82ED02-7E44-4D90-AA80-85DAE28EF6E0}" dt="2025-05-10T01:51:08.835" v="1965" actId="1035"/>
          <ac:grpSpMkLst>
            <pc:docMk/>
            <pc:sldMk cId="1135461668" sldId="2018"/>
            <ac:grpSpMk id="88" creationId="{367C89C0-0B7E-0CA1-288A-B3DDF49E4D64}"/>
          </ac:grpSpMkLst>
        </pc:grpChg>
        <pc:grpChg chg="mod">
          <ac:chgData name="Jun Ge" userId="b8e2f334ff6b24d1" providerId="LiveId" clId="{0D82ED02-7E44-4D90-AA80-85DAE28EF6E0}" dt="2025-05-10T01:51:08.835" v="1965" actId="1035"/>
          <ac:grpSpMkLst>
            <pc:docMk/>
            <pc:sldMk cId="1135461668" sldId="2018"/>
            <ac:grpSpMk id="89" creationId="{47CCE292-5561-CB07-7541-26FA9D7C4946}"/>
          </ac:grpSpMkLst>
        </pc:grpChg>
        <pc:picChg chg="mod">
          <ac:chgData name="Jun Ge" userId="b8e2f334ff6b24d1" providerId="LiveId" clId="{0D82ED02-7E44-4D90-AA80-85DAE28EF6E0}" dt="2025-05-10T01:46:48.007" v="1783" actId="164"/>
          <ac:picMkLst>
            <pc:docMk/>
            <pc:sldMk cId="1135461668" sldId="2018"/>
            <ac:picMk id="9" creationId="{B2AB7953-798B-B44C-452B-EF7CEC52C973}"/>
          </ac:picMkLst>
        </pc:picChg>
        <pc:picChg chg="mod">
          <ac:chgData name="Jun Ge" userId="b8e2f334ff6b24d1" providerId="LiveId" clId="{0D82ED02-7E44-4D90-AA80-85DAE28EF6E0}" dt="2025-05-10T01:46:34.460" v="1780" actId="164"/>
          <ac:picMkLst>
            <pc:docMk/>
            <pc:sldMk cId="1135461668" sldId="2018"/>
            <ac:picMk id="12" creationId="{3C4A485D-7D55-8C69-F44E-C69AB1384629}"/>
          </ac:picMkLst>
        </pc:picChg>
        <pc:picChg chg="mod">
          <ac:chgData name="Jun Ge" userId="b8e2f334ff6b24d1" providerId="LiveId" clId="{0D82ED02-7E44-4D90-AA80-85DAE28EF6E0}" dt="2025-05-10T01:46:25.571" v="1778" actId="164"/>
          <ac:picMkLst>
            <pc:docMk/>
            <pc:sldMk cId="1135461668" sldId="2018"/>
            <ac:picMk id="13" creationId="{F5CA2C23-6E1E-C0FB-8714-492CB6AF3D62}"/>
          </ac:picMkLst>
        </pc:picChg>
        <pc:picChg chg="mod">
          <ac:chgData name="Jun Ge" userId="b8e2f334ff6b24d1" providerId="LiveId" clId="{0D82ED02-7E44-4D90-AA80-85DAE28EF6E0}" dt="2025-05-10T01:46:30.624" v="1779" actId="164"/>
          <ac:picMkLst>
            <pc:docMk/>
            <pc:sldMk cId="1135461668" sldId="2018"/>
            <ac:picMk id="52" creationId="{4940B860-9B87-BAFA-3377-EF7CCEF10277}"/>
          </ac:picMkLst>
        </pc:picChg>
      </pc:sldChg>
      <pc:sldChg chg="modSp mod">
        <pc:chgData name="Jun Ge" userId="b8e2f334ff6b24d1" providerId="LiveId" clId="{0D82ED02-7E44-4D90-AA80-85DAE28EF6E0}" dt="2025-05-23T00:25:29.574" v="2641" actId="20577"/>
        <pc:sldMkLst>
          <pc:docMk/>
          <pc:sldMk cId="1948246596" sldId="2019"/>
        </pc:sldMkLst>
        <pc:spChg chg="mod">
          <ac:chgData name="Jun Ge" userId="b8e2f334ff6b24d1" providerId="LiveId" clId="{0D82ED02-7E44-4D90-AA80-85DAE28EF6E0}" dt="2025-05-23T00:25:29.574" v="2641" actId="20577"/>
          <ac:spMkLst>
            <pc:docMk/>
            <pc:sldMk cId="1948246596" sldId="2019"/>
            <ac:spMk id="2" creationId="{B1E5F03D-16D8-BF5B-49FA-8A1C55928D75}"/>
          </ac:spMkLst>
        </pc:spChg>
      </pc:sldChg>
      <pc:sldChg chg="addSp delSp modSp mod">
        <pc:chgData name="Jun Ge" userId="b8e2f334ff6b24d1" providerId="LiveId" clId="{0D82ED02-7E44-4D90-AA80-85DAE28EF6E0}" dt="2025-05-23T00:26:04.044" v="2646" actId="20577"/>
        <pc:sldMkLst>
          <pc:docMk/>
          <pc:sldMk cId="736711877" sldId="2020"/>
        </pc:sldMkLst>
        <pc:spChg chg="add mod">
          <ac:chgData name="Jun Ge" userId="b8e2f334ff6b24d1" providerId="LiveId" clId="{0D82ED02-7E44-4D90-AA80-85DAE28EF6E0}" dt="2025-05-23T00:26:04.044" v="2646" actId="20577"/>
          <ac:spMkLst>
            <pc:docMk/>
            <pc:sldMk cId="736711877" sldId="2020"/>
            <ac:spMk id="45" creationId="{86896ECD-177D-6042-8254-2106B50AC8F4}"/>
          </ac:spMkLst>
        </pc:spChg>
        <pc:picChg chg="add mod modCrop">
          <ac:chgData name="Jun Ge" userId="b8e2f334ff6b24d1" providerId="LiveId" clId="{0D82ED02-7E44-4D90-AA80-85DAE28EF6E0}" dt="2025-05-08T07:35:15.512" v="430" actId="1076"/>
          <ac:picMkLst>
            <pc:docMk/>
            <pc:sldMk cId="736711877" sldId="2020"/>
            <ac:picMk id="41" creationId="{5ABAF9F6-F0CE-E7D6-E334-85B7206FF0B4}"/>
          </ac:picMkLst>
        </pc:picChg>
        <pc:picChg chg="add mod modCrop">
          <ac:chgData name="Jun Ge" userId="b8e2f334ff6b24d1" providerId="LiveId" clId="{0D82ED02-7E44-4D90-AA80-85DAE28EF6E0}" dt="2025-05-10T01:59:46.253" v="2089" actId="1076"/>
          <ac:picMkLst>
            <pc:docMk/>
            <pc:sldMk cId="736711877" sldId="2020"/>
            <ac:picMk id="42" creationId="{F5772F9E-C505-9925-0130-DD81519CE03A}"/>
          </ac:picMkLst>
        </pc:picChg>
      </pc:sldChg>
      <pc:sldChg chg="new del">
        <pc:chgData name="Jun Ge" userId="b8e2f334ff6b24d1" providerId="LiveId" clId="{0D82ED02-7E44-4D90-AA80-85DAE28EF6E0}" dt="2025-05-09T08:50:03.895" v="497" actId="47"/>
        <pc:sldMkLst>
          <pc:docMk/>
          <pc:sldMk cId="598340779" sldId="2021"/>
        </pc:sldMkLst>
      </pc:sldChg>
      <pc:sldChg chg="addSp delSp modSp new mod">
        <pc:chgData name="Jun Ge" userId="b8e2f334ff6b24d1" providerId="LiveId" clId="{0D82ED02-7E44-4D90-AA80-85DAE28EF6E0}" dt="2025-05-22T23:36:49.908" v="2452" actId="13926"/>
        <pc:sldMkLst>
          <pc:docMk/>
          <pc:sldMk cId="1082031398" sldId="2022"/>
        </pc:sldMkLst>
        <pc:spChg chg="add mod">
          <ac:chgData name="Jun Ge" userId="b8e2f334ff6b24d1" providerId="LiveId" clId="{0D82ED02-7E44-4D90-AA80-85DAE28EF6E0}" dt="2025-05-07T07:13:27.263" v="20" actId="1076"/>
          <ac:spMkLst>
            <pc:docMk/>
            <pc:sldMk cId="1082031398" sldId="2022"/>
            <ac:spMk id="5" creationId="{BB71CCFE-C9B2-DF0F-4970-C178D824A9F4}"/>
          </ac:spMkLst>
        </pc:spChg>
        <pc:graphicFrameChg chg="add mod modGraphic">
          <ac:chgData name="Jun Ge" userId="b8e2f334ff6b24d1" providerId="LiveId" clId="{0D82ED02-7E44-4D90-AA80-85DAE28EF6E0}" dt="2025-05-22T23:36:49.908" v="2452" actId="13926"/>
          <ac:graphicFrameMkLst>
            <pc:docMk/>
            <pc:sldMk cId="1082031398" sldId="2022"/>
            <ac:graphicFrameMk id="7" creationId="{8C18C645-16B0-3614-5CD9-14BA3E973DD7}"/>
          </ac:graphicFrameMkLst>
        </pc:graphicFrameChg>
      </pc:sldChg>
      <pc:sldChg chg="addSp modSp new mod">
        <pc:chgData name="Jun Ge" userId="b8e2f334ff6b24d1" providerId="LiveId" clId="{0D82ED02-7E44-4D90-AA80-85DAE28EF6E0}" dt="2025-05-09T09:15:26.795" v="554" actId="1076"/>
        <pc:sldMkLst>
          <pc:docMk/>
          <pc:sldMk cId="4247067011" sldId="2023"/>
        </pc:sldMkLst>
        <pc:spChg chg="add mod">
          <ac:chgData name="Jun Ge" userId="b8e2f334ff6b24d1" providerId="LiveId" clId="{0D82ED02-7E44-4D90-AA80-85DAE28EF6E0}" dt="2025-05-09T09:15:26.795" v="554" actId="1076"/>
          <ac:spMkLst>
            <pc:docMk/>
            <pc:sldMk cId="4247067011" sldId="2023"/>
            <ac:spMk id="3" creationId="{C43BC855-A394-BDA4-68D4-EBF51437CCDF}"/>
          </ac:spMkLst>
        </pc:spChg>
      </pc:sldChg>
      <pc:sldChg chg="addSp delSp modSp new del mod">
        <pc:chgData name="Jun Ge" userId="b8e2f334ff6b24d1" providerId="LiveId" clId="{0D82ED02-7E44-4D90-AA80-85DAE28EF6E0}" dt="2025-05-10T02:23:09.345" v="2333" actId="47"/>
        <pc:sldMkLst>
          <pc:docMk/>
          <pc:sldMk cId="2407463922" sldId="2024"/>
        </pc:sldMkLst>
      </pc:sldChg>
      <pc:sldChg chg="addSp modSp new del mod">
        <pc:chgData name="Jun Ge" userId="b8e2f334ff6b24d1" providerId="LiveId" clId="{0D82ED02-7E44-4D90-AA80-85DAE28EF6E0}" dt="2025-05-09T09:13:47.948" v="528" actId="47"/>
        <pc:sldMkLst>
          <pc:docMk/>
          <pc:sldMk cId="2081226483" sldId="2025"/>
        </pc:sldMkLst>
      </pc:sldChg>
      <pc:sldChg chg="delSp new del mod ord">
        <pc:chgData name="Jun Ge" userId="b8e2f334ff6b24d1" providerId="LiveId" clId="{0D82ED02-7E44-4D90-AA80-85DAE28EF6E0}" dt="2025-05-10T01:13:04.868" v="1135" actId="47"/>
        <pc:sldMkLst>
          <pc:docMk/>
          <pc:sldMk cId="3881269887" sldId="2025"/>
        </pc:sldMkLst>
      </pc:sldChg>
      <pc:sldChg chg="addSp delSp modSp new del mod">
        <pc:chgData name="Jun Ge" userId="b8e2f334ff6b24d1" providerId="LiveId" clId="{0D82ED02-7E44-4D90-AA80-85DAE28EF6E0}" dt="2025-05-09T09:15:05.808" v="549" actId="47"/>
        <pc:sldMkLst>
          <pc:docMk/>
          <pc:sldMk cId="1706042778" sldId="2026"/>
        </pc:sldMkLst>
      </pc:sldChg>
      <pc:sldChg chg="addSp delSp modSp new mod">
        <pc:chgData name="Jun Ge" userId="b8e2f334ff6b24d1" providerId="LiveId" clId="{0D82ED02-7E44-4D90-AA80-85DAE28EF6E0}" dt="2025-05-13T09:30:17.411" v="2431" actId="255"/>
        <pc:sldMkLst>
          <pc:docMk/>
          <pc:sldMk cId="1714582132" sldId="2026"/>
        </pc:sldMkLst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10" creationId="{B66E21F6-EC1F-A28D-A376-3273189278B1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11" creationId="{29D24195-537B-E4BF-F314-D50B484BCB52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12" creationId="{53E69223-F716-D5A0-F97E-1A971604373C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13" creationId="{B6EB8513-244F-59E8-E1F8-643F82F95C31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36" creationId="{1B775BE9-22F5-80B0-71E7-4F08BBF7AAAF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38" creationId="{FBF7C08E-2CF7-D341-D7A4-39A1BC423E83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41" creationId="{B41522DC-5630-2A0B-41F3-65619D1472F3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46" creationId="{88B47493-A9A1-E5FC-7F37-A6BC9C3A300D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67" creationId="{F592BE3D-DDF1-0BC5-9207-0916A12E8EAE}"/>
          </ac:spMkLst>
        </pc:spChg>
        <pc:spChg chg="add mod topLvl">
          <ac:chgData name="Jun Ge" userId="b8e2f334ff6b24d1" providerId="LiveId" clId="{0D82ED02-7E44-4D90-AA80-85DAE28EF6E0}" dt="2025-05-10T01:09:51.802" v="1130" actId="164"/>
          <ac:spMkLst>
            <pc:docMk/>
            <pc:sldMk cId="1714582132" sldId="2026"/>
            <ac:spMk id="69" creationId="{B461A4B8-751F-7F3C-A20C-BBC404F56C27}"/>
          </ac:spMkLst>
        </pc:spChg>
        <pc:spChg chg="add mod">
          <ac:chgData name="Jun Ge" userId="b8e2f334ff6b24d1" providerId="LiveId" clId="{0D82ED02-7E44-4D90-AA80-85DAE28EF6E0}" dt="2025-05-13T09:30:17.411" v="2431" actId="255"/>
          <ac:spMkLst>
            <pc:docMk/>
            <pc:sldMk cId="1714582132" sldId="2026"/>
            <ac:spMk id="82" creationId="{E1F9210C-D7EF-E736-55D0-EB2EFE95F4DD}"/>
          </ac:spMkLst>
        </pc:spChg>
        <pc:grpChg chg="mod">
          <ac:chgData name="Jun Ge" userId="b8e2f334ff6b24d1" providerId="LiveId" clId="{0D82ED02-7E44-4D90-AA80-85DAE28EF6E0}" dt="2025-05-10T02:10:26.303" v="2332" actId="1035"/>
          <ac:grpSpMkLst>
            <pc:docMk/>
            <pc:sldMk cId="1714582132" sldId="2026"/>
            <ac:grpSpMk id="76" creationId="{7FABC92F-0181-351A-8CA3-81A5726D3937}"/>
          </ac:grpSpMkLst>
        </pc:grpChg>
        <pc:picChg chg="add mod">
          <ac:chgData name="Jun Ge" userId="b8e2f334ff6b24d1" providerId="LiveId" clId="{0D82ED02-7E44-4D90-AA80-85DAE28EF6E0}" dt="2025-05-10T01:08:45.204" v="1103" actId="12788"/>
          <ac:picMkLst>
            <pc:docMk/>
            <pc:sldMk cId="1714582132" sldId="2026"/>
            <ac:picMk id="47" creationId="{08DE9FC1-F274-7F4D-CFD5-29C0BC76C387}"/>
          </ac:picMkLst>
        </pc:picChg>
        <pc:picChg chg="add mod">
          <ac:chgData name="Jun Ge" userId="b8e2f334ff6b24d1" providerId="LiveId" clId="{0D82ED02-7E44-4D90-AA80-85DAE28EF6E0}" dt="2025-05-10T01:08:40.683" v="1101" actId="12788"/>
          <ac:picMkLst>
            <pc:docMk/>
            <pc:sldMk cId="1714582132" sldId="2026"/>
            <ac:picMk id="49" creationId="{AB402875-FF3F-239A-427E-E576C275158C}"/>
          </ac:picMkLst>
        </pc:picChg>
        <pc:picChg chg="add mod">
          <ac:chgData name="Jun Ge" userId="b8e2f334ff6b24d1" providerId="LiveId" clId="{0D82ED02-7E44-4D90-AA80-85DAE28EF6E0}" dt="2025-05-10T01:08:42.454" v="1102" actId="12788"/>
          <ac:picMkLst>
            <pc:docMk/>
            <pc:sldMk cId="1714582132" sldId="2026"/>
            <ac:picMk id="50" creationId="{7653CBA7-CE8C-E4CA-30A7-92DBE4228D03}"/>
          </ac:picMkLst>
        </pc:picChg>
        <pc:picChg chg="add mod">
          <ac:chgData name="Jun Ge" userId="b8e2f334ff6b24d1" providerId="LiveId" clId="{0D82ED02-7E44-4D90-AA80-85DAE28EF6E0}" dt="2025-05-10T01:08:38.554" v="1100" actId="12788"/>
          <ac:picMkLst>
            <pc:docMk/>
            <pc:sldMk cId="1714582132" sldId="2026"/>
            <ac:picMk id="51" creationId="{388EB121-794F-9A1A-1043-081FD2D59CF6}"/>
          </ac:picMkLst>
        </pc:picChg>
        <pc:picChg chg="add mod">
          <ac:chgData name="Jun Ge" userId="b8e2f334ff6b24d1" providerId="LiveId" clId="{0D82ED02-7E44-4D90-AA80-85DAE28EF6E0}" dt="2025-05-10T01:08:40.683" v="1101" actId="12788"/>
          <ac:picMkLst>
            <pc:docMk/>
            <pc:sldMk cId="1714582132" sldId="2026"/>
            <ac:picMk id="52" creationId="{FD824134-E83A-BFE8-20B2-899A832614F4}"/>
          </ac:picMkLst>
        </pc:picChg>
        <pc:picChg chg="add mod">
          <ac:chgData name="Jun Ge" userId="b8e2f334ff6b24d1" providerId="LiveId" clId="{0D82ED02-7E44-4D90-AA80-85DAE28EF6E0}" dt="2025-05-10T01:08:42.454" v="1102" actId="12788"/>
          <ac:picMkLst>
            <pc:docMk/>
            <pc:sldMk cId="1714582132" sldId="2026"/>
            <ac:picMk id="53" creationId="{32BCEFF9-981B-6DCC-2380-06C312548894}"/>
          </ac:picMkLst>
        </pc:picChg>
        <pc:picChg chg="add mod">
          <ac:chgData name="Jun Ge" userId="b8e2f334ff6b24d1" providerId="LiveId" clId="{0D82ED02-7E44-4D90-AA80-85DAE28EF6E0}" dt="2025-05-10T01:08:45.204" v="1103" actId="12788"/>
          <ac:picMkLst>
            <pc:docMk/>
            <pc:sldMk cId="1714582132" sldId="2026"/>
            <ac:picMk id="54" creationId="{26C7B13C-70D4-0FF0-1691-CF3747CEF6F8}"/>
          </ac:picMkLst>
        </pc:picChg>
        <pc:picChg chg="add mod">
          <ac:chgData name="Jun Ge" userId="b8e2f334ff6b24d1" providerId="LiveId" clId="{0D82ED02-7E44-4D90-AA80-85DAE28EF6E0}" dt="2025-05-10T01:08:38.554" v="1100" actId="12788"/>
          <ac:picMkLst>
            <pc:docMk/>
            <pc:sldMk cId="1714582132" sldId="2026"/>
            <ac:picMk id="58" creationId="{20F5B4BC-22FC-22B5-6FD7-FD9345CD0C2E}"/>
          </ac:picMkLst>
        </pc:picChg>
        <pc:picChg chg="add mod">
          <ac:chgData name="Jun Ge" userId="b8e2f334ff6b24d1" providerId="LiveId" clId="{0D82ED02-7E44-4D90-AA80-85DAE28EF6E0}" dt="2025-05-10T01:08:38.554" v="1100" actId="12788"/>
          <ac:picMkLst>
            <pc:docMk/>
            <pc:sldMk cId="1714582132" sldId="2026"/>
            <ac:picMk id="63" creationId="{29DE904E-9BA5-FDD4-4AB1-9E06C31D13CF}"/>
          </ac:picMkLst>
        </pc:picChg>
        <pc:picChg chg="add mod">
          <ac:chgData name="Jun Ge" userId="b8e2f334ff6b24d1" providerId="LiveId" clId="{0D82ED02-7E44-4D90-AA80-85DAE28EF6E0}" dt="2025-05-10T01:08:40.683" v="1101" actId="12788"/>
          <ac:picMkLst>
            <pc:docMk/>
            <pc:sldMk cId="1714582132" sldId="2026"/>
            <ac:picMk id="64" creationId="{DA1E13BA-14A2-2A8C-E098-914F92314081}"/>
          </ac:picMkLst>
        </pc:picChg>
        <pc:picChg chg="add mod">
          <ac:chgData name="Jun Ge" userId="b8e2f334ff6b24d1" providerId="LiveId" clId="{0D82ED02-7E44-4D90-AA80-85DAE28EF6E0}" dt="2025-05-10T01:08:42.454" v="1102" actId="12788"/>
          <ac:picMkLst>
            <pc:docMk/>
            <pc:sldMk cId="1714582132" sldId="2026"/>
            <ac:picMk id="65" creationId="{D6145FA1-329C-B5B4-D620-42A022B93BDE}"/>
          </ac:picMkLst>
        </pc:picChg>
        <pc:picChg chg="add mod">
          <ac:chgData name="Jun Ge" userId="b8e2f334ff6b24d1" providerId="LiveId" clId="{0D82ED02-7E44-4D90-AA80-85DAE28EF6E0}" dt="2025-05-10T01:08:45.204" v="1103" actId="12788"/>
          <ac:picMkLst>
            <pc:docMk/>
            <pc:sldMk cId="1714582132" sldId="2026"/>
            <ac:picMk id="66" creationId="{FC613B72-9B0B-1F68-5282-B1654943657F}"/>
          </ac:picMkLst>
        </pc:picChg>
        <pc:picChg chg="add mod">
          <ac:chgData name="Jun Ge" userId="b8e2f334ff6b24d1" providerId="LiveId" clId="{0D82ED02-7E44-4D90-AA80-85DAE28EF6E0}" dt="2025-05-10T01:08:38.554" v="1100" actId="12788"/>
          <ac:picMkLst>
            <pc:docMk/>
            <pc:sldMk cId="1714582132" sldId="2026"/>
            <ac:picMk id="75" creationId="{06B35733-BD1C-46E3-EE16-A41D0ED8B437}"/>
          </ac:picMkLst>
        </pc:picChg>
        <pc:picChg chg="add mod">
          <ac:chgData name="Jun Ge" userId="b8e2f334ff6b24d1" providerId="LiveId" clId="{0D82ED02-7E44-4D90-AA80-85DAE28EF6E0}" dt="2025-05-10T01:08:40.683" v="1101" actId="12788"/>
          <ac:picMkLst>
            <pc:docMk/>
            <pc:sldMk cId="1714582132" sldId="2026"/>
            <ac:picMk id="77" creationId="{6A6219EB-00DB-1970-D3EE-7DF7EEAD5E2B}"/>
          </ac:picMkLst>
        </pc:picChg>
        <pc:picChg chg="add mod">
          <ac:chgData name="Jun Ge" userId="b8e2f334ff6b24d1" providerId="LiveId" clId="{0D82ED02-7E44-4D90-AA80-85DAE28EF6E0}" dt="2025-05-10T01:08:42.454" v="1102" actId="12788"/>
          <ac:picMkLst>
            <pc:docMk/>
            <pc:sldMk cId="1714582132" sldId="2026"/>
            <ac:picMk id="79" creationId="{C2B4206E-A957-D76A-43B9-94822373156C}"/>
          </ac:picMkLst>
        </pc:picChg>
        <pc:picChg chg="add mod">
          <ac:chgData name="Jun Ge" userId="b8e2f334ff6b24d1" providerId="LiveId" clId="{0D82ED02-7E44-4D90-AA80-85DAE28EF6E0}" dt="2025-05-10T01:08:45.204" v="1103" actId="12788"/>
          <ac:picMkLst>
            <pc:docMk/>
            <pc:sldMk cId="1714582132" sldId="2026"/>
            <ac:picMk id="81" creationId="{88B906A1-441C-3365-FC69-31A088910736}"/>
          </ac:picMkLst>
        </pc:picChg>
        <pc:cxnChg chg="add mod">
          <ac:chgData name="Jun Ge" userId="b8e2f334ff6b24d1" providerId="LiveId" clId="{0D82ED02-7E44-4D90-AA80-85DAE28EF6E0}" dt="2025-05-10T01:08:57.436" v="1107" actId="1037"/>
          <ac:cxnSpMkLst>
            <pc:docMk/>
            <pc:sldMk cId="1714582132" sldId="2026"/>
            <ac:cxnSpMk id="39" creationId="{42A6D118-BB32-1981-17A7-8A12DA7A0F30}"/>
          </ac:cxnSpMkLst>
        </pc:cxnChg>
        <pc:cxnChg chg="add mod">
          <ac:chgData name="Jun Ge" userId="b8e2f334ff6b24d1" providerId="LiveId" clId="{0D82ED02-7E44-4D90-AA80-85DAE28EF6E0}" dt="2025-05-10T01:08:57.436" v="1107" actId="1037"/>
          <ac:cxnSpMkLst>
            <pc:docMk/>
            <pc:sldMk cId="1714582132" sldId="2026"/>
            <ac:cxnSpMk id="68" creationId="{CD53E481-EEF2-28E9-74E7-2C17AA73C81F}"/>
          </ac:cxnSpMkLst>
        </pc:cxnChg>
      </pc:sldChg>
      <pc:sldChg chg="addSp delSp modSp new del mod">
        <pc:chgData name="Jun Ge" userId="b8e2f334ff6b24d1" providerId="LiveId" clId="{0D82ED02-7E44-4D90-AA80-85DAE28EF6E0}" dt="2025-05-10T01:11:21.564" v="1134" actId="47"/>
        <pc:sldMkLst>
          <pc:docMk/>
          <pc:sldMk cId="2498002261" sldId="2027"/>
        </pc:sldMkLst>
      </pc:sldChg>
      <pc:sldChg chg="del">
        <pc:chgData name="Jun Ge" userId="b8e2f334ff6b24d1" providerId="LiveId" clId="{0D82ED02-7E44-4D90-AA80-85DAE28EF6E0}" dt="2025-05-13T07:02:32.253" v="2375" actId="47"/>
        <pc:sldMkLst>
          <pc:docMk/>
          <pc:sldMk cId="3785711134" sldId="2027"/>
        </pc:sldMkLst>
      </pc:sldChg>
      <pc:sldChg chg="modSp mod">
        <pc:chgData name="Jun Ge" userId="b8e2f334ff6b24d1" providerId="LiveId" clId="{0D82ED02-7E44-4D90-AA80-85DAE28EF6E0}" dt="2025-05-13T09:30:27.176" v="2434" actId="255"/>
        <pc:sldMkLst>
          <pc:docMk/>
          <pc:sldMk cId="2250533917" sldId="2028"/>
        </pc:sldMkLst>
        <pc:spChg chg="mod">
          <ac:chgData name="Jun Ge" userId="b8e2f334ff6b24d1" providerId="LiveId" clId="{0D82ED02-7E44-4D90-AA80-85DAE28EF6E0}" dt="2025-05-13T09:30:27.176" v="2434" actId="255"/>
          <ac:spMkLst>
            <pc:docMk/>
            <pc:sldMk cId="2250533917" sldId="2028"/>
            <ac:spMk id="2" creationId="{0F3B34B3-6A36-9677-5340-FBFF722798A9}"/>
          </ac:spMkLst>
        </pc:spChg>
      </pc:sldChg>
      <pc:sldChg chg="addSp delSp modSp new del mod">
        <pc:chgData name="Jun Ge" userId="b8e2f334ff6b24d1" providerId="LiveId" clId="{0D82ED02-7E44-4D90-AA80-85DAE28EF6E0}" dt="2025-05-13T07:02:33.482" v="2376" actId="47"/>
        <pc:sldMkLst>
          <pc:docMk/>
          <pc:sldMk cId="993524414" sldId="2029"/>
        </pc:sldMkLst>
      </pc:sldChg>
    </pc:docChg>
  </pc:docChgLst>
  <pc:docChgLst>
    <pc:chgData name="Jun Ge" userId="b8e2f334ff6b24d1" providerId="LiveId" clId="{C43AB18E-16A3-4074-98CE-74F3D438E944}"/>
    <pc:docChg chg="undo custSel addSld modSld modMainMaster modNotesMaster">
      <pc:chgData name="Jun Ge" userId="b8e2f334ff6b24d1" providerId="LiveId" clId="{C43AB18E-16A3-4074-98CE-74F3D438E944}" dt="2025-05-12T11:50:36.281" v="1317" actId="1035"/>
      <pc:docMkLst>
        <pc:docMk/>
      </pc:docMkLst>
      <pc:sldChg chg="modSp mod">
        <pc:chgData name="Jun Ge" userId="b8e2f334ff6b24d1" providerId="LiveId" clId="{C43AB18E-16A3-4074-98CE-74F3D438E944}" dt="2025-05-12T11:48:46.210" v="1265" actId="2710"/>
        <pc:sldMkLst>
          <pc:docMk/>
          <pc:sldMk cId="27041322" sldId="1998"/>
        </pc:sldMkLst>
        <pc:spChg chg="mod">
          <ac:chgData name="Jun Ge" userId="b8e2f334ff6b24d1" providerId="LiveId" clId="{C43AB18E-16A3-4074-98CE-74F3D438E944}" dt="2025-05-12T11:48:46.210" v="1265" actId="2710"/>
          <ac:spMkLst>
            <pc:docMk/>
            <pc:sldMk cId="27041322" sldId="1998"/>
            <ac:spMk id="4" creationId="{A1CA2BD4-D252-654F-BB3B-46156A64F2D3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5" creationId="{AA0F7AB3-3D0E-C714-4605-D7DB7A0682D9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6" creationId="{A8B5F1E6-390D-9891-F022-49650288C61D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8" creationId="{68E91C1B-7BE1-4321-4AE6-A79FA583124E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10" creationId="{BAC8779B-C1C2-C8F8-F150-C6B59098023F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7041322" sldId="1998"/>
            <ac:spMk id="11" creationId="{61C8AD14-E0FB-D968-6202-DA32F0B96607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13" creationId="{27F27D76-FE6D-D2C6-CEAE-D28DFE44D142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16" creationId="{179730D8-AC89-E78F-2A07-843116FDE7AE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17" creationId="{30B113A1-C556-0A1F-B3B1-DC1C9C3F0092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20" creationId="{1FC403F7-3899-3753-4E1B-CDCB6D79EE78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21" creationId="{5879D0B7-788E-51AC-CEC3-70AF414E8308}"/>
          </ac:spMkLst>
        </pc:spChg>
        <pc:spChg chg="mod">
          <ac:chgData name="Jun Ge" userId="b8e2f334ff6b24d1" providerId="LiveId" clId="{C43AB18E-16A3-4074-98CE-74F3D438E944}" dt="2025-05-07T16:13:22.937" v="307" actId="404"/>
          <ac:spMkLst>
            <pc:docMk/>
            <pc:sldMk cId="27041322" sldId="1998"/>
            <ac:spMk id="22" creationId="{031C0CE9-4348-D10D-8F5D-6656662D0CFB}"/>
          </ac:spMkLst>
        </pc:spChg>
        <pc:grpChg chg="mod">
          <ac:chgData name="Jun Ge" userId="b8e2f334ff6b24d1" providerId="LiveId" clId="{C43AB18E-16A3-4074-98CE-74F3D438E944}" dt="2025-05-10T03:11:47.967" v="689" actId="1037"/>
          <ac:grpSpMkLst>
            <pc:docMk/>
            <pc:sldMk cId="27041322" sldId="1998"/>
            <ac:grpSpMk id="23" creationId="{60F03238-C980-184C-4620-428CC846A53B}"/>
          </ac:grpSpMkLst>
        </pc:grpChg>
      </pc:sldChg>
      <pc:sldChg chg="modSp mod">
        <pc:chgData name="Jun Ge" userId="b8e2f334ff6b24d1" providerId="LiveId" clId="{C43AB18E-16A3-4074-98CE-74F3D438E944}" dt="2025-05-11T15:24:22.392" v="701" actId="255"/>
        <pc:sldMkLst>
          <pc:docMk/>
          <pc:sldMk cId="3540714721" sldId="2000"/>
        </pc:sldMkLst>
        <pc:spChg chg="mod">
          <ac:chgData name="Jun Ge" userId="b8e2f334ff6b24d1" providerId="LiveId" clId="{C43AB18E-16A3-4074-98CE-74F3D438E944}" dt="2025-05-11T15:24:22.392" v="701" actId="255"/>
          <ac:spMkLst>
            <pc:docMk/>
            <pc:sldMk cId="3540714721" sldId="2000"/>
            <ac:spMk id="2" creationId="{12579D72-C2F3-2410-4C4D-4CFB43ED32A6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6" creationId="{605CD3A3-E61B-4319-9ADF-2E1C6ABF59DD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8" creationId="{C7512B90-F3AC-867C-66BA-3ADEA5257219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9" creationId="{E8D8E224-A05E-8CFD-F209-8874C4845769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10" creationId="{7F2C2C2A-C34E-278E-710D-CA0C671D50E5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11" creationId="{AF8BE2A4-CD1C-EBB1-A52A-C97A2A3DDADE}"/>
          </ac:spMkLst>
        </pc:spChg>
        <pc:spChg chg="mod">
          <ac:chgData name="Jun Ge" userId="b8e2f334ff6b24d1" providerId="LiveId" clId="{C43AB18E-16A3-4074-98CE-74F3D438E944}" dt="2025-05-07T16:26:39.480" v="625" actId="255"/>
          <ac:spMkLst>
            <pc:docMk/>
            <pc:sldMk cId="3540714721" sldId="2000"/>
            <ac:spMk id="12" creationId="{BC0B45F1-E5FB-9192-4EC5-1FC28B4A7E2E}"/>
          </ac:spMkLst>
        </pc:spChg>
        <pc:spChg chg="mod">
          <ac:chgData name="Jun Ge" userId="b8e2f334ff6b24d1" providerId="LiveId" clId="{C43AB18E-16A3-4074-98CE-74F3D438E944}" dt="2025-05-07T16:27:01.623" v="643" actId="403"/>
          <ac:spMkLst>
            <pc:docMk/>
            <pc:sldMk cId="3540714721" sldId="2000"/>
            <ac:spMk id="13" creationId="{8ACDE1A8-6181-29B5-0278-8804384EC2BC}"/>
          </ac:spMkLst>
        </pc:spChg>
        <pc:spChg chg="mod">
          <ac:chgData name="Jun Ge" userId="b8e2f334ff6b24d1" providerId="LiveId" clId="{C43AB18E-16A3-4074-98CE-74F3D438E944}" dt="2025-05-07T16:27:01.623" v="643" actId="403"/>
          <ac:spMkLst>
            <pc:docMk/>
            <pc:sldMk cId="3540714721" sldId="2000"/>
            <ac:spMk id="14" creationId="{8B1AD08E-0425-5C96-654A-DB475A29349D}"/>
          </ac:spMkLst>
        </pc:spChg>
        <pc:spChg chg="mod">
          <ac:chgData name="Jun Ge" userId="b8e2f334ff6b24d1" providerId="LiveId" clId="{C43AB18E-16A3-4074-98CE-74F3D438E944}" dt="2025-05-07T16:27:01.623" v="643" actId="403"/>
          <ac:spMkLst>
            <pc:docMk/>
            <pc:sldMk cId="3540714721" sldId="2000"/>
            <ac:spMk id="15" creationId="{32AEFE3A-E702-BB9D-8B0A-C1EF1DA17C92}"/>
          </ac:spMkLst>
        </pc:spChg>
        <pc:grpChg chg="mod">
          <ac:chgData name="Jun Ge" userId="b8e2f334ff6b24d1" providerId="LiveId" clId="{C43AB18E-16A3-4074-98CE-74F3D438E944}" dt="2025-05-07T16:27:51.452" v="674" actId="14100"/>
          <ac:grpSpMkLst>
            <pc:docMk/>
            <pc:sldMk cId="3540714721" sldId="2000"/>
            <ac:grpSpMk id="33" creationId="{061FAB31-3008-DE9A-40E2-246A8E0F3249}"/>
          </ac:grpSpMkLst>
        </pc:grpChg>
        <pc:cxnChg chg="mod">
          <ac:chgData name="Jun Ge" userId="b8e2f334ff6b24d1" providerId="LiveId" clId="{C43AB18E-16A3-4074-98CE-74F3D438E944}" dt="2025-05-07T16:27:41.524" v="673" actId="1035"/>
          <ac:cxnSpMkLst>
            <pc:docMk/>
            <pc:sldMk cId="3540714721" sldId="2000"/>
            <ac:cxnSpMk id="4" creationId="{A5B565D6-CD70-4249-7FD0-C13EF567F9DA}"/>
          </ac:cxnSpMkLst>
        </pc:cxnChg>
        <pc:cxnChg chg="mod">
          <ac:chgData name="Jun Ge" userId="b8e2f334ff6b24d1" providerId="LiveId" clId="{C43AB18E-16A3-4074-98CE-74F3D438E944}" dt="2025-05-07T16:27:15.746" v="644" actId="1582"/>
          <ac:cxnSpMkLst>
            <pc:docMk/>
            <pc:sldMk cId="3540714721" sldId="2000"/>
            <ac:cxnSpMk id="18" creationId="{235C73CD-3336-1B4D-A7B3-FE39A61190E4}"/>
          </ac:cxnSpMkLst>
        </pc:cxnChg>
        <pc:cxnChg chg="mod">
          <ac:chgData name="Jun Ge" userId="b8e2f334ff6b24d1" providerId="LiveId" clId="{C43AB18E-16A3-4074-98CE-74F3D438E944}" dt="2025-05-07T16:27:15.746" v="644" actId="1582"/>
          <ac:cxnSpMkLst>
            <pc:docMk/>
            <pc:sldMk cId="3540714721" sldId="2000"/>
            <ac:cxnSpMk id="20" creationId="{C9E7ABC3-AD74-681B-E573-B5680298DC2D}"/>
          </ac:cxnSpMkLst>
        </pc:cxnChg>
        <pc:cxnChg chg="mod">
          <ac:chgData name="Jun Ge" userId="b8e2f334ff6b24d1" providerId="LiveId" clId="{C43AB18E-16A3-4074-98CE-74F3D438E944}" dt="2025-05-07T16:27:15.746" v="644" actId="1582"/>
          <ac:cxnSpMkLst>
            <pc:docMk/>
            <pc:sldMk cId="3540714721" sldId="2000"/>
            <ac:cxnSpMk id="23" creationId="{35C5192C-661F-60A5-22F3-873AFC4DDBFD}"/>
          </ac:cxnSpMkLst>
        </pc:cxnChg>
        <pc:cxnChg chg="mod">
          <ac:chgData name="Jun Ge" userId="b8e2f334ff6b24d1" providerId="LiveId" clId="{C43AB18E-16A3-4074-98CE-74F3D438E944}" dt="2025-05-07T16:27:15.746" v="644" actId="1582"/>
          <ac:cxnSpMkLst>
            <pc:docMk/>
            <pc:sldMk cId="3540714721" sldId="2000"/>
            <ac:cxnSpMk id="25" creationId="{B974221A-2386-4835-452D-F6B95A6FAD7D}"/>
          </ac:cxnSpMkLst>
        </pc:cxnChg>
        <pc:cxnChg chg="mod">
          <ac:chgData name="Jun Ge" userId="b8e2f334ff6b24d1" providerId="LiveId" clId="{C43AB18E-16A3-4074-98CE-74F3D438E944}" dt="2025-05-07T16:27:15.746" v="644" actId="1582"/>
          <ac:cxnSpMkLst>
            <pc:docMk/>
            <pc:sldMk cId="3540714721" sldId="2000"/>
            <ac:cxnSpMk id="28" creationId="{3A9D2AB0-15FB-47CC-EE92-9594FABB7DC7}"/>
          </ac:cxnSpMkLst>
        </pc:cxnChg>
      </pc:sldChg>
      <pc:sldChg chg="modSp mod">
        <pc:chgData name="Jun Ge" userId="b8e2f334ff6b24d1" providerId="LiveId" clId="{C43AB18E-16A3-4074-98CE-74F3D438E944}" dt="2025-05-12T11:50:15.708" v="1302" actId="1035"/>
        <pc:sldMkLst>
          <pc:docMk/>
          <pc:sldMk cId="2645669267" sldId="2004"/>
        </pc:sldMkLst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14" creationId="{C2118672-3F23-C03C-00C8-3B3664CA5C42}"/>
          </ac:spMkLst>
        </pc:spChg>
        <pc:spChg chg="mod">
          <ac:chgData name="Jun Ge" userId="b8e2f334ff6b24d1" providerId="LiveId" clId="{C43AB18E-16A3-4074-98CE-74F3D438E944}" dt="2025-05-12T11:50:15.708" v="1302" actId="1035"/>
          <ac:spMkLst>
            <pc:docMk/>
            <pc:sldMk cId="2645669267" sldId="2004"/>
            <ac:spMk id="21" creationId="{3E17923C-6528-88A8-14E7-E5F054F6F19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84" creationId="{29C04F4B-5BF9-6E69-66BC-3A5EF828A9C9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87" creationId="{218236ED-A403-9C5F-2C34-957FBB6D6F19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93" creationId="{0D8C0D5D-7116-8E87-C15B-CC3561D6DC05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96" creationId="{C20B7EAA-80E8-55F4-BF70-AD92FC228800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100" creationId="{E1B09A4E-DBE1-946C-2DA5-0A29B5C4E52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102" creationId="{31570DDA-B008-2A62-4E7B-478CCC5581D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103" creationId="{AD73CBDE-1BAF-B19D-11B6-16A36572F2D1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645669267" sldId="2004"/>
            <ac:spMk id="106" creationId="{E50ACE19-4D64-843C-C27F-78C7198D0E55}"/>
          </ac:spMkLst>
        </pc:spChg>
      </pc:sldChg>
      <pc:sldChg chg="modSp mod">
        <pc:chgData name="Jun Ge" userId="b8e2f334ff6b24d1" providerId="LiveId" clId="{C43AB18E-16A3-4074-98CE-74F3D438E944}" dt="2025-05-12T11:50:00.894" v="1291" actId="2710"/>
        <pc:sldMkLst>
          <pc:docMk/>
          <pc:sldMk cId="1997357976" sldId="2005"/>
        </pc:sldMkLst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4" creationId="{C5BD7561-E74E-09CA-2911-5DBD22E99F4E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6" creationId="{43A83290-04E1-CAB7-F49B-5C4042FD8339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7" creationId="{4E9D0195-194E-B1D8-179F-EC12E72E25A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10" creationId="{08F20DC8-989A-4685-5B97-3DF0F7AB6EC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11" creationId="{5AEF9C79-ADB5-2C9A-F4D1-E3C9D1886D8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14" creationId="{EA33387F-B3FE-5E82-6E65-6C8877FEED41}"/>
          </ac:spMkLst>
        </pc:spChg>
        <pc:spChg chg="mod">
          <ac:chgData name="Jun Ge" userId="b8e2f334ff6b24d1" providerId="LiveId" clId="{C43AB18E-16A3-4074-98CE-74F3D438E944}" dt="2025-05-12T11:50:00.894" v="1291" actId="2710"/>
          <ac:spMkLst>
            <pc:docMk/>
            <pc:sldMk cId="1997357976" sldId="2005"/>
            <ac:spMk id="16" creationId="{7E7742CD-2B28-CFC8-E9D3-A831EFD23A85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17" creationId="{06721ABE-DB95-D2E1-F1B3-C6A7C7901F0C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20" creationId="{4B5D7921-1E24-B265-29DA-B488432B16F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997357976" sldId="2005"/>
            <ac:spMk id="27" creationId="{759E0D2A-AA1C-7012-68FA-A1AD8ED97476}"/>
          </ac:spMkLst>
        </pc:spChg>
        <pc:grpChg chg="mod">
          <ac:chgData name="Jun Ge" userId="b8e2f334ff6b24d1" providerId="LiveId" clId="{C43AB18E-16A3-4074-98CE-74F3D438E944}" dt="2025-05-07T16:16:05.860" v="345" actId="1076"/>
          <ac:grpSpMkLst>
            <pc:docMk/>
            <pc:sldMk cId="1997357976" sldId="2005"/>
            <ac:grpSpMk id="50" creationId="{1085BC55-2191-D32C-151D-D2CA0EF0BA68}"/>
          </ac:grpSpMkLst>
        </pc:grpChg>
      </pc:sldChg>
      <pc:sldChg chg="modSp mod modNotes">
        <pc:chgData name="Jun Ge" userId="b8e2f334ff6b24d1" providerId="LiveId" clId="{C43AB18E-16A3-4074-98CE-74F3D438E944}" dt="2025-05-12T11:39:49.397" v="1083" actId="1035"/>
        <pc:sldMkLst>
          <pc:docMk/>
          <pc:sldMk cId="2950916666" sldId="2007"/>
        </pc:sldMkLst>
        <pc:spChg chg="mod">
          <ac:chgData name="Jun Ge" userId="b8e2f334ff6b24d1" providerId="LiveId" clId="{C43AB18E-16A3-4074-98CE-74F3D438E944}" dt="2025-05-12T11:39:49.397" v="1083" actId="1035"/>
          <ac:spMkLst>
            <pc:docMk/>
            <pc:sldMk cId="2950916666" sldId="2007"/>
            <ac:spMk id="10" creationId="{BF0F2345-9415-21C9-E045-24D5A13E0A98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35" creationId="{ABC1E357-BC68-2984-10E9-1F86962BE05A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36" creationId="{BF7FC62D-0DA3-3A21-89E9-F59D1E826099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63" creationId="{8852B8D5-CBA2-C20E-31D2-90ACD6C151C2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70" creationId="{4DA9A1AB-BA30-AB1F-6FC5-F022111AB88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71" creationId="{488CA966-5582-11C8-467B-E54600D221E4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74" creationId="{E1F6A4A5-5A95-8C87-609F-5F1322CF77A4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75" creationId="{BC64C1CC-C7CA-9EE2-27B7-F264BD15D438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77" creationId="{A7BD6F0F-A41D-6304-EDC4-5235D329FC45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82" creationId="{20BE4FD8-C771-82C2-66E5-B30CBE6C779D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2950916666" sldId="2007"/>
            <ac:spMk id="84" creationId="{69E171E6-087D-2414-9F35-4BC8C2FD7661}"/>
          </ac:spMkLst>
        </pc:spChg>
        <pc:grpChg chg="mod">
          <ac:chgData name="Jun Ge" userId="b8e2f334ff6b24d1" providerId="LiveId" clId="{C43AB18E-16A3-4074-98CE-74F3D438E944}" dt="2025-05-12T11:39:46.856" v="1082" actId="1035"/>
          <ac:grpSpMkLst>
            <pc:docMk/>
            <pc:sldMk cId="2950916666" sldId="2007"/>
            <ac:grpSpMk id="27" creationId="{5436E9EA-29D5-7BA4-5F17-E2BA7FED86DD}"/>
          </ac:grpSpMkLst>
        </pc:grpChg>
      </pc:sldChg>
      <pc:sldChg chg="addSp delSp modSp mod">
        <pc:chgData name="Jun Ge" userId="b8e2f334ff6b24d1" providerId="LiveId" clId="{C43AB18E-16A3-4074-98CE-74F3D438E944}" dt="2025-05-12T11:50:36.281" v="1317" actId="1035"/>
        <pc:sldMkLst>
          <pc:docMk/>
          <pc:sldMk cId="3613101676" sldId="2008"/>
        </pc:sldMkLst>
        <pc:spChg chg="mod">
          <ac:chgData name="Jun Ge" userId="b8e2f334ff6b24d1" providerId="LiveId" clId="{C43AB18E-16A3-4074-98CE-74F3D438E944}" dt="2025-05-12T11:50:36.281" v="1317" actId="1035"/>
          <ac:spMkLst>
            <pc:docMk/>
            <pc:sldMk cId="3613101676" sldId="2008"/>
            <ac:spMk id="12" creationId="{20E29743-C3CF-318D-42F2-7B206212A56E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40" creationId="{CD1D83C4-4969-4B87-B4C5-47CE7F75B28A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42" creationId="{A7CD4B46-67B2-E346-A2AD-6ABC4B26704F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43" creationId="{ED8E62EB-85A3-2B6E-AEA2-5512F8D7EEF2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46" creationId="{AC9ACEDD-4618-6086-EBC8-8C85971E0EF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47" creationId="{56470F29-E0C1-90ED-BEFB-BD74309907F8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51" creationId="{AA162EBF-9EE9-0B4A-E557-09CBC32B792C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52" creationId="{7129C280-4355-61D5-BD49-48F5E4F44AA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53" creationId="{17A5746F-23EA-87FE-B1D1-ED53379875DE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55" creationId="{6F41EE58-C38E-E2A4-2D3D-0CB37BFF0ABD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56" creationId="{AB265FD9-9DC9-90F0-F2E3-C10BA77C7CFB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57" creationId="{6C499BF0-3B5F-738A-0172-1775040EC71B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61" creationId="{13621A7C-3D05-0AB4-67C8-B24BB163AB1D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13101676" sldId="2008"/>
            <ac:spMk id="64" creationId="{61EA8552-BE8E-9648-4076-0977138B61EC}"/>
          </ac:spMkLst>
        </pc:spChg>
        <pc:spChg chg="mod topLvl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71" creationId="{11FBF21F-E3F1-9164-459E-CA28AAF2071F}"/>
          </ac:spMkLst>
        </pc:spChg>
        <pc:spChg chg="mod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72" creationId="{8D274D0D-3AEB-5C2E-BE75-D981F52815F1}"/>
          </ac:spMkLst>
        </pc:spChg>
        <pc:spChg chg="mod">
          <ac:chgData name="Jun Ge" userId="b8e2f334ff6b24d1" providerId="LiveId" clId="{C43AB18E-16A3-4074-98CE-74F3D438E944}" dt="2025-05-07T16:21:02.961" v="420" actId="165"/>
          <ac:spMkLst>
            <pc:docMk/>
            <pc:sldMk cId="3613101676" sldId="2008"/>
            <ac:spMk id="74" creationId="{E46B9B09-BA66-F0AB-4F85-F556C104C6A4}"/>
          </ac:spMkLst>
        </pc:spChg>
        <pc:spChg chg="mod topLvl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79" creationId="{8CD9A29A-3069-6DA1-1628-FE0DCEB6B815}"/>
          </ac:spMkLst>
        </pc:spChg>
        <pc:spChg chg="mod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80" creationId="{2B167E9F-0438-E350-D76A-0615C9D64CF0}"/>
          </ac:spMkLst>
        </pc:spChg>
        <pc:spChg chg="mod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81" creationId="{053A79B3-F8EE-CD09-D942-7DB88967C012}"/>
          </ac:spMkLst>
        </pc:spChg>
        <pc:spChg chg="mod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82" creationId="{72E61E01-6609-CB7A-CCA7-FC5F58AB7640}"/>
          </ac:spMkLst>
        </pc:spChg>
        <pc:spChg chg="mod">
          <ac:chgData name="Jun Ge" userId="b8e2f334ff6b24d1" providerId="LiveId" clId="{C43AB18E-16A3-4074-98CE-74F3D438E944}" dt="2025-05-07T16:22:17.889" v="540" actId="164"/>
          <ac:spMkLst>
            <pc:docMk/>
            <pc:sldMk cId="3613101676" sldId="2008"/>
            <ac:spMk id="83" creationId="{B9C59564-F675-9FA4-58CE-6E0C6C9AECC1}"/>
          </ac:spMkLst>
        </pc:spChg>
        <pc:grpChg chg="mod">
          <ac:chgData name="Jun Ge" userId="b8e2f334ff6b24d1" providerId="LiveId" clId="{C43AB18E-16A3-4074-98CE-74F3D438E944}" dt="2025-05-12T11:50:34.325" v="1316" actId="1036"/>
          <ac:grpSpMkLst>
            <pc:docMk/>
            <pc:sldMk cId="3613101676" sldId="2008"/>
            <ac:grpSpMk id="2" creationId="{0278F5C0-0722-7A20-A250-4084BAE0F3EB}"/>
          </ac:grpSpMkLst>
        </pc:grpChg>
        <pc:grpChg chg="mod">
          <ac:chgData name="Jun Ge" userId="b8e2f334ff6b24d1" providerId="LiveId" clId="{C43AB18E-16A3-4074-98CE-74F3D438E944}" dt="2025-05-07T16:20:15.189" v="400" actId="1076"/>
          <ac:grpSpMkLst>
            <pc:docMk/>
            <pc:sldMk cId="3613101676" sldId="2008"/>
            <ac:grpSpMk id="3" creationId="{30F64282-03F5-36A6-7395-B5C98519DFEE}"/>
          </ac:grpSpMkLst>
        </pc:grpChg>
        <pc:grpChg chg="mod">
          <ac:chgData name="Jun Ge" userId="b8e2f334ff6b24d1" providerId="LiveId" clId="{C43AB18E-16A3-4074-98CE-74F3D438E944}" dt="2025-05-07T16:22:17.889" v="540" actId="164"/>
          <ac:grpSpMkLst>
            <pc:docMk/>
            <pc:sldMk cId="3613101676" sldId="2008"/>
            <ac:grpSpMk id="4" creationId="{82059345-0548-51B4-1362-80CF3931E991}"/>
          </ac:grpSpMkLst>
        </pc:grpChg>
        <pc:grpChg chg="mod">
          <ac:chgData name="Jun Ge" userId="b8e2f334ff6b24d1" providerId="LiveId" clId="{C43AB18E-16A3-4074-98CE-74F3D438E944}" dt="2025-05-07T16:21:25.138" v="447" actId="1038"/>
          <ac:grpSpMkLst>
            <pc:docMk/>
            <pc:sldMk cId="3613101676" sldId="2008"/>
            <ac:grpSpMk id="5" creationId="{7009E736-FD6E-C9DE-59AC-3E22216400D7}"/>
          </ac:grpSpMkLst>
        </pc:grpChg>
        <pc:grpChg chg="mod">
          <ac:chgData name="Jun Ge" userId="b8e2f334ff6b24d1" providerId="LiveId" clId="{C43AB18E-16A3-4074-98CE-74F3D438E944}" dt="2025-05-07T16:21:55.692" v="511" actId="1036"/>
          <ac:grpSpMkLst>
            <pc:docMk/>
            <pc:sldMk cId="3613101676" sldId="2008"/>
            <ac:grpSpMk id="6" creationId="{3A2049D3-3E97-18A7-562F-979BE921450C}"/>
          </ac:grpSpMkLst>
        </pc:grpChg>
        <pc:grpChg chg="mod">
          <ac:chgData name="Jun Ge" userId="b8e2f334ff6b24d1" providerId="LiveId" clId="{C43AB18E-16A3-4074-98CE-74F3D438E944}" dt="2025-05-07T16:21:55.692" v="511" actId="1036"/>
          <ac:grpSpMkLst>
            <pc:docMk/>
            <pc:sldMk cId="3613101676" sldId="2008"/>
            <ac:grpSpMk id="7" creationId="{26B97364-F3C1-7806-185C-6DBBE35AEAB1}"/>
          </ac:grpSpMkLst>
        </pc:grpChg>
        <pc:grpChg chg="mod">
          <ac:chgData name="Jun Ge" userId="b8e2f334ff6b24d1" providerId="LiveId" clId="{C43AB18E-16A3-4074-98CE-74F3D438E944}" dt="2025-05-07T16:22:17.889" v="540" actId="164"/>
          <ac:grpSpMkLst>
            <pc:docMk/>
            <pc:sldMk cId="3613101676" sldId="2008"/>
            <ac:grpSpMk id="8" creationId="{DB6A0B16-C9C2-18E3-8268-AA9C195C36B4}"/>
          </ac:grpSpMkLst>
        </pc:grpChg>
        <pc:grpChg chg="mod">
          <ac:chgData name="Jun Ge" userId="b8e2f334ff6b24d1" providerId="LiveId" clId="{C43AB18E-16A3-4074-98CE-74F3D438E944}" dt="2025-05-07T16:22:17.889" v="540" actId="164"/>
          <ac:grpSpMkLst>
            <pc:docMk/>
            <pc:sldMk cId="3613101676" sldId="2008"/>
            <ac:grpSpMk id="9" creationId="{1117728C-3D2F-DFB9-9069-52B2A281D6D4}"/>
          </ac:grpSpMkLst>
        </pc:grpChg>
      </pc:sldChg>
      <pc:sldChg chg="addSp delSp modSp mod">
        <pc:chgData name="Jun Ge" userId="b8e2f334ff6b24d1" providerId="LiveId" clId="{C43AB18E-16A3-4074-98CE-74F3D438E944}" dt="2025-05-12T11:38:35.656" v="1043" actId="2710"/>
        <pc:sldMkLst>
          <pc:docMk/>
          <pc:sldMk cId="1294620802" sldId="2011"/>
        </pc:sldMkLst>
        <pc:spChg chg="mod">
          <ac:chgData name="Jun Ge" userId="b8e2f334ff6b24d1" providerId="LiveId" clId="{C43AB18E-16A3-4074-98CE-74F3D438E944}" dt="2025-05-12T11:38:35.656" v="1043" actId="2710"/>
          <ac:spMkLst>
            <pc:docMk/>
            <pc:sldMk cId="1294620802" sldId="2011"/>
            <ac:spMk id="4" creationId="{D950673E-A140-94AF-7077-3A50F58A780A}"/>
          </ac:spMkLst>
        </pc:spChg>
        <pc:spChg chg="mod topLvl">
          <ac:chgData name="Jun Ge" userId="b8e2f334ff6b24d1" providerId="LiveId" clId="{C43AB18E-16A3-4074-98CE-74F3D438E944}" dt="2025-05-07T16:25:44.717" v="617" actId="1037"/>
          <ac:spMkLst>
            <pc:docMk/>
            <pc:sldMk cId="1294620802" sldId="2011"/>
            <ac:spMk id="8" creationId="{F4D71C03-088C-67D7-2514-C2B96D44C258}"/>
          </ac:spMkLst>
        </pc:spChg>
        <pc:spChg chg="mod topLvl">
          <ac:chgData name="Jun Ge" userId="b8e2f334ff6b24d1" providerId="LiveId" clId="{C43AB18E-16A3-4074-98CE-74F3D438E944}" dt="2025-05-07T16:25:44.717" v="617" actId="1037"/>
          <ac:spMkLst>
            <pc:docMk/>
            <pc:sldMk cId="1294620802" sldId="2011"/>
            <ac:spMk id="10" creationId="{C07E77E7-1E9B-06EF-7F0C-8AEF68E90FAA}"/>
          </ac:spMkLst>
        </pc:spChg>
        <pc:spChg chg="mod">
          <ac:chgData name="Jun Ge" userId="b8e2f334ff6b24d1" providerId="LiveId" clId="{C43AB18E-16A3-4074-98CE-74F3D438E944}" dt="2025-05-07T16:25:06.510" v="582" actId="1076"/>
          <ac:spMkLst>
            <pc:docMk/>
            <pc:sldMk cId="1294620802" sldId="2011"/>
            <ac:spMk id="12" creationId="{3CF4A49F-904E-084A-0E50-FB7679168A65}"/>
          </ac:spMkLst>
        </pc:spChg>
        <pc:spChg chg="mod topLvl">
          <ac:chgData name="Jun Ge" userId="b8e2f334ff6b24d1" providerId="LiveId" clId="{C43AB18E-16A3-4074-98CE-74F3D438E944}" dt="2025-05-07T16:25:17.653" v="590" actId="164"/>
          <ac:spMkLst>
            <pc:docMk/>
            <pc:sldMk cId="1294620802" sldId="2011"/>
            <ac:spMk id="13" creationId="{91BF0159-9276-CE91-A27B-12F51A225BB5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14" creationId="{87DB7EF6-1ACB-FBC7-20EF-A55D843E5688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15" creationId="{98A7B034-11F1-01B2-7C0D-1BAA68B05AD5}"/>
          </ac:spMkLst>
        </pc:spChg>
        <pc:spChg chg="mod topLvl">
          <ac:chgData name="Jun Ge" userId="b8e2f334ff6b24d1" providerId="LiveId" clId="{C43AB18E-16A3-4074-98CE-74F3D438E944}" dt="2025-05-07T16:25:06.510" v="582" actId="1076"/>
          <ac:spMkLst>
            <pc:docMk/>
            <pc:sldMk cId="1294620802" sldId="2011"/>
            <ac:spMk id="16" creationId="{FAA7F2E5-41D6-DE39-213E-C3D155993272}"/>
          </ac:spMkLst>
        </pc:spChg>
        <pc:spChg chg="mod">
          <ac:chgData name="Jun Ge" userId="b8e2f334ff6b24d1" providerId="LiveId" clId="{C43AB18E-16A3-4074-98CE-74F3D438E944}" dt="2025-05-07T16:25:17.653" v="590" actId="164"/>
          <ac:spMkLst>
            <pc:docMk/>
            <pc:sldMk cId="1294620802" sldId="2011"/>
            <ac:spMk id="18" creationId="{97F0CFC0-02C0-18FA-D063-5F496A14C7D3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19" creationId="{E1D21721-4354-52A3-98E6-C5FEFB213373}"/>
          </ac:spMkLst>
        </pc:spChg>
        <pc:spChg chg="mod topLvl">
          <ac:chgData name="Jun Ge" userId="b8e2f334ff6b24d1" providerId="LiveId" clId="{C43AB18E-16A3-4074-98CE-74F3D438E944}" dt="2025-05-07T16:25:17.653" v="590" actId="164"/>
          <ac:spMkLst>
            <pc:docMk/>
            <pc:sldMk cId="1294620802" sldId="2011"/>
            <ac:spMk id="20" creationId="{C9A758BE-F44D-89C5-9FC1-00CBA9B2061F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21" creationId="{FBCF92E4-3B4F-3E42-3987-F1A2D8A098B7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22" creationId="{965C2BD8-C031-D2E6-52B6-44FD4BBF7DD8}"/>
          </ac:spMkLst>
        </pc:spChg>
        <pc:spChg chg="mod">
          <ac:chgData name="Jun Ge" userId="b8e2f334ff6b24d1" providerId="LiveId" clId="{C43AB18E-16A3-4074-98CE-74F3D438E944}" dt="2025-05-07T16:25:01.016" v="581" actId="1076"/>
          <ac:spMkLst>
            <pc:docMk/>
            <pc:sldMk cId="1294620802" sldId="2011"/>
            <ac:spMk id="33" creationId="{D084994C-A503-A232-863B-F9E380142224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34" creationId="{765742F3-0EA2-9DEF-E279-B81FEEBCFE78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35" creationId="{5C07B92E-5014-8477-C29A-580CD4F1430E}"/>
          </ac:spMkLst>
        </pc:spChg>
        <pc:spChg chg="mod topLvl">
          <ac:chgData name="Jun Ge" userId="b8e2f334ff6b24d1" providerId="LiveId" clId="{C43AB18E-16A3-4074-98CE-74F3D438E944}" dt="2025-05-07T16:25:19.365" v="591" actId="164"/>
          <ac:spMkLst>
            <pc:docMk/>
            <pc:sldMk cId="1294620802" sldId="2011"/>
            <ac:spMk id="36" creationId="{CEC784B1-5CD0-CC21-7BD3-31997B814EE4}"/>
          </ac:spMkLst>
        </pc:spChg>
        <pc:spChg chg="mod topLvl">
          <ac:chgData name="Jun Ge" userId="b8e2f334ff6b24d1" providerId="LiveId" clId="{C43AB18E-16A3-4074-98CE-74F3D438E944}" dt="2025-05-07T16:25:17.653" v="590" actId="164"/>
          <ac:spMkLst>
            <pc:docMk/>
            <pc:sldMk cId="1294620802" sldId="2011"/>
            <ac:spMk id="37" creationId="{0D6107DC-FBC8-7690-6817-70304D97862B}"/>
          </ac:spMkLst>
        </pc:spChg>
        <pc:spChg chg="mod">
          <ac:chgData name="Jun Ge" userId="b8e2f334ff6b24d1" providerId="LiveId" clId="{C43AB18E-16A3-4074-98CE-74F3D438E944}" dt="2025-05-07T16:25:01.016" v="581" actId="1076"/>
          <ac:spMkLst>
            <pc:docMk/>
            <pc:sldMk cId="1294620802" sldId="2011"/>
            <ac:spMk id="38" creationId="{65D1174A-7F01-FB72-D20F-E356B7E08332}"/>
          </ac:spMkLst>
        </pc:spChg>
        <pc:spChg chg="mod topLvl">
          <ac:chgData name="Jun Ge" userId="b8e2f334ff6b24d1" providerId="LiveId" clId="{C43AB18E-16A3-4074-98CE-74F3D438E944}" dt="2025-05-07T16:25:01.016" v="581" actId="1076"/>
          <ac:spMkLst>
            <pc:docMk/>
            <pc:sldMk cId="1294620802" sldId="2011"/>
            <ac:spMk id="39" creationId="{B8AAA289-B34E-EF24-7EE4-061F95E310E7}"/>
          </ac:spMkLst>
        </pc:spChg>
        <pc:spChg chg="mod">
          <ac:chgData name="Jun Ge" userId="b8e2f334ff6b24d1" providerId="LiveId" clId="{C43AB18E-16A3-4074-98CE-74F3D438E944}" dt="2025-05-07T16:25:01.016" v="581" actId="1076"/>
          <ac:spMkLst>
            <pc:docMk/>
            <pc:sldMk cId="1294620802" sldId="2011"/>
            <ac:spMk id="40" creationId="{856120BD-4A5C-4F39-4242-BE79A59B4E44}"/>
          </ac:spMkLst>
        </pc:spChg>
        <pc:spChg chg="mod topLvl">
          <ac:chgData name="Jun Ge" userId="b8e2f334ff6b24d1" providerId="LiveId" clId="{C43AB18E-16A3-4074-98CE-74F3D438E944}" dt="2025-05-07T16:25:17.653" v="590" actId="164"/>
          <ac:spMkLst>
            <pc:docMk/>
            <pc:sldMk cId="1294620802" sldId="2011"/>
            <ac:spMk id="41" creationId="{81B3484B-ADB2-01E2-F745-B62D1ABCB7E4}"/>
          </ac:spMkLst>
        </pc:spChg>
        <pc:spChg chg="mod topLvl">
          <ac:chgData name="Jun Ge" userId="b8e2f334ff6b24d1" providerId="LiveId" clId="{C43AB18E-16A3-4074-98CE-74F3D438E944}" dt="2025-05-07T16:25:01.016" v="581" actId="1076"/>
          <ac:spMkLst>
            <pc:docMk/>
            <pc:sldMk cId="1294620802" sldId="2011"/>
            <ac:spMk id="42" creationId="{2B45674B-B2A4-86FD-EE1B-BAC18602B732}"/>
          </ac:spMkLst>
        </pc:spChg>
        <pc:grpChg chg="mod">
          <ac:chgData name="Jun Ge" userId="b8e2f334ff6b24d1" providerId="LiveId" clId="{C43AB18E-16A3-4074-98CE-74F3D438E944}" dt="2025-05-07T16:25:52.553" v="620" actId="1076"/>
          <ac:grpSpMkLst>
            <pc:docMk/>
            <pc:sldMk cId="1294620802" sldId="2011"/>
            <ac:grpSpMk id="6" creationId="{DE8BCD0F-0090-9E05-C2A9-802DF3E0FCFB}"/>
          </ac:grpSpMkLst>
        </pc:grpChg>
      </pc:sldChg>
      <pc:sldChg chg="addSp delSp modSp mod">
        <pc:chgData name="Jun Ge" userId="b8e2f334ff6b24d1" providerId="LiveId" clId="{C43AB18E-16A3-4074-98CE-74F3D438E944}" dt="2025-05-12T11:39:30.768" v="1077" actId="255"/>
        <pc:sldMkLst>
          <pc:docMk/>
          <pc:sldMk cId="3927637345" sldId="2012"/>
        </pc:sldMkLst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2" creationId="{430BB8FA-1A6A-9BA7-6321-E4BC58578519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4" creationId="{A557BC3E-9863-203B-1557-E87CA9810746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6" creationId="{555C60E8-FB8B-6B70-7B29-1773D8A5BB99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8" creationId="{BCE8A75C-9116-03E6-B9D4-AF7B21E49966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10" creationId="{6BE1357B-6D99-C888-D6DD-5180C9F4816C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12" creationId="{2BE08D64-874A-DB89-65BF-2825A0860C04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14" creationId="{021021F0-ABE1-F18B-7D8F-6E2A157892C8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16" creationId="{86100581-9D0A-CBFB-160A-A1FEFA16329B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17" creationId="{CFC134D6-35B8-50F9-FA68-5E205BE075BF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23" creationId="{5B470E50-9D94-11B3-9DD2-9C4AD8EFAEA2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24" creationId="{B6030661-F39D-DFAA-C05B-EDA5BC40FA2A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25" creationId="{BCB7F137-F033-5ECC-7878-377F912DF301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26" creationId="{53D8E3FF-19CB-FDE9-E5D4-77E0DF6BD155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28" creationId="{26FCB5A6-077D-C56E-DA31-CC628CCB31C5}"/>
          </ac:spMkLst>
        </pc:spChg>
        <pc:spChg chg="mod">
          <ac:chgData name="Jun Ge" userId="b8e2f334ff6b24d1" providerId="LiveId" clId="{C43AB18E-16A3-4074-98CE-74F3D438E944}" dt="2025-05-07T16:09:43.611" v="212" actId="1035"/>
          <ac:spMkLst>
            <pc:docMk/>
            <pc:sldMk cId="3927637345" sldId="2012"/>
            <ac:spMk id="29" creationId="{E424201E-04BE-DC27-43A6-41F621F05F97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30" creationId="{5DCD7342-3390-AD85-782F-6E6D1CAB6169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31" creationId="{5DD4E2F7-7CFC-1676-5617-794180260B21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32" creationId="{F658A455-1F42-1069-7576-61DEC34C4B49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33" creationId="{16DFF568-0A91-5491-1B3B-17DDE6BB3353}"/>
          </ac:spMkLst>
        </pc:spChg>
        <pc:spChg chg="mod">
          <ac:chgData name="Jun Ge" userId="b8e2f334ff6b24d1" providerId="LiveId" clId="{C43AB18E-16A3-4074-98CE-74F3D438E944}" dt="2025-05-12T11:39:30.768" v="1077" actId="255"/>
          <ac:spMkLst>
            <pc:docMk/>
            <pc:sldMk cId="3927637345" sldId="2012"/>
            <ac:spMk id="36" creationId="{8630C500-F622-1EE2-F2D1-EA0F091186DC}"/>
          </ac:spMkLst>
        </pc:spChg>
        <pc:spChg chg="mod">
          <ac:chgData name="Jun Ge" userId="b8e2f334ff6b24d1" providerId="LiveId" clId="{C43AB18E-16A3-4074-98CE-74F3D438E944}" dt="2025-05-07T16:09:34.442" v="207" actId="1035"/>
          <ac:spMkLst>
            <pc:docMk/>
            <pc:sldMk cId="3927637345" sldId="2012"/>
            <ac:spMk id="38" creationId="{CF8EF4B4-F902-60CF-98D8-FB79B7340E0A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39" creationId="{855C1EA0-33B4-CA17-5F9A-BC09AF77E79C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0" creationId="{B73E172A-0545-7260-6790-463B18B82C8F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1" creationId="{827E080A-B60E-86DD-D7F9-47A7990636E6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2" creationId="{62A3C473-0887-A04F-9351-6BC521D4AD8F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3" creationId="{0DB1E9D2-926D-CC42-0A7E-D1FA137B63D2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4" creationId="{12C6D543-CA92-E7D6-1554-3C09D2EB7319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5" creationId="{BC3CC0CF-A85A-576F-8DCB-6E04688A7298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6" creationId="{972D40E8-BB41-A941-5B44-8B9A945B8583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7" creationId="{35F73A9D-5A15-880E-AB0F-02AD79A548FD}"/>
          </ac:spMkLst>
        </pc:spChg>
        <pc:spChg chg="mod">
          <ac:chgData name="Jun Ge" userId="b8e2f334ff6b24d1" providerId="LiveId" clId="{C43AB18E-16A3-4074-98CE-74F3D438E944}" dt="2025-05-07T16:09:55.917" v="217" actId="1035"/>
          <ac:spMkLst>
            <pc:docMk/>
            <pc:sldMk cId="3927637345" sldId="2012"/>
            <ac:spMk id="48" creationId="{E3E753BF-41ED-145E-9A87-C6C4F08DAADC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49" creationId="{CCD4258F-A7FB-FFE0-9149-C6BF279DA7A1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0" creationId="{47DB6B0E-037A-052F-E01B-0BEB8A357A7C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1" creationId="{0E3CEB4D-4CDB-382C-D637-3967E4F6F7D5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2" creationId="{7E5D4F4B-FFFB-F734-B257-5A324060BC1B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3" creationId="{B8978AC7-EB02-735C-40C1-644CA9A0CD94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4" creationId="{8AD05BF0-1232-20C5-4936-9B29D45B935A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5" creationId="{BA483C3C-3648-6F8E-871A-BA1ECB5E94A9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6" creationId="{A58B506F-655B-08F9-7ABA-0B6CFF5E977D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7" creationId="{2BC61F1A-E349-AA11-F788-13294666C006}"/>
          </ac:spMkLst>
        </pc:spChg>
        <pc:spChg chg="mod">
          <ac:chgData name="Jun Ge" userId="b8e2f334ff6b24d1" providerId="LiveId" clId="{C43AB18E-16A3-4074-98CE-74F3D438E944}" dt="2025-05-07T16:10:12.195" v="227" actId="1035"/>
          <ac:spMkLst>
            <pc:docMk/>
            <pc:sldMk cId="3927637345" sldId="2012"/>
            <ac:spMk id="58" creationId="{D8D4A1E5-D34B-FD46-E68A-35634828EDBD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59" creationId="{9E09C334-EE1A-8C69-B3ED-CE85B2230994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0" creationId="{04722FDB-2539-59BF-E72A-EC3EB924F7F6}"/>
          </ac:spMkLst>
        </pc:spChg>
        <pc:spChg chg="mod">
          <ac:chgData name="Jun Ge" userId="b8e2f334ff6b24d1" providerId="LiveId" clId="{C43AB18E-16A3-4074-98CE-74F3D438E944}" dt="2025-05-07T16:10:27.802" v="243" actId="1035"/>
          <ac:spMkLst>
            <pc:docMk/>
            <pc:sldMk cId="3927637345" sldId="2012"/>
            <ac:spMk id="61" creationId="{B09EEDA8-E69A-37A0-C3DE-ED634BE6500E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2" creationId="{2A49CF05-ACC6-C961-A2E2-78C0FB8BA6C5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3" creationId="{04BE5671-D392-6D62-5B18-D89592217500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4" creationId="{7F6B4452-8AEF-35D7-7022-F182CD8E6E9E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5" creationId="{785C77AB-E557-438B-C030-80CDD14E3A5A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6" creationId="{6CAF84C9-B5BD-02D5-CB23-B1A8754FD38F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7" creationId="{B112C0A8-260F-EE1C-5BDF-356A95307530}"/>
          </ac:spMkLst>
        </pc:spChg>
        <pc:spChg chg="mod">
          <ac:chgData name="Jun Ge" userId="b8e2f334ff6b24d1" providerId="LiveId" clId="{C43AB18E-16A3-4074-98CE-74F3D438E944}" dt="2025-05-07T16:10:24.907" v="235" actId="1035"/>
          <ac:spMkLst>
            <pc:docMk/>
            <pc:sldMk cId="3927637345" sldId="2012"/>
            <ac:spMk id="68" creationId="{FAFAB273-C505-A922-7B2A-CEA596BBA7E1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69" creationId="{11BBB3E0-D893-8D8A-CDD9-00ACE31600C6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0" creationId="{1F588461-BA7C-281C-A7AD-68E8B3C36A35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1" creationId="{F868BED5-B59A-2C54-191D-50A14193566A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2" creationId="{FB944488-14FC-28BA-79A1-0435729145E4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3" creationId="{A85E63AA-2A4C-8E64-63B0-A76D9AA95C06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4" creationId="{EACB9913-30ED-3D58-5A79-9A5EDFDBD16C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5" creationId="{40407F44-EB2F-2AB1-3F96-FB647EEA5A17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6" creationId="{1ABB3339-5662-7A82-106B-EE4BF3D1F838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7" creationId="{14BC3C6F-6E16-0517-2BB4-F7E649E769D2}"/>
          </ac:spMkLst>
        </pc:spChg>
        <pc:spChg chg="mod">
          <ac:chgData name="Jun Ge" userId="b8e2f334ff6b24d1" providerId="LiveId" clId="{C43AB18E-16A3-4074-98CE-74F3D438E944}" dt="2025-05-07T16:10:57.905" v="270" actId="1035"/>
          <ac:spMkLst>
            <pc:docMk/>
            <pc:sldMk cId="3927637345" sldId="2012"/>
            <ac:spMk id="78" creationId="{D1980DE9-9219-D0F0-07ED-F35DAB7DF3D4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79" creationId="{772277CA-8D1D-0E01-03BC-80C4BA87E121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0" creationId="{270B439A-C1C5-2E94-3C4D-FBF53C6B3C7E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1" creationId="{CC03BC47-F4F2-AAE1-83A4-BFB00C20DA97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2" creationId="{EE714252-082A-003C-D208-FA77ADF90293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3" creationId="{E9FC7A53-F545-4F69-F629-916147259FEC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4" creationId="{6D57C24A-4A7B-1C2A-72F5-295792099164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5" creationId="{E868FE04-8257-3635-5B2B-4074912246A6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6" creationId="{58E4D728-54FB-E5ED-85F4-C7525EC0D3D6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7" creationId="{A3F9B586-C71B-2B17-C793-4723257BB25B}"/>
          </ac:spMkLst>
        </pc:spChg>
        <pc:spChg chg="mod">
          <ac:chgData name="Jun Ge" userId="b8e2f334ff6b24d1" providerId="LiveId" clId="{C43AB18E-16A3-4074-98CE-74F3D438E944}" dt="2025-05-07T16:10:41.067" v="256" actId="1035"/>
          <ac:spMkLst>
            <pc:docMk/>
            <pc:sldMk cId="3927637345" sldId="2012"/>
            <ac:spMk id="88" creationId="{F05F050F-FCAF-C4AB-436A-2E915E5F59FB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1" creationId="{666F45FB-308B-CFBE-280E-61E319A6B9AD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2" creationId="{B885AB24-3BFC-93B7-C5FB-0F1F0FFCCA55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3" creationId="{92656B68-661F-15D9-DEB5-4C98DACA4BBA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4" creationId="{5787BCB1-BBA0-0BE9-A0BE-CCDE07C85C06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5" creationId="{7B8E41CD-4772-EF79-F0E7-E6F2B0B23ED6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7" creationId="{D7007142-A09E-264E-B700-7F7B83BAE17A}"/>
          </ac:spMkLst>
        </pc:spChg>
        <pc:spChg chg="mod">
          <ac:chgData name="Jun Ge" userId="b8e2f334ff6b24d1" providerId="LiveId" clId="{C43AB18E-16A3-4074-98CE-74F3D438E944}" dt="2025-05-07T16:11:25.730" v="283" actId="164"/>
          <ac:spMkLst>
            <pc:docMk/>
            <pc:sldMk cId="3927637345" sldId="2012"/>
            <ac:spMk id="98" creationId="{0FC5B015-0B86-D2C8-2A02-415C895C5AFA}"/>
          </ac:spMkLst>
        </pc:spChg>
        <pc:grpChg chg="mod">
          <ac:chgData name="Jun Ge" userId="b8e2f334ff6b24d1" providerId="LiveId" clId="{C43AB18E-16A3-4074-98CE-74F3D438E944}" dt="2025-05-07T16:11:25.730" v="283" actId="164"/>
          <ac:grpSpMkLst>
            <pc:docMk/>
            <pc:sldMk cId="3927637345" sldId="2012"/>
            <ac:grpSpMk id="18" creationId="{66975222-9EE1-9F36-537F-AA77556044BF}"/>
          </ac:grpSpMkLst>
        </pc:grpChg>
        <pc:grpChg chg="mod">
          <ac:chgData name="Jun Ge" userId="b8e2f334ff6b24d1" providerId="LiveId" clId="{C43AB18E-16A3-4074-98CE-74F3D438E944}" dt="2025-05-07T16:11:25.730" v="283" actId="164"/>
          <ac:grpSpMkLst>
            <pc:docMk/>
            <pc:sldMk cId="3927637345" sldId="2012"/>
            <ac:grpSpMk id="19" creationId="{D66CBDD7-5B95-89A0-7752-69D26A03E1A8}"/>
          </ac:grpSpMkLst>
        </pc:grpChg>
        <pc:grpChg chg="mod">
          <ac:chgData name="Jun Ge" userId="b8e2f334ff6b24d1" providerId="LiveId" clId="{C43AB18E-16A3-4074-98CE-74F3D438E944}" dt="2025-05-07T16:11:04.530" v="274" actId="1036"/>
          <ac:grpSpMkLst>
            <pc:docMk/>
            <pc:sldMk cId="3927637345" sldId="2012"/>
            <ac:grpSpMk id="20" creationId="{326367EC-871C-1338-6478-920E33C47C81}"/>
          </ac:grpSpMkLst>
        </pc:grpChg>
        <pc:grpChg chg="mod">
          <ac:chgData name="Jun Ge" userId="b8e2f334ff6b24d1" providerId="LiveId" clId="{C43AB18E-16A3-4074-98CE-74F3D438E944}" dt="2025-05-07T16:09:02.535" v="196" actId="1037"/>
          <ac:grpSpMkLst>
            <pc:docMk/>
            <pc:sldMk cId="3927637345" sldId="2012"/>
            <ac:grpSpMk id="22" creationId="{1A79EDB4-A6C4-4AFE-C580-59411FEC1AB9}"/>
          </ac:grpSpMkLst>
        </pc:grpChg>
        <pc:grpChg chg="mod">
          <ac:chgData name="Jun Ge" userId="b8e2f334ff6b24d1" providerId="LiveId" clId="{C43AB18E-16A3-4074-98CE-74F3D438E944}" dt="2025-05-07T16:09:16.888" v="200" actId="1076"/>
          <ac:grpSpMkLst>
            <pc:docMk/>
            <pc:sldMk cId="3927637345" sldId="2012"/>
            <ac:grpSpMk id="34" creationId="{C5ED0C81-E723-0F23-D04F-9F3E97180E6D}"/>
          </ac:grpSpMkLst>
        </pc:grpChg>
        <pc:grpChg chg="mod">
          <ac:chgData name="Jun Ge" userId="b8e2f334ff6b24d1" providerId="LiveId" clId="{C43AB18E-16A3-4074-98CE-74F3D438E944}" dt="2025-05-07T16:11:04.530" v="274" actId="1036"/>
          <ac:grpSpMkLst>
            <pc:docMk/>
            <pc:sldMk cId="3927637345" sldId="2012"/>
            <ac:grpSpMk id="35" creationId="{F5E338CE-1BB7-E37B-C733-116482574268}"/>
          </ac:grpSpMkLst>
        </pc:grpChg>
        <pc:grpChg chg="mod">
          <ac:chgData name="Jun Ge" userId="b8e2f334ff6b24d1" providerId="LiveId" clId="{C43AB18E-16A3-4074-98CE-74F3D438E944}" dt="2025-05-12T11:38:59.480" v="1074" actId="1036"/>
          <ac:grpSpMkLst>
            <pc:docMk/>
            <pc:sldMk cId="3927637345" sldId="2012"/>
            <ac:grpSpMk id="89" creationId="{A5022D69-6DF7-3B16-8DAA-E730FB27894F}"/>
          </ac:grpSpMkLst>
        </pc:grpChg>
      </pc:sldChg>
      <pc:sldChg chg="modSp mod">
        <pc:chgData name="Jun Ge" userId="b8e2f334ff6b24d1" providerId="LiveId" clId="{C43AB18E-16A3-4074-98CE-74F3D438E944}" dt="2025-05-12T11:40:56.842" v="1133" actId="1036"/>
        <pc:sldMkLst>
          <pc:docMk/>
          <pc:sldMk cId="1010496936" sldId="2013"/>
        </pc:sldMkLst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" creationId="{4D2AF7A5-E4B2-47FB-17EF-BF88DE9F7816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12" creationId="{F2E33EFD-6049-8165-C77C-6A246ABB170A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14" creationId="{C69E793E-313C-5665-72D6-9D39A6829233}"/>
          </ac:spMkLst>
        </pc:spChg>
        <pc:spChg chg="mod">
          <ac:chgData name="Jun Ge" userId="b8e2f334ff6b24d1" providerId="LiveId" clId="{C43AB18E-16A3-4074-98CE-74F3D438E944}" dt="2025-05-12T11:40:56.842" v="1133" actId="1036"/>
          <ac:spMkLst>
            <pc:docMk/>
            <pc:sldMk cId="1010496936" sldId="2013"/>
            <ac:spMk id="18" creationId="{2DD5AEA8-9809-7E1D-5A79-34F5F48A657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0" creationId="{75EA06B9-1CB9-91D4-6874-4A999E12DD75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4" creationId="{A2153B20-EB75-9EEE-0AEF-D5FB75719F16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5" creationId="{4FCDD127-4C42-6423-A02D-A4178CEA70D2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6" creationId="{2B20E1AF-0B2C-688E-5BAB-99FF3914BC87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27" creationId="{1C5FB127-8DF3-85C2-F9DD-11E9FD400EED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34" creationId="{E492D282-91DE-E52B-0022-30E648FB4F66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010496936" sldId="2013"/>
            <ac:spMk id="39" creationId="{8D5ABB3F-17BB-07BD-C0A1-3A2FB0E5D87B}"/>
          </ac:spMkLst>
        </pc:spChg>
        <pc:grpChg chg="mod">
          <ac:chgData name="Jun Ge" userId="b8e2f334ff6b24d1" providerId="LiveId" clId="{C43AB18E-16A3-4074-98CE-74F3D438E944}" dt="2025-05-12T11:40:54.272" v="1129" actId="1035"/>
          <ac:grpSpMkLst>
            <pc:docMk/>
            <pc:sldMk cId="1010496936" sldId="2013"/>
            <ac:grpSpMk id="55" creationId="{46372908-CDE1-D474-5709-595848A9FE90}"/>
          </ac:grpSpMkLst>
        </pc:grpChg>
      </pc:sldChg>
      <pc:sldChg chg="addSp modSp mod">
        <pc:chgData name="Jun Ge" userId="b8e2f334ff6b24d1" providerId="LiveId" clId="{C43AB18E-16A3-4074-98CE-74F3D438E944}" dt="2025-05-12T11:49:07.217" v="1273" actId="2710"/>
        <pc:sldMkLst>
          <pc:docMk/>
          <pc:sldMk cId="3682301007" sldId="2015"/>
        </pc:sldMkLst>
        <pc:spChg chg="mod">
          <ac:chgData name="Jun Ge" userId="b8e2f334ff6b24d1" providerId="LiveId" clId="{C43AB18E-16A3-4074-98CE-74F3D438E944}" dt="2025-05-07T16:23:48.461" v="576" actId="1035"/>
          <ac:spMkLst>
            <pc:docMk/>
            <pc:sldMk cId="3682301007" sldId="2015"/>
            <ac:spMk id="5" creationId="{8A40FA5B-702D-5465-6CC3-147436072560}"/>
          </ac:spMkLst>
        </pc:spChg>
        <pc:spChg chg="mod">
          <ac:chgData name="Jun Ge" userId="b8e2f334ff6b24d1" providerId="LiveId" clId="{C43AB18E-16A3-4074-98CE-74F3D438E944}" dt="2025-05-07T16:23:48.461" v="576" actId="1035"/>
          <ac:spMkLst>
            <pc:docMk/>
            <pc:sldMk cId="3682301007" sldId="2015"/>
            <ac:spMk id="6" creationId="{22F635C3-6459-2673-AC77-F4617B59FC4D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82301007" sldId="2015"/>
            <ac:spMk id="8" creationId="{607AC51E-ED11-ED82-3B95-0BA48D81E6D6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9" creationId="{1475C8F7-59A4-DF1F-5373-8E5A6AF74A7B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11" creationId="{99E0D76C-277A-A1C3-0B02-6AE8B920A445}"/>
          </ac:spMkLst>
        </pc:spChg>
        <pc:spChg chg="mod">
          <ac:chgData name="Jun Ge" userId="b8e2f334ff6b24d1" providerId="LiveId" clId="{C43AB18E-16A3-4074-98CE-74F3D438E944}" dt="2025-05-07T16:23:16.137" v="553" actId="571"/>
          <ac:spMkLst>
            <pc:docMk/>
            <pc:sldMk cId="3682301007" sldId="2015"/>
            <ac:spMk id="12" creationId="{B688B260-AA42-1768-5CC0-DB91ECCA8E92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13" creationId="{CF03B69B-1CE4-5D78-297C-58517D494DF5}"/>
          </ac:spMkLst>
        </pc:spChg>
        <pc:spChg chg="mod">
          <ac:chgData name="Jun Ge" userId="b8e2f334ff6b24d1" providerId="LiveId" clId="{C43AB18E-16A3-4074-98CE-74F3D438E944}" dt="2025-05-07T16:23:16.137" v="553" actId="571"/>
          <ac:spMkLst>
            <pc:docMk/>
            <pc:sldMk cId="3682301007" sldId="2015"/>
            <ac:spMk id="14" creationId="{007CDB88-1088-E2D8-92F5-5A5F6570A320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15" creationId="{FABF467D-C420-540A-A1CB-0D77C3FC8AB5}"/>
          </ac:spMkLst>
        </pc:spChg>
        <pc:spChg chg="mod">
          <ac:chgData name="Jun Ge" userId="b8e2f334ff6b24d1" providerId="LiveId" clId="{C43AB18E-16A3-4074-98CE-74F3D438E944}" dt="2025-05-07T16:23:16.137" v="553" actId="571"/>
          <ac:spMkLst>
            <pc:docMk/>
            <pc:sldMk cId="3682301007" sldId="2015"/>
            <ac:spMk id="16" creationId="{F0BD5D86-C541-00A6-BB15-96900B56E88C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17" creationId="{4CB19E41-AF5B-D1A7-6729-C2FEB72214EE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19" creationId="{9FC26628-9DC2-5EAC-DA58-9BC405A18E9F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3682301007" sldId="2015"/>
            <ac:spMk id="20" creationId="{CB8C969C-F2EE-4EC5-01E1-0DC2CE776C1B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21" creationId="{1E9F67F4-BB1D-61EE-C91A-A32FED6DE3F2}"/>
          </ac:spMkLst>
        </pc:spChg>
        <pc:spChg chg="mod">
          <ac:chgData name="Jun Ge" userId="b8e2f334ff6b24d1" providerId="LiveId" clId="{C43AB18E-16A3-4074-98CE-74F3D438E944}" dt="2025-05-07T16:23:16.137" v="553" actId="571"/>
          <ac:spMkLst>
            <pc:docMk/>
            <pc:sldMk cId="3682301007" sldId="2015"/>
            <ac:spMk id="22" creationId="{0AFDF182-2742-265B-5961-8F28CE61EB93}"/>
          </ac:spMkLst>
        </pc:spChg>
        <pc:spChg chg="mod">
          <ac:chgData name="Jun Ge" userId="b8e2f334ff6b24d1" providerId="LiveId" clId="{C43AB18E-16A3-4074-98CE-74F3D438E944}" dt="2025-05-07T16:23:31.141" v="571" actId="1037"/>
          <ac:spMkLst>
            <pc:docMk/>
            <pc:sldMk cId="3682301007" sldId="2015"/>
            <ac:spMk id="23" creationId="{83FAA93A-8658-E62C-1714-60BBFA358C1B}"/>
          </ac:spMkLst>
        </pc:spChg>
        <pc:spChg chg="mod">
          <ac:chgData name="Jun Ge" userId="b8e2f334ff6b24d1" providerId="LiveId" clId="{C43AB18E-16A3-4074-98CE-74F3D438E944}" dt="2025-05-12T11:49:07.217" v="1273" actId="2710"/>
          <ac:spMkLst>
            <pc:docMk/>
            <pc:sldMk cId="3682301007" sldId="2015"/>
            <ac:spMk id="29" creationId="{238251D4-08E8-AB92-9823-7837288781AC}"/>
          </ac:spMkLst>
        </pc:spChg>
        <pc:grpChg chg="mod">
          <ac:chgData name="Jun Ge" userId="b8e2f334ff6b24d1" providerId="LiveId" clId="{C43AB18E-16A3-4074-98CE-74F3D438E944}" dt="2025-05-07T16:14:09.363" v="322" actId="1076"/>
          <ac:grpSpMkLst>
            <pc:docMk/>
            <pc:sldMk cId="3682301007" sldId="2015"/>
            <ac:grpSpMk id="4" creationId="{3D55C447-9242-86D8-B0A5-436B406DB6C4}"/>
          </ac:grpSpMkLst>
        </pc:grpChg>
      </pc:sldChg>
      <pc:sldChg chg="modSp mod">
        <pc:chgData name="Jun Ge" userId="b8e2f334ff6b24d1" providerId="LiveId" clId="{C43AB18E-16A3-4074-98CE-74F3D438E944}" dt="2025-05-12T11:41:37.378" v="1160" actId="14100"/>
        <pc:sldMkLst>
          <pc:docMk/>
          <pc:sldMk cId="1135461668" sldId="2018"/>
        </pc:sldMkLst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2" creationId="{23ECA110-D907-7BF6-FAB3-CCE6D5FACF98}"/>
          </ac:spMkLst>
        </pc:spChg>
        <pc:spChg chg="mod">
          <ac:chgData name="Jun Ge" userId="b8e2f334ff6b24d1" providerId="LiveId" clId="{C43AB18E-16A3-4074-98CE-74F3D438E944}" dt="2025-05-12T11:41:26.412" v="1146" actId="1035"/>
          <ac:spMkLst>
            <pc:docMk/>
            <pc:sldMk cId="1135461668" sldId="2018"/>
            <ac:spMk id="21" creationId="{784D353F-2AC5-618D-8A63-BC05FB46DD96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22" creationId="{EBAC1FBD-03F4-F515-A28E-C9F1CD0D86D3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23" creationId="{B38F02EB-8D3C-FEA4-9732-A15A6007454E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27" creationId="{886593AD-EAC2-F226-CDC9-40B7726D3F6C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30" creationId="{FDD1F94F-810A-A0C4-4640-007070819080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33" creationId="{472A39D7-D04C-91B8-7AC4-612292210E1D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35" creationId="{5E13F4E9-D189-6675-3DEF-B67F6F1B26FF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36" creationId="{0D12FAEA-0DB9-5949-3C4A-2F4E564BF8C1}"/>
          </ac:spMkLst>
        </pc:spChg>
        <pc:spChg chg="mod">
          <ac:chgData name="Jun Ge" userId="b8e2f334ff6b24d1" providerId="LiveId" clId="{C43AB18E-16A3-4074-98CE-74F3D438E944}" dt="2025-05-07T13:30:13.166" v="0"/>
          <ac:spMkLst>
            <pc:docMk/>
            <pc:sldMk cId="1135461668" sldId="2018"/>
            <ac:spMk id="38" creationId="{1C66E24F-E2FF-E9E2-6E47-821ECCAC1DAB}"/>
          </ac:spMkLst>
        </pc:spChg>
        <pc:grpChg chg="mod">
          <ac:chgData name="Jun Ge" userId="b8e2f334ff6b24d1" providerId="LiveId" clId="{C43AB18E-16A3-4074-98CE-74F3D438E944}" dt="2025-05-12T11:41:37.378" v="1160" actId="14100"/>
          <ac:grpSpMkLst>
            <pc:docMk/>
            <pc:sldMk cId="1135461668" sldId="2018"/>
            <ac:grpSpMk id="25" creationId="{85928596-F12A-8FE4-4961-86119D97DD27}"/>
          </ac:grpSpMkLst>
        </pc:grpChg>
      </pc:sldChg>
      <pc:sldChg chg="modSp mod">
        <pc:chgData name="Jun Ge" userId="b8e2f334ff6b24d1" providerId="LiveId" clId="{C43AB18E-16A3-4074-98CE-74F3D438E944}" dt="2025-05-12T11:41:57.796" v="1163" actId="255"/>
        <pc:sldMkLst>
          <pc:docMk/>
          <pc:sldMk cId="1948246596" sldId="2019"/>
        </pc:sldMkLst>
        <pc:spChg chg="mod">
          <ac:chgData name="Jun Ge" userId="b8e2f334ff6b24d1" providerId="LiveId" clId="{C43AB18E-16A3-4074-98CE-74F3D438E944}" dt="2025-05-12T11:41:57.796" v="1163" actId="255"/>
          <ac:spMkLst>
            <pc:docMk/>
            <pc:sldMk cId="1948246596" sldId="2019"/>
            <ac:spMk id="2" creationId="{B1E5F03D-16D8-BF5B-49FA-8A1C55928D75}"/>
          </ac:spMkLst>
        </pc:spChg>
        <pc:spChg chg="mod">
          <ac:chgData name="Jun Ge" userId="b8e2f334ff6b24d1" providerId="LiveId" clId="{C43AB18E-16A3-4074-98CE-74F3D438E944}" dt="2025-05-07T16:15:31.186" v="338" actId="403"/>
          <ac:spMkLst>
            <pc:docMk/>
            <pc:sldMk cId="1948246596" sldId="2019"/>
            <ac:spMk id="79" creationId="{E1DCAE6A-E01F-AB22-230D-F7742A75F259}"/>
          </ac:spMkLst>
        </pc:spChg>
        <pc:spChg chg="mod">
          <ac:chgData name="Jun Ge" userId="b8e2f334ff6b24d1" providerId="LiveId" clId="{C43AB18E-16A3-4074-98CE-74F3D438E944}" dt="2025-05-07T16:15:31.186" v="338" actId="403"/>
          <ac:spMkLst>
            <pc:docMk/>
            <pc:sldMk cId="1948246596" sldId="2019"/>
            <ac:spMk id="80" creationId="{CEB7A46D-13F1-1E7F-F2E2-F5D7516FC3C5}"/>
          </ac:spMkLst>
        </pc:spChg>
        <pc:spChg chg="mod">
          <ac:chgData name="Jun Ge" userId="b8e2f334ff6b24d1" providerId="LiveId" clId="{C43AB18E-16A3-4074-98CE-74F3D438E944}" dt="2025-05-07T16:15:31.186" v="338" actId="403"/>
          <ac:spMkLst>
            <pc:docMk/>
            <pc:sldMk cId="1948246596" sldId="2019"/>
            <ac:spMk id="81" creationId="{F7C19B0C-9258-815F-DD9C-B685F2BDCF2C}"/>
          </ac:spMkLst>
        </pc:spChg>
        <pc:spChg chg="mod">
          <ac:chgData name="Jun Ge" userId="b8e2f334ff6b24d1" providerId="LiveId" clId="{C43AB18E-16A3-4074-98CE-74F3D438E944}" dt="2025-05-07T16:15:31.186" v="338" actId="403"/>
          <ac:spMkLst>
            <pc:docMk/>
            <pc:sldMk cId="1948246596" sldId="2019"/>
            <ac:spMk id="82" creationId="{B639E330-5362-CEBC-1635-5E2B1E5E288E}"/>
          </ac:spMkLst>
        </pc:spChg>
        <pc:grpChg chg="mod">
          <ac:chgData name="Jun Ge" userId="b8e2f334ff6b24d1" providerId="LiveId" clId="{C43AB18E-16A3-4074-98CE-74F3D438E944}" dt="2025-05-07T16:14:37.596" v="334" actId="1076"/>
          <ac:grpSpMkLst>
            <pc:docMk/>
            <pc:sldMk cId="1948246596" sldId="2019"/>
            <ac:grpSpMk id="5" creationId="{298C7AC6-DBF8-3DEF-BE94-FC0EA9ECAE98}"/>
          </ac:grpSpMkLst>
        </pc:grpChg>
        <pc:picChg chg="mod">
          <ac:chgData name="Jun Ge" userId="b8e2f334ff6b24d1" providerId="LiveId" clId="{C43AB18E-16A3-4074-98CE-74F3D438E944}" dt="2025-05-07T13:30:13.166" v="0"/>
          <ac:picMkLst>
            <pc:docMk/>
            <pc:sldMk cId="1948246596" sldId="2019"/>
            <ac:picMk id="4" creationId="{404DF22B-DE3D-9EEA-1842-11CC5DC230BA}"/>
          </ac:picMkLst>
        </pc:picChg>
      </pc:sldChg>
      <pc:sldChg chg="modSp mod">
        <pc:chgData name="Jun Ge" userId="b8e2f334ff6b24d1" providerId="LiveId" clId="{C43AB18E-16A3-4074-98CE-74F3D438E944}" dt="2025-05-12T11:49:17.812" v="1276" actId="255"/>
        <pc:sldMkLst>
          <pc:docMk/>
          <pc:sldMk cId="736711877" sldId="2020"/>
        </pc:sldMkLst>
        <pc:spChg chg="mod">
          <ac:chgData name="Jun Ge" userId="b8e2f334ff6b24d1" providerId="LiveId" clId="{C43AB18E-16A3-4074-98CE-74F3D438E944}" dt="2025-05-12T11:49:17.812" v="1276" actId="255"/>
          <ac:spMkLst>
            <pc:docMk/>
            <pc:sldMk cId="736711877" sldId="2020"/>
            <ac:spMk id="45" creationId="{86896ECD-177D-6042-8254-2106B50AC8F4}"/>
          </ac:spMkLst>
        </pc:spChg>
      </pc:sldChg>
      <pc:sldChg chg="modSp mod">
        <pc:chgData name="Jun Ge" userId="b8e2f334ff6b24d1" providerId="LiveId" clId="{C43AB18E-16A3-4074-98CE-74F3D438E944}" dt="2025-05-07T16:18:56.832" v="392" actId="1035"/>
        <pc:sldMkLst>
          <pc:docMk/>
          <pc:sldMk cId="1082031398" sldId="2022"/>
        </pc:sldMkLst>
        <pc:spChg chg="mod">
          <ac:chgData name="Jun Ge" userId="b8e2f334ff6b24d1" providerId="LiveId" clId="{C43AB18E-16A3-4074-98CE-74F3D438E944}" dt="2025-05-07T16:02:57.157" v="31" actId="1036"/>
          <ac:spMkLst>
            <pc:docMk/>
            <pc:sldMk cId="1082031398" sldId="2022"/>
            <ac:spMk id="5" creationId="{BB71CCFE-C9B2-DF0F-4970-C178D824A9F4}"/>
          </ac:spMkLst>
        </pc:spChg>
        <pc:graphicFrameChg chg="mod modGraphic">
          <ac:chgData name="Jun Ge" userId="b8e2f334ff6b24d1" providerId="LiveId" clId="{C43AB18E-16A3-4074-98CE-74F3D438E944}" dt="2025-05-07T16:18:56.832" v="392" actId="1035"/>
          <ac:graphicFrameMkLst>
            <pc:docMk/>
            <pc:sldMk cId="1082031398" sldId="2022"/>
            <ac:graphicFrameMk id="7" creationId="{8C18C645-16B0-3614-5CD9-14BA3E973DD7}"/>
          </ac:graphicFrameMkLst>
        </pc:graphicFrameChg>
      </pc:sldChg>
      <pc:sldChg chg="modSp mod">
        <pc:chgData name="Jun Ge" userId="b8e2f334ff6b24d1" providerId="LiveId" clId="{C43AB18E-16A3-4074-98CE-74F3D438E944}" dt="2025-05-07T16:17:11.814" v="364" actId="1076"/>
        <pc:sldMkLst>
          <pc:docMk/>
          <pc:sldMk cId="4247067011" sldId="2023"/>
        </pc:sldMkLst>
        <pc:spChg chg="mod">
          <ac:chgData name="Jun Ge" userId="b8e2f334ff6b24d1" providerId="LiveId" clId="{C43AB18E-16A3-4074-98CE-74F3D438E944}" dt="2025-05-07T16:17:11.814" v="364" actId="1076"/>
          <ac:spMkLst>
            <pc:docMk/>
            <pc:sldMk cId="4247067011" sldId="2023"/>
            <ac:spMk id="3" creationId="{C43BC855-A394-BDA4-68D4-EBF51437CCDF}"/>
          </ac:spMkLst>
        </pc:spChg>
      </pc:sldChg>
      <pc:sldChg chg="modSp mod">
        <pc:chgData name="Jun Ge" userId="b8e2f334ff6b24d1" providerId="LiveId" clId="{C43AB18E-16A3-4074-98CE-74F3D438E944}" dt="2025-05-12T11:49:34.989" v="1282" actId="403"/>
        <pc:sldMkLst>
          <pc:docMk/>
          <pc:sldMk cId="1714582132" sldId="2026"/>
        </pc:sldMkLst>
        <pc:spChg chg="mod">
          <ac:chgData name="Jun Ge" userId="b8e2f334ff6b24d1" providerId="LiveId" clId="{C43AB18E-16A3-4074-98CE-74F3D438E944}" dt="2025-05-12T11:49:34.989" v="1282" actId="403"/>
          <ac:spMkLst>
            <pc:docMk/>
            <pc:sldMk cId="1714582132" sldId="2026"/>
            <ac:spMk id="82" creationId="{E1F9210C-D7EF-E736-55D0-EB2EFE95F4DD}"/>
          </ac:spMkLst>
        </pc:spChg>
      </pc:sldChg>
      <pc:sldChg chg="addSp delSp modSp new mod">
        <pc:chgData name="Jun Ge" userId="b8e2f334ff6b24d1" providerId="LiveId" clId="{C43AB18E-16A3-4074-98CE-74F3D438E944}" dt="2025-05-12T11:48:37.256" v="1262" actId="255"/>
        <pc:sldMkLst>
          <pc:docMk/>
          <pc:sldMk cId="3785711134" sldId="2027"/>
        </pc:sldMkLst>
      </pc:sldChg>
      <pc:sldChg chg="addSp delSp modSp new mod">
        <pc:chgData name="Jun Ge" userId="b8e2f334ff6b24d1" providerId="LiveId" clId="{C43AB18E-16A3-4074-98CE-74F3D438E944}" dt="2025-05-12T11:49:46.711" v="1285" actId="255"/>
        <pc:sldMkLst>
          <pc:docMk/>
          <pc:sldMk cId="2250533917" sldId="2028"/>
        </pc:sldMkLst>
        <pc:spChg chg="add mod">
          <ac:chgData name="Jun Ge" userId="b8e2f334ff6b24d1" providerId="LiveId" clId="{C43AB18E-16A3-4074-98CE-74F3D438E944}" dt="2025-05-12T11:49:46.711" v="1285" actId="255"/>
          <ac:spMkLst>
            <pc:docMk/>
            <pc:sldMk cId="2250533917" sldId="2028"/>
            <ac:spMk id="2" creationId="{0F3B34B3-6A36-9677-5340-FBFF722798A9}"/>
          </ac:spMkLst>
        </pc:spChg>
        <pc:spChg chg="add mod topLvl">
          <ac:chgData name="Jun Ge" userId="b8e2f334ff6b24d1" providerId="LiveId" clId="{C43AB18E-16A3-4074-98CE-74F3D438E944}" dt="2025-05-12T10:53:08.167" v="967" actId="1036"/>
          <ac:spMkLst>
            <pc:docMk/>
            <pc:sldMk cId="2250533917" sldId="2028"/>
            <ac:spMk id="21" creationId="{FF26E590-F46A-155B-EC88-C86934C955B3}"/>
          </ac:spMkLst>
        </pc:spChg>
        <pc:spChg chg="add mod topLvl">
          <ac:chgData name="Jun Ge" userId="b8e2f334ff6b24d1" providerId="LiveId" clId="{C43AB18E-16A3-4074-98CE-74F3D438E944}" dt="2025-05-12T10:53:10.261" v="973" actId="1038"/>
          <ac:spMkLst>
            <pc:docMk/>
            <pc:sldMk cId="2250533917" sldId="2028"/>
            <ac:spMk id="23" creationId="{CD902295-970B-6E8B-1E46-F86CEBF52B05}"/>
          </ac:spMkLst>
        </pc:spChg>
        <pc:spChg chg="add mod topLvl">
          <ac:chgData name="Jun Ge" userId="b8e2f334ff6b24d1" providerId="LiveId" clId="{C43AB18E-16A3-4074-98CE-74F3D438E944}" dt="2025-05-12T10:53:12.521" v="978" actId="1035"/>
          <ac:spMkLst>
            <pc:docMk/>
            <pc:sldMk cId="2250533917" sldId="2028"/>
            <ac:spMk id="24" creationId="{71904231-393D-B586-02FA-3A2494341420}"/>
          </ac:spMkLst>
        </pc:spChg>
        <pc:spChg chg="add mod topLvl">
          <ac:chgData name="Jun Ge" userId="b8e2f334ff6b24d1" providerId="LiveId" clId="{C43AB18E-16A3-4074-98CE-74F3D438E944}" dt="2025-05-12T10:53:17.188" v="985" actId="1035"/>
          <ac:spMkLst>
            <pc:docMk/>
            <pc:sldMk cId="2250533917" sldId="2028"/>
            <ac:spMk id="25" creationId="{D2A43804-2649-AF49-9A0D-670AC8575194}"/>
          </ac:spMkLst>
        </pc:spChg>
        <pc:picChg chg="add mod topLvl">
          <ac:chgData name="Jun Ge" userId="b8e2f334ff6b24d1" providerId="LiveId" clId="{C43AB18E-16A3-4074-98CE-74F3D438E944}" dt="2025-05-12T10:53:00.218" v="955" actId="165"/>
          <ac:picMkLst>
            <pc:docMk/>
            <pc:sldMk cId="2250533917" sldId="2028"/>
            <ac:picMk id="37" creationId="{E1991F25-804A-6585-FCFA-D46E72D9074D}"/>
          </ac:picMkLst>
        </pc:picChg>
      </pc:sldChg>
      <pc:sldMasterChg chg="modSp modSldLayout">
        <pc:chgData name="Jun Ge" userId="b8e2f334ff6b24d1" providerId="LiveId" clId="{C43AB18E-16A3-4074-98CE-74F3D438E944}" dt="2025-05-07T13:30:13.166" v="0"/>
        <pc:sldMasterMkLst>
          <pc:docMk/>
          <pc:sldMasterMk cId="925654155" sldId="2147483648"/>
        </pc:sldMasterMkLst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3695167372" sldId="2147483649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1964084124" sldId="2147483651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2700448638" sldId="2147483652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3854907295" sldId="2147483653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1730246231" sldId="2147483656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1060671777" sldId="2147483657"/>
          </pc:sldLayoutMkLst>
        </pc:sldLayoutChg>
        <pc:sldLayoutChg chg="modSp">
          <pc:chgData name="Jun Ge" userId="b8e2f334ff6b24d1" providerId="LiveId" clId="{C43AB18E-16A3-4074-98CE-74F3D438E944}" dt="2025-05-07T13:30:13.166" v="0"/>
          <pc:sldLayoutMkLst>
            <pc:docMk/>
            <pc:sldMasterMk cId="925654155" sldId="2147483648"/>
            <pc:sldLayoutMk cId="3758618843" sldId="2147483659"/>
          </pc:sldLayoutMkLst>
        </pc:sldLayoutChg>
      </pc:sldMasterChg>
      <pc:sldMasterChg chg="modSldLayout">
        <pc:chgData name="Jun Ge" userId="b8e2f334ff6b24d1" providerId="LiveId" clId="{C43AB18E-16A3-4074-98CE-74F3D438E944}" dt="2025-05-07T16:14:50.406" v="335" actId="735"/>
        <pc:sldMasterMkLst>
          <pc:docMk/>
          <pc:sldMasterMk cId="492520014" sldId="2147483660"/>
        </pc:sldMasterMkLst>
        <pc:sldLayoutChg chg="modSp">
          <pc:chgData name="Jun Ge" userId="b8e2f334ff6b24d1" providerId="LiveId" clId="{C43AB18E-16A3-4074-98CE-74F3D438E944}" dt="2025-05-07T16:14:50.406" v="335" actId="735"/>
          <pc:sldLayoutMkLst>
            <pc:docMk/>
            <pc:sldMasterMk cId="492520014" sldId="2147483660"/>
            <pc:sldLayoutMk cId="2000593797" sldId="2147483667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4870" cy="502675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1699" y="0"/>
            <a:ext cx="2984870" cy="502675"/>
          </a:xfrm>
          <a:prstGeom prst="rect">
            <a:avLst/>
          </a:prstGeom>
        </p:spPr>
        <p:txBody>
          <a:bodyPr vert="horz" lIns="94229" tIns="47114" rIns="94229" bIns="47114" rtlCol="0"/>
          <a:lstStyle>
            <a:lvl1pPr algn="r">
              <a:defRPr sz="1200"/>
            </a:lvl1pPr>
          </a:lstStyle>
          <a:p>
            <a:fld id="{FADDD470-ADA1-4B22-A5AC-0797218E0332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2538"/>
            <a:ext cx="45100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9" tIns="47114" rIns="94229" bIns="47114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4229" tIns="47114" rIns="94229" bIns="47114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516039"/>
            <a:ext cx="2984870" cy="50267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1699" y="9516039"/>
            <a:ext cx="2984870" cy="502674"/>
          </a:xfrm>
          <a:prstGeom prst="rect">
            <a:avLst/>
          </a:prstGeom>
        </p:spPr>
        <p:txBody>
          <a:bodyPr vert="horz" lIns="94229" tIns="47114" rIns="94229" bIns="47114" rtlCol="0" anchor="b"/>
          <a:lstStyle>
            <a:lvl1pPr algn="r">
              <a:defRPr sz="1200"/>
            </a:lvl1pPr>
          </a:lstStyle>
          <a:p>
            <a:fld id="{E460447C-EFD7-4D04-9DD1-3CABA33079A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03245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60447C-EFD7-4D04-9DD1-3CABA33079A3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36692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0086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509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3751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082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0994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778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7109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3167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059379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288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2558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64840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85A64B-D8F8-4D9C-986C-6AD8D9405584}" type="datetimeFigureOut">
              <a:rPr lang="zh-CN" altLang="en-US" smtClean="0"/>
              <a:t>2025/5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76CF99-CDBC-4B9C-9563-90ADEC68CFF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2520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jpeg"/><Relationship Id="rId13" Type="http://schemas.openxmlformats.org/officeDocument/2006/relationships/image" Target="../media/image57.jpeg"/><Relationship Id="rId3" Type="http://schemas.openxmlformats.org/officeDocument/2006/relationships/image" Target="../media/image47.tiff"/><Relationship Id="rId7" Type="http://schemas.openxmlformats.org/officeDocument/2006/relationships/image" Target="../media/image51.tiff"/><Relationship Id="rId12" Type="http://schemas.openxmlformats.org/officeDocument/2006/relationships/image" Target="../media/image56.jpeg"/><Relationship Id="rId17" Type="http://schemas.openxmlformats.org/officeDocument/2006/relationships/image" Target="../media/image61.jpeg"/><Relationship Id="rId2" Type="http://schemas.openxmlformats.org/officeDocument/2006/relationships/image" Target="../media/image46.jpeg"/><Relationship Id="rId16" Type="http://schemas.openxmlformats.org/officeDocument/2006/relationships/image" Target="../media/image6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tiff"/><Relationship Id="rId11" Type="http://schemas.openxmlformats.org/officeDocument/2006/relationships/image" Target="../media/image55.tiff"/><Relationship Id="rId5" Type="http://schemas.openxmlformats.org/officeDocument/2006/relationships/image" Target="../media/image49.tiff"/><Relationship Id="rId15" Type="http://schemas.openxmlformats.org/officeDocument/2006/relationships/image" Target="../media/image59.tiff"/><Relationship Id="rId10" Type="http://schemas.openxmlformats.org/officeDocument/2006/relationships/image" Target="../media/image54.tiff"/><Relationship Id="rId4" Type="http://schemas.openxmlformats.org/officeDocument/2006/relationships/image" Target="../media/image48.tiff"/><Relationship Id="rId9" Type="http://schemas.openxmlformats.org/officeDocument/2006/relationships/image" Target="../media/image53.tiff"/><Relationship Id="rId14" Type="http://schemas.openxmlformats.org/officeDocument/2006/relationships/image" Target="../media/image58.tif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e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1.png"/><Relationship Id="rId3" Type="http://schemas.openxmlformats.org/officeDocument/2006/relationships/image" Target="../media/image66.png"/><Relationship Id="rId7" Type="http://schemas.openxmlformats.org/officeDocument/2006/relationships/image" Target="../media/image70.png"/><Relationship Id="rId2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png"/><Relationship Id="rId5" Type="http://schemas.openxmlformats.org/officeDocument/2006/relationships/image" Target="../media/image68.png"/><Relationship Id="rId4" Type="http://schemas.openxmlformats.org/officeDocument/2006/relationships/image" Target="../media/image67.png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4" Type="http://schemas.openxmlformats.org/officeDocument/2006/relationships/image" Target="../media/image74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microsoft.com/office/2007/relationships/hdphoto" Target="../media/hdphoto7.wdp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image" Target="../media/image40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5" Type="http://schemas.microsoft.com/office/2007/relationships/hdphoto" Target="../media/hdphoto8.wdp"/><Relationship Id="rId10" Type="http://schemas.openxmlformats.org/officeDocument/2006/relationships/image" Target="../media/image39.png"/><Relationship Id="rId4" Type="http://schemas.openxmlformats.org/officeDocument/2006/relationships/image" Target="../media/image36.png"/><Relationship Id="rId9" Type="http://schemas.microsoft.com/office/2007/relationships/hdphoto" Target="../media/hdphoto5.wdp"/><Relationship Id="rId1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B71CCFE-C9B2-DF0F-4970-C178D824A9F4}"/>
              </a:ext>
            </a:extLst>
          </p:cNvPr>
          <p:cNvSpPr txBox="1"/>
          <p:nvPr/>
        </p:nvSpPr>
        <p:spPr>
          <a:xfrm>
            <a:off x="102790" y="38100"/>
            <a:ext cx="6097712" cy="3204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tabLst>
                <a:tab pos="2911475" algn="l"/>
              </a:tabLst>
            </a:pPr>
            <a:r>
              <a:rPr lang="en-US" altLang="ja-JP" sz="1100" b="1" kern="10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Table S1.</a:t>
            </a:r>
            <a:r>
              <a:rPr lang="en-US" altLang="ja-JP" sz="1100" kern="10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List of primer sequences.</a:t>
            </a:r>
            <a:endParaRPr lang="ja-JP" altLang="ja-JP" sz="1100" kern="100">
              <a:latin typeface="Aptos Display" panose="020B0004020202020204" pitchFamily="34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8C18C645-16B0-3614-5CD9-14BA3E973D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627143"/>
              </p:ext>
            </p:extLst>
          </p:nvPr>
        </p:nvGraphicFramePr>
        <p:xfrm>
          <a:off x="188515" y="390957"/>
          <a:ext cx="8766969" cy="6346800"/>
        </p:xfrm>
        <a:graphic>
          <a:graphicData uri="http://schemas.openxmlformats.org/drawingml/2006/table">
            <a:tbl>
              <a:tblPr firstRow="1" firstCol="1" bandRow="1"/>
              <a:tblGrid>
                <a:gridCol w="2535635">
                  <a:extLst>
                    <a:ext uri="{9D8B030D-6E8A-4147-A177-3AD203B41FA5}">
                      <a16:colId xmlns:a16="http://schemas.microsoft.com/office/drawing/2014/main" val="2280350267"/>
                    </a:ext>
                  </a:extLst>
                </a:gridCol>
                <a:gridCol w="3620214">
                  <a:extLst>
                    <a:ext uri="{9D8B030D-6E8A-4147-A177-3AD203B41FA5}">
                      <a16:colId xmlns:a16="http://schemas.microsoft.com/office/drawing/2014/main" val="3752912059"/>
                    </a:ext>
                  </a:extLst>
                </a:gridCol>
                <a:gridCol w="2611120">
                  <a:extLst>
                    <a:ext uri="{9D8B030D-6E8A-4147-A177-3AD203B41FA5}">
                      <a16:colId xmlns:a16="http://schemas.microsoft.com/office/drawing/2014/main" val="3081198395"/>
                    </a:ext>
                  </a:extLst>
                </a:gridCol>
              </a:tblGrid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imer ID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equences (5</a:t>
                      </a:r>
                      <a:r>
                        <a:rPr lang="zh-CN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′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to 3</a:t>
                      </a:r>
                      <a:r>
                        <a:rPr lang="zh-CN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′</a:t>
                      </a: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rpos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044868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1-HE/NHE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CGTCAACGGGAGGAGAAG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4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expression level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972541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1-HE/NHE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AGGGAGACTCGGAATCG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9968410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2-HE/NHE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GCCACTCTGTTAATTCACTC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462585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2-HE/NHE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ATCCAACGCATCCACCTC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073128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9-HE/NHE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AACTTCCGTCGCCTCCTT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386490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9-HE/NHE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TCTTCTCGCCCTCCTC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560112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10-HE/NHE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TGCTCGCTATTCACTTTCG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7984190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10-HE/NHE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CTCACGGTGTCTATGTGCTTT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8723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11-HE/NHE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AAGCGAGACACGAGCA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8777145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11-HE/NHE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GAAGGGAGTCCAAGGT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603572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Actin1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TGCTTTCCCTCTATGC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769893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Actin1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TCAGCAGTGGTTGT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475747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FP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altLang="ja-JP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CGTAAACGGCCACAAGTT</a:t>
                      </a: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476667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FP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TCATGTGGTCGGGGTAG</a:t>
                      </a: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290919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sRed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CAACACCGAGGACGTCAT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458250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sRed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CCTTGGTCACCTGCAGCT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38759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MTP8.1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ACTGGTCTGGAACGGTGTG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775174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MTP8.1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GCTTGATTTGAGGATGATGTC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767047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Histone H3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TTTGGTCGCTCTCGATTTC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082459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sHistone H3-qR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CAACAAGTTGACCACGTCAC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9509964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MTP8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TGTCGAGGTGGATATAGAACTGC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884963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MTP8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AATGTTCAGGCTTGTGATGAC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6888212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Actin-q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GACTTTCAATGCCCCTGC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968139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Actin-q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ATCTCCAGAGTCGAGCAC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8174171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1-HE/NHE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AATCGCAGTTCCGAAAAATA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ene clonin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8845907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TP8.1-HE/NHE-R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GACGTAGGAGTGTTGAGGGCT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356024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HE-pro-infu-EcoRI-F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tgaccatgattacgaattcCAAGGTGGCGAGTGTTCA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romoter activity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48671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HE-pro-infu-SalI-R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cttgctcaccatgtcgacCGCTTATTTTTCGGAACTGC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36025663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NHE-pro-infu-EcoRI-F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atgaccatgattacgaattcCAAGGTGATGAGCGTTCA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8537346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NHE-pro-infu-SalI-R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ccttgctcaccatgtcgacCGCTTATTTTTTGGTACTGC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9734472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HE/NHE-GFP-infu-KpnI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cgagctcggtaccATGGGGTTGAGAAACGGA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ubcellular localization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233108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00GFP-SaMTP8.1-HE/NHE-GFP-infu-SalI-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ctcaccatgtcgacCTGACTGTTGGGAAGTCTGC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1558054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YES2-SaMTP8.1-HE/NHE-infu-EcoRI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cgccagtgtgctggATGGGGTTGAGAAACGGA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Yeast expression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791030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YES2-SaMTP8.1-HE/NHE-infu-XbaI-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atgcggccctctagCTACTGACTGTTGGGAAGTCT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308935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OsMTP8.1-pro-infu-KpnI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cgaattgggtacCTGTGCATGGAGTGTGCAA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nstruction of complementation lines in ric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496949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OsMTP8.1-pro-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TCCGTTTCTCAACCCCATcgaatcacctctctcctttct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17460235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SaMTP8.1-HE-cds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gaaaggagagaggtgattcgATGGGGTTGAGAAACGGA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9774012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SaMTP8.1-HE-cds-infu-HindIII-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cgatatcaagctCTActtgtcatcgtcgtccttgtaatcCTGAGTGTTGGGAAGTCTG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3781554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SaMTP8.1-HE-pro-infu-KpnI-F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10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ggcgaattgggtacCAAGGTGGCGAGTGTTCA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onstruction of over-expression lines in Arabidopsis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0262108"/>
                  </a:ext>
                </a:extLst>
              </a:tr>
              <a:tr h="154800"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PZP-SaMTP8.1-HE-cds-infu-HindIII-R1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buNone/>
                      </a:pPr>
                      <a:r>
                        <a:rPr lang="en-US" sz="900" kern="0" dirty="0" err="1"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ttcgatatcaagctCTActtgtcatcgtcgtccttgtaatcCTGAGTGTTGGGAAGTCTG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6841" marR="36841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28547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8203139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7">
            <a:extLst>
              <a:ext uri="{FF2B5EF4-FFF2-40B4-BE49-F238E27FC236}">
                <a16:creationId xmlns:a16="http://schemas.microsoft.com/office/drawing/2014/main" id="{238251D4-08E8-AB92-9823-7837288781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00" y="5142004"/>
            <a:ext cx="8910000" cy="1277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9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Alignment and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hylogenetic analysis of SaMTP8.1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(A) Protein sequence alignment of SaMTP8.1-HE, SaMTP8.1-NHE, SaMTP8.2-HE, SaMTP8.2-NHE, OsMTP8.1, and AtMTP8. Shading indicates identical (black) or similar (pink for 75% and blue for 50%) amino acid residues. The transmembrane domains of SaMTP8.1-HE are predicted by TMHMM and are marked in blue boxes. The DxxxD consensus sequence (x for any amino acid) which were conserved in Mn-CDF group close to transmembrane domain 2 and 5 (Montanini et al., 2007) were marked in red boxes. TM, transmembrane domain. (B) Phylogenetic analysis of the MTP family protein sequences from 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rice, and Arabidopsis. Red text indicates MTP8.1 members from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 Blue text indicates MTP8.1 from rice and MTP8 from Arabidopsis. Gray text indicates protein IDs in the respective databases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3D55C447-9242-86D8-B0A5-436B406DB6C4}"/>
              </a:ext>
            </a:extLst>
          </p:cNvPr>
          <p:cNvGrpSpPr>
            <a:grpSpLocks noChangeAspect="1"/>
          </p:cNvGrpSpPr>
          <p:nvPr/>
        </p:nvGrpSpPr>
        <p:grpSpPr>
          <a:xfrm>
            <a:off x="1332001" y="547409"/>
            <a:ext cx="6480003" cy="4266690"/>
            <a:chOff x="2385862" y="-86420"/>
            <a:chExt cx="8311350" cy="5472527"/>
          </a:xfrm>
        </p:grpSpPr>
        <p:sp>
          <p:nvSpPr>
            <p:cNvPr id="5" name="テキスト ボックス 7">
              <a:extLst>
                <a:ext uri="{FF2B5EF4-FFF2-40B4-BE49-F238E27FC236}">
                  <a16:creationId xmlns:a16="http://schemas.microsoft.com/office/drawing/2014/main" id="{8A40FA5B-702D-5465-6CC3-147436072560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2385862" y="-86420"/>
              <a:ext cx="498945" cy="355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6" name="テキスト ボックス 7">
              <a:extLst>
                <a:ext uri="{FF2B5EF4-FFF2-40B4-BE49-F238E27FC236}">
                  <a16:creationId xmlns:a16="http://schemas.microsoft.com/office/drawing/2014/main" id="{22F635C3-6459-2673-AC77-F4617B59FC4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7316277" y="-86420"/>
              <a:ext cx="498944" cy="355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7BF73D61-F3C3-A99D-7724-3BA071845DD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60363" y="306499"/>
              <a:ext cx="4891475" cy="5079608"/>
            </a:xfrm>
            <a:prstGeom prst="rect">
              <a:avLst/>
            </a:prstGeom>
          </p:spPr>
        </p:pic>
        <p:sp>
          <p:nvSpPr>
            <p:cNvPr id="8" name="Rectangle 15">
              <a:extLst>
                <a:ext uri="{FF2B5EF4-FFF2-40B4-BE49-F238E27FC236}">
                  <a16:creationId xmlns:a16="http://schemas.microsoft.com/office/drawing/2014/main" id="{607AC51E-ED11-ED82-3B95-0BA48D81E6D6}"/>
                </a:ext>
              </a:extLst>
            </p:cNvPr>
            <p:cNvSpPr/>
            <p:nvPr/>
          </p:nvSpPr>
          <p:spPr>
            <a:xfrm>
              <a:off x="5515189" y="1146362"/>
              <a:ext cx="1423449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9" name="TextBox 16">
              <a:extLst>
                <a:ext uri="{FF2B5EF4-FFF2-40B4-BE49-F238E27FC236}">
                  <a16:creationId xmlns:a16="http://schemas.microsoft.com/office/drawing/2014/main" id="{1475C8F7-59A4-DF1F-5373-8E5A6AF74A7B}"/>
                </a:ext>
              </a:extLst>
            </p:cNvPr>
            <p:cNvSpPr txBox="1"/>
            <p:nvPr/>
          </p:nvSpPr>
          <p:spPr>
            <a:xfrm>
              <a:off x="5994970" y="941716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1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10" name="Rectangle 15">
              <a:extLst>
                <a:ext uri="{FF2B5EF4-FFF2-40B4-BE49-F238E27FC236}">
                  <a16:creationId xmlns:a16="http://schemas.microsoft.com/office/drawing/2014/main" id="{FE908B03-26E5-B84A-67AF-7A42DB7597FA}"/>
                </a:ext>
              </a:extLst>
            </p:cNvPr>
            <p:cNvSpPr/>
            <p:nvPr/>
          </p:nvSpPr>
          <p:spPr>
            <a:xfrm>
              <a:off x="3156117" y="1995168"/>
              <a:ext cx="245824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1" name="TextBox 16">
              <a:extLst>
                <a:ext uri="{FF2B5EF4-FFF2-40B4-BE49-F238E27FC236}">
                  <a16:creationId xmlns:a16="http://schemas.microsoft.com/office/drawing/2014/main" id="{99E0D76C-277A-A1C3-0B02-6AE8B920A445}"/>
                </a:ext>
              </a:extLst>
            </p:cNvPr>
            <p:cNvSpPr txBox="1"/>
            <p:nvPr/>
          </p:nvSpPr>
          <p:spPr>
            <a:xfrm>
              <a:off x="3047086" y="1790524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1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B688B260-AA42-1768-5CC0-DB91ECCA8E92}"/>
                </a:ext>
              </a:extLst>
            </p:cNvPr>
            <p:cNvSpPr/>
            <p:nvPr/>
          </p:nvSpPr>
          <p:spPr>
            <a:xfrm>
              <a:off x="3581516" y="1995167"/>
              <a:ext cx="236994" cy="67054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3" name="TextBox 10">
              <a:extLst>
                <a:ext uri="{FF2B5EF4-FFF2-40B4-BE49-F238E27FC236}">
                  <a16:creationId xmlns:a16="http://schemas.microsoft.com/office/drawing/2014/main" id="{CF03B69B-1CE4-5D78-297C-58517D494DF5}"/>
                </a:ext>
              </a:extLst>
            </p:cNvPr>
            <p:cNvSpPr txBox="1"/>
            <p:nvPr/>
          </p:nvSpPr>
          <p:spPr>
            <a:xfrm>
              <a:off x="3423629" y="1790524"/>
              <a:ext cx="59255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FF0000"/>
                  </a:solidFill>
                </a:rPr>
                <a:t>DxxxD</a:t>
              </a:r>
              <a:endParaRPr lang="zh-CN" altLang="en-US" sz="700" b="1">
                <a:solidFill>
                  <a:srgbClr val="FF0000"/>
                </a:solidFill>
              </a:endParaRPr>
            </a:p>
          </p:txBody>
        </p:sp>
        <p:sp>
          <p:nvSpPr>
            <p:cNvPr id="14" name="Rectangle 15">
              <a:extLst>
                <a:ext uri="{FF2B5EF4-FFF2-40B4-BE49-F238E27FC236}">
                  <a16:creationId xmlns:a16="http://schemas.microsoft.com/office/drawing/2014/main" id="{007CDB88-1088-E2D8-92F5-5A5F6570A320}"/>
                </a:ext>
              </a:extLst>
            </p:cNvPr>
            <p:cNvSpPr/>
            <p:nvPr/>
          </p:nvSpPr>
          <p:spPr>
            <a:xfrm>
              <a:off x="3828050" y="1995166"/>
              <a:ext cx="936954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5" name="TextBox 16">
              <a:extLst>
                <a:ext uri="{FF2B5EF4-FFF2-40B4-BE49-F238E27FC236}">
                  <a16:creationId xmlns:a16="http://schemas.microsoft.com/office/drawing/2014/main" id="{FABF467D-C420-540A-A1CB-0D77C3FC8AB5}"/>
                </a:ext>
              </a:extLst>
            </p:cNvPr>
            <p:cNvSpPr txBox="1"/>
            <p:nvPr/>
          </p:nvSpPr>
          <p:spPr>
            <a:xfrm>
              <a:off x="4064584" y="1790524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2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F0BD5D86-C541-00A6-BB15-96900B56E88C}"/>
                </a:ext>
              </a:extLst>
            </p:cNvPr>
            <p:cNvSpPr/>
            <p:nvPr/>
          </p:nvSpPr>
          <p:spPr>
            <a:xfrm>
              <a:off x="5277914" y="1994272"/>
              <a:ext cx="1092941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CB19E41-AF5B-D1A7-6729-C2FEB72214EE}"/>
                </a:ext>
              </a:extLst>
            </p:cNvPr>
            <p:cNvSpPr txBox="1"/>
            <p:nvPr/>
          </p:nvSpPr>
          <p:spPr>
            <a:xfrm>
              <a:off x="5592442" y="1790524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3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8B130E3A-F7B6-633C-0D58-C72DA613E20B}"/>
                </a:ext>
              </a:extLst>
            </p:cNvPr>
            <p:cNvSpPr/>
            <p:nvPr/>
          </p:nvSpPr>
          <p:spPr>
            <a:xfrm>
              <a:off x="3260553" y="2841375"/>
              <a:ext cx="1080047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FC26628-9DC2-5EAC-DA58-9BC405A18E9F}"/>
                </a:ext>
              </a:extLst>
            </p:cNvPr>
            <p:cNvSpPr txBox="1"/>
            <p:nvPr/>
          </p:nvSpPr>
          <p:spPr>
            <a:xfrm>
              <a:off x="3568633" y="2636166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4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CB8C969C-F2EE-4EC5-01E1-0DC2CE776C1B}"/>
                </a:ext>
              </a:extLst>
            </p:cNvPr>
            <p:cNvSpPr/>
            <p:nvPr/>
          </p:nvSpPr>
          <p:spPr>
            <a:xfrm>
              <a:off x="5237917" y="2841375"/>
              <a:ext cx="895884" cy="670549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1E9F67F4-BB1D-61EE-C91A-A32FED6DE3F2}"/>
                </a:ext>
              </a:extLst>
            </p:cNvPr>
            <p:cNvSpPr txBox="1"/>
            <p:nvPr/>
          </p:nvSpPr>
          <p:spPr>
            <a:xfrm>
              <a:off x="5453916" y="2636166"/>
              <a:ext cx="46713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0070C0"/>
                  </a:solidFill>
                </a:rPr>
                <a:t>TM5</a:t>
              </a:r>
              <a:endParaRPr lang="zh-CN" altLang="en-US" sz="700" b="1">
                <a:solidFill>
                  <a:srgbClr val="0070C0"/>
                </a:solidFill>
              </a:endParaRPr>
            </a:p>
          </p:txBody>
        </p:sp>
        <p:sp>
          <p:nvSpPr>
            <p:cNvPr id="22" name="Rectangle 9">
              <a:extLst>
                <a:ext uri="{FF2B5EF4-FFF2-40B4-BE49-F238E27FC236}">
                  <a16:creationId xmlns:a16="http://schemas.microsoft.com/office/drawing/2014/main" id="{0AFDF182-2742-265B-5961-8F28CE61EB93}"/>
                </a:ext>
              </a:extLst>
            </p:cNvPr>
            <p:cNvSpPr/>
            <p:nvPr/>
          </p:nvSpPr>
          <p:spPr>
            <a:xfrm>
              <a:off x="4952938" y="2845151"/>
              <a:ext cx="236468" cy="670548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23" name="TextBox 10">
              <a:extLst>
                <a:ext uri="{FF2B5EF4-FFF2-40B4-BE49-F238E27FC236}">
                  <a16:creationId xmlns:a16="http://schemas.microsoft.com/office/drawing/2014/main" id="{83FAA93A-8658-E62C-1714-60BBFA358C1B}"/>
                </a:ext>
              </a:extLst>
            </p:cNvPr>
            <p:cNvSpPr txBox="1"/>
            <p:nvPr/>
          </p:nvSpPr>
          <p:spPr>
            <a:xfrm>
              <a:off x="4786994" y="2636166"/>
              <a:ext cx="592551" cy="2565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b="1">
                  <a:solidFill>
                    <a:srgbClr val="FF0000"/>
                  </a:solidFill>
                </a:rPr>
                <a:t>DxxxD</a:t>
              </a:r>
              <a:endParaRPr lang="zh-CN" altLang="en-US" sz="700" b="1">
                <a:solidFill>
                  <a:srgbClr val="FF0000"/>
                </a:solidFill>
              </a:endParaRPr>
            </a:p>
          </p:txBody>
        </p:sp>
        <p:pic>
          <p:nvPicPr>
            <p:cNvPr id="27" name="Picture 26" descr="A screenshot of a computer&#10;&#10;AI-generated content may be incorrect.">
              <a:extLst>
                <a:ext uri="{FF2B5EF4-FFF2-40B4-BE49-F238E27FC236}">
                  <a16:creationId xmlns:a16="http://schemas.microsoft.com/office/drawing/2014/main" id="{8E7F746A-29C6-2DB8-D8ED-5088F01D1A5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381134" y="255857"/>
              <a:ext cx="3316078" cy="50097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823010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40">
            <a:extLst>
              <a:ext uri="{FF2B5EF4-FFF2-40B4-BE49-F238E27FC236}">
                <a16:creationId xmlns:a16="http://schemas.microsoft.com/office/drawing/2014/main" id="{5ABAF9F6-F0CE-E7D6-E334-85B7206FF0B4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9027" y="165382"/>
            <a:ext cx="4500000" cy="5094545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F5772F9E-C505-9925-0130-DD81519CE03A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614975" y="165382"/>
            <a:ext cx="4500000" cy="5187367"/>
          </a:xfrm>
          <a:prstGeom prst="rect">
            <a:avLst/>
          </a:prstGeom>
        </p:spPr>
      </p:pic>
      <p:sp>
        <p:nvSpPr>
          <p:cNvPr id="45" name="Rectangle 7">
            <a:extLst>
              <a:ext uri="{FF2B5EF4-FFF2-40B4-BE49-F238E27FC236}">
                <a16:creationId xmlns:a16="http://schemas.microsoft.com/office/drawing/2014/main" id="{86896ECD-177D-6042-8254-2106B50AC8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00" y="5630405"/>
            <a:ext cx="8910000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0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Alignment of putativ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promoter regions from two ecotypes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quence comparison of putative promoter regions between HE and NHE. These regions correspond to 3276 bp and 2823 bp upstream of the translational start codon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HE and NHE, respectively. Red letters indicate nucleotide differences between the two ecotypes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671187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7FABC92F-0181-351A-8CA3-81A5726D3937}"/>
              </a:ext>
            </a:extLst>
          </p:cNvPr>
          <p:cNvGrpSpPr>
            <a:grpSpLocks noChangeAspect="1"/>
          </p:cNvGrpSpPr>
          <p:nvPr/>
        </p:nvGrpSpPr>
        <p:grpSpPr>
          <a:xfrm>
            <a:off x="1331999" y="88702"/>
            <a:ext cx="6479998" cy="6072190"/>
            <a:chOff x="1480802" y="111136"/>
            <a:chExt cx="6456424" cy="6050104"/>
          </a:xfrm>
        </p:grpSpPr>
        <p:sp>
          <p:nvSpPr>
            <p:cNvPr id="10" name="TextBox 61">
              <a:extLst>
                <a:ext uri="{FF2B5EF4-FFF2-40B4-BE49-F238E27FC236}">
                  <a16:creationId xmlns:a16="http://schemas.microsoft.com/office/drawing/2014/main" id="{B66E21F6-EC1F-A28D-A376-3273189278B1}"/>
                </a:ext>
              </a:extLst>
            </p:cNvPr>
            <p:cNvSpPr txBox="1"/>
            <p:nvPr/>
          </p:nvSpPr>
          <p:spPr>
            <a:xfrm>
              <a:off x="2213366" y="111136"/>
              <a:ext cx="540919" cy="2980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61">
              <a:extLst>
                <a:ext uri="{FF2B5EF4-FFF2-40B4-BE49-F238E27FC236}">
                  <a16:creationId xmlns:a16="http://schemas.microsoft.com/office/drawing/2014/main" id="{29D24195-537B-E4BF-F314-D50B484BCB52}"/>
                </a:ext>
              </a:extLst>
            </p:cNvPr>
            <p:cNvSpPr txBox="1"/>
            <p:nvPr/>
          </p:nvSpPr>
          <p:spPr>
            <a:xfrm>
              <a:off x="3557495" y="111136"/>
              <a:ext cx="721711" cy="2980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DsRed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61">
              <a:extLst>
                <a:ext uri="{FF2B5EF4-FFF2-40B4-BE49-F238E27FC236}">
                  <a16:creationId xmlns:a16="http://schemas.microsoft.com/office/drawing/2014/main" id="{53E69223-F716-D5A0-F97E-1A971604373C}"/>
                </a:ext>
              </a:extLst>
            </p:cNvPr>
            <p:cNvSpPr txBox="1"/>
            <p:nvPr/>
          </p:nvSpPr>
          <p:spPr>
            <a:xfrm>
              <a:off x="4830216" y="111136"/>
              <a:ext cx="1055905" cy="2980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Bright field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61">
              <a:extLst>
                <a:ext uri="{FF2B5EF4-FFF2-40B4-BE49-F238E27FC236}">
                  <a16:creationId xmlns:a16="http://schemas.microsoft.com/office/drawing/2014/main" id="{B6EB8513-244F-59E8-E1F8-643F82F95C31}"/>
                </a:ext>
              </a:extLst>
            </p:cNvPr>
            <p:cNvSpPr txBox="1"/>
            <p:nvPr/>
          </p:nvSpPr>
          <p:spPr>
            <a:xfrm>
              <a:off x="6412981" y="111136"/>
              <a:ext cx="781975" cy="2980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18">
              <a:extLst>
                <a:ext uri="{FF2B5EF4-FFF2-40B4-BE49-F238E27FC236}">
                  <a16:creationId xmlns:a16="http://schemas.microsoft.com/office/drawing/2014/main" id="{1B775BE9-22F5-80B0-71E7-4F08BBF7AAAF}"/>
                </a:ext>
              </a:extLst>
            </p:cNvPr>
            <p:cNvSpPr txBox="1"/>
            <p:nvPr/>
          </p:nvSpPr>
          <p:spPr>
            <a:xfrm rot="16200000">
              <a:off x="879836" y="950847"/>
              <a:ext cx="14558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1050" b="1" i="1">
                  <a:latin typeface="Arial" panose="020B0604020202020204" pitchFamily="34" charset="0"/>
                  <a:cs typeface="Arial" panose="020B0604020202020204" pitchFamily="34" charset="0"/>
                </a:rPr>
                <a:t>SaMTP8.1-HE-GFP</a:t>
              </a:r>
              <a:endParaRPr lang="zh-CN" altLang="en-US" sz="105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18">
              <a:extLst>
                <a:ext uri="{FF2B5EF4-FFF2-40B4-BE49-F238E27FC236}">
                  <a16:creationId xmlns:a16="http://schemas.microsoft.com/office/drawing/2014/main" id="{FBF7C08E-2CF7-D341-D7A4-39A1BC423E83}"/>
                </a:ext>
              </a:extLst>
            </p:cNvPr>
            <p:cNvSpPr txBox="1"/>
            <p:nvPr/>
          </p:nvSpPr>
          <p:spPr>
            <a:xfrm rot="16200000">
              <a:off x="830945" y="2388589"/>
              <a:ext cx="1553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1050" b="1" i="1">
                  <a:latin typeface="Arial" panose="020B0604020202020204" pitchFamily="34" charset="0"/>
                  <a:cs typeface="Arial" panose="020B0604020202020204" pitchFamily="34" charset="0"/>
                </a:rPr>
                <a:t>SaMTP8.1-NHE-GFP</a:t>
              </a:r>
              <a:endParaRPr lang="zh-CN" altLang="en-US" sz="105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Straight Connector 23">
              <a:extLst>
                <a:ext uri="{FF2B5EF4-FFF2-40B4-BE49-F238E27FC236}">
                  <a16:creationId xmlns:a16="http://schemas.microsoft.com/office/drawing/2014/main" id="{42A6D118-BB32-1981-17A7-8A12DA7A0F30}"/>
                </a:ext>
              </a:extLst>
            </p:cNvPr>
            <p:cNvCxnSpPr>
              <a:cxnSpLocks/>
            </p:cNvCxnSpPr>
            <p:nvPr/>
          </p:nvCxnSpPr>
          <p:spPr>
            <a:xfrm>
              <a:off x="7593971" y="380595"/>
              <a:ext cx="0" cy="283216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文本框 15">
              <a:extLst>
                <a:ext uri="{FF2B5EF4-FFF2-40B4-BE49-F238E27FC236}">
                  <a16:creationId xmlns:a16="http://schemas.microsoft.com/office/drawing/2014/main" id="{B41522DC-5630-2A0B-41F3-65619D1472F3}"/>
                </a:ext>
              </a:extLst>
            </p:cNvPr>
            <p:cNvSpPr txBox="1"/>
            <p:nvPr/>
          </p:nvSpPr>
          <p:spPr>
            <a:xfrm rot="16200000">
              <a:off x="7099002" y="1638894"/>
              <a:ext cx="1360878" cy="3155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HE protoplast</a:t>
              </a:r>
              <a:endParaRPr lang="zh-CN" altLang="en-US" sz="1200" b="1">
                <a:latin typeface="+mj-lt"/>
              </a:endParaRPr>
            </a:p>
          </p:txBody>
        </p:sp>
        <p:sp>
          <p:nvSpPr>
            <p:cNvPr id="46" name="TextBox 18">
              <a:extLst>
                <a:ext uri="{FF2B5EF4-FFF2-40B4-BE49-F238E27FC236}">
                  <a16:creationId xmlns:a16="http://schemas.microsoft.com/office/drawing/2014/main" id="{88B47493-A9A1-E5FC-7F37-A6BC9C3A300D}"/>
                </a:ext>
              </a:extLst>
            </p:cNvPr>
            <p:cNvSpPr txBox="1"/>
            <p:nvPr/>
          </p:nvSpPr>
          <p:spPr>
            <a:xfrm rot="16200000">
              <a:off x="830946" y="5257467"/>
              <a:ext cx="155363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1050" b="1" i="1">
                  <a:latin typeface="Arial" panose="020B0604020202020204" pitchFamily="34" charset="0"/>
                  <a:cs typeface="Arial" panose="020B0604020202020204" pitchFamily="34" charset="0"/>
                </a:rPr>
                <a:t>SaMTP8.1-NHE-GFP</a:t>
              </a:r>
              <a:endParaRPr lang="zh-CN" altLang="en-US" sz="105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" name="図 46" descr="星, 甲殻類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08DE9FC1-F274-7F4D-CFD5-29C0BC76C38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106759" y="380594"/>
              <a:ext cx="1394419" cy="1394419"/>
            </a:xfrm>
            <a:prstGeom prst="rect">
              <a:avLst/>
            </a:prstGeom>
          </p:spPr>
        </p:pic>
        <p:pic>
          <p:nvPicPr>
            <p:cNvPr id="49" name="図 48" descr="紫の光を放つ星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AB402875-FF3F-239A-427E-E576C27515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21140" y="380594"/>
              <a:ext cx="1394419" cy="1394419"/>
            </a:xfrm>
            <a:prstGeom prst="rect">
              <a:avLst/>
            </a:prstGeom>
          </p:spPr>
        </p:pic>
        <p:pic>
          <p:nvPicPr>
            <p:cNvPr id="50" name="図 49" descr="屋内, 自然, 座る, 鏡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7653CBA7-CE8C-E4CA-30A7-92DBE4228D0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60958" y="380594"/>
              <a:ext cx="1394419" cy="1394419"/>
            </a:xfrm>
            <a:prstGeom prst="rect">
              <a:avLst/>
            </a:prstGeom>
          </p:spPr>
        </p:pic>
        <p:pic>
          <p:nvPicPr>
            <p:cNvPr id="51" name="図 50" descr="星と惑星のcg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388EB121-794F-9A1A-1043-081FD2D59CF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6616" y="1818336"/>
              <a:ext cx="1394419" cy="1394419"/>
            </a:xfrm>
            <a:prstGeom prst="rect">
              <a:avLst/>
            </a:prstGeom>
          </p:spPr>
        </p:pic>
        <p:pic>
          <p:nvPicPr>
            <p:cNvPr id="52" name="図 51" descr="星と惑星のcg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FD824134-E83A-BFE8-20B2-899A832614F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21140" y="1818336"/>
              <a:ext cx="1394419" cy="1394419"/>
            </a:xfrm>
            <a:prstGeom prst="rect">
              <a:avLst/>
            </a:prstGeom>
          </p:spPr>
        </p:pic>
        <p:pic>
          <p:nvPicPr>
            <p:cNvPr id="53" name="図 52" descr="屋内, 座る, テーブル, 写真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32BCEFF9-981B-6DCC-2380-06C31254889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60958" y="1818336"/>
              <a:ext cx="1394419" cy="1394419"/>
            </a:xfrm>
            <a:prstGeom prst="rect">
              <a:avLst/>
            </a:prstGeom>
          </p:spPr>
        </p:pic>
        <p:pic>
          <p:nvPicPr>
            <p:cNvPr id="54" name="図 53" descr="バブル, チョーク, 星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26C7B13C-70D4-0FF0-1691-CF3747CEF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106759" y="1818336"/>
              <a:ext cx="1394419" cy="1394419"/>
            </a:xfrm>
            <a:prstGeom prst="rect">
              <a:avLst/>
            </a:prstGeom>
          </p:spPr>
        </p:pic>
        <p:pic>
          <p:nvPicPr>
            <p:cNvPr id="58" name="図 57" descr="緑の光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20F5B4BC-22FC-22B5-6FD7-FD9345CD0C2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6616" y="380594"/>
              <a:ext cx="1394419" cy="1394419"/>
            </a:xfrm>
            <a:prstGeom prst="rect">
              <a:avLst/>
            </a:prstGeom>
          </p:spPr>
        </p:pic>
        <p:pic>
          <p:nvPicPr>
            <p:cNvPr id="63" name="図 62" descr="緑の光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29DE904E-9BA5-FDD4-4AB1-9E06C31D13CF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6616" y="4687215"/>
              <a:ext cx="1394419" cy="1394419"/>
            </a:xfrm>
            <a:prstGeom prst="rect">
              <a:avLst/>
            </a:prstGeom>
          </p:spPr>
        </p:pic>
        <p:pic>
          <p:nvPicPr>
            <p:cNvPr id="64" name="図 63" descr="紫に光る星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DA1E13BA-14A2-2A8C-E098-914F923140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21140" y="4687215"/>
              <a:ext cx="1394419" cy="1394419"/>
            </a:xfrm>
            <a:prstGeom prst="rect">
              <a:avLst/>
            </a:prstGeom>
          </p:spPr>
        </p:pic>
        <p:pic>
          <p:nvPicPr>
            <p:cNvPr id="65" name="図 64" descr="白黒の写真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D6145FA1-329C-B5B4-D620-42A022B93BDE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60958" y="4687215"/>
              <a:ext cx="1394419" cy="1394419"/>
            </a:xfrm>
            <a:prstGeom prst="rect">
              <a:avLst/>
            </a:prstGeom>
          </p:spPr>
        </p:pic>
        <p:pic>
          <p:nvPicPr>
            <p:cNvPr id="66" name="図 65" descr="ピンク, ウニ, 座る, 紫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FC613B72-9B0B-1F68-5282-B16549436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106759" y="4687215"/>
              <a:ext cx="1394419" cy="1394419"/>
            </a:xfrm>
            <a:prstGeom prst="rect">
              <a:avLst/>
            </a:prstGeom>
          </p:spPr>
        </p:pic>
        <p:sp>
          <p:nvSpPr>
            <p:cNvPr id="67" name="TextBox 18">
              <a:extLst>
                <a:ext uri="{FF2B5EF4-FFF2-40B4-BE49-F238E27FC236}">
                  <a16:creationId xmlns:a16="http://schemas.microsoft.com/office/drawing/2014/main" id="{F592BE3D-DDF1-0BC5-9207-0916A12E8EAE}"/>
                </a:ext>
              </a:extLst>
            </p:cNvPr>
            <p:cNvSpPr txBox="1"/>
            <p:nvPr/>
          </p:nvSpPr>
          <p:spPr>
            <a:xfrm rot="16200000">
              <a:off x="879836" y="3823647"/>
              <a:ext cx="145584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50" b="1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sz="1050" b="1" i="1">
                  <a:latin typeface="Arial" panose="020B0604020202020204" pitchFamily="34" charset="0"/>
                  <a:cs typeface="Arial" panose="020B0604020202020204" pitchFamily="34" charset="0"/>
                </a:rPr>
                <a:t>SaMTP8.1-HE-GFP</a:t>
              </a:r>
              <a:endParaRPr lang="zh-CN" altLang="en-US" sz="105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Straight Connector 23">
              <a:extLst>
                <a:ext uri="{FF2B5EF4-FFF2-40B4-BE49-F238E27FC236}">
                  <a16:creationId xmlns:a16="http://schemas.microsoft.com/office/drawing/2014/main" id="{CD53E481-EEF2-28E9-74E7-2C17AA73C81F}"/>
                </a:ext>
              </a:extLst>
            </p:cNvPr>
            <p:cNvCxnSpPr>
              <a:cxnSpLocks/>
            </p:cNvCxnSpPr>
            <p:nvPr/>
          </p:nvCxnSpPr>
          <p:spPr>
            <a:xfrm>
              <a:off x="7593971" y="3256707"/>
              <a:ext cx="0" cy="2832161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文本框 15">
              <a:extLst>
                <a:ext uri="{FF2B5EF4-FFF2-40B4-BE49-F238E27FC236}">
                  <a16:creationId xmlns:a16="http://schemas.microsoft.com/office/drawing/2014/main" id="{B461A4B8-751F-7F3C-A20C-BBC404F56C27}"/>
                </a:ext>
              </a:extLst>
            </p:cNvPr>
            <p:cNvSpPr txBox="1"/>
            <p:nvPr/>
          </p:nvSpPr>
          <p:spPr>
            <a:xfrm rot="16200000">
              <a:off x="7036000" y="4515005"/>
              <a:ext cx="1486885" cy="3155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NHE protoplast</a:t>
              </a:r>
              <a:endParaRPr lang="zh-CN" altLang="en-US" sz="1200" b="1">
                <a:latin typeface="+mj-lt"/>
              </a:endParaRPr>
            </a:p>
          </p:txBody>
        </p:sp>
        <p:pic>
          <p:nvPicPr>
            <p:cNvPr id="75" name="図 74" descr="夜空に光る星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06B35733-BD1C-46E3-EE16-A41D0ED8B43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786616" y="3253394"/>
              <a:ext cx="1394419" cy="1394419"/>
            </a:xfrm>
            <a:prstGeom prst="rect">
              <a:avLst/>
            </a:prstGeom>
          </p:spPr>
        </p:pic>
        <p:pic>
          <p:nvPicPr>
            <p:cNvPr id="77" name="図 76" descr="紫の背景にある星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6A6219EB-00DB-1970-D3EE-7DF7EEAD5E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21140" y="3253394"/>
              <a:ext cx="1394419" cy="1394419"/>
            </a:xfrm>
            <a:prstGeom prst="rect">
              <a:avLst/>
            </a:prstGeom>
          </p:spPr>
        </p:pic>
        <p:pic>
          <p:nvPicPr>
            <p:cNvPr id="79" name="図 78" descr="屋内, カップ, 座る, テーブル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C2B4206E-A957-D76A-43B9-94822373156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660958" y="3253394"/>
              <a:ext cx="1394419" cy="1394419"/>
            </a:xfrm>
            <a:prstGeom prst="rect">
              <a:avLst/>
            </a:prstGeom>
          </p:spPr>
        </p:pic>
        <p:pic>
          <p:nvPicPr>
            <p:cNvPr id="81" name="図 80" descr="バブル, 星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88B906A1-441C-3365-FC69-31A0889107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106759" y="3253394"/>
              <a:ext cx="1394419" cy="1394419"/>
            </a:xfrm>
            <a:prstGeom prst="rect">
              <a:avLst/>
            </a:prstGeom>
          </p:spPr>
        </p:pic>
      </p:grpSp>
      <p:sp>
        <p:nvSpPr>
          <p:cNvPr id="82" name="Rectangle 7">
            <a:extLst>
              <a:ext uri="{FF2B5EF4-FFF2-40B4-BE49-F238E27FC236}">
                <a16:creationId xmlns:a16="http://schemas.microsoft.com/office/drawing/2014/main" id="{E1F9210C-D7EF-E736-55D0-EB2EFE95F4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00" y="6181833"/>
            <a:ext cx="8910000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>
              <a:buNone/>
            </a:pP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1</a:t>
            </a: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Expression of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and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35S-DsRed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HE and NHE protoplast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s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rotoplasts isolated from HE and NHE were co-transformed with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HE-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or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NHE-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along with p3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5S-DsRed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as an internal control. From left to right: GFP signals, DsRed signals, bright field images, and merged images. Scale bar, 10 μm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45821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図 36" descr="グラフ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1991F25-804A-6585-FCFA-D46E72D907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2000" y="1189743"/>
            <a:ext cx="2880000" cy="2880000"/>
          </a:xfrm>
          <a:prstGeom prst="rect">
            <a:avLst/>
          </a:prstGeom>
        </p:spPr>
      </p:pic>
      <p:sp>
        <p:nvSpPr>
          <p:cNvPr id="21" name="テキスト ボックス 7">
            <a:extLst>
              <a:ext uri="{FF2B5EF4-FFF2-40B4-BE49-F238E27FC236}">
                <a16:creationId xmlns:a16="http://schemas.microsoft.com/office/drawing/2014/main" id="{FF26E590-F46A-155B-EC88-C86934C955B3}"/>
              </a:ext>
            </a:extLst>
          </p:cNvPr>
          <p:cNvSpPr txBox="1"/>
          <p:nvPr/>
        </p:nvSpPr>
        <p:spPr>
          <a:xfrm>
            <a:off x="3885348" y="162732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7">
            <a:extLst>
              <a:ext uri="{FF2B5EF4-FFF2-40B4-BE49-F238E27FC236}">
                <a16:creationId xmlns:a16="http://schemas.microsoft.com/office/drawing/2014/main" id="{CD902295-970B-6E8B-1E46-F86CEBF52B05}"/>
              </a:ext>
            </a:extLst>
          </p:cNvPr>
          <p:cNvSpPr txBox="1"/>
          <p:nvPr/>
        </p:nvSpPr>
        <p:spPr>
          <a:xfrm>
            <a:off x="4350313" y="23465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7">
            <a:extLst>
              <a:ext uri="{FF2B5EF4-FFF2-40B4-BE49-F238E27FC236}">
                <a16:creationId xmlns:a16="http://schemas.microsoft.com/office/drawing/2014/main" id="{71904231-393D-B586-02FA-3A2494341420}"/>
              </a:ext>
            </a:extLst>
          </p:cNvPr>
          <p:cNvSpPr txBox="1"/>
          <p:nvPr/>
        </p:nvSpPr>
        <p:spPr>
          <a:xfrm>
            <a:off x="4917465" y="228852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7">
            <a:extLst>
              <a:ext uri="{FF2B5EF4-FFF2-40B4-BE49-F238E27FC236}">
                <a16:creationId xmlns:a16="http://schemas.microsoft.com/office/drawing/2014/main" id="{D2A43804-2649-AF49-9A0D-670AC8575194}"/>
              </a:ext>
            </a:extLst>
          </p:cNvPr>
          <p:cNvSpPr txBox="1"/>
          <p:nvPr/>
        </p:nvSpPr>
        <p:spPr>
          <a:xfrm>
            <a:off x="5390080" y="149489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7">
            <a:extLst>
              <a:ext uri="{FF2B5EF4-FFF2-40B4-BE49-F238E27FC236}">
                <a16:creationId xmlns:a16="http://schemas.microsoft.com/office/drawing/2014/main" id="{0F3B34B3-6A36-9677-5340-FBFF722798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000" y="4627557"/>
            <a:ext cx="8910000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>
              <a:buNone/>
            </a:pP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2</a:t>
            </a: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Promoter activity of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hyperaccumulating ecotype (HE) and non-hyperaccumulating ecotype (NHE) of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driven by the putative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promoter from HE and NHE was introduced into protoplast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s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solated from HE and NHE, with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35S-DsRed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as an internal control. The expression of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as normalized to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DsRed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 Expression relative to p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NHE-GF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NHE protoplast was shown. 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rotoplasts were isolated from stems of six individual plants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of each ecotype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pooled, and evenly divided into three samples for independent transformations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.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Data represent the mean ± SD of three biological replicates. Significant differences are marked by different letters at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53391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7E7742CD-2B28-CFC8-E9D3-A831EFD23A85}"/>
              </a:ext>
            </a:extLst>
          </p:cNvPr>
          <p:cNvSpPr txBox="1"/>
          <p:nvPr/>
        </p:nvSpPr>
        <p:spPr>
          <a:xfrm>
            <a:off x="117000" y="4984578"/>
            <a:ext cx="891000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3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d and Zn transport activities of SaMTP8.1 from two ecotypes in yeast (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ccharomyces cerevisiae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)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(A) Growth of Cd sensitive yeast strain Δ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ycf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arrying an empty vector (EV)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HE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NHE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or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s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a SD/-uracil/+galactose solid medium with (5 or 10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Cd) or without additional Cd supply. (B) Growth of Zn sensitive yeast strain Δ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zrc1/cot1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carrying an empty vector (EV)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HE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-NHE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or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s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in a SD/-uracil/+galactose solid medium with (200 or 500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Zn) or without additional Zn supply. The plates were incubated at 30 </a:t>
            </a:r>
            <a:r>
              <a:rPr lang="en-US" altLang="ja-JP" sz="11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C for 2 days and photographed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1085BC55-2191-D32C-151D-D2CA0EF0BA68}"/>
              </a:ext>
            </a:extLst>
          </p:cNvPr>
          <p:cNvGrpSpPr>
            <a:grpSpLocks noChangeAspect="1"/>
          </p:cNvGrpSpPr>
          <p:nvPr/>
        </p:nvGrpSpPr>
        <p:grpSpPr>
          <a:xfrm>
            <a:off x="1332000" y="1071530"/>
            <a:ext cx="6479998" cy="3518182"/>
            <a:chOff x="2584764" y="881030"/>
            <a:chExt cx="6559287" cy="3561229"/>
          </a:xfrm>
        </p:grpSpPr>
        <p:pic>
          <p:nvPicPr>
            <p:cNvPr id="32" name="Picture 31" descr="A close-up of several circles&#10;&#10;AI-generated content may be incorrect.">
              <a:extLst>
                <a:ext uri="{FF2B5EF4-FFF2-40B4-BE49-F238E27FC236}">
                  <a16:creationId xmlns:a16="http://schemas.microsoft.com/office/drawing/2014/main" id="{A0D7160F-46AC-2813-B6C7-97E9AF9AAD3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856696" y="2679986"/>
              <a:ext cx="5170319" cy="1762273"/>
            </a:xfrm>
            <a:prstGeom prst="rect">
              <a:avLst/>
            </a:prstGeom>
          </p:spPr>
        </p:pic>
        <p:sp>
          <p:nvSpPr>
            <p:cNvPr id="5" name="文本框 9">
              <a:extLst>
                <a:ext uri="{FF2B5EF4-FFF2-40B4-BE49-F238E27FC236}">
                  <a16:creationId xmlns:a16="http://schemas.microsoft.com/office/drawing/2014/main" id="{1505154E-D268-2D28-B8ED-ED909AD2153C}"/>
                </a:ext>
              </a:extLst>
            </p:cNvPr>
            <p:cNvSpPr txBox="1"/>
            <p:nvPr/>
          </p:nvSpPr>
          <p:spPr>
            <a:xfrm>
              <a:off x="4401319" y="915056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Control</a:t>
              </a:r>
              <a:endParaRPr lang="zh-CN" altLang="en-US" sz="1200" b="1"/>
            </a:p>
          </p:txBody>
        </p:sp>
        <p:sp>
          <p:nvSpPr>
            <p:cNvPr id="6" name="文本框 13">
              <a:extLst>
                <a:ext uri="{FF2B5EF4-FFF2-40B4-BE49-F238E27FC236}">
                  <a16:creationId xmlns:a16="http://schemas.microsoft.com/office/drawing/2014/main" id="{43A83290-04E1-CAB7-F49B-5C4042FD8339}"/>
                </a:ext>
              </a:extLst>
            </p:cNvPr>
            <p:cNvSpPr txBox="1"/>
            <p:nvPr/>
          </p:nvSpPr>
          <p:spPr>
            <a:xfrm>
              <a:off x="6005897" y="915056"/>
              <a:ext cx="7841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5 μM Cd</a:t>
              </a:r>
              <a:endParaRPr lang="zh-CN" altLang="en-US" sz="1200" b="1"/>
            </a:p>
          </p:txBody>
        </p:sp>
        <p:sp>
          <p:nvSpPr>
            <p:cNvPr id="7" name="文本框 14">
              <a:extLst>
                <a:ext uri="{FF2B5EF4-FFF2-40B4-BE49-F238E27FC236}">
                  <a16:creationId xmlns:a16="http://schemas.microsoft.com/office/drawing/2014/main" id="{4E9D0195-194E-B1D8-179F-EC12E72E25A7}"/>
                </a:ext>
              </a:extLst>
            </p:cNvPr>
            <p:cNvSpPr txBox="1"/>
            <p:nvPr/>
          </p:nvSpPr>
          <p:spPr>
            <a:xfrm>
              <a:off x="7547109" y="915056"/>
              <a:ext cx="8691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10 μM Cd</a:t>
              </a:r>
              <a:endParaRPr lang="zh-CN" altLang="en-US" sz="1200" b="1"/>
            </a:p>
          </p:txBody>
        </p:sp>
        <p:sp>
          <p:nvSpPr>
            <p:cNvPr id="8" name="文本框 15">
              <a:extLst>
                <a:ext uri="{FF2B5EF4-FFF2-40B4-BE49-F238E27FC236}">
                  <a16:creationId xmlns:a16="http://schemas.microsoft.com/office/drawing/2014/main" id="{07514E36-8BC6-9563-AE50-EF3B9FC7BFB8}"/>
                </a:ext>
              </a:extLst>
            </p:cNvPr>
            <p:cNvSpPr txBox="1"/>
            <p:nvPr/>
          </p:nvSpPr>
          <p:spPr>
            <a:xfrm>
              <a:off x="3521850" y="1158029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EV</a:t>
              </a:r>
              <a:endParaRPr lang="zh-CN" altLang="en-US" sz="1200" b="1"/>
            </a:p>
          </p:txBody>
        </p:sp>
        <p:sp>
          <p:nvSpPr>
            <p:cNvPr id="9" name="文本框 16">
              <a:extLst>
                <a:ext uri="{FF2B5EF4-FFF2-40B4-BE49-F238E27FC236}">
                  <a16:creationId xmlns:a16="http://schemas.microsoft.com/office/drawing/2014/main" id="{4F154125-93A8-0F24-A66A-83D7F9FCA861}"/>
                </a:ext>
              </a:extLst>
            </p:cNvPr>
            <p:cNvSpPr txBox="1"/>
            <p:nvPr/>
          </p:nvSpPr>
          <p:spPr>
            <a:xfrm>
              <a:off x="2736377" y="1506232"/>
              <a:ext cx="11753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b="1"/>
                <a:t>SaMTP8.1-HE</a:t>
              </a:r>
              <a:endParaRPr lang="zh-CN" altLang="en-US" sz="1200" b="1"/>
            </a:p>
          </p:txBody>
        </p:sp>
        <p:sp>
          <p:nvSpPr>
            <p:cNvPr id="10" name="文本框 18">
              <a:extLst>
                <a:ext uri="{FF2B5EF4-FFF2-40B4-BE49-F238E27FC236}">
                  <a16:creationId xmlns:a16="http://schemas.microsoft.com/office/drawing/2014/main" id="{08F20DC8-989A-4685-5B97-3DF0F7AB6EC3}"/>
                </a:ext>
              </a:extLst>
            </p:cNvPr>
            <p:cNvSpPr txBox="1"/>
            <p:nvPr/>
          </p:nvSpPr>
          <p:spPr>
            <a:xfrm>
              <a:off x="2625771" y="1854435"/>
              <a:ext cx="12859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b="1"/>
                <a:t>SaMTP8.1-NHE</a:t>
              </a:r>
              <a:endParaRPr lang="zh-CN" altLang="en-US" sz="1200" b="1"/>
            </a:p>
          </p:txBody>
        </p:sp>
        <p:sp>
          <p:nvSpPr>
            <p:cNvPr id="11" name="文本框 17">
              <a:extLst>
                <a:ext uri="{FF2B5EF4-FFF2-40B4-BE49-F238E27FC236}">
                  <a16:creationId xmlns:a16="http://schemas.microsoft.com/office/drawing/2014/main" id="{5AEF9C79-ADB5-2C9A-F4D1-E3C9D1886D83}"/>
                </a:ext>
              </a:extLst>
            </p:cNvPr>
            <p:cNvSpPr txBox="1"/>
            <p:nvPr/>
          </p:nvSpPr>
          <p:spPr>
            <a:xfrm>
              <a:off x="2983241" y="2202638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OsMTP8.1</a:t>
              </a:r>
              <a:endParaRPr lang="zh-CN" altLang="en-US" sz="1200" b="1"/>
            </a:p>
          </p:txBody>
        </p:sp>
        <p:pic>
          <p:nvPicPr>
            <p:cNvPr id="12" name="Picture 11" descr="A collage of images of different types of cells&#10;&#10;AI-generated content may be incorrect.">
              <a:extLst>
                <a:ext uri="{FF2B5EF4-FFF2-40B4-BE49-F238E27FC236}">
                  <a16:creationId xmlns:a16="http://schemas.microsoft.com/office/drawing/2014/main" id="{4BFF08F8-D0B5-A274-9BF5-148ADCD501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928241" y="1160389"/>
              <a:ext cx="4930009" cy="1418867"/>
            </a:xfrm>
            <a:prstGeom prst="rect">
              <a:avLst/>
            </a:prstGeom>
          </p:spPr>
        </p:pic>
        <p:sp>
          <p:nvSpPr>
            <p:cNvPr id="14" name="テキスト ボックス 7">
              <a:extLst>
                <a:ext uri="{FF2B5EF4-FFF2-40B4-BE49-F238E27FC236}">
                  <a16:creationId xmlns:a16="http://schemas.microsoft.com/office/drawing/2014/main" id="{EA33387F-B3FE-5E82-6E65-6C8877FEED41}"/>
                </a:ext>
              </a:extLst>
            </p:cNvPr>
            <p:cNvSpPr txBox="1"/>
            <p:nvPr/>
          </p:nvSpPr>
          <p:spPr>
            <a:xfrm>
              <a:off x="2584764" y="881030"/>
              <a:ext cx="402734" cy="280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15" name="テキスト ボックス 7">
              <a:extLst>
                <a:ext uri="{FF2B5EF4-FFF2-40B4-BE49-F238E27FC236}">
                  <a16:creationId xmlns:a16="http://schemas.microsoft.com/office/drawing/2014/main" id="{03991227-1849-6C62-F9B8-6CFAAED2D75C}"/>
                </a:ext>
              </a:extLst>
            </p:cNvPr>
            <p:cNvSpPr txBox="1"/>
            <p:nvPr/>
          </p:nvSpPr>
          <p:spPr>
            <a:xfrm>
              <a:off x="2584764" y="2579256"/>
              <a:ext cx="402734" cy="2803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4" name="文本框 15">
              <a:extLst>
                <a:ext uri="{FF2B5EF4-FFF2-40B4-BE49-F238E27FC236}">
                  <a16:creationId xmlns:a16="http://schemas.microsoft.com/office/drawing/2014/main" id="{C5BD7561-E74E-09CA-2911-5DBD22E99F4E}"/>
                </a:ext>
              </a:extLst>
            </p:cNvPr>
            <p:cNvSpPr txBox="1"/>
            <p:nvPr/>
          </p:nvSpPr>
          <p:spPr>
            <a:xfrm>
              <a:off x="3521850" y="2842837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EV</a:t>
              </a:r>
              <a:endParaRPr lang="zh-CN" altLang="en-US" sz="1200" b="1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06721ABE-DB95-D2E1-F1B3-C6A7C7901F0C}"/>
                </a:ext>
              </a:extLst>
            </p:cNvPr>
            <p:cNvSpPr txBox="1"/>
            <p:nvPr/>
          </p:nvSpPr>
          <p:spPr>
            <a:xfrm>
              <a:off x="2736377" y="3257503"/>
              <a:ext cx="11753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b="1"/>
                <a:t>SaMTP8.1-HE</a:t>
              </a:r>
              <a:endParaRPr lang="zh-CN" altLang="en-US" sz="1200" b="1"/>
            </a:p>
          </p:txBody>
        </p:sp>
        <p:sp>
          <p:nvSpPr>
            <p:cNvPr id="18" name="文本框 18">
              <a:extLst>
                <a:ext uri="{FF2B5EF4-FFF2-40B4-BE49-F238E27FC236}">
                  <a16:creationId xmlns:a16="http://schemas.microsoft.com/office/drawing/2014/main" id="{9FEF4706-0D60-6339-A31C-D1BBC41078C5}"/>
                </a:ext>
              </a:extLst>
            </p:cNvPr>
            <p:cNvSpPr txBox="1"/>
            <p:nvPr/>
          </p:nvSpPr>
          <p:spPr>
            <a:xfrm>
              <a:off x="2625771" y="3672169"/>
              <a:ext cx="12859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200" b="1"/>
                <a:t>SaMTP8.1-NHE</a:t>
              </a:r>
              <a:endParaRPr lang="zh-CN" altLang="en-US" sz="1200" b="1"/>
            </a:p>
          </p:txBody>
        </p:sp>
        <p:sp>
          <p:nvSpPr>
            <p:cNvPr id="19" name="文本框 17">
              <a:extLst>
                <a:ext uri="{FF2B5EF4-FFF2-40B4-BE49-F238E27FC236}">
                  <a16:creationId xmlns:a16="http://schemas.microsoft.com/office/drawing/2014/main" id="{C4DEDFE2-3DE7-A835-3A62-F3F314A61AE7}"/>
                </a:ext>
              </a:extLst>
            </p:cNvPr>
            <p:cNvSpPr txBox="1"/>
            <p:nvPr/>
          </p:nvSpPr>
          <p:spPr>
            <a:xfrm>
              <a:off x="2983241" y="4086836"/>
              <a:ext cx="928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OsMTP8.1</a:t>
              </a:r>
              <a:endParaRPr lang="zh-CN" altLang="en-US" sz="1200" b="1"/>
            </a:p>
          </p:txBody>
        </p:sp>
        <p:sp>
          <p:nvSpPr>
            <p:cNvPr id="20" name="文本框 9">
              <a:extLst>
                <a:ext uri="{FF2B5EF4-FFF2-40B4-BE49-F238E27FC236}">
                  <a16:creationId xmlns:a16="http://schemas.microsoft.com/office/drawing/2014/main" id="{4B5D7921-1E24-B265-29DA-B488432B16F3}"/>
                </a:ext>
              </a:extLst>
            </p:cNvPr>
            <p:cNvSpPr txBox="1"/>
            <p:nvPr/>
          </p:nvSpPr>
          <p:spPr>
            <a:xfrm>
              <a:off x="4401319" y="2556396"/>
              <a:ext cx="7328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/>
                <a:t>Control</a:t>
              </a:r>
              <a:endParaRPr lang="zh-CN" altLang="en-US" sz="1200" b="1"/>
            </a:p>
          </p:txBody>
        </p:sp>
        <p:sp>
          <p:nvSpPr>
            <p:cNvPr id="21" name="文本框 13">
              <a:extLst>
                <a:ext uri="{FF2B5EF4-FFF2-40B4-BE49-F238E27FC236}">
                  <a16:creationId xmlns:a16="http://schemas.microsoft.com/office/drawing/2014/main" id="{947A5600-7E8A-BB4F-48F6-1145DC66C268}"/>
                </a:ext>
              </a:extLst>
            </p:cNvPr>
            <p:cNvSpPr txBox="1"/>
            <p:nvPr/>
          </p:nvSpPr>
          <p:spPr>
            <a:xfrm>
              <a:off x="5928953" y="2556396"/>
              <a:ext cx="9380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200 μM Zn</a:t>
              </a:r>
              <a:endParaRPr lang="zh-CN" altLang="en-US" sz="1200" b="1"/>
            </a:p>
          </p:txBody>
        </p:sp>
        <p:sp>
          <p:nvSpPr>
            <p:cNvPr id="22" name="文本框 14">
              <a:extLst>
                <a:ext uri="{FF2B5EF4-FFF2-40B4-BE49-F238E27FC236}">
                  <a16:creationId xmlns:a16="http://schemas.microsoft.com/office/drawing/2014/main" id="{A235ED7F-D508-8163-C031-3F98ED6A19A5}"/>
                </a:ext>
              </a:extLst>
            </p:cNvPr>
            <p:cNvSpPr txBox="1"/>
            <p:nvPr/>
          </p:nvSpPr>
          <p:spPr>
            <a:xfrm>
              <a:off x="7512644" y="2556396"/>
              <a:ext cx="9380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500 μM Zn</a:t>
              </a:r>
              <a:endParaRPr lang="zh-CN" altLang="en-US" sz="1200" b="1"/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3A24A572-D8AA-0AF5-3EE0-53FC0072FE6D}"/>
                </a:ext>
              </a:extLst>
            </p:cNvPr>
            <p:cNvCxnSpPr>
              <a:cxnSpLocks/>
            </p:cNvCxnSpPr>
            <p:nvPr/>
          </p:nvCxnSpPr>
          <p:spPr>
            <a:xfrm>
              <a:off x="8848724" y="1201581"/>
              <a:ext cx="0" cy="12600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15">
              <a:extLst>
                <a:ext uri="{FF2B5EF4-FFF2-40B4-BE49-F238E27FC236}">
                  <a16:creationId xmlns:a16="http://schemas.microsoft.com/office/drawing/2014/main" id="{005E400C-FDF8-CD8C-4D27-38FA709A2907}"/>
                </a:ext>
              </a:extLst>
            </p:cNvPr>
            <p:cNvSpPr txBox="1"/>
            <p:nvPr/>
          </p:nvSpPr>
          <p:spPr>
            <a:xfrm rot="16200000">
              <a:off x="8704827" y="1693082"/>
              <a:ext cx="6014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Δ</a:t>
              </a:r>
              <a:r>
                <a:rPr lang="en-US" altLang="zh-CN" sz="1200" b="1" i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ycf1</a:t>
              </a:r>
              <a:endParaRPr lang="zh-CN" altLang="en-US" sz="1200" b="1">
                <a:latin typeface="+mj-lt"/>
              </a:endParaRP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009FA244-B4DE-F09A-C148-A86BD2E81AAE}"/>
                </a:ext>
              </a:extLst>
            </p:cNvPr>
            <p:cNvCxnSpPr>
              <a:cxnSpLocks/>
            </p:cNvCxnSpPr>
            <p:nvPr/>
          </p:nvCxnSpPr>
          <p:spPr>
            <a:xfrm>
              <a:off x="8848724" y="2835573"/>
              <a:ext cx="0" cy="151920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文本框 15">
              <a:extLst>
                <a:ext uri="{FF2B5EF4-FFF2-40B4-BE49-F238E27FC236}">
                  <a16:creationId xmlns:a16="http://schemas.microsoft.com/office/drawing/2014/main" id="{759E0D2A-AA1C-7012-68FA-A1AD8ED97476}"/>
                </a:ext>
              </a:extLst>
            </p:cNvPr>
            <p:cNvSpPr txBox="1"/>
            <p:nvPr/>
          </p:nvSpPr>
          <p:spPr>
            <a:xfrm rot="16200000">
              <a:off x="8525292" y="3445330"/>
              <a:ext cx="96051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Δ</a:t>
              </a:r>
              <a:r>
                <a:rPr lang="en-US" altLang="zh-CN" sz="1200" b="1" i="1" kern="0">
                  <a:latin typeface="+mj-lt"/>
                  <a:ea typeface="宋体" panose="02010600030101010101" pitchFamily="2" charset="-122"/>
                  <a:cs typeface="Arial" panose="020B0604020202020204" pitchFamily="34" charset="0"/>
                </a:rPr>
                <a:t>zrc1/cot1</a:t>
              </a:r>
              <a:endParaRPr lang="zh-CN" altLang="en-US" sz="1200" b="1">
                <a:latin typeface="+mj-lt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9735797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AC94F770-76F3-CD82-C40D-42CA45A19D78}"/>
              </a:ext>
            </a:extLst>
          </p:cNvPr>
          <p:cNvGrpSpPr>
            <a:grpSpLocks noChangeAspect="1"/>
          </p:cNvGrpSpPr>
          <p:nvPr/>
        </p:nvGrpSpPr>
        <p:grpSpPr>
          <a:xfrm>
            <a:off x="1311754" y="148771"/>
            <a:ext cx="6509148" cy="5749151"/>
            <a:chOff x="884795" y="118890"/>
            <a:chExt cx="7061147" cy="6236702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CD2F699-4012-18A2-B180-BC0D2B81765B}"/>
                </a:ext>
              </a:extLst>
            </p:cNvPr>
            <p:cNvGrpSpPr/>
            <p:nvPr/>
          </p:nvGrpSpPr>
          <p:grpSpPr>
            <a:xfrm>
              <a:off x="1191554" y="182745"/>
              <a:ext cx="2142837" cy="2142837"/>
              <a:chOff x="3821589" y="559109"/>
              <a:chExt cx="2160000" cy="2160000"/>
            </a:xfrm>
          </p:grpSpPr>
          <p:pic>
            <p:nvPicPr>
              <p:cNvPr id="77" name="Picture 76" descr="A graph of a graph showing the amount of mg in a certain amount&#10;&#10;AI-generated content may be incorrect.">
                <a:extLst>
                  <a:ext uri="{FF2B5EF4-FFF2-40B4-BE49-F238E27FC236}">
                    <a16:creationId xmlns:a16="http://schemas.microsoft.com/office/drawing/2014/main" id="{D3083C22-FB0A-316A-B115-A881219A8F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21589" y="55910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84" name="テキスト ボックス 7">
                <a:extLst>
                  <a:ext uri="{FF2B5EF4-FFF2-40B4-BE49-F238E27FC236}">
                    <a16:creationId xmlns:a16="http://schemas.microsoft.com/office/drawing/2014/main" id="{29C04F4B-5BF9-6E69-66BC-3A5EF828A9C9}"/>
                  </a:ext>
                </a:extLst>
              </p:cNvPr>
              <p:cNvSpPr txBox="1"/>
              <p:nvPr/>
            </p:nvSpPr>
            <p:spPr>
              <a:xfrm>
                <a:off x="4399683" y="96994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5" name="テキスト ボックス 7">
                <a:extLst>
                  <a:ext uri="{FF2B5EF4-FFF2-40B4-BE49-F238E27FC236}">
                    <a16:creationId xmlns:a16="http://schemas.microsoft.com/office/drawing/2014/main" id="{8BE97B76-6EB2-D5CE-42BB-AABD2EB2F533}"/>
                  </a:ext>
                </a:extLst>
              </p:cNvPr>
              <p:cNvSpPr txBox="1"/>
              <p:nvPr/>
            </p:nvSpPr>
            <p:spPr>
              <a:xfrm>
                <a:off x="4783977" y="1053751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  <p:sp>
            <p:nvSpPr>
              <p:cNvPr id="86" name="テキスト ボックス 7">
                <a:extLst>
                  <a:ext uri="{FF2B5EF4-FFF2-40B4-BE49-F238E27FC236}">
                    <a16:creationId xmlns:a16="http://schemas.microsoft.com/office/drawing/2014/main" id="{06DF3F1A-78BB-7768-895F-F0C6BBADC408}"/>
                  </a:ext>
                </a:extLst>
              </p:cNvPr>
              <p:cNvSpPr txBox="1"/>
              <p:nvPr/>
            </p:nvSpPr>
            <p:spPr>
              <a:xfrm>
                <a:off x="5169611" y="1043226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  <p:sp>
            <p:nvSpPr>
              <p:cNvPr id="87" name="テキスト ボックス 7">
                <a:extLst>
                  <a:ext uri="{FF2B5EF4-FFF2-40B4-BE49-F238E27FC236}">
                    <a16:creationId xmlns:a16="http://schemas.microsoft.com/office/drawing/2014/main" id="{218236ED-A403-9C5F-2C34-957FBB6D6F19}"/>
                  </a:ext>
                </a:extLst>
              </p:cNvPr>
              <p:cNvSpPr txBox="1"/>
              <p:nvPr/>
            </p:nvSpPr>
            <p:spPr>
              <a:xfrm>
                <a:off x="5557158" y="1072516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1358D61F-167D-114B-C1B3-0FEB392A8011}"/>
                </a:ext>
              </a:extLst>
            </p:cNvPr>
            <p:cNvGrpSpPr/>
            <p:nvPr/>
          </p:nvGrpSpPr>
          <p:grpSpPr>
            <a:xfrm>
              <a:off x="3521826" y="182745"/>
              <a:ext cx="2142837" cy="2142837"/>
              <a:chOff x="5981589" y="559109"/>
              <a:chExt cx="2160000" cy="2160000"/>
            </a:xfrm>
          </p:grpSpPr>
          <p:pic>
            <p:nvPicPr>
              <p:cNvPr id="83" name="Picture 82" descr="A graph of a graph of a graph&#10;&#10;AI-generated content may be incorrect.">
                <a:extLst>
                  <a:ext uri="{FF2B5EF4-FFF2-40B4-BE49-F238E27FC236}">
                    <a16:creationId xmlns:a16="http://schemas.microsoft.com/office/drawing/2014/main" id="{5DE5E300-3DB6-0866-783F-DD329C09071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81589" y="55910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88" name="テキスト ボックス 7">
                <a:extLst>
                  <a:ext uri="{FF2B5EF4-FFF2-40B4-BE49-F238E27FC236}">
                    <a16:creationId xmlns:a16="http://schemas.microsoft.com/office/drawing/2014/main" id="{08F83C23-A8EB-D4A6-0D7F-EC1FC72F0A10}"/>
                  </a:ext>
                </a:extLst>
              </p:cNvPr>
              <p:cNvSpPr txBox="1"/>
              <p:nvPr/>
            </p:nvSpPr>
            <p:spPr>
              <a:xfrm>
                <a:off x="6611885" y="97232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9" name="テキスト ボックス 7">
                <a:extLst>
                  <a:ext uri="{FF2B5EF4-FFF2-40B4-BE49-F238E27FC236}">
                    <a16:creationId xmlns:a16="http://schemas.microsoft.com/office/drawing/2014/main" id="{103FF474-489C-FF6F-5AD8-0B3A3BBC0ECA}"/>
                  </a:ext>
                </a:extLst>
              </p:cNvPr>
              <p:cNvSpPr txBox="1"/>
              <p:nvPr/>
            </p:nvSpPr>
            <p:spPr>
              <a:xfrm>
                <a:off x="6978598" y="98156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0" name="テキスト ボックス 7">
                <a:extLst>
                  <a:ext uri="{FF2B5EF4-FFF2-40B4-BE49-F238E27FC236}">
                    <a16:creationId xmlns:a16="http://schemas.microsoft.com/office/drawing/2014/main" id="{AEF90F8A-4E6C-0277-06EB-2696FB06303B}"/>
                  </a:ext>
                </a:extLst>
              </p:cNvPr>
              <p:cNvSpPr txBox="1"/>
              <p:nvPr/>
            </p:nvSpPr>
            <p:spPr>
              <a:xfrm>
                <a:off x="7352508" y="95803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1" name="テキスト ボックス 7">
                <a:extLst>
                  <a:ext uri="{FF2B5EF4-FFF2-40B4-BE49-F238E27FC236}">
                    <a16:creationId xmlns:a16="http://schemas.microsoft.com/office/drawing/2014/main" id="{7F4CC89D-31B1-3F3B-7377-B2A1BBF8E4CC}"/>
                  </a:ext>
                </a:extLst>
              </p:cNvPr>
              <p:cNvSpPr txBox="1"/>
              <p:nvPr/>
            </p:nvSpPr>
            <p:spPr>
              <a:xfrm>
                <a:off x="7722873" y="98870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AE687C38-84DE-7B61-B319-59031EC9B2EB}"/>
                </a:ext>
              </a:extLst>
            </p:cNvPr>
            <p:cNvGrpSpPr/>
            <p:nvPr/>
          </p:nvGrpSpPr>
          <p:grpSpPr>
            <a:xfrm>
              <a:off x="5803105" y="182745"/>
              <a:ext cx="2142837" cy="2142837"/>
              <a:chOff x="8154223" y="559109"/>
              <a:chExt cx="2160000" cy="2160000"/>
            </a:xfrm>
          </p:grpSpPr>
          <p:pic>
            <p:nvPicPr>
              <p:cNvPr id="82" name="Picture 81" descr="A graph of a graph of a graph&#10;&#10;AI-generated content may be incorrect.">
                <a:extLst>
                  <a:ext uri="{FF2B5EF4-FFF2-40B4-BE49-F238E27FC236}">
                    <a16:creationId xmlns:a16="http://schemas.microsoft.com/office/drawing/2014/main" id="{8C913CAB-53A0-742A-A59E-ABD4F0F99C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54223" y="55910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93" name="テキスト ボックス 7">
                <a:extLst>
                  <a:ext uri="{FF2B5EF4-FFF2-40B4-BE49-F238E27FC236}">
                    <a16:creationId xmlns:a16="http://schemas.microsoft.com/office/drawing/2014/main" id="{0D8C0D5D-7116-8E87-C15B-CC3561D6DC05}"/>
                  </a:ext>
                </a:extLst>
              </p:cNvPr>
              <p:cNvSpPr txBox="1"/>
              <p:nvPr/>
            </p:nvSpPr>
            <p:spPr>
              <a:xfrm>
                <a:off x="8784235" y="81155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4" name="テキスト ボックス 7">
                <a:extLst>
                  <a:ext uri="{FF2B5EF4-FFF2-40B4-BE49-F238E27FC236}">
                    <a16:creationId xmlns:a16="http://schemas.microsoft.com/office/drawing/2014/main" id="{48917F53-0F72-DCC7-044E-0CEFD6F59F3E}"/>
                  </a:ext>
                </a:extLst>
              </p:cNvPr>
              <p:cNvSpPr txBox="1"/>
              <p:nvPr/>
            </p:nvSpPr>
            <p:spPr>
              <a:xfrm>
                <a:off x="9155711" y="86156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5" name="テキスト ボックス 7">
                <a:extLst>
                  <a:ext uri="{FF2B5EF4-FFF2-40B4-BE49-F238E27FC236}">
                    <a16:creationId xmlns:a16="http://schemas.microsoft.com/office/drawing/2014/main" id="{FC7FD9BC-3578-9920-E4F4-6E664F08EE7F}"/>
                  </a:ext>
                </a:extLst>
              </p:cNvPr>
              <p:cNvSpPr txBox="1"/>
              <p:nvPr/>
            </p:nvSpPr>
            <p:spPr>
              <a:xfrm>
                <a:off x="9527940" y="80440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6" name="テキスト ボックス 7">
                <a:extLst>
                  <a:ext uri="{FF2B5EF4-FFF2-40B4-BE49-F238E27FC236}">
                    <a16:creationId xmlns:a16="http://schemas.microsoft.com/office/drawing/2014/main" id="{C20B7EAA-80E8-55F4-BF70-AD92FC228800}"/>
                  </a:ext>
                </a:extLst>
              </p:cNvPr>
              <p:cNvSpPr txBox="1"/>
              <p:nvPr/>
            </p:nvSpPr>
            <p:spPr>
              <a:xfrm>
                <a:off x="9899416" y="8401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3F77F583-867A-5229-5DCC-8E60AB47D18F}"/>
                </a:ext>
              </a:extLst>
            </p:cNvPr>
            <p:cNvGrpSpPr/>
            <p:nvPr/>
          </p:nvGrpSpPr>
          <p:grpSpPr>
            <a:xfrm>
              <a:off x="1191554" y="2201755"/>
              <a:ext cx="2142837" cy="2142837"/>
              <a:chOff x="1705655" y="2623399"/>
              <a:chExt cx="2160000" cy="2160000"/>
            </a:xfrm>
          </p:grpSpPr>
          <p:pic>
            <p:nvPicPr>
              <p:cNvPr id="81" name="Picture 80" descr="A graph of a graph showing the amount of weight&#10;&#10;AI-generated content may be incorrect.">
                <a:extLst>
                  <a:ext uri="{FF2B5EF4-FFF2-40B4-BE49-F238E27FC236}">
                    <a16:creationId xmlns:a16="http://schemas.microsoft.com/office/drawing/2014/main" id="{68C7445B-0331-CC0F-6CE8-1A5D8151C6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05655" y="262339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97" name="テキスト ボックス 7">
                <a:extLst>
                  <a:ext uri="{FF2B5EF4-FFF2-40B4-BE49-F238E27FC236}">
                    <a16:creationId xmlns:a16="http://schemas.microsoft.com/office/drawing/2014/main" id="{47216C09-720E-9E19-8B9C-D31FFBB86027}"/>
                  </a:ext>
                </a:extLst>
              </p:cNvPr>
              <p:cNvSpPr txBox="1"/>
              <p:nvPr/>
            </p:nvSpPr>
            <p:spPr>
              <a:xfrm>
                <a:off x="2289775" y="291690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98" name="テキスト ボックス 7">
                <a:extLst>
                  <a:ext uri="{FF2B5EF4-FFF2-40B4-BE49-F238E27FC236}">
                    <a16:creationId xmlns:a16="http://schemas.microsoft.com/office/drawing/2014/main" id="{DB7F2CF1-BF7E-05D9-4555-735843071357}"/>
                  </a:ext>
                </a:extLst>
              </p:cNvPr>
              <p:cNvSpPr txBox="1"/>
              <p:nvPr/>
            </p:nvSpPr>
            <p:spPr>
              <a:xfrm>
                <a:off x="2663869" y="3058794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  <p:sp>
            <p:nvSpPr>
              <p:cNvPr id="99" name="テキスト ボックス 7">
                <a:extLst>
                  <a:ext uri="{FF2B5EF4-FFF2-40B4-BE49-F238E27FC236}">
                    <a16:creationId xmlns:a16="http://schemas.microsoft.com/office/drawing/2014/main" id="{5C1C01E5-75FC-1216-B559-546E77E6C35E}"/>
                  </a:ext>
                </a:extLst>
              </p:cNvPr>
              <p:cNvSpPr txBox="1"/>
              <p:nvPr/>
            </p:nvSpPr>
            <p:spPr>
              <a:xfrm>
                <a:off x="3437840" y="3081019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  <p:sp>
            <p:nvSpPr>
              <p:cNvPr id="100" name="テキスト ボックス 7">
                <a:extLst>
                  <a:ext uri="{FF2B5EF4-FFF2-40B4-BE49-F238E27FC236}">
                    <a16:creationId xmlns:a16="http://schemas.microsoft.com/office/drawing/2014/main" id="{E1B09A4E-DBE1-946C-2DA5-0A29B5C4E523}"/>
                  </a:ext>
                </a:extLst>
              </p:cNvPr>
              <p:cNvSpPr txBox="1"/>
              <p:nvPr/>
            </p:nvSpPr>
            <p:spPr>
              <a:xfrm>
                <a:off x="3052993" y="3178729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c</a:t>
                </a:r>
                <a:endParaRPr lang="zh-CN" altLang="en-US" sz="1000" b="1"/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99E305A-6040-E28D-D758-F267A6B297B2}"/>
                </a:ext>
              </a:extLst>
            </p:cNvPr>
            <p:cNvGrpSpPr/>
            <p:nvPr/>
          </p:nvGrpSpPr>
          <p:grpSpPr>
            <a:xfrm>
              <a:off x="3521826" y="2201755"/>
              <a:ext cx="2142837" cy="2142837"/>
              <a:chOff x="3826300" y="2623399"/>
              <a:chExt cx="2160000" cy="2160000"/>
            </a:xfrm>
          </p:grpSpPr>
          <p:pic>
            <p:nvPicPr>
              <p:cNvPr id="80" name="Picture 79" descr="A graph of a graph showing the amount of fe in a certain number&#10;&#10;AI-generated content may be incorrect.">
                <a:extLst>
                  <a:ext uri="{FF2B5EF4-FFF2-40B4-BE49-F238E27FC236}">
                    <a16:creationId xmlns:a16="http://schemas.microsoft.com/office/drawing/2014/main" id="{E472691A-4B6A-BEB3-DE27-F61471ADB6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26300" y="262339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101" name="テキスト ボックス 7">
                <a:extLst>
                  <a:ext uri="{FF2B5EF4-FFF2-40B4-BE49-F238E27FC236}">
                    <a16:creationId xmlns:a16="http://schemas.microsoft.com/office/drawing/2014/main" id="{E0A74196-2D96-7D77-3352-5FF7AEB8C18F}"/>
                  </a:ext>
                </a:extLst>
              </p:cNvPr>
              <p:cNvSpPr txBox="1"/>
              <p:nvPr/>
            </p:nvSpPr>
            <p:spPr>
              <a:xfrm>
                <a:off x="4352486" y="3068622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02" name="テキスト ボックス 7">
                <a:extLst>
                  <a:ext uri="{FF2B5EF4-FFF2-40B4-BE49-F238E27FC236}">
                    <a16:creationId xmlns:a16="http://schemas.microsoft.com/office/drawing/2014/main" id="{31570DDA-B008-2A62-4E7B-478CCC5581D7}"/>
                  </a:ext>
                </a:extLst>
              </p:cNvPr>
              <p:cNvSpPr txBox="1"/>
              <p:nvPr/>
            </p:nvSpPr>
            <p:spPr>
              <a:xfrm>
                <a:off x="4751910" y="3257389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03" name="テキスト ボックス 7">
                <a:extLst>
                  <a:ext uri="{FF2B5EF4-FFF2-40B4-BE49-F238E27FC236}">
                    <a16:creationId xmlns:a16="http://schemas.microsoft.com/office/drawing/2014/main" id="{AD73CBDE-1BAF-B19D-11B6-16A36572F2D1}"/>
                  </a:ext>
                </a:extLst>
              </p:cNvPr>
              <p:cNvSpPr txBox="1"/>
              <p:nvPr/>
            </p:nvSpPr>
            <p:spPr>
              <a:xfrm>
                <a:off x="5152444" y="3055922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04" name="テキスト ボックス 7">
                <a:extLst>
                  <a:ext uri="{FF2B5EF4-FFF2-40B4-BE49-F238E27FC236}">
                    <a16:creationId xmlns:a16="http://schemas.microsoft.com/office/drawing/2014/main" id="{9281F98C-C196-263F-7041-C1D90AB51AB1}"/>
                  </a:ext>
                </a:extLst>
              </p:cNvPr>
              <p:cNvSpPr txBox="1"/>
              <p:nvPr/>
            </p:nvSpPr>
            <p:spPr>
              <a:xfrm>
                <a:off x="5547254" y="3011389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48727D59-5610-D6E5-B202-0B74677A20D8}"/>
                </a:ext>
              </a:extLst>
            </p:cNvPr>
            <p:cNvGrpSpPr/>
            <p:nvPr/>
          </p:nvGrpSpPr>
          <p:grpSpPr>
            <a:xfrm>
              <a:off x="5803105" y="2201755"/>
              <a:ext cx="2142837" cy="2142837"/>
              <a:chOff x="6010982" y="2623399"/>
              <a:chExt cx="2160000" cy="2160000"/>
            </a:xfrm>
          </p:grpSpPr>
          <p:pic>
            <p:nvPicPr>
              <p:cNvPr id="78" name="Picture 77" descr="A graph of a number of objects&#10;&#10;AI-generated content may be incorrect.">
                <a:extLst>
                  <a:ext uri="{FF2B5EF4-FFF2-40B4-BE49-F238E27FC236}">
                    <a16:creationId xmlns:a16="http://schemas.microsoft.com/office/drawing/2014/main" id="{EFD0A592-2BFE-BDBF-3AE7-0E1BCB0F96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10982" y="262339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105" name="テキスト ボックス 7">
                <a:extLst>
                  <a:ext uri="{FF2B5EF4-FFF2-40B4-BE49-F238E27FC236}">
                    <a16:creationId xmlns:a16="http://schemas.microsoft.com/office/drawing/2014/main" id="{25F96B5C-0212-56FB-7C51-C941062D76C9}"/>
                  </a:ext>
                </a:extLst>
              </p:cNvPr>
              <p:cNvSpPr txBox="1"/>
              <p:nvPr/>
            </p:nvSpPr>
            <p:spPr>
              <a:xfrm>
                <a:off x="6490043" y="305445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06" name="テキスト ボックス 7">
                <a:extLst>
                  <a:ext uri="{FF2B5EF4-FFF2-40B4-BE49-F238E27FC236}">
                    <a16:creationId xmlns:a16="http://schemas.microsoft.com/office/drawing/2014/main" id="{E50ACE19-4D64-843C-C27F-78C7198D0E55}"/>
                  </a:ext>
                </a:extLst>
              </p:cNvPr>
              <p:cNvSpPr txBox="1"/>
              <p:nvPr/>
            </p:nvSpPr>
            <p:spPr>
              <a:xfrm>
                <a:off x="6861935" y="3057626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b</a:t>
                </a:r>
                <a:endParaRPr lang="zh-CN" altLang="en-US" sz="1000" b="1"/>
              </a:p>
            </p:txBody>
          </p:sp>
          <p:sp>
            <p:nvSpPr>
              <p:cNvPr id="107" name="テキスト ボックス 7">
                <a:extLst>
                  <a:ext uri="{FF2B5EF4-FFF2-40B4-BE49-F238E27FC236}">
                    <a16:creationId xmlns:a16="http://schemas.microsoft.com/office/drawing/2014/main" id="{17E744E6-7246-820B-A06B-4063718CC7C7}"/>
                  </a:ext>
                </a:extLst>
              </p:cNvPr>
              <p:cNvSpPr txBox="1"/>
              <p:nvPr/>
            </p:nvSpPr>
            <p:spPr>
              <a:xfrm>
                <a:off x="7691595" y="3199786"/>
                <a:ext cx="3337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c</a:t>
                </a:r>
                <a:endParaRPr lang="zh-CN" altLang="en-US" sz="1000" b="1"/>
              </a:p>
            </p:txBody>
          </p:sp>
          <p:sp>
            <p:nvSpPr>
              <p:cNvPr id="108" name="テキスト ボックス 7">
                <a:extLst>
                  <a:ext uri="{FF2B5EF4-FFF2-40B4-BE49-F238E27FC236}">
                    <a16:creationId xmlns:a16="http://schemas.microsoft.com/office/drawing/2014/main" id="{215DCFEC-2BF3-DFDB-2A6B-5B12AAE3169A}"/>
                  </a:ext>
                </a:extLst>
              </p:cNvPr>
              <p:cNvSpPr txBox="1"/>
              <p:nvPr/>
            </p:nvSpPr>
            <p:spPr>
              <a:xfrm>
                <a:off x="7317890" y="317438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c</a:t>
                </a:r>
                <a:endParaRPr lang="zh-CN" altLang="en-US" sz="1000" b="1"/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0432618C-05EA-D300-B81A-006E90CE702C}"/>
                </a:ext>
              </a:extLst>
            </p:cNvPr>
            <p:cNvGrpSpPr/>
            <p:nvPr/>
          </p:nvGrpSpPr>
          <p:grpSpPr>
            <a:xfrm>
              <a:off x="1191554" y="4212755"/>
              <a:ext cx="2142837" cy="2142837"/>
              <a:chOff x="8177299" y="2623399"/>
              <a:chExt cx="2160000" cy="2160000"/>
            </a:xfrm>
          </p:grpSpPr>
          <p:pic>
            <p:nvPicPr>
              <p:cNvPr id="79" name="Picture 78" descr="A graph of a graph showing the amount of zinc in different sizes&#10;&#10;AI-generated content may be incorrect.">
                <a:extLst>
                  <a:ext uri="{FF2B5EF4-FFF2-40B4-BE49-F238E27FC236}">
                    <a16:creationId xmlns:a16="http://schemas.microsoft.com/office/drawing/2014/main" id="{E18727E1-8F7C-AC62-8C22-BBC17F6B28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177299" y="2623399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109" name="テキスト ボックス 7">
                <a:extLst>
                  <a:ext uri="{FF2B5EF4-FFF2-40B4-BE49-F238E27FC236}">
                    <a16:creationId xmlns:a16="http://schemas.microsoft.com/office/drawing/2014/main" id="{86AA50F2-239C-D60C-9960-A7294520040C}"/>
                  </a:ext>
                </a:extLst>
              </p:cNvPr>
              <p:cNvSpPr txBox="1"/>
              <p:nvPr/>
            </p:nvSpPr>
            <p:spPr>
              <a:xfrm>
                <a:off x="9104673" y="309334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10" name="テキスト ボックス 7">
                <a:extLst>
                  <a:ext uri="{FF2B5EF4-FFF2-40B4-BE49-F238E27FC236}">
                    <a16:creationId xmlns:a16="http://schemas.microsoft.com/office/drawing/2014/main" id="{528851AC-3AB4-73D6-0160-B93B9F31B553}"/>
                  </a:ext>
                </a:extLst>
              </p:cNvPr>
              <p:cNvSpPr txBox="1"/>
              <p:nvPr/>
            </p:nvSpPr>
            <p:spPr>
              <a:xfrm>
                <a:off x="9502711" y="304889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11" name="テキスト ボックス 7">
                <a:extLst>
                  <a:ext uri="{FF2B5EF4-FFF2-40B4-BE49-F238E27FC236}">
                    <a16:creationId xmlns:a16="http://schemas.microsoft.com/office/drawing/2014/main" id="{3D19CF76-EDC3-07BB-899E-BCC554A2B892}"/>
                  </a:ext>
                </a:extLst>
              </p:cNvPr>
              <p:cNvSpPr txBox="1"/>
              <p:nvPr/>
            </p:nvSpPr>
            <p:spPr>
              <a:xfrm>
                <a:off x="9903130" y="310626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12" name="テキスト ボックス 7">
                <a:extLst>
                  <a:ext uri="{FF2B5EF4-FFF2-40B4-BE49-F238E27FC236}">
                    <a16:creationId xmlns:a16="http://schemas.microsoft.com/office/drawing/2014/main" id="{51A98370-A145-85A9-F26F-88DD167249D1}"/>
                  </a:ext>
                </a:extLst>
              </p:cNvPr>
              <p:cNvSpPr txBox="1"/>
              <p:nvPr/>
            </p:nvSpPr>
            <p:spPr>
              <a:xfrm>
                <a:off x="8701406" y="3175974"/>
                <a:ext cx="2632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b</a:t>
                </a:r>
                <a:endParaRPr lang="zh-CN" altLang="en-US" sz="1000" b="1"/>
              </a:p>
            </p:txBody>
          </p:sp>
        </p:grpSp>
        <p:sp>
          <p:nvSpPr>
            <p:cNvPr id="11" name="テキスト ボックス 4">
              <a:extLst>
                <a:ext uri="{FF2B5EF4-FFF2-40B4-BE49-F238E27FC236}">
                  <a16:creationId xmlns:a16="http://schemas.microsoft.com/office/drawing/2014/main" id="{2C0529D5-D538-8937-DDEB-F1E65C1B5E96}"/>
                </a:ext>
              </a:extLst>
            </p:cNvPr>
            <p:cNvSpPr txBox="1"/>
            <p:nvPr/>
          </p:nvSpPr>
          <p:spPr>
            <a:xfrm>
              <a:off x="890012" y="118890"/>
              <a:ext cx="431606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12" name="テキスト ボックス 4">
              <a:extLst>
                <a:ext uri="{FF2B5EF4-FFF2-40B4-BE49-F238E27FC236}">
                  <a16:creationId xmlns:a16="http://schemas.microsoft.com/office/drawing/2014/main" id="{D7860481-ABA4-A926-C48C-24A7F90F26C0}"/>
                </a:ext>
              </a:extLst>
            </p:cNvPr>
            <p:cNvSpPr txBox="1"/>
            <p:nvPr/>
          </p:nvSpPr>
          <p:spPr>
            <a:xfrm>
              <a:off x="3234178" y="118890"/>
              <a:ext cx="431606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13" name="テキスト ボックス 4">
              <a:extLst>
                <a:ext uri="{FF2B5EF4-FFF2-40B4-BE49-F238E27FC236}">
                  <a16:creationId xmlns:a16="http://schemas.microsoft.com/office/drawing/2014/main" id="{8D7C34D6-CD87-897E-5586-C1193DA15CA9}"/>
                </a:ext>
              </a:extLst>
            </p:cNvPr>
            <p:cNvSpPr txBox="1"/>
            <p:nvPr/>
          </p:nvSpPr>
          <p:spPr>
            <a:xfrm>
              <a:off x="5512995" y="118890"/>
              <a:ext cx="431606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sp>
          <p:nvSpPr>
            <p:cNvPr id="14" name="テキスト ボックス 4">
              <a:extLst>
                <a:ext uri="{FF2B5EF4-FFF2-40B4-BE49-F238E27FC236}">
                  <a16:creationId xmlns:a16="http://schemas.microsoft.com/office/drawing/2014/main" id="{C2118672-3F23-C03C-00C8-3B3664CA5C42}"/>
                </a:ext>
              </a:extLst>
            </p:cNvPr>
            <p:cNvSpPr txBox="1"/>
            <p:nvPr/>
          </p:nvSpPr>
          <p:spPr>
            <a:xfrm>
              <a:off x="890013" y="2121879"/>
              <a:ext cx="431606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15" name="テキスト ボックス 4">
              <a:extLst>
                <a:ext uri="{FF2B5EF4-FFF2-40B4-BE49-F238E27FC236}">
                  <a16:creationId xmlns:a16="http://schemas.microsoft.com/office/drawing/2014/main" id="{6005BD6F-206B-BE0A-8A16-F12FB5701D32}"/>
                </a:ext>
              </a:extLst>
            </p:cNvPr>
            <p:cNvSpPr txBox="1"/>
            <p:nvPr/>
          </p:nvSpPr>
          <p:spPr>
            <a:xfrm>
              <a:off x="3238527" y="2121879"/>
              <a:ext cx="422911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16" name="テキスト ボックス 4">
              <a:extLst>
                <a:ext uri="{FF2B5EF4-FFF2-40B4-BE49-F238E27FC236}">
                  <a16:creationId xmlns:a16="http://schemas.microsoft.com/office/drawing/2014/main" id="{5D65F8AB-EC32-8311-FC12-119C9CC2F88A}"/>
                </a:ext>
              </a:extLst>
            </p:cNvPr>
            <p:cNvSpPr txBox="1"/>
            <p:nvPr/>
          </p:nvSpPr>
          <p:spPr>
            <a:xfrm>
              <a:off x="5521691" y="2121879"/>
              <a:ext cx="414217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  <p:sp>
          <p:nvSpPr>
            <p:cNvPr id="17" name="テキスト ボックス 4">
              <a:extLst>
                <a:ext uri="{FF2B5EF4-FFF2-40B4-BE49-F238E27FC236}">
                  <a16:creationId xmlns:a16="http://schemas.microsoft.com/office/drawing/2014/main" id="{A883D369-F644-2CF3-D889-8D66B3FF2C5D}"/>
                </a:ext>
              </a:extLst>
            </p:cNvPr>
            <p:cNvSpPr txBox="1"/>
            <p:nvPr/>
          </p:nvSpPr>
          <p:spPr>
            <a:xfrm>
              <a:off x="884795" y="4135802"/>
              <a:ext cx="442040" cy="300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</p:grpSp>
      <p:sp>
        <p:nvSpPr>
          <p:cNvPr id="21" name="TextBox 15">
            <a:extLst>
              <a:ext uri="{FF2B5EF4-FFF2-40B4-BE49-F238E27FC236}">
                <a16:creationId xmlns:a16="http://schemas.microsoft.com/office/drawing/2014/main" id="{3E17923C-6528-88A8-14E7-E5F054F6F197}"/>
              </a:ext>
            </a:extLst>
          </p:cNvPr>
          <p:cNvSpPr txBox="1"/>
          <p:nvPr/>
        </p:nvSpPr>
        <p:spPr>
          <a:xfrm>
            <a:off x="117000" y="5726474"/>
            <a:ext cx="8910000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4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Effect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omplementation in ric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s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mutant on mineral (Mg, P, K, Ca, Fe, Cu, and Zn) accumulation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Concentrations of Mg (A), P (B), K (C), Ca (D), Fe (E), Cu (F), and Zn (G) in the shoots of wild-type rice (WT, cv. Nipponbare)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s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mutant, and two complementation lines (Comp#1 and Comp#2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from HE under the control of ric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s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promoter. Seedlings (17-d old) were treated with 500 μM Mn for 4 days. The mineral concentrations were determined by ICP-MS after digestion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DW, dry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66926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20E29743-C3CF-318D-42F2-7B206212A56E}"/>
              </a:ext>
            </a:extLst>
          </p:cNvPr>
          <p:cNvSpPr txBox="1"/>
          <p:nvPr/>
        </p:nvSpPr>
        <p:spPr>
          <a:xfrm>
            <a:off x="117000" y="5723188"/>
            <a:ext cx="891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5</a:t>
            </a: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Effect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overexpression in wild-type Arabidopsis on mineral (Mg, P, K, Ca, Fe, Cu, and Zn) accumulation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Concentrations of Mg (A), P (B), K (C), Ca (D), Fe (E), Cu (F), and Zn (G) in the shoots of wild-type Arabidopsis Col-0 (WT) and two overexpression lines (OX#1 and OX#2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from HE under the control of its own promoter. The plants were treated with 0.5 or 100 μM Mn for 10 days. The mineral concentrations were determined by ICP-MS after digestion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FW, fresh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0278F5C0-0722-7A20-A250-4084BAE0F3EB}"/>
              </a:ext>
            </a:extLst>
          </p:cNvPr>
          <p:cNvGrpSpPr/>
          <p:nvPr/>
        </p:nvGrpSpPr>
        <p:grpSpPr>
          <a:xfrm>
            <a:off x="1306634" y="73410"/>
            <a:ext cx="6505366" cy="5713361"/>
            <a:chOff x="1306634" y="111510"/>
            <a:chExt cx="6505366" cy="5713361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0F64282-03F5-36A6-7395-B5C98519DFEE}"/>
                </a:ext>
              </a:extLst>
            </p:cNvPr>
            <p:cNvGrpSpPr/>
            <p:nvPr/>
          </p:nvGrpSpPr>
          <p:grpSpPr>
            <a:xfrm>
              <a:off x="1590876" y="111510"/>
              <a:ext cx="1963693" cy="1963693"/>
              <a:chOff x="3873000" y="93983"/>
              <a:chExt cx="2160000" cy="2160000"/>
            </a:xfrm>
          </p:grpSpPr>
          <p:pic>
            <p:nvPicPr>
              <p:cNvPr id="13" name="Picture 12" descr="A graph of a graph of a number of mg&#10;&#10;AI-generated content may be incorrect.">
                <a:extLst>
                  <a:ext uri="{FF2B5EF4-FFF2-40B4-BE49-F238E27FC236}">
                    <a16:creationId xmlns:a16="http://schemas.microsoft.com/office/drawing/2014/main" id="{7B425044-95CC-BB88-2EE5-297BD185276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73000" y="9398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34" name="テキスト ボックス 7">
                <a:extLst>
                  <a:ext uri="{FF2B5EF4-FFF2-40B4-BE49-F238E27FC236}">
                    <a16:creationId xmlns:a16="http://schemas.microsoft.com/office/drawing/2014/main" id="{F92EB385-D607-65E3-AD1E-3A0E29D88F73}"/>
                  </a:ext>
                </a:extLst>
              </p:cNvPr>
              <p:cNvSpPr txBox="1"/>
              <p:nvPr/>
            </p:nvSpPr>
            <p:spPr>
              <a:xfrm>
                <a:off x="4401640" y="61333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35" name="テキスト ボックス 7">
                <a:extLst>
                  <a:ext uri="{FF2B5EF4-FFF2-40B4-BE49-F238E27FC236}">
                    <a16:creationId xmlns:a16="http://schemas.microsoft.com/office/drawing/2014/main" id="{7105A7EA-515C-FE10-C061-F6575DED0882}"/>
                  </a:ext>
                </a:extLst>
              </p:cNvPr>
              <p:cNvSpPr txBox="1"/>
              <p:nvPr/>
            </p:nvSpPr>
            <p:spPr>
              <a:xfrm>
                <a:off x="4629151" y="7157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36" name="テキスト ボックス 7">
                <a:extLst>
                  <a:ext uri="{FF2B5EF4-FFF2-40B4-BE49-F238E27FC236}">
                    <a16:creationId xmlns:a16="http://schemas.microsoft.com/office/drawing/2014/main" id="{8C31071F-9CF7-E8E2-305C-49657B040FA7}"/>
                  </a:ext>
                </a:extLst>
              </p:cNvPr>
              <p:cNvSpPr txBox="1"/>
              <p:nvPr/>
            </p:nvSpPr>
            <p:spPr>
              <a:xfrm>
                <a:off x="4856662" y="62524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37" name="テキスト ボックス 7">
                <a:extLst>
                  <a:ext uri="{FF2B5EF4-FFF2-40B4-BE49-F238E27FC236}">
                    <a16:creationId xmlns:a16="http://schemas.microsoft.com/office/drawing/2014/main" id="{A11A6DA9-BD0B-5DA2-7B4F-4C5002A56488}"/>
                  </a:ext>
                </a:extLst>
              </p:cNvPr>
              <p:cNvSpPr txBox="1"/>
              <p:nvPr/>
            </p:nvSpPr>
            <p:spPr>
              <a:xfrm>
                <a:off x="5153123" y="81308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38" name="テキスト ボックス 7">
                <a:extLst>
                  <a:ext uri="{FF2B5EF4-FFF2-40B4-BE49-F238E27FC236}">
                    <a16:creationId xmlns:a16="http://schemas.microsoft.com/office/drawing/2014/main" id="{8F9C2476-3E5A-CC59-9E64-0729319FB510}"/>
                  </a:ext>
                </a:extLst>
              </p:cNvPr>
              <p:cNvSpPr txBox="1"/>
              <p:nvPr/>
            </p:nvSpPr>
            <p:spPr>
              <a:xfrm>
                <a:off x="5383015" y="71811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39" name="テキスト ボックス 7">
                <a:extLst>
                  <a:ext uri="{FF2B5EF4-FFF2-40B4-BE49-F238E27FC236}">
                    <a16:creationId xmlns:a16="http://schemas.microsoft.com/office/drawing/2014/main" id="{D48E7DB8-37CE-627B-7967-6E367E040BEC}"/>
                  </a:ext>
                </a:extLst>
              </p:cNvPr>
              <p:cNvSpPr txBox="1"/>
              <p:nvPr/>
            </p:nvSpPr>
            <p:spPr>
              <a:xfrm>
                <a:off x="5611022" y="50689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82059345-0548-51B4-1362-80CF3931E991}"/>
                </a:ext>
              </a:extLst>
            </p:cNvPr>
            <p:cNvGrpSpPr/>
            <p:nvPr/>
          </p:nvGrpSpPr>
          <p:grpSpPr>
            <a:xfrm>
              <a:off x="3705389" y="111510"/>
              <a:ext cx="1963693" cy="1963693"/>
              <a:chOff x="6033000" y="93983"/>
              <a:chExt cx="2160000" cy="2160000"/>
            </a:xfrm>
          </p:grpSpPr>
          <p:pic>
            <p:nvPicPr>
              <p:cNvPr id="25" name="Picture 24" descr="A graph of a graph of a graph&#10;&#10;AI-generated content may be incorrect.">
                <a:extLst>
                  <a:ext uri="{FF2B5EF4-FFF2-40B4-BE49-F238E27FC236}">
                    <a16:creationId xmlns:a16="http://schemas.microsoft.com/office/drawing/2014/main" id="{E55F06D0-9976-DEAD-3CE6-33FBA80F10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33000" y="9398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40" name="テキスト ボックス 7">
                <a:extLst>
                  <a:ext uri="{FF2B5EF4-FFF2-40B4-BE49-F238E27FC236}">
                    <a16:creationId xmlns:a16="http://schemas.microsoft.com/office/drawing/2014/main" id="{CD1D83C4-4969-4B87-B4C5-47CE7F75B28A}"/>
                  </a:ext>
                </a:extLst>
              </p:cNvPr>
              <p:cNvSpPr txBox="1"/>
              <p:nvPr/>
            </p:nvSpPr>
            <p:spPr>
              <a:xfrm>
                <a:off x="6610466" y="60900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1" name="テキスト ボックス 7">
                <a:extLst>
                  <a:ext uri="{FF2B5EF4-FFF2-40B4-BE49-F238E27FC236}">
                    <a16:creationId xmlns:a16="http://schemas.microsoft.com/office/drawing/2014/main" id="{55A71641-3F58-A2D8-D1D5-199273CDDEBB}"/>
                  </a:ext>
                </a:extLst>
              </p:cNvPr>
              <p:cNvSpPr txBox="1"/>
              <p:nvPr/>
            </p:nvSpPr>
            <p:spPr>
              <a:xfrm>
                <a:off x="6830946" y="66916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2" name="テキスト ボックス 7">
                <a:extLst>
                  <a:ext uri="{FF2B5EF4-FFF2-40B4-BE49-F238E27FC236}">
                    <a16:creationId xmlns:a16="http://schemas.microsoft.com/office/drawing/2014/main" id="{A7CD4B46-67B2-E346-A2AD-6ABC4B26704F}"/>
                  </a:ext>
                </a:extLst>
              </p:cNvPr>
              <p:cNvSpPr txBox="1"/>
              <p:nvPr/>
            </p:nvSpPr>
            <p:spPr>
              <a:xfrm>
                <a:off x="7048200" y="69773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3" name="テキスト ボックス 7">
                <a:extLst>
                  <a:ext uri="{FF2B5EF4-FFF2-40B4-BE49-F238E27FC236}">
                    <a16:creationId xmlns:a16="http://schemas.microsoft.com/office/drawing/2014/main" id="{ED8E62EB-85A3-2B6E-AEA2-5512F8D7EEF2}"/>
                  </a:ext>
                </a:extLst>
              </p:cNvPr>
              <p:cNvSpPr txBox="1"/>
              <p:nvPr/>
            </p:nvSpPr>
            <p:spPr>
              <a:xfrm>
                <a:off x="7342523" y="81436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4" name="テキスト ボックス 7">
                <a:extLst>
                  <a:ext uri="{FF2B5EF4-FFF2-40B4-BE49-F238E27FC236}">
                    <a16:creationId xmlns:a16="http://schemas.microsoft.com/office/drawing/2014/main" id="{D22F3FA6-B3FB-DB03-31AA-B370318E6311}"/>
                  </a:ext>
                </a:extLst>
              </p:cNvPr>
              <p:cNvSpPr txBox="1"/>
              <p:nvPr/>
            </p:nvSpPr>
            <p:spPr>
              <a:xfrm>
                <a:off x="7558136" y="61615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5" name="テキスト ボックス 7">
                <a:extLst>
                  <a:ext uri="{FF2B5EF4-FFF2-40B4-BE49-F238E27FC236}">
                    <a16:creationId xmlns:a16="http://schemas.microsoft.com/office/drawing/2014/main" id="{0C0BCF53-34EC-4E68-CF6F-8C72C06EB254}"/>
                  </a:ext>
                </a:extLst>
              </p:cNvPr>
              <p:cNvSpPr txBox="1"/>
              <p:nvPr/>
            </p:nvSpPr>
            <p:spPr>
              <a:xfrm>
                <a:off x="7776784" y="53241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7009E736-FD6E-C9DE-59AC-3E22216400D7}"/>
                </a:ext>
              </a:extLst>
            </p:cNvPr>
            <p:cNvGrpSpPr/>
            <p:nvPr/>
          </p:nvGrpSpPr>
          <p:grpSpPr>
            <a:xfrm>
              <a:off x="5796491" y="111510"/>
              <a:ext cx="1963693" cy="1963693"/>
              <a:chOff x="8232125" y="93983"/>
              <a:chExt cx="2160000" cy="2160000"/>
            </a:xfrm>
          </p:grpSpPr>
          <p:pic>
            <p:nvPicPr>
              <p:cNvPr id="23" name="Picture 22" descr="A graph of a graph of a number of different levels&#10;&#10;AI-generated content may be incorrect.">
                <a:extLst>
                  <a:ext uri="{FF2B5EF4-FFF2-40B4-BE49-F238E27FC236}">
                    <a16:creationId xmlns:a16="http://schemas.microsoft.com/office/drawing/2014/main" id="{F9F673E0-1C1B-9E02-FA1E-4F740367F1C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232125" y="93983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46" name="テキスト ボックス 7">
                <a:extLst>
                  <a:ext uri="{FF2B5EF4-FFF2-40B4-BE49-F238E27FC236}">
                    <a16:creationId xmlns:a16="http://schemas.microsoft.com/office/drawing/2014/main" id="{AC9ACEDD-4618-6086-EBC8-8C85971E0EF7}"/>
                  </a:ext>
                </a:extLst>
              </p:cNvPr>
              <p:cNvSpPr txBox="1"/>
              <p:nvPr/>
            </p:nvSpPr>
            <p:spPr>
              <a:xfrm>
                <a:off x="8813450" y="79750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7" name="テキスト ボックス 7">
                <a:extLst>
                  <a:ext uri="{FF2B5EF4-FFF2-40B4-BE49-F238E27FC236}">
                    <a16:creationId xmlns:a16="http://schemas.microsoft.com/office/drawing/2014/main" id="{56470F29-E0C1-90ED-BEFB-BD74309907F8}"/>
                  </a:ext>
                </a:extLst>
              </p:cNvPr>
              <p:cNvSpPr txBox="1"/>
              <p:nvPr/>
            </p:nvSpPr>
            <p:spPr>
              <a:xfrm>
                <a:off x="9032526" y="88884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8" name="テキスト ボックス 7">
                <a:extLst>
                  <a:ext uri="{FF2B5EF4-FFF2-40B4-BE49-F238E27FC236}">
                    <a16:creationId xmlns:a16="http://schemas.microsoft.com/office/drawing/2014/main" id="{8B5EA2A5-114D-DB58-1774-7BC95949FB44}"/>
                  </a:ext>
                </a:extLst>
              </p:cNvPr>
              <p:cNvSpPr txBox="1"/>
              <p:nvPr/>
            </p:nvSpPr>
            <p:spPr>
              <a:xfrm>
                <a:off x="9251406" y="85546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9" name="テキスト ボックス 7">
                <a:extLst>
                  <a:ext uri="{FF2B5EF4-FFF2-40B4-BE49-F238E27FC236}">
                    <a16:creationId xmlns:a16="http://schemas.microsoft.com/office/drawing/2014/main" id="{52560773-C8AA-9C3E-6C62-0D8CFE96E156}"/>
                  </a:ext>
                </a:extLst>
              </p:cNvPr>
              <p:cNvSpPr txBox="1"/>
              <p:nvPr/>
            </p:nvSpPr>
            <p:spPr>
              <a:xfrm>
                <a:off x="9539087" y="84355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0" name="テキスト ボックス 7">
                <a:extLst>
                  <a:ext uri="{FF2B5EF4-FFF2-40B4-BE49-F238E27FC236}">
                    <a16:creationId xmlns:a16="http://schemas.microsoft.com/office/drawing/2014/main" id="{FE1B867A-BE85-B445-12EF-3288E9BF4B4E}"/>
                  </a:ext>
                </a:extLst>
              </p:cNvPr>
              <p:cNvSpPr txBox="1"/>
              <p:nvPr/>
            </p:nvSpPr>
            <p:spPr>
              <a:xfrm>
                <a:off x="9760602" y="62833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1" name="テキスト ボックス 7">
                <a:extLst>
                  <a:ext uri="{FF2B5EF4-FFF2-40B4-BE49-F238E27FC236}">
                    <a16:creationId xmlns:a16="http://schemas.microsoft.com/office/drawing/2014/main" id="{AA162EBF-9EE9-0B4A-E557-09CBC32B792C}"/>
                  </a:ext>
                </a:extLst>
              </p:cNvPr>
              <p:cNvSpPr txBox="1"/>
              <p:nvPr/>
            </p:nvSpPr>
            <p:spPr>
              <a:xfrm>
                <a:off x="9976628" y="51227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3A2049D3-3E97-18A7-562F-979BE921450C}"/>
                </a:ext>
              </a:extLst>
            </p:cNvPr>
            <p:cNvGrpSpPr/>
            <p:nvPr/>
          </p:nvGrpSpPr>
          <p:grpSpPr>
            <a:xfrm>
              <a:off x="1575862" y="1991327"/>
              <a:ext cx="1963693" cy="1963693"/>
              <a:chOff x="1799875" y="2220710"/>
              <a:chExt cx="2160000" cy="2160000"/>
            </a:xfrm>
          </p:grpSpPr>
          <p:pic>
            <p:nvPicPr>
              <p:cNvPr id="21" name="Picture 20" descr="A graph of a number of different sizes and colors&#10;&#10;AI-generated content may be incorrect.">
                <a:extLst>
                  <a:ext uri="{FF2B5EF4-FFF2-40B4-BE49-F238E27FC236}">
                    <a16:creationId xmlns:a16="http://schemas.microsoft.com/office/drawing/2014/main" id="{AA0AF033-88A4-15AB-5CBB-27815ABB2E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799875" y="2220710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52" name="テキスト ボックス 7">
                <a:extLst>
                  <a:ext uri="{FF2B5EF4-FFF2-40B4-BE49-F238E27FC236}">
                    <a16:creationId xmlns:a16="http://schemas.microsoft.com/office/drawing/2014/main" id="{7129C280-4355-61D5-BD49-48F5E4F44AA3}"/>
                  </a:ext>
                </a:extLst>
              </p:cNvPr>
              <p:cNvSpPr txBox="1"/>
              <p:nvPr/>
            </p:nvSpPr>
            <p:spPr>
              <a:xfrm>
                <a:off x="2376501" y="273202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3" name="テキスト ボックス 7">
                <a:extLst>
                  <a:ext uri="{FF2B5EF4-FFF2-40B4-BE49-F238E27FC236}">
                    <a16:creationId xmlns:a16="http://schemas.microsoft.com/office/drawing/2014/main" id="{17A5746F-23EA-87FE-B1D1-ED53379875DE}"/>
                  </a:ext>
                </a:extLst>
              </p:cNvPr>
              <p:cNvSpPr txBox="1"/>
              <p:nvPr/>
            </p:nvSpPr>
            <p:spPr>
              <a:xfrm>
                <a:off x="2598658" y="279066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4" name="テキスト ボックス 7">
                <a:extLst>
                  <a:ext uri="{FF2B5EF4-FFF2-40B4-BE49-F238E27FC236}">
                    <a16:creationId xmlns:a16="http://schemas.microsoft.com/office/drawing/2014/main" id="{D0639DA2-F85A-816E-D6DA-C8588E81BC26}"/>
                  </a:ext>
                </a:extLst>
              </p:cNvPr>
              <p:cNvSpPr txBox="1"/>
              <p:nvPr/>
            </p:nvSpPr>
            <p:spPr>
              <a:xfrm>
                <a:off x="2818939" y="278207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5" name="テキスト ボックス 7">
                <a:extLst>
                  <a:ext uri="{FF2B5EF4-FFF2-40B4-BE49-F238E27FC236}">
                    <a16:creationId xmlns:a16="http://schemas.microsoft.com/office/drawing/2014/main" id="{6F41EE58-C38E-E2A4-2D3D-0CB37BFF0ABD}"/>
                  </a:ext>
                </a:extLst>
              </p:cNvPr>
              <p:cNvSpPr txBox="1"/>
              <p:nvPr/>
            </p:nvSpPr>
            <p:spPr>
              <a:xfrm>
                <a:off x="3108290" y="292304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6" name="テキスト ボックス 7">
                <a:extLst>
                  <a:ext uri="{FF2B5EF4-FFF2-40B4-BE49-F238E27FC236}">
                    <a16:creationId xmlns:a16="http://schemas.microsoft.com/office/drawing/2014/main" id="{AB265FD9-9DC9-90F0-F2E3-C10BA77C7CFB}"/>
                  </a:ext>
                </a:extLst>
              </p:cNvPr>
              <p:cNvSpPr txBox="1"/>
              <p:nvPr/>
            </p:nvSpPr>
            <p:spPr>
              <a:xfrm>
                <a:off x="3324799" y="285034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7" name="テキスト ボックス 7">
                <a:extLst>
                  <a:ext uri="{FF2B5EF4-FFF2-40B4-BE49-F238E27FC236}">
                    <a16:creationId xmlns:a16="http://schemas.microsoft.com/office/drawing/2014/main" id="{6C499BF0-3B5F-738A-0172-1775040EC71B}"/>
                  </a:ext>
                </a:extLst>
              </p:cNvPr>
              <p:cNvSpPr txBox="1"/>
              <p:nvPr/>
            </p:nvSpPr>
            <p:spPr>
              <a:xfrm>
                <a:off x="3544709" y="268750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26B97364-F3C1-7806-185C-6DBBE35AEAB1}"/>
                </a:ext>
              </a:extLst>
            </p:cNvPr>
            <p:cNvGrpSpPr/>
            <p:nvPr/>
          </p:nvGrpSpPr>
          <p:grpSpPr>
            <a:xfrm>
              <a:off x="3751898" y="2039599"/>
              <a:ext cx="1963693" cy="1963693"/>
              <a:chOff x="3959875" y="2220710"/>
              <a:chExt cx="2160000" cy="2160000"/>
            </a:xfrm>
          </p:grpSpPr>
          <p:pic>
            <p:nvPicPr>
              <p:cNvPr id="19" name="Picture 18" descr="A graph of a graph of a number of different levels&#10;&#10;AI-generated content may be incorrect.">
                <a:extLst>
                  <a:ext uri="{FF2B5EF4-FFF2-40B4-BE49-F238E27FC236}">
                    <a16:creationId xmlns:a16="http://schemas.microsoft.com/office/drawing/2014/main" id="{75AB418C-789E-5A4D-3CFD-C236A1F64C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959875" y="2220710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58" name="テキスト ボックス 7">
                <a:extLst>
                  <a:ext uri="{FF2B5EF4-FFF2-40B4-BE49-F238E27FC236}">
                    <a16:creationId xmlns:a16="http://schemas.microsoft.com/office/drawing/2014/main" id="{D7FA96E7-510C-00E9-9AA8-17EE685D3EF4}"/>
                  </a:ext>
                </a:extLst>
              </p:cNvPr>
              <p:cNvSpPr txBox="1"/>
              <p:nvPr/>
            </p:nvSpPr>
            <p:spPr>
              <a:xfrm>
                <a:off x="4440568" y="27812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9" name="テキスト ボックス 7">
                <a:extLst>
                  <a:ext uri="{FF2B5EF4-FFF2-40B4-BE49-F238E27FC236}">
                    <a16:creationId xmlns:a16="http://schemas.microsoft.com/office/drawing/2014/main" id="{DB18412B-A6BD-CEEF-F239-9D2F705E5EA1}"/>
                  </a:ext>
                </a:extLst>
              </p:cNvPr>
              <p:cNvSpPr txBox="1"/>
              <p:nvPr/>
            </p:nvSpPr>
            <p:spPr>
              <a:xfrm>
                <a:off x="4674464" y="326719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0" name="テキスト ボックス 7">
                <a:extLst>
                  <a:ext uri="{FF2B5EF4-FFF2-40B4-BE49-F238E27FC236}">
                    <a16:creationId xmlns:a16="http://schemas.microsoft.com/office/drawing/2014/main" id="{19947CEF-A6E4-17F5-46DE-C7341C8E56E0}"/>
                  </a:ext>
                </a:extLst>
              </p:cNvPr>
              <p:cNvSpPr txBox="1"/>
              <p:nvPr/>
            </p:nvSpPr>
            <p:spPr>
              <a:xfrm>
                <a:off x="4907515" y="289547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1" name="テキスト ボックス 7">
                <a:extLst>
                  <a:ext uri="{FF2B5EF4-FFF2-40B4-BE49-F238E27FC236}">
                    <a16:creationId xmlns:a16="http://schemas.microsoft.com/office/drawing/2014/main" id="{13621A7C-3D05-0AB4-67C8-B24BB163AB1D}"/>
                  </a:ext>
                </a:extLst>
              </p:cNvPr>
              <p:cNvSpPr txBox="1"/>
              <p:nvPr/>
            </p:nvSpPr>
            <p:spPr>
              <a:xfrm>
                <a:off x="5219770" y="335657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2" name="テキスト ボックス 7">
                <a:extLst>
                  <a:ext uri="{FF2B5EF4-FFF2-40B4-BE49-F238E27FC236}">
                    <a16:creationId xmlns:a16="http://schemas.microsoft.com/office/drawing/2014/main" id="{B1680D9A-7197-B16B-93FD-34C5F320171B}"/>
                  </a:ext>
                </a:extLst>
              </p:cNvPr>
              <p:cNvSpPr txBox="1"/>
              <p:nvPr/>
            </p:nvSpPr>
            <p:spPr>
              <a:xfrm>
                <a:off x="5454187" y="27391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3" name="テキスト ボックス 7">
                <a:extLst>
                  <a:ext uri="{FF2B5EF4-FFF2-40B4-BE49-F238E27FC236}">
                    <a16:creationId xmlns:a16="http://schemas.microsoft.com/office/drawing/2014/main" id="{A3740F9D-ED52-9FAA-28EA-8B44687859BC}"/>
                  </a:ext>
                </a:extLst>
              </p:cNvPr>
              <p:cNvSpPr txBox="1"/>
              <p:nvPr/>
            </p:nvSpPr>
            <p:spPr>
              <a:xfrm>
                <a:off x="5686992" y="281589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B6A0B16-C9C2-18E3-8268-AA9C195C36B4}"/>
                </a:ext>
              </a:extLst>
            </p:cNvPr>
            <p:cNvGrpSpPr/>
            <p:nvPr/>
          </p:nvGrpSpPr>
          <p:grpSpPr>
            <a:xfrm>
              <a:off x="5848307" y="2039599"/>
              <a:ext cx="1963693" cy="1963693"/>
              <a:chOff x="6071100" y="2202690"/>
              <a:chExt cx="2160000" cy="2160000"/>
            </a:xfrm>
          </p:grpSpPr>
          <p:pic>
            <p:nvPicPr>
              <p:cNvPr id="17" name="Picture 16" descr="A graph of a graph of a number of different sizes&#10;&#10;AI-generated content may be incorrect.">
                <a:extLst>
                  <a:ext uri="{FF2B5EF4-FFF2-40B4-BE49-F238E27FC236}">
                    <a16:creationId xmlns:a16="http://schemas.microsoft.com/office/drawing/2014/main" id="{B7E1F5FE-2D00-D328-532D-0985B8EEF6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071100" y="2202690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64" name="テキスト ボックス 7">
                <a:extLst>
                  <a:ext uri="{FF2B5EF4-FFF2-40B4-BE49-F238E27FC236}">
                    <a16:creationId xmlns:a16="http://schemas.microsoft.com/office/drawing/2014/main" id="{61EA8552-BE8E-9648-4076-0977138B61EC}"/>
                  </a:ext>
                </a:extLst>
              </p:cNvPr>
              <p:cNvSpPr txBox="1"/>
              <p:nvPr/>
            </p:nvSpPr>
            <p:spPr>
              <a:xfrm>
                <a:off x="6575667" y="30412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5" name="テキスト ボックス 7">
                <a:extLst>
                  <a:ext uri="{FF2B5EF4-FFF2-40B4-BE49-F238E27FC236}">
                    <a16:creationId xmlns:a16="http://schemas.microsoft.com/office/drawing/2014/main" id="{9FFBF20D-18B9-55ED-5305-7A86105D9BEF}"/>
                  </a:ext>
                </a:extLst>
              </p:cNvPr>
              <p:cNvSpPr txBox="1"/>
              <p:nvPr/>
            </p:nvSpPr>
            <p:spPr>
              <a:xfrm>
                <a:off x="6809003" y="316487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6" name="テキスト ボックス 7">
                <a:extLst>
                  <a:ext uri="{FF2B5EF4-FFF2-40B4-BE49-F238E27FC236}">
                    <a16:creationId xmlns:a16="http://schemas.microsoft.com/office/drawing/2014/main" id="{0E6452F8-B8B4-D996-8001-C14322F9E25A}"/>
                  </a:ext>
                </a:extLst>
              </p:cNvPr>
              <p:cNvSpPr txBox="1"/>
              <p:nvPr/>
            </p:nvSpPr>
            <p:spPr>
              <a:xfrm>
                <a:off x="7034981" y="302218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7" name="テキスト ボックス 7">
                <a:extLst>
                  <a:ext uri="{FF2B5EF4-FFF2-40B4-BE49-F238E27FC236}">
                    <a16:creationId xmlns:a16="http://schemas.microsoft.com/office/drawing/2014/main" id="{2413BB83-B940-9F9F-1F5D-9E4809B23539}"/>
                  </a:ext>
                </a:extLst>
              </p:cNvPr>
              <p:cNvSpPr txBox="1"/>
              <p:nvPr/>
            </p:nvSpPr>
            <p:spPr>
              <a:xfrm>
                <a:off x="7575474" y="300113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8" name="テキスト ボックス 7">
                <a:extLst>
                  <a:ext uri="{FF2B5EF4-FFF2-40B4-BE49-F238E27FC236}">
                    <a16:creationId xmlns:a16="http://schemas.microsoft.com/office/drawing/2014/main" id="{BB7E795B-511A-C742-C4FE-5F8FAEC655DF}"/>
                  </a:ext>
                </a:extLst>
              </p:cNvPr>
              <p:cNvSpPr txBox="1"/>
              <p:nvPr/>
            </p:nvSpPr>
            <p:spPr>
              <a:xfrm>
                <a:off x="7342671" y="246727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9" name="テキスト ボックス 7">
                <a:extLst>
                  <a:ext uri="{FF2B5EF4-FFF2-40B4-BE49-F238E27FC236}">
                    <a16:creationId xmlns:a16="http://schemas.microsoft.com/office/drawing/2014/main" id="{39B4DED1-0DF8-032A-D3B0-54BAB7EA2C1E}"/>
                  </a:ext>
                </a:extLst>
              </p:cNvPr>
              <p:cNvSpPr txBox="1"/>
              <p:nvPr/>
            </p:nvSpPr>
            <p:spPr>
              <a:xfrm>
                <a:off x="7805307" y="286933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117728C-3D2F-DFB9-9069-52B2A281D6D4}"/>
                </a:ext>
              </a:extLst>
            </p:cNvPr>
            <p:cNvGrpSpPr/>
            <p:nvPr/>
          </p:nvGrpSpPr>
          <p:grpSpPr>
            <a:xfrm>
              <a:off x="1590876" y="3861178"/>
              <a:ext cx="1963693" cy="1963693"/>
              <a:chOff x="8231100" y="2202690"/>
              <a:chExt cx="2160000" cy="2160000"/>
            </a:xfrm>
          </p:grpSpPr>
          <p:pic>
            <p:nvPicPr>
              <p:cNvPr id="15" name="Picture 14" descr="A graph of a graph of a number of different levels&#10;&#10;AI-generated content may be incorrect.">
                <a:extLst>
                  <a:ext uri="{FF2B5EF4-FFF2-40B4-BE49-F238E27FC236}">
                    <a16:creationId xmlns:a16="http://schemas.microsoft.com/office/drawing/2014/main" id="{4D972CA3-A9E7-C8C8-66DD-D4A8EE44AA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231100" y="2202690"/>
                <a:ext cx="2160000" cy="2160000"/>
              </a:xfrm>
              <a:prstGeom prst="rect">
                <a:avLst/>
              </a:prstGeom>
            </p:spPr>
          </p:pic>
          <p:sp>
            <p:nvSpPr>
              <p:cNvPr id="70" name="テキスト ボックス 7">
                <a:extLst>
                  <a:ext uri="{FF2B5EF4-FFF2-40B4-BE49-F238E27FC236}">
                    <a16:creationId xmlns:a16="http://schemas.microsoft.com/office/drawing/2014/main" id="{8CE6294D-27E3-3AAE-15B9-17F191D6D9EB}"/>
                  </a:ext>
                </a:extLst>
              </p:cNvPr>
              <p:cNvSpPr txBox="1"/>
              <p:nvPr/>
            </p:nvSpPr>
            <p:spPr>
              <a:xfrm>
                <a:off x="8706300" y="299482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3" name="テキスト ボックス 7">
                <a:extLst>
                  <a:ext uri="{FF2B5EF4-FFF2-40B4-BE49-F238E27FC236}">
                    <a16:creationId xmlns:a16="http://schemas.microsoft.com/office/drawing/2014/main" id="{6C368036-4F70-FBC0-99DA-E8B51E15265D}"/>
                  </a:ext>
                </a:extLst>
              </p:cNvPr>
              <p:cNvSpPr txBox="1"/>
              <p:nvPr/>
            </p:nvSpPr>
            <p:spPr>
              <a:xfrm>
                <a:off x="8944849" y="308305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4" name="テキスト ボックス 7">
                <a:extLst>
                  <a:ext uri="{FF2B5EF4-FFF2-40B4-BE49-F238E27FC236}">
                    <a16:creationId xmlns:a16="http://schemas.microsoft.com/office/drawing/2014/main" id="{E46B9B09-BA66-F0AB-4F85-F556C104C6A4}"/>
                  </a:ext>
                </a:extLst>
              </p:cNvPr>
              <p:cNvSpPr txBox="1"/>
              <p:nvPr/>
            </p:nvSpPr>
            <p:spPr>
              <a:xfrm>
                <a:off x="9179340" y="294757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5" name="テキスト ボックス 7">
                <a:extLst>
                  <a:ext uri="{FF2B5EF4-FFF2-40B4-BE49-F238E27FC236}">
                    <a16:creationId xmlns:a16="http://schemas.microsoft.com/office/drawing/2014/main" id="{EC2668AA-9523-2532-4D92-D6B7ADC2C767}"/>
                  </a:ext>
                </a:extLst>
              </p:cNvPr>
              <p:cNvSpPr txBox="1"/>
              <p:nvPr/>
            </p:nvSpPr>
            <p:spPr>
              <a:xfrm>
                <a:off x="9490669" y="291812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6" name="テキスト ボックス 7">
                <a:extLst>
                  <a:ext uri="{FF2B5EF4-FFF2-40B4-BE49-F238E27FC236}">
                    <a16:creationId xmlns:a16="http://schemas.microsoft.com/office/drawing/2014/main" id="{6A68D583-8CE6-F122-724B-CA10BE56EFA9}"/>
                  </a:ext>
                </a:extLst>
              </p:cNvPr>
              <p:cNvSpPr txBox="1"/>
              <p:nvPr/>
            </p:nvSpPr>
            <p:spPr>
              <a:xfrm>
                <a:off x="9727209" y="265855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7" name="テキスト ボックス 7">
                <a:extLst>
                  <a:ext uri="{FF2B5EF4-FFF2-40B4-BE49-F238E27FC236}">
                    <a16:creationId xmlns:a16="http://schemas.microsoft.com/office/drawing/2014/main" id="{AC3C384F-2254-0796-DDDF-EF7D3FE6947E}"/>
                  </a:ext>
                </a:extLst>
              </p:cNvPr>
              <p:cNvSpPr txBox="1"/>
              <p:nvPr/>
            </p:nvSpPr>
            <p:spPr>
              <a:xfrm>
                <a:off x="9959598" y="254880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</p:grpSp>
        <p:sp>
          <p:nvSpPr>
            <p:cNvPr id="71" name="テキスト ボックス 4">
              <a:extLst>
                <a:ext uri="{FF2B5EF4-FFF2-40B4-BE49-F238E27FC236}">
                  <a16:creationId xmlns:a16="http://schemas.microsoft.com/office/drawing/2014/main" id="{11FBF21F-E3F1-9164-459E-CA28AAF2071F}"/>
                </a:ext>
              </a:extLst>
            </p:cNvPr>
            <p:cNvSpPr txBox="1"/>
            <p:nvPr/>
          </p:nvSpPr>
          <p:spPr>
            <a:xfrm>
              <a:off x="1309970" y="17608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72" name="テキスト ボックス 4">
              <a:extLst>
                <a:ext uri="{FF2B5EF4-FFF2-40B4-BE49-F238E27FC236}">
                  <a16:creationId xmlns:a16="http://schemas.microsoft.com/office/drawing/2014/main" id="{8D274D0D-3AEB-5C2E-BE75-D981F52815F1}"/>
                </a:ext>
              </a:extLst>
            </p:cNvPr>
            <p:cNvSpPr txBox="1"/>
            <p:nvPr/>
          </p:nvSpPr>
          <p:spPr>
            <a:xfrm>
              <a:off x="3428375" y="17608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79" name="テキスト ボックス 4">
              <a:extLst>
                <a:ext uri="{FF2B5EF4-FFF2-40B4-BE49-F238E27FC236}">
                  <a16:creationId xmlns:a16="http://schemas.microsoft.com/office/drawing/2014/main" id="{8CD9A29A-3069-6DA1-1628-FE0DCEB6B815}"/>
                </a:ext>
              </a:extLst>
            </p:cNvPr>
            <p:cNvSpPr txBox="1"/>
            <p:nvPr/>
          </p:nvSpPr>
          <p:spPr>
            <a:xfrm>
              <a:off x="5535075" y="17608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sp>
          <p:nvSpPr>
            <p:cNvPr id="80" name="テキスト ボックス 4">
              <a:extLst>
                <a:ext uri="{FF2B5EF4-FFF2-40B4-BE49-F238E27FC236}">
                  <a16:creationId xmlns:a16="http://schemas.microsoft.com/office/drawing/2014/main" id="{2B167E9F-0438-E350-D76A-0615C9D64CF0}"/>
                </a:ext>
              </a:extLst>
            </p:cNvPr>
            <p:cNvSpPr txBox="1"/>
            <p:nvPr/>
          </p:nvSpPr>
          <p:spPr>
            <a:xfrm>
              <a:off x="1306634" y="205590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81" name="テキスト ボックス 4">
              <a:extLst>
                <a:ext uri="{FF2B5EF4-FFF2-40B4-BE49-F238E27FC236}">
                  <a16:creationId xmlns:a16="http://schemas.microsoft.com/office/drawing/2014/main" id="{053A79B3-F8EE-CD09-D942-7DB88967C012}"/>
                </a:ext>
              </a:extLst>
            </p:cNvPr>
            <p:cNvSpPr txBox="1"/>
            <p:nvPr/>
          </p:nvSpPr>
          <p:spPr>
            <a:xfrm>
              <a:off x="3475001" y="2102434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82" name="テキスト ボックス 4">
              <a:extLst>
                <a:ext uri="{FF2B5EF4-FFF2-40B4-BE49-F238E27FC236}">
                  <a16:creationId xmlns:a16="http://schemas.microsoft.com/office/drawing/2014/main" id="{72E61E01-6609-CB7A-CCA7-FC5F58AB7640}"/>
                </a:ext>
              </a:extLst>
            </p:cNvPr>
            <p:cNvSpPr txBox="1"/>
            <p:nvPr/>
          </p:nvSpPr>
          <p:spPr>
            <a:xfrm>
              <a:off x="5577634" y="2102434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  <p:sp>
          <p:nvSpPr>
            <p:cNvPr id="83" name="テキスト ボックス 4">
              <a:extLst>
                <a:ext uri="{FF2B5EF4-FFF2-40B4-BE49-F238E27FC236}">
                  <a16:creationId xmlns:a16="http://schemas.microsoft.com/office/drawing/2014/main" id="{B9C59564-F675-9FA4-58CE-6E0C6C9AECC1}"/>
                </a:ext>
              </a:extLst>
            </p:cNvPr>
            <p:cNvSpPr txBox="1"/>
            <p:nvPr/>
          </p:nvSpPr>
          <p:spPr>
            <a:xfrm>
              <a:off x="1308942" y="3924014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61310167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43BC855-A394-BDA4-68D4-EBF51437CCDF}"/>
              </a:ext>
            </a:extLst>
          </p:cNvPr>
          <p:cNvSpPr txBox="1"/>
          <p:nvPr/>
        </p:nvSpPr>
        <p:spPr>
          <a:xfrm>
            <a:off x="376237" y="379872"/>
            <a:ext cx="8391525" cy="109773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1000"/>
              </a:spcBef>
              <a:spcAft>
                <a:spcPts val="1000"/>
              </a:spcAft>
            </a:pPr>
            <a:r>
              <a:rPr lang="en-US" altLang="ja-JP" sz="1400" b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ferences</a:t>
            </a:r>
            <a:endParaRPr lang="ja-JP" altLang="ja-JP" sz="140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marL="450850" indent="-450850" algn="just"/>
            <a:r>
              <a:rPr lang="en-US" altLang="ja-JP" sz="1200" b="1" kern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ontanini</a:t>
            </a:r>
            <a:r>
              <a:rPr lang="en-US" altLang="ja-JP" sz="1200" b="1" ker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B., Blaudez, D., </a:t>
            </a:r>
            <a:r>
              <a:rPr lang="en-US" altLang="ja-JP" sz="1200" b="1" kern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eandroz</a:t>
            </a:r>
            <a:r>
              <a:rPr lang="en-US" altLang="ja-JP" sz="1200" b="1" ker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S., Sanders, D. &amp; </a:t>
            </a:r>
            <a:r>
              <a:rPr lang="en-US" altLang="ja-JP" sz="1200" b="1" kern="0" err="1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halot</a:t>
            </a:r>
            <a:r>
              <a:rPr lang="en-US" altLang="ja-JP" sz="1200" b="1" ker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M.</a:t>
            </a:r>
            <a:r>
              <a:rPr lang="en-US" altLang="ja-JP" sz="1200" ker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2007) Phylogenetic and functional analysis of the Cation Diffusion Facilitator (CDF) family: improved signature and prediction of substrate specificity. BMC Genomics, 8, 107. https://doi.org/10.1186/1471-2164-8-107</a:t>
            </a:r>
            <a:endParaRPr lang="ja-JP" altLang="ja-JP" sz="1200" kern="100"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7067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E8BCD0F-0090-9E05-C2A9-802DF3E0FCFB}"/>
              </a:ext>
            </a:extLst>
          </p:cNvPr>
          <p:cNvGrpSpPr>
            <a:grpSpLocks noChangeAspect="1"/>
          </p:cNvGrpSpPr>
          <p:nvPr/>
        </p:nvGrpSpPr>
        <p:grpSpPr>
          <a:xfrm>
            <a:off x="3132000" y="328784"/>
            <a:ext cx="2880000" cy="4544699"/>
            <a:chOff x="741190" y="-42122"/>
            <a:chExt cx="3332150" cy="5258206"/>
          </a:xfrm>
        </p:grpSpPr>
        <p:pic>
          <p:nvPicPr>
            <p:cNvPr id="3" name="Picture 2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46F5C443-E072-8380-38DA-9B1447BF466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26306" y="2699257"/>
              <a:ext cx="3147034" cy="2516827"/>
            </a:xfrm>
            <a:prstGeom prst="rect">
              <a:avLst/>
            </a:prstGeom>
          </p:spPr>
        </p:pic>
        <p:pic>
          <p:nvPicPr>
            <p:cNvPr id="7" name="Picture 6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09E66018-987B-AAD4-D93A-83FB5D113CE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26306" y="143111"/>
              <a:ext cx="3147034" cy="2516827"/>
            </a:xfrm>
            <a:prstGeom prst="rect">
              <a:avLst/>
            </a:prstGeom>
          </p:spPr>
        </p:pic>
        <p:sp>
          <p:nvSpPr>
            <p:cNvPr id="8" name="テキスト ボックス 4">
              <a:extLst>
                <a:ext uri="{FF2B5EF4-FFF2-40B4-BE49-F238E27FC236}">
                  <a16:creationId xmlns:a16="http://schemas.microsoft.com/office/drawing/2014/main" id="{F4D71C03-088C-67D7-2514-C2B96D44C258}"/>
                </a:ext>
              </a:extLst>
            </p:cNvPr>
            <p:cNvSpPr txBox="1"/>
            <p:nvPr/>
          </p:nvSpPr>
          <p:spPr>
            <a:xfrm>
              <a:off x="751410" y="-42122"/>
              <a:ext cx="460330" cy="320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10" name="テキスト ボックス 4">
              <a:extLst>
                <a:ext uri="{FF2B5EF4-FFF2-40B4-BE49-F238E27FC236}">
                  <a16:creationId xmlns:a16="http://schemas.microsoft.com/office/drawing/2014/main" id="{C07E77E7-1E9B-06EF-7F0C-8AEF68E90FAA}"/>
                </a:ext>
              </a:extLst>
            </p:cNvPr>
            <p:cNvSpPr txBox="1"/>
            <p:nvPr/>
          </p:nvSpPr>
          <p:spPr>
            <a:xfrm>
              <a:off x="741190" y="2514022"/>
              <a:ext cx="460330" cy="3204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12" name="テキスト ボックス 7">
              <a:extLst>
                <a:ext uri="{FF2B5EF4-FFF2-40B4-BE49-F238E27FC236}">
                  <a16:creationId xmlns:a16="http://schemas.microsoft.com/office/drawing/2014/main" id="{3CF4A49F-904E-084A-0E50-FB7679168A65}"/>
                </a:ext>
              </a:extLst>
            </p:cNvPr>
            <p:cNvSpPr txBox="1"/>
            <p:nvPr/>
          </p:nvSpPr>
          <p:spPr>
            <a:xfrm>
              <a:off x="1448252" y="3586079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7">
              <a:extLst>
                <a:ext uri="{FF2B5EF4-FFF2-40B4-BE49-F238E27FC236}">
                  <a16:creationId xmlns:a16="http://schemas.microsoft.com/office/drawing/2014/main" id="{91BF0159-9276-CE91-A27B-12F51A225BB5}"/>
                </a:ext>
              </a:extLst>
            </p:cNvPr>
            <p:cNvSpPr txBox="1"/>
            <p:nvPr/>
          </p:nvSpPr>
          <p:spPr>
            <a:xfrm>
              <a:off x="2447323" y="3058448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7">
              <a:extLst>
                <a:ext uri="{FF2B5EF4-FFF2-40B4-BE49-F238E27FC236}">
                  <a16:creationId xmlns:a16="http://schemas.microsoft.com/office/drawing/2014/main" id="{87DB7EF6-1ACB-FBC7-20EF-A55D843E5688}"/>
                </a:ext>
              </a:extLst>
            </p:cNvPr>
            <p:cNvSpPr txBox="1"/>
            <p:nvPr/>
          </p:nvSpPr>
          <p:spPr>
            <a:xfrm>
              <a:off x="1948095" y="3223527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7">
              <a:extLst>
                <a:ext uri="{FF2B5EF4-FFF2-40B4-BE49-F238E27FC236}">
                  <a16:creationId xmlns:a16="http://schemas.microsoft.com/office/drawing/2014/main" id="{98A7B034-11F1-01B2-7C0D-1BAA68B05AD5}"/>
                </a:ext>
              </a:extLst>
            </p:cNvPr>
            <p:cNvSpPr txBox="1"/>
            <p:nvPr/>
          </p:nvSpPr>
          <p:spPr>
            <a:xfrm>
              <a:off x="2947931" y="3267020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7">
              <a:extLst>
                <a:ext uri="{FF2B5EF4-FFF2-40B4-BE49-F238E27FC236}">
                  <a16:creationId xmlns:a16="http://schemas.microsoft.com/office/drawing/2014/main" id="{FAA7F2E5-41D6-DE39-213E-C3D155993272}"/>
                </a:ext>
              </a:extLst>
            </p:cNvPr>
            <p:cNvSpPr txBox="1"/>
            <p:nvPr/>
          </p:nvSpPr>
          <p:spPr>
            <a:xfrm>
              <a:off x="3448538" y="3582379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7">
              <a:extLst>
                <a:ext uri="{FF2B5EF4-FFF2-40B4-BE49-F238E27FC236}">
                  <a16:creationId xmlns:a16="http://schemas.microsoft.com/office/drawing/2014/main" id="{97F0CFC0-02C0-18FA-D063-5F496A14C7D3}"/>
                </a:ext>
              </a:extLst>
            </p:cNvPr>
            <p:cNvSpPr txBox="1"/>
            <p:nvPr/>
          </p:nvSpPr>
          <p:spPr>
            <a:xfrm>
              <a:off x="1658394" y="3498192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テキスト ボックス 7">
              <a:extLst>
                <a:ext uri="{FF2B5EF4-FFF2-40B4-BE49-F238E27FC236}">
                  <a16:creationId xmlns:a16="http://schemas.microsoft.com/office/drawing/2014/main" id="{E1D21721-4354-52A3-98E6-C5FEFB213373}"/>
                </a:ext>
              </a:extLst>
            </p:cNvPr>
            <p:cNvSpPr txBox="1"/>
            <p:nvPr/>
          </p:nvSpPr>
          <p:spPr>
            <a:xfrm>
              <a:off x="2163578" y="3603735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7">
              <a:extLst>
                <a:ext uri="{FF2B5EF4-FFF2-40B4-BE49-F238E27FC236}">
                  <a16:creationId xmlns:a16="http://schemas.microsoft.com/office/drawing/2014/main" id="{C9A758BE-F44D-89C5-9FC1-00CBA9B2061F}"/>
                </a:ext>
              </a:extLst>
            </p:cNvPr>
            <p:cNvSpPr txBox="1"/>
            <p:nvPr/>
          </p:nvSpPr>
          <p:spPr>
            <a:xfrm>
              <a:off x="2657664" y="3809852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テキスト ボックス 7">
              <a:extLst>
                <a:ext uri="{FF2B5EF4-FFF2-40B4-BE49-F238E27FC236}">
                  <a16:creationId xmlns:a16="http://schemas.microsoft.com/office/drawing/2014/main" id="{FBCF92E4-3B4F-3E42-3987-F1A2D8A098B7}"/>
                </a:ext>
              </a:extLst>
            </p:cNvPr>
            <p:cNvSpPr txBox="1"/>
            <p:nvPr/>
          </p:nvSpPr>
          <p:spPr>
            <a:xfrm>
              <a:off x="3151933" y="4024423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テキスト ボックス 7">
              <a:extLst>
                <a:ext uri="{FF2B5EF4-FFF2-40B4-BE49-F238E27FC236}">
                  <a16:creationId xmlns:a16="http://schemas.microsoft.com/office/drawing/2014/main" id="{965C2BD8-C031-D2E6-52B6-44FD4BBF7DD8}"/>
                </a:ext>
              </a:extLst>
            </p:cNvPr>
            <p:cNvSpPr txBox="1"/>
            <p:nvPr/>
          </p:nvSpPr>
          <p:spPr>
            <a:xfrm>
              <a:off x="3662272" y="4020724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7">
              <a:extLst>
                <a:ext uri="{FF2B5EF4-FFF2-40B4-BE49-F238E27FC236}">
                  <a16:creationId xmlns:a16="http://schemas.microsoft.com/office/drawing/2014/main" id="{D084994C-A503-A232-863B-F9E380142224}"/>
                </a:ext>
              </a:extLst>
            </p:cNvPr>
            <p:cNvSpPr txBox="1"/>
            <p:nvPr/>
          </p:nvSpPr>
          <p:spPr>
            <a:xfrm>
              <a:off x="1444194" y="995237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7">
              <a:extLst>
                <a:ext uri="{FF2B5EF4-FFF2-40B4-BE49-F238E27FC236}">
                  <a16:creationId xmlns:a16="http://schemas.microsoft.com/office/drawing/2014/main" id="{765742F3-0EA2-9DEF-E279-B81FEEBCFE78}"/>
                </a:ext>
              </a:extLst>
            </p:cNvPr>
            <p:cNvSpPr txBox="1"/>
            <p:nvPr/>
          </p:nvSpPr>
          <p:spPr>
            <a:xfrm>
              <a:off x="2453623" y="756549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7">
              <a:extLst>
                <a:ext uri="{FF2B5EF4-FFF2-40B4-BE49-F238E27FC236}">
                  <a16:creationId xmlns:a16="http://schemas.microsoft.com/office/drawing/2014/main" id="{5C07B92E-5014-8477-C29A-580CD4F1430E}"/>
                </a:ext>
              </a:extLst>
            </p:cNvPr>
            <p:cNvSpPr txBox="1"/>
            <p:nvPr/>
          </p:nvSpPr>
          <p:spPr>
            <a:xfrm>
              <a:off x="1938118" y="1239405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テキスト ボックス 7">
              <a:extLst>
                <a:ext uri="{FF2B5EF4-FFF2-40B4-BE49-F238E27FC236}">
                  <a16:creationId xmlns:a16="http://schemas.microsoft.com/office/drawing/2014/main" id="{CEC784B1-5CD0-CC21-7BD3-31997B814EE4}"/>
                </a:ext>
              </a:extLst>
            </p:cNvPr>
            <p:cNvSpPr txBox="1"/>
            <p:nvPr/>
          </p:nvSpPr>
          <p:spPr>
            <a:xfrm>
              <a:off x="2948681" y="840808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テキスト ボックス 7">
              <a:extLst>
                <a:ext uri="{FF2B5EF4-FFF2-40B4-BE49-F238E27FC236}">
                  <a16:creationId xmlns:a16="http://schemas.microsoft.com/office/drawing/2014/main" id="{0D6107DC-FBC8-7690-6817-70304D97862B}"/>
                </a:ext>
              </a:extLst>
            </p:cNvPr>
            <p:cNvSpPr txBox="1"/>
            <p:nvPr/>
          </p:nvSpPr>
          <p:spPr>
            <a:xfrm>
              <a:off x="3450768" y="786218"/>
              <a:ext cx="260835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テキスト ボックス 7">
              <a:extLst>
                <a:ext uri="{FF2B5EF4-FFF2-40B4-BE49-F238E27FC236}">
                  <a16:creationId xmlns:a16="http://schemas.microsoft.com/office/drawing/2014/main" id="{65D1174A-7F01-FB72-D20F-E356B7E08332}"/>
                </a:ext>
              </a:extLst>
            </p:cNvPr>
            <p:cNvSpPr txBox="1"/>
            <p:nvPr/>
          </p:nvSpPr>
          <p:spPr>
            <a:xfrm>
              <a:off x="1655815" y="1107124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テキスト ボックス 7">
              <a:extLst>
                <a:ext uri="{FF2B5EF4-FFF2-40B4-BE49-F238E27FC236}">
                  <a16:creationId xmlns:a16="http://schemas.microsoft.com/office/drawing/2014/main" id="{B8AAA289-B34E-EF24-7EE4-061F95E310E7}"/>
                </a:ext>
              </a:extLst>
            </p:cNvPr>
            <p:cNvSpPr txBox="1"/>
            <p:nvPr/>
          </p:nvSpPr>
          <p:spPr>
            <a:xfrm>
              <a:off x="2161000" y="1234864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テキスト ボックス 7">
              <a:extLst>
                <a:ext uri="{FF2B5EF4-FFF2-40B4-BE49-F238E27FC236}">
                  <a16:creationId xmlns:a16="http://schemas.microsoft.com/office/drawing/2014/main" id="{856120BD-4A5C-4F39-4242-BE79A59B4E44}"/>
                </a:ext>
              </a:extLst>
            </p:cNvPr>
            <p:cNvSpPr txBox="1"/>
            <p:nvPr/>
          </p:nvSpPr>
          <p:spPr>
            <a:xfrm>
              <a:off x="2655085" y="1139473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7">
              <a:extLst>
                <a:ext uri="{FF2B5EF4-FFF2-40B4-BE49-F238E27FC236}">
                  <a16:creationId xmlns:a16="http://schemas.microsoft.com/office/drawing/2014/main" id="{81B3484B-ADB2-01E2-F745-B62D1ABCB7E4}"/>
                </a:ext>
              </a:extLst>
            </p:cNvPr>
            <p:cNvSpPr txBox="1"/>
            <p:nvPr/>
          </p:nvSpPr>
          <p:spPr>
            <a:xfrm>
              <a:off x="3167112" y="1034036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テキスト ボックス 7">
              <a:extLst>
                <a:ext uri="{FF2B5EF4-FFF2-40B4-BE49-F238E27FC236}">
                  <a16:creationId xmlns:a16="http://schemas.microsoft.com/office/drawing/2014/main" id="{2B45674B-B2A4-86FD-EE1B-BAC18602B732}"/>
                </a:ext>
              </a:extLst>
            </p:cNvPr>
            <p:cNvSpPr txBox="1"/>
            <p:nvPr/>
          </p:nvSpPr>
          <p:spPr>
            <a:xfrm>
              <a:off x="3659693" y="221458"/>
              <a:ext cx="287839" cy="2592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100" b="1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altLang="zh-CN" sz="1100">
                  <a:solidFill>
                    <a:schemeClr val="bg1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'</a:t>
              </a:r>
              <a:endParaRPr lang="zh-CN" altLang="en-US" sz="1100" b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D950673E-A140-94AF-7077-3A50F58A780A}"/>
              </a:ext>
            </a:extLst>
          </p:cNvPr>
          <p:cNvSpPr txBox="1"/>
          <p:nvPr/>
        </p:nvSpPr>
        <p:spPr>
          <a:xfrm>
            <a:off x="117000" y="5118589"/>
            <a:ext cx="89100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1.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Time- and does-dependent changes in shoot biomas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under Mn treatmen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(A) Time-dependent changes in shoot biomass. Seedlings (20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50 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Mn for 3, 6, 12, 24, and 48 h. Shoot fresh weigh at 3 h was defined as 100% for HE and NHE, respectively. (B) Dose-dependent changes in shoot biomass. Seedlings (16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different Mn concentrations including 0.5, 5, 50, 200, or 500 μM for 12 d</a:t>
            </a:r>
            <a:r>
              <a:rPr lang="en-US" altLang="zh-CN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ays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 Shoot fresh weigh in the presence of 0.5 μM Mn treatment was defined as 100% for HE and NHE, respectively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FW, fresh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4620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>
            <a:extLst>
              <a:ext uri="{FF2B5EF4-FFF2-40B4-BE49-F238E27FC236}">
                <a16:creationId xmlns:a16="http://schemas.microsoft.com/office/drawing/2014/main" id="{8630C500-F622-1EE2-F2D1-EA0F091186DC}"/>
              </a:ext>
            </a:extLst>
          </p:cNvPr>
          <p:cNvSpPr txBox="1"/>
          <p:nvPr/>
        </p:nvSpPr>
        <p:spPr>
          <a:xfrm>
            <a:off x="117000" y="5712182"/>
            <a:ext cx="891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Time-dependent accumulation of mineral elements (Mg, P, K, Ca, Fe, Cu, and Zn) in the shoot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20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50 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Mn for 3, 6, 12, 24, and 48 h. The concentrations of Mg (A), P (B), K (C), Ca (D), Fe (E), Cu (F), and Zn (G) in the shoots were determined by ICP-MS after digestion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DW, dry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A5022D69-6DF7-3B16-8DAA-E730FB27894F}"/>
              </a:ext>
            </a:extLst>
          </p:cNvPr>
          <p:cNvGrpSpPr/>
          <p:nvPr/>
        </p:nvGrpSpPr>
        <p:grpSpPr>
          <a:xfrm>
            <a:off x="1303854" y="5888"/>
            <a:ext cx="6508146" cy="5695325"/>
            <a:chOff x="1303854" y="82088"/>
            <a:chExt cx="6508146" cy="5695325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1A79EDB4-A6C4-4AFE-C580-59411FEC1AB9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507546" y="351690"/>
              <a:ext cx="2136174" cy="1708396"/>
              <a:chOff x="3294570" y="243842"/>
              <a:chExt cx="2700858" cy="2160000"/>
            </a:xfrm>
          </p:grpSpPr>
          <p:pic>
            <p:nvPicPr>
              <p:cNvPr id="13" name="Picture 12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8C81F397-67BC-3100-CC73-67E4FC31B7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94570" y="243842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29" name="テキスト ボックス 7">
                <a:extLst>
                  <a:ext uri="{FF2B5EF4-FFF2-40B4-BE49-F238E27FC236}">
                    <a16:creationId xmlns:a16="http://schemas.microsoft.com/office/drawing/2014/main" id="{E424201E-04BE-DC27-43A6-41F621F05F97}"/>
                  </a:ext>
                </a:extLst>
              </p:cNvPr>
              <p:cNvSpPr txBox="1"/>
              <p:nvPr/>
            </p:nvSpPr>
            <p:spPr>
              <a:xfrm>
                <a:off x="4029173" y="84015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2" name="テキスト ボックス 7">
                <a:extLst>
                  <a:ext uri="{FF2B5EF4-FFF2-40B4-BE49-F238E27FC236}">
                    <a16:creationId xmlns:a16="http://schemas.microsoft.com/office/drawing/2014/main" id="{430BB8FA-1A6A-9BA7-6321-E4BC58578519}"/>
                  </a:ext>
                </a:extLst>
              </p:cNvPr>
              <p:cNvSpPr txBox="1"/>
              <p:nvPr/>
            </p:nvSpPr>
            <p:spPr>
              <a:xfrm>
                <a:off x="3858928" y="8001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" name="テキスト ボックス 7">
                <a:extLst>
                  <a:ext uri="{FF2B5EF4-FFF2-40B4-BE49-F238E27FC236}">
                    <a16:creationId xmlns:a16="http://schemas.microsoft.com/office/drawing/2014/main" id="{A557BC3E-9863-203B-1557-E87CA9810746}"/>
                  </a:ext>
                </a:extLst>
              </p:cNvPr>
              <p:cNvSpPr txBox="1"/>
              <p:nvPr/>
            </p:nvSpPr>
            <p:spPr>
              <a:xfrm>
                <a:off x="4256214" y="106916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" name="テキスト ボックス 7">
                <a:extLst>
                  <a:ext uri="{FF2B5EF4-FFF2-40B4-BE49-F238E27FC236}">
                    <a16:creationId xmlns:a16="http://schemas.microsoft.com/office/drawing/2014/main" id="{555C60E8-FB8B-6B70-7B29-1773D8A5BB99}"/>
                  </a:ext>
                </a:extLst>
              </p:cNvPr>
              <p:cNvSpPr txBox="1"/>
              <p:nvPr/>
            </p:nvSpPr>
            <p:spPr>
              <a:xfrm>
                <a:off x="4656895" y="48872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BCE8A75C-9116-03E6-B9D4-AF7B21E49966}"/>
                  </a:ext>
                </a:extLst>
              </p:cNvPr>
              <p:cNvSpPr txBox="1"/>
              <p:nvPr/>
            </p:nvSpPr>
            <p:spPr>
              <a:xfrm>
                <a:off x="5062636" y="99184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0" name="テキスト ボックス 7">
                <a:extLst>
                  <a:ext uri="{FF2B5EF4-FFF2-40B4-BE49-F238E27FC236}">
                    <a16:creationId xmlns:a16="http://schemas.microsoft.com/office/drawing/2014/main" id="{6BE1357B-6D99-C888-D6DD-5180C9F4816C}"/>
                  </a:ext>
                </a:extLst>
              </p:cNvPr>
              <p:cNvSpPr txBox="1"/>
              <p:nvPr/>
            </p:nvSpPr>
            <p:spPr>
              <a:xfrm>
                <a:off x="5467102" y="52591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12" name="テキスト ボックス 7">
                <a:extLst>
                  <a:ext uri="{FF2B5EF4-FFF2-40B4-BE49-F238E27FC236}">
                    <a16:creationId xmlns:a16="http://schemas.microsoft.com/office/drawing/2014/main" id="{2BE08D64-874A-DB89-65BF-2825A0860C04}"/>
                  </a:ext>
                </a:extLst>
              </p:cNvPr>
              <p:cNvSpPr txBox="1"/>
              <p:nvPr/>
            </p:nvSpPr>
            <p:spPr>
              <a:xfrm>
                <a:off x="4432399" y="756264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14" name="テキスト ボックス 7">
                <a:extLst>
                  <a:ext uri="{FF2B5EF4-FFF2-40B4-BE49-F238E27FC236}">
                    <a16:creationId xmlns:a16="http://schemas.microsoft.com/office/drawing/2014/main" id="{021021F0-ABE1-F18B-7D8F-6E2A157892C8}"/>
                  </a:ext>
                </a:extLst>
              </p:cNvPr>
              <p:cNvSpPr txBox="1"/>
              <p:nvPr/>
            </p:nvSpPr>
            <p:spPr>
              <a:xfrm>
                <a:off x="4832353" y="865055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16" name="テキスト ボックス 7">
                <a:extLst>
                  <a:ext uri="{FF2B5EF4-FFF2-40B4-BE49-F238E27FC236}">
                    <a16:creationId xmlns:a16="http://schemas.microsoft.com/office/drawing/2014/main" id="{86100581-9D0A-CBFB-160A-A1FEFA16329B}"/>
                  </a:ext>
                </a:extLst>
              </p:cNvPr>
              <p:cNvSpPr txBox="1"/>
              <p:nvPr/>
            </p:nvSpPr>
            <p:spPr>
              <a:xfrm>
                <a:off x="5234283" y="36589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17" name="テキスト ボックス 7">
                <a:extLst>
                  <a:ext uri="{FF2B5EF4-FFF2-40B4-BE49-F238E27FC236}">
                    <a16:creationId xmlns:a16="http://schemas.microsoft.com/office/drawing/2014/main" id="{CFC134D6-35B8-50F9-FA68-5E205BE075BF}"/>
                  </a:ext>
                </a:extLst>
              </p:cNvPr>
              <p:cNvSpPr txBox="1"/>
              <p:nvPr/>
            </p:nvSpPr>
            <p:spPr>
              <a:xfrm>
                <a:off x="5628889" y="404640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pic>
          <p:nvPicPr>
            <p:cNvPr id="15" name="Picture 14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BC659FCF-BE50-6FC2-8A36-5E2C1C52A3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32000" y="351690"/>
              <a:ext cx="2136174" cy="1708396"/>
            </a:xfrm>
            <a:prstGeom prst="rect">
              <a:avLst/>
            </a:prstGeom>
          </p:spPr>
        </p:pic>
        <p:sp>
          <p:nvSpPr>
            <p:cNvPr id="23" name="テキスト ボックス 7">
              <a:extLst>
                <a:ext uri="{FF2B5EF4-FFF2-40B4-BE49-F238E27FC236}">
                  <a16:creationId xmlns:a16="http://schemas.microsoft.com/office/drawing/2014/main" id="{5B470E50-9D94-11B3-9DD2-9C4AD8EFAEA2}"/>
                </a:ext>
              </a:extLst>
            </p:cNvPr>
            <p:cNvSpPr txBox="1"/>
            <p:nvPr/>
          </p:nvSpPr>
          <p:spPr>
            <a:xfrm>
              <a:off x="1750907" y="977896"/>
              <a:ext cx="26000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24" name="テキスト ボックス 7">
              <a:extLst>
                <a:ext uri="{FF2B5EF4-FFF2-40B4-BE49-F238E27FC236}">
                  <a16:creationId xmlns:a16="http://schemas.microsoft.com/office/drawing/2014/main" id="{B6030661-F39D-DFAA-C05B-EDA5BC40FA2A}"/>
                </a:ext>
              </a:extLst>
            </p:cNvPr>
            <p:cNvSpPr txBox="1"/>
            <p:nvPr/>
          </p:nvSpPr>
          <p:spPr>
            <a:xfrm>
              <a:off x="2071451" y="968462"/>
              <a:ext cx="26000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25" name="テキスト ボックス 7">
              <a:extLst>
                <a:ext uri="{FF2B5EF4-FFF2-40B4-BE49-F238E27FC236}">
                  <a16:creationId xmlns:a16="http://schemas.microsoft.com/office/drawing/2014/main" id="{BCB7F137-F033-5ECC-7878-377F912DF301}"/>
                </a:ext>
              </a:extLst>
            </p:cNvPr>
            <p:cNvSpPr txBox="1"/>
            <p:nvPr/>
          </p:nvSpPr>
          <p:spPr>
            <a:xfrm>
              <a:off x="2386932" y="947857"/>
              <a:ext cx="26000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26" name="テキスト ボックス 7">
              <a:extLst>
                <a:ext uri="{FF2B5EF4-FFF2-40B4-BE49-F238E27FC236}">
                  <a16:creationId xmlns:a16="http://schemas.microsoft.com/office/drawing/2014/main" id="{53D8E3FF-19CB-FDE9-E5D4-77E0DF6BD155}"/>
                </a:ext>
              </a:extLst>
            </p:cNvPr>
            <p:cNvSpPr txBox="1"/>
            <p:nvPr/>
          </p:nvSpPr>
          <p:spPr>
            <a:xfrm>
              <a:off x="2707403" y="952984"/>
              <a:ext cx="26000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28" name="テキスト ボックス 7">
              <a:extLst>
                <a:ext uri="{FF2B5EF4-FFF2-40B4-BE49-F238E27FC236}">
                  <a16:creationId xmlns:a16="http://schemas.microsoft.com/office/drawing/2014/main" id="{26FCB5A6-077D-C56E-DA31-CC628CCB31C5}"/>
                </a:ext>
              </a:extLst>
            </p:cNvPr>
            <p:cNvSpPr txBox="1"/>
            <p:nvPr/>
          </p:nvSpPr>
          <p:spPr>
            <a:xfrm>
              <a:off x="2972326" y="821282"/>
              <a:ext cx="26000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0" name="テキスト ボックス 7">
              <a:extLst>
                <a:ext uri="{FF2B5EF4-FFF2-40B4-BE49-F238E27FC236}">
                  <a16:creationId xmlns:a16="http://schemas.microsoft.com/office/drawing/2014/main" id="{5DCD7342-3390-AD85-782F-6E6D1CAB6169}"/>
                </a:ext>
              </a:extLst>
            </p:cNvPr>
            <p:cNvSpPr txBox="1"/>
            <p:nvPr/>
          </p:nvSpPr>
          <p:spPr>
            <a:xfrm>
              <a:off x="2199723" y="1012378"/>
              <a:ext cx="2856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31" name="テキスト ボックス 7">
              <a:extLst>
                <a:ext uri="{FF2B5EF4-FFF2-40B4-BE49-F238E27FC236}">
                  <a16:creationId xmlns:a16="http://schemas.microsoft.com/office/drawing/2014/main" id="{5DD4E2F7-7CFC-1676-5617-794180260B21}"/>
                </a:ext>
              </a:extLst>
            </p:cNvPr>
            <p:cNvSpPr txBox="1"/>
            <p:nvPr/>
          </p:nvSpPr>
          <p:spPr>
            <a:xfrm>
              <a:off x="2513387" y="1024511"/>
              <a:ext cx="2856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32" name="テキスト ボックス 7">
              <a:extLst>
                <a:ext uri="{FF2B5EF4-FFF2-40B4-BE49-F238E27FC236}">
                  <a16:creationId xmlns:a16="http://schemas.microsoft.com/office/drawing/2014/main" id="{F658A455-1F42-1069-7576-61DEC34C4B49}"/>
                </a:ext>
              </a:extLst>
            </p:cNvPr>
            <p:cNvSpPr txBox="1"/>
            <p:nvPr/>
          </p:nvSpPr>
          <p:spPr>
            <a:xfrm>
              <a:off x="2832789" y="1022628"/>
              <a:ext cx="2856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33" name="テキスト ボックス 7">
              <a:extLst>
                <a:ext uri="{FF2B5EF4-FFF2-40B4-BE49-F238E27FC236}">
                  <a16:creationId xmlns:a16="http://schemas.microsoft.com/office/drawing/2014/main" id="{16DFF568-0A91-5491-1B3B-17DDE6BB3353}"/>
                </a:ext>
              </a:extLst>
            </p:cNvPr>
            <p:cNvSpPr txBox="1"/>
            <p:nvPr/>
          </p:nvSpPr>
          <p:spPr>
            <a:xfrm>
              <a:off x="3151650" y="805752"/>
              <a:ext cx="2856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38" name="テキスト ボックス 7">
              <a:extLst>
                <a:ext uri="{FF2B5EF4-FFF2-40B4-BE49-F238E27FC236}">
                  <a16:creationId xmlns:a16="http://schemas.microsoft.com/office/drawing/2014/main" id="{CF8EF4B4-F902-60CF-98D8-FB79B7340E0A}"/>
                </a:ext>
              </a:extLst>
            </p:cNvPr>
            <p:cNvSpPr txBox="1"/>
            <p:nvPr/>
          </p:nvSpPr>
          <p:spPr>
            <a:xfrm>
              <a:off x="1878775" y="809328"/>
              <a:ext cx="28565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C5ED0C81-E723-0F23-D04F-9F3E97180E6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75826" y="351690"/>
              <a:ext cx="2136174" cy="1708396"/>
              <a:chOff x="5995428" y="243842"/>
              <a:chExt cx="2700858" cy="2160000"/>
            </a:xfrm>
          </p:grpSpPr>
          <p:pic>
            <p:nvPicPr>
              <p:cNvPr id="11" name="Picture 10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F4994A0C-7A32-A393-38C7-98EB78C368C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95428" y="243842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39" name="テキスト ボックス 7">
                <a:extLst>
                  <a:ext uri="{FF2B5EF4-FFF2-40B4-BE49-F238E27FC236}">
                    <a16:creationId xmlns:a16="http://schemas.microsoft.com/office/drawing/2014/main" id="{855C1EA0-33B4-CA17-5F9A-BC09AF77E79C}"/>
                  </a:ext>
                </a:extLst>
              </p:cNvPr>
              <p:cNvSpPr txBox="1"/>
              <p:nvPr/>
            </p:nvSpPr>
            <p:spPr>
              <a:xfrm>
                <a:off x="6616212" y="111266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0" name="テキスト ボックス 7">
                <a:extLst>
                  <a:ext uri="{FF2B5EF4-FFF2-40B4-BE49-F238E27FC236}">
                    <a16:creationId xmlns:a16="http://schemas.microsoft.com/office/drawing/2014/main" id="{B73E172A-0545-7260-6790-463B18B82C8F}"/>
                  </a:ext>
                </a:extLst>
              </p:cNvPr>
              <p:cNvSpPr txBox="1"/>
              <p:nvPr/>
            </p:nvSpPr>
            <p:spPr>
              <a:xfrm>
                <a:off x="7012732" y="11549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1" name="テキスト ボックス 7">
                <a:extLst>
                  <a:ext uri="{FF2B5EF4-FFF2-40B4-BE49-F238E27FC236}">
                    <a16:creationId xmlns:a16="http://schemas.microsoft.com/office/drawing/2014/main" id="{827E080A-B60E-86DD-D7F9-47A7990636E6}"/>
                  </a:ext>
                </a:extLst>
              </p:cNvPr>
              <p:cNvSpPr txBox="1"/>
              <p:nvPr/>
            </p:nvSpPr>
            <p:spPr>
              <a:xfrm>
                <a:off x="7393110" y="116752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2" name="テキスト ボックス 7">
                <a:extLst>
                  <a:ext uri="{FF2B5EF4-FFF2-40B4-BE49-F238E27FC236}">
                    <a16:creationId xmlns:a16="http://schemas.microsoft.com/office/drawing/2014/main" id="{62A3C473-0887-A04F-9351-6BC521D4AD8F}"/>
                  </a:ext>
                </a:extLst>
              </p:cNvPr>
              <p:cNvSpPr txBox="1"/>
              <p:nvPr/>
            </p:nvSpPr>
            <p:spPr>
              <a:xfrm>
                <a:off x="7787467" y="100771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3" name="テキスト ボックス 7">
                <a:extLst>
                  <a:ext uri="{FF2B5EF4-FFF2-40B4-BE49-F238E27FC236}">
                    <a16:creationId xmlns:a16="http://schemas.microsoft.com/office/drawing/2014/main" id="{0DB1E9D2-926D-CC42-0A7E-D1FA137B63D2}"/>
                  </a:ext>
                </a:extLst>
              </p:cNvPr>
              <p:cNvSpPr txBox="1"/>
              <p:nvPr/>
            </p:nvSpPr>
            <p:spPr>
              <a:xfrm>
                <a:off x="8177115" y="65397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44" name="テキスト ボックス 7">
                <a:extLst>
                  <a:ext uri="{FF2B5EF4-FFF2-40B4-BE49-F238E27FC236}">
                    <a16:creationId xmlns:a16="http://schemas.microsoft.com/office/drawing/2014/main" id="{12C6D543-CA92-E7D6-1554-3C09D2EB7319}"/>
                  </a:ext>
                </a:extLst>
              </p:cNvPr>
              <p:cNvSpPr txBox="1"/>
              <p:nvPr/>
            </p:nvSpPr>
            <p:spPr>
              <a:xfrm>
                <a:off x="7168808" y="737152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45" name="テキスト ボックス 7">
                <a:extLst>
                  <a:ext uri="{FF2B5EF4-FFF2-40B4-BE49-F238E27FC236}">
                    <a16:creationId xmlns:a16="http://schemas.microsoft.com/office/drawing/2014/main" id="{BC3CC0CF-A85A-576F-8DCB-6E04688A7298}"/>
                  </a:ext>
                </a:extLst>
              </p:cNvPr>
              <p:cNvSpPr txBox="1"/>
              <p:nvPr/>
            </p:nvSpPr>
            <p:spPr>
              <a:xfrm>
                <a:off x="7569125" y="775844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46" name="テキスト ボックス 7">
                <a:extLst>
                  <a:ext uri="{FF2B5EF4-FFF2-40B4-BE49-F238E27FC236}">
                    <a16:creationId xmlns:a16="http://schemas.microsoft.com/office/drawing/2014/main" id="{972D40E8-BB41-A941-5B44-8B9A945B8583}"/>
                  </a:ext>
                </a:extLst>
              </p:cNvPr>
              <p:cNvSpPr txBox="1"/>
              <p:nvPr/>
            </p:nvSpPr>
            <p:spPr>
              <a:xfrm>
                <a:off x="7956705" y="730971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47" name="テキスト ボックス 7">
                <a:extLst>
                  <a:ext uri="{FF2B5EF4-FFF2-40B4-BE49-F238E27FC236}">
                    <a16:creationId xmlns:a16="http://schemas.microsoft.com/office/drawing/2014/main" id="{35F73A9D-5A15-880E-AB0F-02AD79A548FD}"/>
                  </a:ext>
                </a:extLst>
              </p:cNvPr>
              <p:cNvSpPr txBox="1"/>
              <p:nvPr/>
            </p:nvSpPr>
            <p:spPr>
              <a:xfrm>
                <a:off x="8341933" y="383550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48" name="テキスト ボックス 7">
                <a:extLst>
                  <a:ext uri="{FF2B5EF4-FFF2-40B4-BE49-F238E27FC236}">
                    <a16:creationId xmlns:a16="http://schemas.microsoft.com/office/drawing/2014/main" id="{E3E753BF-41ED-145E-9A87-C6C4F08DAADC}"/>
                  </a:ext>
                </a:extLst>
              </p:cNvPr>
              <p:cNvSpPr txBox="1"/>
              <p:nvPr/>
            </p:nvSpPr>
            <p:spPr>
              <a:xfrm>
                <a:off x="6782073" y="770943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F5E338CE-1BB7-E37B-C733-11648257426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32000" y="2206970"/>
              <a:ext cx="2136174" cy="1708396"/>
              <a:chOff x="8696286" y="243842"/>
              <a:chExt cx="2700858" cy="2160000"/>
            </a:xfrm>
          </p:grpSpPr>
          <p:pic>
            <p:nvPicPr>
              <p:cNvPr id="9" name="Picture 8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E7FC662B-60FB-0412-CFD5-09B54A9568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8696286" y="243842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49" name="テキスト ボックス 7">
                <a:extLst>
                  <a:ext uri="{FF2B5EF4-FFF2-40B4-BE49-F238E27FC236}">
                    <a16:creationId xmlns:a16="http://schemas.microsoft.com/office/drawing/2014/main" id="{CCD4258F-A7FB-FFE0-9149-C6BF279DA7A1}"/>
                  </a:ext>
                </a:extLst>
              </p:cNvPr>
              <p:cNvSpPr txBox="1"/>
              <p:nvPr/>
            </p:nvSpPr>
            <p:spPr>
              <a:xfrm>
                <a:off x="9316505" y="107350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0" name="テキスト ボックス 7">
                <a:extLst>
                  <a:ext uri="{FF2B5EF4-FFF2-40B4-BE49-F238E27FC236}">
                    <a16:creationId xmlns:a16="http://schemas.microsoft.com/office/drawing/2014/main" id="{47DB6B0E-037A-052F-E01B-0BEB8A357A7C}"/>
                  </a:ext>
                </a:extLst>
              </p:cNvPr>
              <p:cNvSpPr txBox="1"/>
              <p:nvPr/>
            </p:nvSpPr>
            <p:spPr>
              <a:xfrm>
                <a:off x="9706964" y="105047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1" name="テキスト ボックス 7">
                <a:extLst>
                  <a:ext uri="{FF2B5EF4-FFF2-40B4-BE49-F238E27FC236}">
                    <a16:creationId xmlns:a16="http://schemas.microsoft.com/office/drawing/2014/main" id="{0E3CEB4D-4CDB-382C-D637-3967E4F6F7D5}"/>
                  </a:ext>
                </a:extLst>
              </p:cNvPr>
              <p:cNvSpPr txBox="1"/>
              <p:nvPr/>
            </p:nvSpPr>
            <p:spPr>
              <a:xfrm>
                <a:off x="10100181" y="94959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2" name="テキスト ボックス 7">
                <a:extLst>
                  <a:ext uri="{FF2B5EF4-FFF2-40B4-BE49-F238E27FC236}">
                    <a16:creationId xmlns:a16="http://schemas.microsoft.com/office/drawing/2014/main" id="{7E5D4F4B-FFFB-F734-B257-5A324060BC1B}"/>
                  </a:ext>
                </a:extLst>
              </p:cNvPr>
              <p:cNvSpPr txBox="1"/>
              <p:nvPr/>
            </p:nvSpPr>
            <p:spPr>
              <a:xfrm>
                <a:off x="10485818" y="108912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3" name="テキスト ボックス 7">
                <a:extLst>
                  <a:ext uri="{FF2B5EF4-FFF2-40B4-BE49-F238E27FC236}">
                    <a16:creationId xmlns:a16="http://schemas.microsoft.com/office/drawing/2014/main" id="{B8978AC7-EB02-735C-40C1-644CA9A0CD94}"/>
                  </a:ext>
                </a:extLst>
              </p:cNvPr>
              <p:cNvSpPr txBox="1"/>
              <p:nvPr/>
            </p:nvSpPr>
            <p:spPr>
              <a:xfrm>
                <a:off x="10808049" y="77416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54" name="テキスト ボックス 7">
                <a:extLst>
                  <a:ext uri="{FF2B5EF4-FFF2-40B4-BE49-F238E27FC236}">
                    <a16:creationId xmlns:a16="http://schemas.microsoft.com/office/drawing/2014/main" id="{8AD05BF0-1232-20C5-4936-9B29D45B935A}"/>
                  </a:ext>
                </a:extLst>
              </p:cNvPr>
              <p:cNvSpPr txBox="1"/>
              <p:nvPr/>
            </p:nvSpPr>
            <p:spPr>
              <a:xfrm>
                <a:off x="9871950" y="93371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55" name="テキスト ボックス 7">
                <a:extLst>
                  <a:ext uri="{FF2B5EF4-FFF2-40B4-BE49-F238E27FC236}">
                    <a16:creationId xmlns:a16="http://schemas.microsoft.com/office/drawing/2014/main" id="{BA483C3C-3648-6F8E-871A-BA1ECB5E94A9}"/>
                  </a:ext>
                </a:extLst>
              </p:cNvPr>
              <p:cNvSpPr txBox="1"/>
              <p:nvPr/>
            </p:nvSpPr>
            <p:spPr>
              <a:xfrm>
                <a:off x="10260880" y="981476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56" name="テキスト ボックス 7">
                <a:extLst>
                  <a:ext uri="{FF2B5EF4-FFF2-40B4-BE49-F238E27FC236}">
                    <a16:creationId xmlns:a16="http://schemas.microsoft.com/office/drawing/2014/main" id="{A58B506F-655B-08F9-7ABA-0B6CFF5E977D}"/>
                  </a:ext>
                </a:extLst>
              </p:cNvPr>
              <p:cNvSpPr txBox="1"/>
              <p:nvPr/>
            </p:nvSpPr>
            <p:spPr>
              <a:xfrm>
                <a:off x="10649355" y="934117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57" name="テキスト ボックス 7">
                <a:extLst>
                  <a:ext uri="{FF2B5EF4-FFF2-40B4-BE49-F238E27FC236}">
                    <a16:creationId xmlns:a16="http://schemas.microsoft.com/office/drawing/2014/main" id="{2BC61F1A-E349-AA11-F788-13294666C006}"/>
                  </a:ext>
                </a:extLst>
              </p:cNvPr>
              <p:cNvSpPr txBox="1"/>
              <p:nvPr/>
            </p:nvSpPr>
            <p:spPr>
              <a:xfrm>
                <a:off x="11043140" y="587550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58" name="テキスト ボックス 7">
                <a:extLst>
                  <a:ext uri="{FF2B5EF4-FFF2-40B4-BE49-F238E27FC236}">
                    <a16:creationId xmlns:a16="http://schemas.microsoft.com/office/drawing/2014/main" id="{D8D4A1E5-D34B-FD46-E68A-35634828EDBD}"/>
                  </a:ext>
                </a:extLst>
              </p:cNvPr>
              <p:cNvSpPr txBox="1"/>
              <p:nvPr/>
            </p:nvSpPr>
            <p:spPr>
              <a:xfrm>
                <a:off x="9482660" y="975541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326367EC-871C-1338-6478-920E33C47C8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507546" y="2206970"/>
              <a:ext cx="2136174" cy="1708396"/>
              <a:chOff x="593712" y="2423478"/>
              <a:chExt cx="2700858" cy="2160000"/>
            </a:xfrm>
          </p:grpSpPr>
          <p:pic>
            <p:nvPicPr>
              <p:cNvPr id="7" name="Picture 6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F0BB1CE0-D557-773C-E73F-0F52F4EF73F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3712" y="2423478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59" name="テキスト ボックス 7">
                <a:extLst>
                  <a:ext uri="{FF2B5EF4-FFF2-40B4-BE49-F238E27FC236}">
                    <a16:creationId xmlns:a16="http://schemas.microsoft.com/office/drawing/2014/main" id="{9E09C334-EE1A-8C69-B3ED-CE85B2230994}"/>
                  </a:ext>
                </a:extLst>
              </p:cNvPr>
              <p:cNvSpPr txBox="1"/>
              <p:nvPr/>
            </p:nvSpPr>
            <p:spPr>
              <a:xfrm>
                <a:off x="1055615" y="292885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0" name="テキスト ボックス 7">
                <a:extLst>
                  <a:ext uri="{FF2B5EF4-FFF2-40B4-BE49-F238E27FC236}">
                    <a16:creationId xmlns:a16="http://schemas.microsoft.com/office/drawing/2014/main" id="{04722FDB-2539-59BF-E72A-EC3EB924F7F6}"/>
                  </a:ext>
                </a:extLst>
              </p:cNvPr>
              <p:cNvSpPr txBox="1"/>
              <p:nvPr/>
            </p:nvSpPr>
            <p:spPr>
              <a:xfrm>
                <a:off x="1474656" y="295980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1" name="テキスト ボックス 7">
                <a:extLst>
                  <a:ext uri="{FF2B5EF4-FFF2-40B4-BE49-F238E27FC236}">
                    <a16:creationId xmlns:a16="http://schemas.microsoft.com/office/drawing/2014/main" id="{B09EEDA8-E69A-37A0-C3DE-ED634BE6500E}"/>
                  </a:ext>
                </a:extLst>
              </p:cNvPr>
              <p:cNvSpPr txBox="1"/>
              <p:nvPr/>
            </p:nvSpPr>
            <p:spPr>
              <a:xfrm>
                <a:off x="1897643" y="311452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2" name="テキスト ボックス 7">
                <a:extLst>
                  <a:ext uri="{FF2B5EF4-FFF2-40B4-BE49-F238E27FC236}">
                    <a16:creationId xmlns:a16="http://schemas.microsoft.com/office/drawing/2014/main" id="{2A49CF05-ACC6-C961-A2E2-78C0FB8BA6C5}"/>
                  </a:ext>
                </a:extLst>
              </p:cNvPr>
              <p:cNvSpPr txBox="1"/>
              <p:nvPr/>
            </p:nvSpPr>
            <p:spPr>
              <a:xfrm>
                <a:off x="2244314" y="291170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3" name="テキスト ボックス 7">
                <a:extLst>
                  <a:ext uri="{FF2B5EF4-FFF2-40B4-BE49-F238E27FC236}">
                    <a16:creationId xmlns:a16="http://schemas.microsoft.com/office/drawing/2014/main" id="{04BE5671-D392-6D62-5B18-D89592217500}"/>
                  </a:ext>
                </a:extLst>
              </p:cNvPr>
              <p:cNvSpPr txBox="1"/>
              <p:nvPr/>
            </p:nvSpPr>
            <p:spPr>
              <a:xfrm>
                <a:off x="2666974" y="276455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64" name="テキスト ボックス 7">
                <a:extLst>
                  <a:ext uri="{FF2B5EF4-FFF2-40B4-BE49-F238E27FC236}">
                    <a16:creationId xmlns:a16="http://schemas.microsoft.com/office/drawing/2014/main" id="{7F6B4452-8AEF-35D7-7022-F182CD8E6E9E}"/>
                  </a:ext>
                </a:extLst>
              </p:cNvPr>
              <p:cNvSpPr txBox="1"/>
              <p:nvPr/>
            </p:nvSpPr>
            <p:spPr>
              <a:xfrm>
                <a:off x="1656155" y="3426824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65" name="テキスト ボックス 7">
                <a:extLst>
                  <a:ext uri="{FF2B5EF4-FFF2-40B4-BE49-F238E27FC236}">
                    <a16:creationId xmlns:a16="http://schemas.microsoft.com/office/drawing/2014/main" id="{785C77AB-E557-438B-C030-80CDD14E3A5A}"/>
                  </a:ext>
                </a:extLst>
              </p:cNvPr>
              <p:cNvSpPr txBox="1"/>
              <p:nvPr/>
            </p:nvSpPr>
            <p:spPr>
              <a:xfrm>
                <a:off x="2079633" y="3194837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66" name="テキスト ボックス 7">
                <a:extLst>
                  <a:ext uri="{FF2B5EF4-FFF2-40B4-BE49-F238E27FC236}">
                    <a16:creationId xmlns:a16="http://schemas.microsoft.com/office/drawing/2014/main" id="{6CAF84C9-B5BD-02D5-CB23-B1A8754FD38F}"/>
                  </a:ext>
                </a:extLst>
              </p:cNvPr>
              <p:cNvSpPr txBox="1"/>
              <p:nvPr/>
            </p:nvSpPr>
            <p:spPr>
              <a:xfrm>
                <a:off x="2501996" y="3333822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67" name="テキスト ボックス 7">
                <a:extLst>
                  <a:ext uri="{FF2B5EF4-FFF2-40B4-BE49-F238E27FC236}">
                    <a16:creationId xmlns:a16="http://schemas.microsoft.com/office/drawing/2014/main" id="{B112C0A8-260F-EE1C-5BDF-356A95307530}"/>
                  </a:ext>
                </a:extLst>
              </p:cNvPr>
              <p:cNvSpPr txBox="1"/>
              <p:nvPr/>
            </p:nvSpPr>
            <p:spPr>
              <a:xfrm>
                <a:off x="2927208" y="3252188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68" name="テキスト ボックス 7">
                <a:extLst>
                  <a:ext uri="{FF2B5EF4-FFF2-40B4-BE49-F238E27FC236}">
                    <a16:creationId xmlns:a16="http://schemas.microsoft.com/office/drawing/2014/main" id="{FAFAB273-C505-A922-7B2A-CEA596BBA7E1}"/>
                  </a:ext>
                </a:extLst>
              </p:cNvPr>
              <p:cNvSpPr txBox="1"/>
              <p:nvPr/>
            </p:nvSpPr>
            <p:spPr>
              <a:xfrm>
                <a:off x="1231372" y="320639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6975222-9EE1-9F36-537F-AA77556044BF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32000" y="4069017"/>
              <a:ext cx="2136174" cy="1708396"/>
              <a:chOff x="5999788" y="2394124"/>
              <a:chExt cx="2700858" cy="2160000"/>
            </a:xfrm>
          </p:grpSpPr>
          <p:pic>
            <p:nvPicPr>
              <p:cNvPr id="3" name="Picture 2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EF953571-A5AC-3C91-5393-1B0898B768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999788" y="2394124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69" name="テキスト ボックス 7">
                <a:extLst>
                  <a:ext uri="{FF2B5EF4-FFF2-40B4-BE49-F238E27FC236}">
                    <a16:creationId xmlns:a16="http://schemas.microsoft.com/office/drawing/2014/main" id="{11BBB3E0-D893-8D8A-CDD9-00ACE31600C6}"/>
                  </a:ext>
                </a:extLst>
              </p:cNvPr>
              <p:cNvSpPr txBox="1"/>
              <p:nvPr/>
            </p:nvSpPr>
            <p:spPr>
              <a:xfrm>
                <a:off x="6444820" y="327621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0" name="テキスト ボックス 7">
                <a:extLst>
                  <a:ext uri="{FF2B5EF4-FFF2-40B4-BE49-F238E27FC236}">
                    <a16:creationId xmlns:a16="http://schemas.microsoft.com/office/drawing/2014/main" id="{1F588461-BA7C-281C-A7AD-68E8B3C36A35}"/>
                  </a:ext>
                </a:extLst>
              </p:cNvPr>
              <p:cNvSpPr txBox="1"/>
              <p:nvPr/>
            </p:nvSpPr>
            <p:spPr>
              <a:xfrm>
                <a:off x="6851708" y="334036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1" name="テキスト ボックス 7">
                <a:extLst>
                  <a:ext uri="{FF2B5EF4-FFF2-40B4-BE49-F238E27FC236}">
                    <a16:creationId xmlns:a16="http://schemas.microsoft.com/office/drawing/2014/main" id="{F868BED5-B59A-2C54-191D-50A14193566A}"/>
                  </a:ext>
                </a:extLst>
              </p:cNvPr>
              <p:cNvSpPr txBox="1"/>
              <p:nvPr/>
            </p:nvSpPr>
            <p:spPr>
              <a:xfrm>
                <a:off x="7339797" y="3353694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2" name="テキスト ボックス 7">
                <a:extLst>
                  <a:ext uri="{FF2B5EF4-FFF2-40B4-BE49-F238E27FC236}">
                    <a16:creationId xmlns:a16="http://schemas.microsoft.com/office/drawing/2014/main" id="{FB944488-14FC-28BA-79A1-0435729145E4}"/>
                  </a:ext>
                </a:extLst>
              </p:cNvPr>
              <p:cNvSpPr txBox="1"/>
              <p:nvPr/>
            </p:nvSpPr>
            <p:spPr>
              <a:xfrm>
                <a:off x="7751696" y="344375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3" name="テキスト ボックス 7">
                <a:extLst>
                  <a:ext uri="{FF2B5EF4-FFF2-40B4-BE49-F238E27FC236}">
                    <a16:creationId xmlns:a16="http://schemas.microsoft.com/office/drawing/2014/main" id="{A85E63AA-2A4C-8E64-63B0-A76D9AA95C06}"/>
                  </a:ext>
                </a:extLst>
              </p:cNvPr>
              <p:cNvSpPr txBox="1"/>
              <p:nvPr/>
            </p:nvSpPr>
            <p:spPr>
              <a:xfrm>
                <a:off x="8081942" y="334074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74" name="テキスト ボックス 7">
                <a:extLst>
                  <a:ext uri="{FF2B5EF4-FFF2-40B4-BE49-F238E27FC236}">
                    <a16:creationId xmlns:a16="http://schemas.microsoft.com/office/drawing/2014/main" id="{EACB9913-30ED-3D58-5A79-9A5EDFDBD16C}"/>
                  </a:ext>
                </a:extLst>
              </p:cNvPr>
              <p:cNvSpPr txBox="1"/>
              <p:nvPr/>
            </p:nvSpPr>
            <p:spPr>
              <a:xfrm>
                <a:off x="7110929" y="3937328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75" name="テキスト ボックス 7">
                <a:extLst>
                  <a:ext uri="{FF2B5EF4-FFF2-40B4-BE49-F238E27FC236}">
                    <a16:creationId xmlns:a16="http://schemas.microsoft.com/office/drawing/2014/main" id="{40407F44-EB2F-2AB1-3F96-FB647EEA5A17}"/>
                  </a:ext>
                </a:extLst>
              </p:cNvPr>
              <p:cNvSpPr txBox="1"/>
              <p:nvPr/>
            </p:nvSpPr>
            <p:spPr>
              <a:xfrm>
                <a:off x="7525269" y="394643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76" name="テキスト ボックス 7">
                <a:extLst>
                  <a:ext uri="{FF2B5EF4-FFF2-40B4-BE49-F238E27FC236}">
                    <a16:creationId xmlns:a16="http://schemas.microsoft.com/office/drawing/2014/main" id="{1ABB3339-5662-7A82-106B-EE4BF3D1F838}"/>
                  </a:ext>
                </a:extLst>
              </p:cNvPr>
              <p:cNvSpPr txBox="1"/>
              <p:nvPr/>
            </p:nvSpPr>
            <p:spPr>
              <a:xfrm>
                <a:off x="7932794" y="3930977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77" name="テキスト ボックス 7">
                <a:extLst>
                  <a:ext uri="{FF2B5EF4-FFF2-40B4-BE49-F238E27FC236}">
                    <a16:creationId xmlns:a16="http://schemas.microsoft.com/office/drawing/2014/main" id="{14BC3C6F-6E16-0517-2BB4-F7E649E769D2}"/>
                  </a:ext>
                </a:extLst>
              </p:cNvPr>
              <p:cNvSpPr txBox="1"/>
              <p:nvPr/>
            </p:nvSpPr>
            <p:spPr>
              <a:xfrm>
                <a:off x="8334814" y="3908112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78" name="テキスト ボックス 7">
                <a:extLst>
                  <a:ext uri="{FF2B5EF4-FFF2-40B4-BE49-F238E27FC236}">
                    <a16:creationId xmlns:a16="http://schemas.microsoft.com/office/drawing/2014/main" id="{D1980DE9-9219-D0F0-07ED-F35DAB7DF3D4}"/>
                  </a:ext>
                </a:extLst>
              </p:cNvPr>
              <p:cNvSpPr txBox="1"/>
              <p:nvPr/>
            </p:nvSpPr>
            <p:spPr>
              <a:xfrm>
                <a:off x="6691302" y="3950029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D66CBDD7-5B95-89A0-7752-69D26A03E1A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75826" y="2206970"/>
              <a:ext cx="2136174" cy="1708396"/>
              <a:chOff x="3292379" y="2423265"/>
              <a:chExt cx="2700858" cy="2160000"/>
            </a:xfrm>
          </p:grpSpPr>
          <p:pic>
            <p:nvPicPr>
              <p:cNvPr id="5" name="Picture 4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C763036B-4060-6C92-BF4B-3608C5BDC96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292379" y="2423265"/>
                <a:ext cx="2700858" cy="2160000"/>
              </a:xfrm>
              <a:prstGeom prst="rect">
                <a:avLst/>
              </a:prstGeom>
            </p:spPr>
          </p:pic>
          <p:sp>
            <p:nvSpPr>
              <p:cNvPr id="79" name="テキスト ボックス 7">
                <a:extLst>
                  <a:ext uri="{FF2B5EF4-FFF2-40B4-BE49-F238E27FC236}">
                    <a16:creationId xmlns:a16="http://schemas.microsoft.com/office/drawing/2014/main" id="{772277CA-8D1D-0E01-03BC-80C4BA87E121}"/>
                  </a:ext>
                </a:extLst>
              </p:cNvPr>
              <p:cNvSpPr txBox="1"/>
              <p:nvPr/>
            </p:nvSpPr>
            <p:spPr>
              <a:xfrm>
                <a:off x="3696330" y="3409857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0" name="テキスト ボックス 7">
                <a:extLst>
                  <a:ext uri="{FF2B5EF4-FFF2-40B4-BE49-F238E27FC236}">
                    <a16:creationId xmlns:a16="http://schemas.microsoft.com/office/drawing/2014/main" id="{270B439A-C1C5-2E94-3C4D-FBF53C6B3C7E}"/>
                  </a:ext>
                </a:extLst>
              </p:cNvPr>
              <p:cNvSpPr txBox="1"/>
              <p:nvPr/>
            </p:nvSpPr>
            <p:spPr>
              <a:xfrm>
                <a:off x="4131842" y="329243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1" name="テキスト ボックス 7">
                <a:extLst>
                  <a:ext uri="{FF2B5EF4-FFF2-40B4-BE49-F238E27FC236}">
                    <a16:creationId xmlns:a16="http://schemas.microsoft.com/office/drawing/2014/main" id="{CC03BC47-F4F2-AAE1-83A4-BFB00C20DA97}"/>
                  </a:ext>
                </a:extLst>
              </p:cNvPr>
              <p:cNvSpPr txBox="1"/>
              <p:nvPr/>
            </p:nvSpPr>
            <p:spPr>
              <a:xfrm>
                <a:off x="4566607" y="344757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2" name="テキスト ボックス 7">
                <a:extLst>
                  <a:ext uri="{FF2B5EF4-FFF2-40B4-BE49-F238E27FC236}">
                    <a16:creationId xmlns:a16="http://schemas.microsoft.com/office/drawing/2014/main" id="{EE714252-082A-003C-D208-FA77ADF90293}"/>
                  </a:ext>
                </a:extLst>
              </p:cNvPr>
              <p:cNvSpPr txBox="1"/>
              <p:nvPr/>
            </p:nvSpPr>
            <p:spPr>
              <a:xfrm>
                <a:off x="5001372" y="3450750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3" name="テキスト ボックス 7">
                <a:extLst>
                  <a:ext uri="{FF2B5EF4-FFF2-40B4-BE49-F238E27FC236}">
                    <a16:creationId xmlns:a16="http://schemas.microsoft.com/office/drawing/2014/main" id="{E9FC7A53-F545-4F69-F629-916147259FEC}"/>
                  </a:ext>
                </a:extLst>
              </p:cNvPr>
              <p:cNvSpPr txBox="1"/>
              <p:nvPr/>
            </p:nvSpPr>
            <p:spPr>
              <a:xfrm>
                <a:off x="5354552" y="3300713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a</a:t>
                </a:r>
                <a:endParaRPr lang="zh-CN" altLang="en-US" sz="1000" b="1"/>
              </a:p>
            </p:txBody>
          </p:sp>
          <p:sp>
            <p:nvSpPr>
              <p:cNvPr id="84" name="テキスト ボックス 7">
                <a:extLst>
                  <a:ext uri="{FF2B5EF4-FFF2-40B4-BE49-F238E27FC236}">
                    <a16:creationId xmlns:a16="http://schemas.microsoft.com/office/drawing/2014/main" id="{6D57C24A-4A7B-1C2A-72F5-295792099164}"/>
                  </a:ext>
                </a:extLst>
              </p:cNvPr>
              <p:cNvSpPr txBox="1"/>
              <p:nvPr/>
            </p:nvSpPr>
            <p:spPr>
              <a:xfrm>
                <a:off x="4315393" y="3141048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85" name="テキスト ボックス 7">
                <a:extLst>
                  <a:ext uri="{FF2B5EF4-FFF2-40B4-BE49-F238E27FC236}">
                    <a16:creationId xmlns:a16="http://schemas.microsoft.com/office/drawing/2014/main" id="{E868FE04-8257-3635-5B2B-4074912246A6}"/>
                  </a:ext>
                </a:extLst>
              </p:cNvPr>
              <p:cNvSpPr txBox="1"/>
              <p:nvPr/>
            </p:nvSpPr>
            <p:spPr>
              <a:xfrm>
                <a:off x="4757983" y="3201353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86" name="テキスト ボックス 7">
                <a:extLst>
                  <a:ext uri="{FF2B5EF4-FFF2-40B4-BE49-F238E27FC236}">
                    <a16:creationId xmlns:a16="http://schemas.microsoft.com/office/drawing/2014/main" id="{58E4D728-54FB-E5ED-85F4-C7525EC0D3D6}"/>
                  </a:ext>
                </a:extLst>
              </p:cNvPr>
              <p:cNvSpPr txBox="1"/>
              <p:nvPr/>
            </p:nvSpPr>
            <p:spPr>
              <a:xfrm>
                <a:off x="5110450" y="3041432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87" name="テキスト ボックス 7">
                <a:extLst>
                  <a:ext uri="{FF2B5EF4-FFF2-40B4-BE49-F238E27FC236}">
                    <a16:creationId xmlns:a16="http://schemas.microsoft.com/office/drawing/2014/main" id="{A3F9B586-C71B-2B17-C793-4723257BB25B}"/>
                  </a:ext>
                </a:extLst>
              </p:cNvPr>
              <p:cNvSpPr txBox="1"/>
              <p:nvPr/>
            </p:nvSpPr>
            <p:spPr>
              <a:xfrm>
                <a:off x="5620824" y="2956972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  <p:sp>
            <p:nvSpPr>
              <p:cNvPr id="88" name="テキスト ボックス 7">
                <a:extLst>
                  <a:ext uri="{FF2B5EF4-FFF2-40B4-BE49-F238E27FC236}">
                    <a16:creationId xmlns:a16="http://schemas.microsoft.com/office/drawing/2014/main" id="{F05F050F-FCAF-C4AB-436A-2E915E5F59FB}"/>
                  </a:ext>
                </a:extLst>
              </p:cNvPr>
              <p:cNvSpPr txBox="1"/>
              <p:nvPr/>
            </p:nvSpPr>
            <p:spPr>
              <a:xfrm>
                <a:off x="3795712" y="3035367"/>
                <a:ext cx="2792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a</a:t>
                </a:r>
                <a:r>
                  <a:rPr lang="en-US" altLang="zh-CN" sz="1000">
                    <a:solidFill>
                      <a:schemeClr val="bg1">
                        <a:lumMod val="50000"/>
                      </a:schemeClr>
                    </a:solidFill>
                    <a:latin typeface="+mj-lt"/>
                  </a:rPr>
                  <a:t>'</a:t>
                </a:r>
                <a:endParaRPr lang="zh-CN" altLang="en-US" sz="1000" b="1">
                  <a:solidFill>
                    <a:schemeClr val="bg1">
                      <a:lumMod val="50000"/>
                    </a:schemeClr>
                  </a:solidFill>
                  <a:latin typeface="+mj-lt"/>
                </a:endParaRPr>
              </a:p>
            </p:txBody>
          </p:sp>
        </p:grpSp>
        <p:sp>
          <p:nvSpPr>
            <p:cNvPr id="91" name="テキスト ボックス 4">
              <a:extLst>
                <a:ext uri="{FF2B5EF4-FFF2-40B4-BE49-F238E27FC236}">
                  <a16:creationId xmlns:a16="http://schemas.microsoft.com/office/drawing/2014/main" id="{666F45FB-308B-CFBE-280E-61E319A6B9A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308663" y="8208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92" name="テキスト ボックス 4">
              <a:extLst>
                <a:ext uri="{FF2B5EF4-FFF2-40B4-BE49-F238E27FC236}">
                  <a16:creationId xmlns:a16="http://schemas.microsoft.com/office/drawing/2014/main" id="{B885AB24-3BFC-93B7-C5FB-0F1F0FFCCA5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415673" y="8208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93" name="テキスト ボックス 4">
              <a:extLst>
                <a:ext uri="{FF2B5EF4-FFF2-40B4-BE49-F238E27FC236}">
                  <a16:creationId xmlns:a16="http://schemas.microsoft.com/office/drawing/2014/main" id="{92656B68-661F-15D9-DEB5-4C98DACA4BB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77582" y="82088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sp>
          <p:nvSpPr>
            <p:cNvPr id="94" name="テキスト ボックス 4">
              <a:extLst>
                <a:ext uri="{FF2B5EF4-FFF2-40B4-BE49-F238E27FC236}">
                  <a16:creationId xmlns:a16="http://schemas.microsoft.com/office/drawing/2014/main" id="{5787BCB1-BBA0-0BE9-A0BE-CCDE07C85C0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308663" y="191459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95" name="テキスト ボックス 4">
              <a:extLst>
                <a:ext uri="{FF2B5EF4-FFF2-40B4-BE49-F238E27FC236}">
                  <a16:creationId xmlns:a16="http://schemas.microsoft.com/office/drawing/2014/main" id="{7B8E41CD-4772-EF79-F0E7-E6F2B0B23ED6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419681" y="1914593"/>
              <a:ext cx="3898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97" name="テキスト ボックス 4">
              <a:extLst>
                <a:ext uri="{FF2B5EF4-FFF2-40B4-BE49-F238E27FC236}">
                  <a16:creationId xmlns:a16="http://schemas.microsoft.com/office/drawing/2014/main" id="{D7007142-A09E-264E-B700-7F7B83BAE17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85597" y="1914593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  <p:sp>
          <p:nvSpPr>
            <p:cNvPr id="98" name="テキスト ボックス 4">
              <a:extLst>
                <a:ext uri="{FF2B5EF4-FFF2-40B4-BE49-F238E27FC236}">
                  <a16:creationId xmlns:a16="http://schemas.microsoft.com/office/drawing/2014/main" id="{0FC5B015-0B86-D2C8-2A02-415C895C5AFA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303854" y="3768384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9276373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BF0F2345-9415-21C9-E045-24D5A13E0A98}"/>
              </a:ext>
            </a:extLst>
          </p:cNvPr>
          <p:cNvSpPr txBox="1"/>
          <p:nvPr/>
        </p:nvSpPr>
        <p:spPr>
          <a:xfrm>
            <a:off x="117000" y="5728441"/>
            <a:ext cx="891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3.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Dose-dependent accumulation of mineral elements (Mg, P, K, Ca, Fe, Cu, and Zn) in the shoot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16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different Mn concentrations including 0.5, 5, 50, 200, or 500 μM for 12 days. The concentrations of Mg (A), P (B), K (C), Ca (D), Fe (E), Cu (F), and Zn (G) in the shoots were determined by ICP-MS after digestion. Data represent the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ean ± SD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DW, dry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5436E9EA-29D5-7BA4-5F17-E2BA7FED86DD}"/>
              </a:ext>
            </a:extLst>
          </p:cNvPr>
          <p:cNvGrpSpPr/>
          <p:nvPr/>
        </p:nvGrpSpPr>
        <p:grpSpPr>
          <a:xfrm>
            <a:off x="1278518" y="99707"/>
            <a:ext cx="6533482" cy="5598526"/>
            <a:chOff x="1278518" y="118757"/>
            <a:chExt cx="6533482" cy="5598526"/>
          </a:xfrm>
        </p:grpSpPr>
        <p:pic>
          <p:nvPicPr>
            <p:cNvPr id="12" name="Picture 11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1D5DFC55-B369-E01B-8DF5-09C0F5FAC49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686317" y="2206413"/>
              <a:ext cx="2125683" cy="1700005"/>
            </a:xfrm>
            <a:prstGeom prst="rect">
              <a:avLst/>
            </a:prstGeom>
          </p:spPr>
        </p:pic>
        <p:pic>
          <p:nvPicPr>
            <p:cNvPr id="31" name="Picture 30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959BCFA5-8B9A-881C-50F4-41E1C60D224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43951" y="375523"/>
              <a:ext cx="2125683" cy="1700005"/>
            </a:xfrm>
            <a:prstGeom prst="rect">
              <a:avLst/>
            </a:prstGeom>
          </p:spPr>
        </p:pic>
        <p:sp>
          <p:nvSpPr>
            <p:cNvPr id="33" name="テキスト ボックス 7">
              <a:extLst>
                <a:ext uri="{FF2B5EF4-FFF2-40B4-BE49-F238E27FC236}">
                  <a16:creationId xmlns:a16="http://schemas.microsoft.com/office/drawing/2014/main" id="{710CAEFD-2663-F3D1-8E6F-E44B29980210}"/>
                </a:ext>
              </a:extLst>
            </p:cNvPr>
            <p:cNvSpPr txBox="1"/>
            <p:nvPr/>
          </p:nvSpPr>
          <p:spPr>
            <a:xfrm>
              <a:off x="2246522" y="75382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34" name="テキスト ボックス 7">
              <a:extLst>
                <a:ext uri="{FF2B5EF4-FFF2-40B4-BE49-F238E27FC236}">
                  <a16:creationId xmlns:a16="http://schemas.microsoft.com/office/drawing/2014/main" id="{BCE7DBF8-CCC8-EBED-E15A-5AFD576D1EF9}"/>
                </a:ext>
              </a:extLst>
            </p:cNvPr>
            <p:cNvSpPr txBox="1"/>
            <p:nvPr/>
          </p:nvSpPr>
          <p:spPr>
            <a:xfrm>
              <a:off x="1791235" y="49973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5" name="テキスト ボックス 7">
              <a:extLst>
                <a:ext uri="{FF2B5EF4-FFF2-40B4-BE49-F238E27FC236}">
                  <a16:creationId xmlns:a16="http://schemas.microsoft.com/office/drawing/2014/main" id="{ABC1E357-BC68-2984-10E9-1F86962BE05A}"/>
                </a:ext>
              </a:extLst>
            </p:cNvPr>
            <p:cNvSpPr txBox="1"/>
            <p:nvPr/>
          </p:nvSpPr>
          <p:spPr>
            <a:xfrm>
              <a:off x="2105404" y="614660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6" name="テキスト ボックス 7">
              <a:extLst>
                <a:ext uri="{FF2B5EF4-FFF2-40B4-BE49-F238E27FC236}">
                  <a16:creationId xmlns:a16="http://schemas.microsoft.com/office/drawing/2014/main" id="{BF7FC62D-0DA3-3A21-89E9-F59D1E826099}"/>
                </a:ext>
              </a:extLst>
            </p:cNvPr>
            <p:cNvSpPr txBox="1"/>
            <p:nvPr/>
          </p:nvSpPr>
          <p:spPr>
            <a:xfrm>
              <a:off x="2422095" y="50535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7" name="テキスト ボックス 7">
              <a:extLst>
                <a:ext uri="{FF2B5EF4-FFF2-40B4-BE49-F238E27FC236}">
                  <a16:creationId xmlns:a16="http://schemas.microsoft.com/office/drawing/2014/main" id="{A9693803-4C4E-0632-A1A9-13E5639F6329}"/>
                </a:ext>
              </a:extLst>
            </p:cNvPr>
            <p:cNvSpPr txBox="1"/>
            <p:nvPr/>
          </p:nvSpPr>
          <p:spPr>
            <a:xfrm>
              <a:off x="2739901" y="751531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8" name="テキスト ボックス 7">
              <a:extLst>
                <a:ext uri="{FF2B5EF4-FFF2-40B4-BE49-F238E27FC236}">
                  <a16:creationId xmlns:a16="http://schemas.microsoft.com/office/drawing/2014/main" id="{D18890DB-CF76-68FA-8ABF-B75CF1FFA9ED}"/>
                </a:ext>
              </a:extLst>
            </p:cNvPr>
            <p:cNvSpPr txBox="1"/>
            <p:nvPr/>
          </p:nvSpPr>
          <p:spPr>
            <a:xfrm>
              <a:off x="3054282" y="807300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39" name="テキスト ボックス 7">
              <a:extLst>
                <a:ext uri="{FF2B5EF4-FFF2-40B4-BE49-F238E27FC236}">
                  <a16:creationId xmlns:a16="http://schemas.microsoft.com/office/drawing/2014/main" id="{C7C2B6CA-725B-4899-E782-926FFE261AD3}"/>
                </a:ext>
              </a:extLst>
            </p:cNvPr>
            <p:cNvSpPr txBox="1"/>
            <p:nvPr/>
          </p:nvSpPr>
          <p:spPr>
            <a:xfrm>
              <a:off x="1904360" y="853136"/>
              <a:ext cx="28159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b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40" name="テキスト ボックス 7">
              <a:extLst>
                <a:ext uri="{FF2B5EF4-FFF2-40B4-BE49-F238E27FC236}">
                  <a16:creationId xmlns:a16="http://schemas.microsoft.com/office/drawing/2014/main" id="{29FA4A7F-0D84-4B31-D6C1-EA9E8E33CFCE}"/>
                </a:ext>
              </a:extLst>
            </p:cNvPr>
            <p:cNvSpPr txBox="1"/>
            <p:nvPr/>
          </p:nvSpPr>
          <p:spPr>
            <a:xfrm>
              <a:off x="2552078" y="805512"/>
              <a:ext cx="28159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b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41" name="テキスト ボックス 7">
              <a:extLst>
                <a:ext uri="{FF2B5EF4-FFF2-40B4-BE49-F238E27FC236}">
                  <a16:creationId xmlns:a16="http://schemas.microsoft.com/office/drawing/2014/main" id="{1BDA3937-F4FA-B4EC-4C1B-DA7AF1B3AE59}"/>
                </a:ext>
              </a:extLst>
            </p:cNvPr>
            <p:cNvSpPr txBox="1"/>
            <p:nvPr/>
          </p:nvSpPr>
          <p:spPr>
            <a:xfrm>
              <a:off x="2853837" y="898886"/>
              <a:ext cx="281596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bc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42" name="テキスト ボックス 7">
              <a:extLst>
                <a:ext uri="{FF2B5EF4-FFF2-40B4-BE49-F238E27FC236}">
                  <a16:creationId xmlns:a16="http://schemas.microsoft.com/office/drawing/2014/main" id="{662867B5-0E79-1E99-B264-638ADC8175DA}"/>
                </a:ext>
              </a:extLst>
            </p:cNvPr>
            <p:cNvSpPr txBox="1"/>
            <p:nvPr/>
          </p:nvSpPr>
          <p:spPr>
            <a:xfrm>
              <a:off x="3189196" y="1037574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c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pic>
          <p:nvPicPr>
            <p:cNvPr id="15" name="Picture 14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7A69F65B-32CF-4589-468A-A68825CA48A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686317" y="375523"/>
              <a:ext cx="2125683" cy="1700005"/>
            </a:xfrm>
            <a:prstGeom prst="rect">
              <a:avLst/>
            </a:prstGeom>
          </p:spPr>
        </p:pic>
        <p:sp>
          <p:nvSpPr>
            <p:cNvPr id="54" name="テキスト ボックス 7">
              <a:extLst>
                <a:ext uri="{FF2B5EF4-FFF2-40B4-BE49-F238E27FC236}">
                  <a16:creationId xmlns:a16="http://schemas.microsoft.com/office/drawing/2014/main" id="{E02B138F-291A-E0E7-0935-6CAD9EBC538D}"/>
                </a:ext>
              </a:extLst>
            </p:cNvPr>
            <p:cNvSpPr txBox="1"/>
            <p:nvPr/>
          </p:nvSpPr>
          <p:spPr>
            <a:xfrm>
              <a:off x="6132911" y="84352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55" name="テキスト ボックス 7">
              <a:extLst>
                <a:ext uri="{FF2B5EF4-FFF2-40B4-BE49-F238E27FC236}">
                  <a16:creationId xmlns:a16="http://schemas.microsoft.com/office/drawing/2014/main" id="{5A01C2AD-912E-67EC-F48A-98734BE6EBC0}"/>
                </a:ext>
              </a:extLst>
            </p:cNvPr>
            <p:cNvSpPr txBox="1"/>
            <p:nvPr/>
          </p:nvSpPr>
          <p:spPr>
            <a:xfrm>
              <a:off x="6451345" y="808946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56" name="テキスト ボックス 7">
              <a:extLst>
                <a:ext uri="{FF2B5EF4-FFF2-40B4-BE49-F238E27FC236}">
                  <a16:creationId xmlns:a16="http://schemas.microsoft.com/office/drawing/2014/main" id="{97FCCEB6-4A1D-41BF-A9D7-DB2BD1126FAE}"/>
                </a:ext>
              </a:extLst>
            </p:cNvPr>
            <p:cNvSpPr txBox="1"/>
            <p:nvPr/>
          </p:nvSpPr>
          <p:spPr>
            <a:xfrm>
              <a:off x="6764926" y="865253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57" name="テキスト ボックス 7">
              <a:extLst>
                <a:ext uri="{FF2B5EF4-FFF2-40B4-BE49-F238E27FC236}">
                  <a16:creationId xmlns:a16="http://schemas.microsoft.com/office/drawing/2014/main" id="{E88CCCD5-1D54-D3AD-01E2-12E45CA18922}"/>
                </a:ext>
              </a:extLst>
            </p:cNvPr>
            <p:cNvSpPr txBox="1"/>
            <p:nvPr/>
          </p:nvSpPr>
          <p:spPr>
            <a:xfrm>
              <a:off x="7080704" y="85245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58" name="テキスト ボックス 7">
              <a:extLst>
                <a:ext uri="{FF2B5EF4-FFF2-40B4-BE49-F238E27FC236}">
                  <a16:creationId xmlns:a16="http://schemas.microsoft.com/office/drawing/2014/main" id="{BF142120-F894-3EB6-6E42-8BDD1A3BD9A5}"/>
                </a:ext>
              </a:extLst>
            </p:cNvPr>
            <p:cNvSpPr txBox="1"/>
            <p:nvPr/>
          </p:nvSpPr>
          <p:spPr>
            <a:xfrm>
              <a:off x="7397159" y="101432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59" name="テキスト ボックス 7">
              <a:extLst>
                <a:ext uri="{FF2B5EF4-FFF2-40B4-BE49-F238E27FC236}">
                  <a16:creationId xmlns:a16="http://schemas.microsoft.com/office/drawing/2014/main" id="{EDD6F072-D7E9-F2EF-23E2-D20992285378}"/>
                </a:ext>
              </a:extLst>
            </p:cNvPr>
            <p:cNvSpPr txBox="1"/>
            <p:nvPr/>
          </p:nvSpPr>
          <p:spPr>
            <a:xfrm>
              <a:off x="6261756" y="653001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60" name="テキスト ボックス 7">
              <a:extLst>
                <a:ext uri="{FF2B5EF4-FFF2-40B4-BE49-F238E27FC236}">
                  <a16:creationId xmlns:a16="http://schemas.microsoft.com/office/drawing/2014/main" id="{338FF72E-FEE0-F46C-C0AA-DB3D17A61F9B}"/>
                </a:ext>
              </a:extLst>
            </p:cNvPr>
            <p:cNvSpPr txBox="1"/>
            <p:nvPr/>
          </p:nvSpPr>
          <p:spPr>
            <a:xfrm>
              <a:off x="6581965" y="692535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61" name="テキスト ボックス 7">
              <a:extLst>
                <a:ext uri="{FF2B5EF4-FFF2-40B4-BE49-F238E27FC236}">
                  <a16:creationId xmlns:a16="http://schemas.microsoft.com/office/drawing/2014/main" id="{CF8A4458-AF13-0DE0-FCC8-4247964B36D3}"/>
                </a:ext>
              </a:extLst>
            </p:cNvPr>
            <p:cNvSpPr txBox="1"/>
            <p:nvPr/>
          </p:nvSpPr>
          <p:spPr>
            <a:xfrm>
              <a:off x="6896241" y="677923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62" name="テキスト ボックス 7">
              <a:extLst>
                <a:ext uri="{FF2B5EF4-FFF2-40B4-BE49-F238E27FC236}">
                  <a16:creationId xmlns:a16="http://schemas.microsoft.com/office/drawing/2014/main" id="{94C66713-88DF-C845-27ED-92921E7B6B9C}"/>
                </a:ext>
              </a:extLst>
            </p:cNvPr>
            <p:cNvSpPr txBox="1"/>
            <p:nvPr/>
          </p:nvSpPr>
          <p:spPr>
            <a:xfrm>
              <a:off x="7213678" y="493421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63" name="テキスト ボックス 7">
              <a:extLst>
                <a:ext uri="{FF2B5EF4-FFF2-40B4-BE49-F238E27FC236}">
                  <a16:creationId xmlns:a16="http://schemas.microsoft.com/office/drawing/2014/main" id="{8852B8D5-CBA2-C20E-31D2-90ACD6C151C2}"/>
                </a:ext>
              </a:extLst>
            </p:cNvPr>
            <p:cNvSpPr txBox="1"/>
            <p:nvPr/>
          </p:nvSpPr>
          <p:spPr>
            <a:xfrm>
              <a:off x="7528037" y="62131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pic>
          <p:nvPicPr>
            <p:cNvPr id="14" name="Picture 13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3B8E793E-53B7-1C7B-7322-686E08654CE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43951" y="2202797"/>
              <a:ext cx="2125683" cy="1700005"/>
            </a:xfrm>
            <a:prstGeom prst="rect">
              <a:avLst/>
            </a:prstGeom>
          </p:spPr>
        </p:pic>
        <p:sp>
          <p:nvSpPr>
            <p:cNvPr id="64" name="テキスト ボックス 7">
              <a:extLst>
                <a:ext uri="{FF2B5EF4-FFF2-40B4-BE49-F238E27FC236}">
                  <a16:creationId xmlns:a16="http://schemas.microsoft.com/office/drawing/2014/main" id="{A54146F9-7AF4-B192-1359-C9B37370F51E}"/>
                </a:ext>
              </a:extLst>
            </p:cNvPr>
            <p:cNvSpPr txBox="1"/>
            <p:nvPr/>
          </p:nvSpPr>
          <p:spPr>
            <a:xfrm>
              <a:off x="1789213" y="252677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65" name="テキスト ボックス 7">
              <a:extLst>
                <a:ext uri="{FF2B5EF4-FFF2-40B4-BE49-F238E27FC236}">
                  <a16:creationId xmlns:a16="http://schemas.microsoft.com/office/drawing/2014/main" id="{E19AD876-483D-399B-FA2E-A997BDD1F874}"/>
                </a:ext>
              </a:extLst>
            </p:cNvPr>
            <p:cNvSpPr txBox="1"/>
            <p:nvPr/>
          </p:nvSpPr>
          <p:spPr>
            <a:xfrm>
              <a:off x="2104435" y="2463407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66" name="テキスト ボックス 7">
              <a:extLst>
                <a:ext uri="{FF2B5EF4-FFF2-40B4-BE49-F238E27FC236}">
                  <a16:creationId xmlns:a16="http://schemas.microsoft.com/office/drawing/2014/main" id="{74BB6492-2E8C-38B1-2315-8E336810D76D}"/>
                </a:ext>
              </a:extLst>
            </p:cNvPr>
            <p:cNvSpPr txBox="1"/>
            <p:nvPr/>
          </p:nvSpPr>
          <p:spPr>
            <a:xfrm>
              <a:off x="2420204" y="2468796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67" name="テキスト ボックス 7">
              <a:extLst>
                <a:ext uri="{FF2B5EF4-FFF2-40B4-BE49-F238E27FC236}">
                  <a16:creationId xmlns:a16="http://schemas.microsoft.com/office/drawing/2014/main" id="{C2A3228C-92B5-F75B-06C8-55F7EF9D2564}"/>
                </a:ext>
              </a:extLst>
            </p:cNvPr>
            <p:cNvSpPr txBox="1"/>
            <p:nvPr/>
          </p:nvSpPr>
          <p:spPr>
            <a:xfrm>
              <a:off x="2734128" y="2673948"/>
              <a:ext cx="20716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b</a:t>
              </a:r>
              <a:endParaRPr lang="zh-CN" altLang="en-US" sz="1000" b="1"/>
            </a:p>
          </p:txBody>
        </p:sp>
        <p:sp>
          <p:nvSpPr>
            <p:cNvPr id="68" name="テキスト ボックス 7">
              <a:extLst>
                <a:ext uri="{FF2B5EF4-FFF2-40B4-BE49-F238E27FC236}">
                  <a16:creationId xmlns:a16="http://schemas.microsoft.com/office/drawing/2014/main" id="{8C6CE3C5-111C-FC3C-A0C2-A89661A4F892}"/>
                </a:ext>
              </a:extLst>
            </p:cNvPr>
            <p:cNvSpPr txBox="1"/>
            <p:nvPr/>
          </p:nvSpPr>
          <p:spPr>
            <a:xfrm>
              <a:off x="3051313" y="2679412"/>
              <a:ext cx="20716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b</a:t>
              </a:r>
              <a:endParaRPr lang="zh-CN" altLang="en-US" sz="1000" b="1"/>
            </a:p>
          </p:txBody>
        </p:sp>
        <p:sp>
          <p:nvSpPr>
            <p:cNvPr id="69" name="テキスト ボックス 7">
              <a:extLst>
                <a:ext uri="{FF2B5EF4-FFF2-40B4-BE49-F238E27FC236}">
                  <a16:creationId xmlns:a16="http://schemas.microsoft.com/office/drawing/2014/main" id="{4CC77D03-BA55-09BE-6A2A-96D28ABB2EC3}"/>
                </a:ext>
              </a:extLst>
            </p:cNvPr>
            <p:cNvSpPr txBox="1"/>
            <p:nvPr/>
          </p:nvSpPr>
          <p:spPr>
            <a:xfrm>
              <a:off x="1922324" y="2428594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0" name="テキスト ボックス 7">
              <a:extLst>
                <a:ext uri="{FF2B5EF4-FFF2-40B4-BE49-F238E27FC236}">
                  <a16:creationId xmlns:a16="http://schemas.microsoft.com/office/drawing/2014/main" id="{4DA9A1AB-BA30-AB1F-6FC5-F022111AB887}"/>
                </a:ext>
              </a:extLst>
            </p:cNvPr>
            <p:cNvSpPr txBox="1"/>
            <p:nvPr/>
          </p:nvSpPr>
          <p:spPr>
            <a:xfrm>
              <a:off x="2243951" y="244863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1" name="テキスト ボックス 7">
              <a:extLst>
                <a:ext uri="{FF2B5EF4-FFF2-40B4-BE49-F238E27FC236}">
                  <a16:creationId xmlns:a16="http://schemas.microsoft.com/office/drawing/2014/main" id="{488CA966-5582-11C8-467B-E54600D221E4}"/>
                </a:ext>
              </a:extLst>
            </p:cNvPr>
            <p:cNvSpPr txBox="1"/>
            <p:nvPr/>
          </p:nvSpPr>
          <p:spPr>
            <a:xfrm>
              <a:off x="2553233" y="2473384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2" name="テキスト ボックス 7">
              <a:extLst>
                <a:ext uri="{FF2B5EF4-FFF2-40B4-BE49-F238E27FC236}">
                  <a16:creationId xmlns:a16="http://schemas.microsoft.com/office/drawing/2014/main" id="{C18D8B66-86A0-DD7B-7354-C894E9C2EB82}"/>
                </a:ext>
              </a:extLst>
            </p:cNvPr>
            <p:cNvSpPr txBox="1"/>
            <p:nvPr/>
          </p:nvSpPr>
          <p:spPr>
            <a:xfrm>
              <a:off x="2870411" y="2532410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3" name="テキスト ボックス 7">
              <a:extLst>
                <a:ext uri="{FF2B5EF4-FFF2-40B4-BE49-F238E27FC236}">
                  <a16:creationId xmlns:a16="http://schemas.microsoft.com/office/drawing/2014/main" id="{5BF22B0A-BFC8-24EF-BE2C-08DEE4EB7BA4}"/>
                </a:ext>
              </a:extLst>
            </p:cNvPr>
            <p:cNvSpPr txBox="1"/>
            <p:nvPr/>
          </p:nvSpPr>
          <p:spPr>
            <a:xfrm>
              <a:off x="3183813" y="2802019"/>
              <a:ext cx="226084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b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pic>
          <p:nvPicPr>
            <p:cNvPr id="13" name="Picture 12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4CF359B6-26E4-6C40-2842-BFA1CC1CE7D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37107" y="2210126"/>
              <a:ext cx="2125683" cy="1700005"/>
            </a:xfrm>
            <a:prstGeom prst="rect">
              <a:avLst/>
            </a:prstGeom>
          </p:spPr>
        </p:pic>
        <p:sp>
          <p:nvSpPr>
            <p:cNvPr id="74" name="テキスト ボックス 7">
              <a:extLst>
                <a:ext uri="{FF2B5EF4-FFF2-40B4-BE49-F238E27FC236}">
                  <a16:creationId xmlns:a16="http://schemas.microsoft.com/office/drawing/2014/main" id="{E1F6A4A5-5A95-8C87-609F-5F1322CF77A4}"/>
                </a:ext>
              </a:extLst>
            </p:cNvPr>
            <p:cNvSpPr txBox="1"/>
            <p:nvPr/>
          </p:nvSpPr>
          <p:spPr>
            <a:xfrm>
              <a:off x="3896149" y="2946179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75" name="テキスト ボックス 7">
              <a:extLst>
                <a:ext uri="{FF2B5EF4-FFF2-40B4-BE49-F238E27FC236}">
                  <a16:creationId xmlns:a16="http://schemas.microsoft.com/office/drawing/2014/main" id="{BC64C1CC-C7CA-9EE2-27B7-F264BD15D438}"/>
                </a:ext>
              </a:extLst>
            </p:cNvPr>
            <p:cNvSpPr txBox="1"/>
            <p:nvPr/>
          </p:nvSpPr>
          <p:spPr>
            <a:xfrm>
              <a:off x="4037882" y="292008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6" name="テキスト ボックス 7">
              <a:extLst>
                <a:ext uri="{FF2B5EF4-FFF2-40B4-BE49-F238E27FC236}">
                  <a16:creationId xmlns:a16="http://schemas.microsoft.com/office/drawing/2014/main" id="{BCA7B75D-F407-5B05-3A58-803DF4591F9E}"/>
                </a:ext>
              </a:extLst>
            </p:cNvPr>
            <p:cNvSpPr txBox="1"/>
            <p:nvPr/>
          </p:nvSpPr>
          <p:spPr>
            <a:xfrm>
              <a:off x="4236546" y="2861827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77" name="テキスト ボックス 7">
              <a:extLst>
                <a:ext uri="{FF2B5EF4-FFF2-40B4-BE49-F238E27FC236}">
                  <a16:creationId xmlns:a16="http://schemas.microsoft.com/office/drawing/2014/main" id="{A7BD6F0F-A41D-6304-EDC4-5235D329FC45}"/>
                </a:ext>
              </a:extLst>
            </p:cNvPr>
            <p:cNvSpPr txBox="1"/>
            <p:nvPr/>
          </p:nvSpPr>
          <p:spPr>
            <a:xfrm>
              <a:off x="4371930" y="283780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78" name="テキスト ボックス 7">
              <a:extLst>
                <a:ext uri="{FF2B5EF4-FFF2-40B4-BE49-F238E27FC236}">
                  <a16:creationId xmlns:a16="http://schemas.microsoft.com/office/drawing/2014/main" id="{AE27A52B-BB06-F675-37EC-416A3DE172A6}"/>
                </a:ext>
              </a:extLst>
            </p:cNvPr>
            <p:cNvSpPr txBox="1"/>
            <p:nvPr/>
          </p:nvSpPr>
          <p:spPr>
            <a:xfrm>
              <a:off x="4565664" y="247296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79" name="テキスト ボックス 7">
              <a:extLst>
                <a:ext uri="{FF2B5EF4-FFF2-40B4-BE49-F238E27FC236}">
                  <a16:creationId xmlns:a16="http://schemas.microsoft.com/office/drawing/2014/main" id="{0A4127D3-355C-4D47-F2B1-94AA7387B265}"/>
                </a:ext>
              </a:extLst>
            </p:cNvPr>
            <p:cNvSpPr txBox="1"/>
            <p:nvPr/>
          </p:nvSpPr>
          <p:spPr>
            <a:xfrm>
              <a:off x="4707398" y="2853035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80" name="テキスト ボックス 7">
              <a:extLst>
                <a:ext uri="{FF2B5EF4-FFF2-40B4-BE49-F238E27FC236}">
                  <a16:creationId xmlns:a16="http://schemas.microsoft.com/office/drawing/2014/main" id="{70AA06FA-8F28-D271-E58F-85413A85FAD3}"/>
                </a:ext>
              </a:extLst>
            </p:cNvPr>
            <p:cNvSpPr txBox="1"/>
            <p:nvPr/>
          </p:nvSpPr>
          <p:spPr>
            <a:xfrm>
              <a:off x="4898849" y="2807342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1" name="テキスト ボックス 7">
              <a:extLst>
                <a:ext uri="{FF2B5EF4-FFF2-40B4-BE49-F238E27FC236}">
                  <a16:creationId xmlns:a16="http://schemas.microsoft.com/office/drawing/2014/main" id="{5CC48CF7-10AF-A3AD-5775-A6088480C2BA}"/>
                </a:ext>
              </a:extLst>
            </p:cNvPr>
            <p:cNvSpPr txBox="1"/>
            <p:nvPr/>
          </p:nvSpPr>
          <p:spPr>
            <a:xfrm>
              <a:off x="5040584" y="2675456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82" name="テキスト ボックス 7">
              <a:extLst>
                <a:ext uri="{FF2B5EF4-FFF2-40B4-BE49-F238E27FC236}">
                  <a16:creationId xmlns:a16="http://schemas.microsoft.com/office/drawing/2014/main" id="{20BE4FD8-C771-82C2-66E5-B30CBE6C779D}"/>
                </a:ext>
              </a:extLst>
            </p:cNvPr>
            <p:cNvSpPr txBox="1"/>
            <p:nvPr/>
          </p:nvSpPr>
          <p:spPr>
            <a:xfrm>
              <a:off x="5233911" y="2826272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3" name="テキスト ボックス 7">
              <a:extLst>
                <a:ext uri="{FF2B5EF4-FFF2-40B4-BE49-F238E27FC236}">
                  <a16:creationId xmlns:a16="http://schemas.microsoft.com/office/drawing/2014/main" id="{5A5D19C7-99CB-61F5-04C1-8E3B5E37FFC2}"/>
                </a:ext>
              </a:extLst>
            </p:cNvPr>
            <p:cNvSpPr txBox="1"/>
            <p:nvPr/>
          </p:nvSpPr>
          <p:spPr>
            <a:xfrm>
              <a:off x="5373770" y="2864517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84" name="テキスト ボックス 7">
              <a:extLst>
                <a:ext uri="{FF2B5EF4-FFF2-40B4-BE49-F238E27FC236}">
                  <a16:creationId xmlns:a16="http://schemas.microsoft.com/office/drawing/2014/main" id="{69E171E6-087D-2414-9F35-4BC8C2FD7661}"/>
                </a:ext>
              </a:extLst>
            </p:cNvPr>
            <p:cNvSpPr txBox="1"/>
            <p:nvPr/>
          </p:nvSpPr>
          <p:spPr>
            <a:xfrm>
              <a:off x="5994557" y="2976162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5" name="テキスト ボックス 7">
              <a:extLst>
                <a:ext uri="{FF2B5EF4-FFF2-40B4-BE49-F238E27FC236}">
                  <a16:creationId xmlns:a16="http://schemas.microsoft.com/office/drawing/2014/main" id="{3A2C0332-E85C-9CB3-6115-C2A67446AD33}"/>
                </a:ext>
              </a:extLst>
            </p:cNvPr>
            <p:cNvSpPr txBox="1"/>
            <p:nvPr/>
          </p:nvSpPr>
          <p:spPr>
            <a:xfrm>
              <a:off x="6348180" y="284568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6" name="テキスト ボックス 7">
              <a:extLst>
                <a:ext uri="{FF2B5EF4-FFF2-40B4-BE49-F238E27FC236}">
                  <a16:creationId xmlns:a16="http://schemas.microsoft.com/office/drawing/2014/main" id="{319F092C-B8C9-B6CE-0CA7-880A22CF4076}"/>
                </a:ext>
              </a:extLst>
            </p:cNvPr>
            <p:cNvSpPr txBox="1"/>
            <p:nvPr/>
          </p:nvSpPr>
          <p:spPr>
            <a:xfrm>
              <a:off x="6696745" y="3028082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7" name="テキスト ボックス 7">
              <a:extLst>
                <a:ext uri="{FF2B5EF4-FFF2-40B4-BE49-F238E27FC236}">
                  <a16:creationId xmlns:a16="http://schemas.microsoft.com/office/drawing/2014/main" id="{468F059E-E643-7A46-C2C8-19B07FE6B7B6}"/>
                </a:ext>
              </a:extLst>
            </p:cNvPr>
            <p:cNvSpPr txBox="1"/>
            <p:nvPr/>
          </p:nvSpPr>
          <p:spPr>
            <a:xfrm>
              <a:off x="7031162" y="2941463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8" name="テキスト ボックス 7">
              <a:extLst>
                <a:ext uri="{FF2B5EF4-FFF2-40B4-BE49-F238E27FC236}">
                  <a16:creationId xmlns:a16="http://schemas.microsoft.com/office/drawing/2014/main" id="{F3BE4764-B84F-F906-538A-7A1B9853824B}"/>
                </a:ext>
              </a:extLst>
            </p:cNvPr>
            <p:cNvSpPr txBox="1"/>
            <p:nvPr/>
          </p:nvSpPr>
          <p:spPr>
            <a:xfrm>
              <a:off x="7371928" y="2932938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89" name="テキスト ボックス 7">
              <a:extLst>
                <a:ext uri="{FF2B5EF4-FFF2-40B4-BE49-F238E27FC236}">
                  <a16:creationId xmlns:a16="http://schemas.microsoft.com/office/drawing/2014/main" id="{517BB582-9626-57D5-6D84-A326FA3EE251}"/>
                </a:ext>
              </a:extLst>
            </p:cNvPr>
            <p:cNvSpPr txBox="1"/>
            <p:nvPr/>
          </p:nvSpPr>
          <p:spPr>
            <a:xfrm>
              <a:off x="6146097" y="2533253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90" name="テキスト ボックス 7">
              <a:extLst>
                <a:ext uri="{FF2B5EF4-FFF2-40B4-BE49-F238E27FC236}">
                  <a16:creationId xmlns:a16="http://schemas.microsoft.com/office/drawing/2014/main" id="{A4B973D4-A5ED-3DE7-8570-6DBDABFB1FC5}"/>
                </a:ext>
              </a:extLst>
            </p:cNvPr>
            <p:cNvSpPr txBox="1"/>
            <p:nvPr/>
          </p:nvSpPr>
          <p:spPr>
            <a:xfrm>
              <a:off x="6493793" y="2736771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91" name="テキスト ボックス 7">
              <a:extLst>
                <a:ext uri="{FF2B5EF4-FFF2-40B4-BE49-F238E27FC236}">
                  <a16:creationId xmlns:a16="http://schemas.microsoft.com/office/drawing/2014/main" id="{263124FD-2330-3EBB-4BE0-18813A8A8E55}"/>
                </a:ext>
              </a:extLst>
            </p:cNvPr>
            <p:cNvSpPr txBox="1"/>
            <p:nvPr/>
          </p:nvSpPr>
          <p:spPr>
            <a:xfrm>
              <a:off x="6832747" y="2478978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92" name="テキスト ボックス 7">
              <a:extLst>
                <a:ext uri="{FF2B5EF4-FFF2-40B4-BE49-F238E27FC236}">
                  <a16:creationId xmlns:a16="http://schemas.microsoft.com/office/drawing/2014/main" id="{E3DAE8FB-C759-AD8F-CBF9-8F7FD4F23A2C}"/>
                </a:ext>
              </a:extLst>
            </p:cNvPr>
            <p:cNvSpPr txBox="1"/>
            <p:nvPr/>
          </p:nvSpPr>
          <p:spPr>
            <a:xfrm>
              <a:off x="7174131" y="2675829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93" name="テキスト ボックス 7">
              <a:extLst>
                <a:ext uri="{FF2B5EF4-FFF2-40B4-BE49-F238E27FC236}">
                  <a16:creationId xmlns:a16="http://schemas.microsoft.com/office/drawing/2014/main" id="{1DCF3315-9C21-0C30-8781-1CC1F1A5D14A}"/>
                </a:ext>
              </a:extLst>
            </p:cNvPr>
            <p:cNvSpPr txBox="1"/>
            <p:nvPr/>
          </p:nvSpPr>
          <p:spPr>
            <a:xfrm>
              <a:off x="7517913" y="2270581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pic>
          <p:nvPicPr>
            <p:cNvPr id="11" name="Picture 10" descr="A graph of a number of patients&#10;&#10;AI-generated content may be incorrect.">
              <a:extLst>
                <a:ext uri="{FF2B5EF4-FFF2-40B4-BE49-F238E27FC236}">
                  <a16:creationId xmlns:a16="http://schemas.microsoft.com/office/drawing/2014/main" id="{4269D400-B4F3-95A7-E145-CAEF00E59ED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343951" y="4017278"/>
              <a:ext cx="2125683" cy="1700005"/>
            </a:xfrm>
            <a:prstGeom prst="rect">
              <a:avLst/>
            </a:prstGeom>
          </p:spPr>
        </p:pic>
        <p:sp>
          <p:nvSpPr>
            <p:cNvPr id="94" name="テキスト ボックス 7">
              <a:extLst>
                <a:ext uri="{FF2B5EF4-FFF2-40B4-BE49-F238E27FC236}">
                  <a16:creationId xmlns:a16="http://schemas.microsoft.com/office/drawing/2014/main" id="{5DAAFB83-1A30-A860-0F87-EE5273DC79E4}"/>
                </a:ext>
              </a:extLst>
            </p:cNvPr>
            <p:cNvSpPr txBox="1"/>
            <p:nvPr/>
          </p:nvSpPr>
          <p:spPr>
            <a:xfrm>
              <a:off x="1750120" y="4513691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95" name="テキスト ボックス 7">
              <a:extLst>
                <a:ext uri="{FF2B5EF4-FFF2-40B4-BE49-F238E27FC236}">
                  <a16:creationId xmlns:a16="http://schemas.microsoft.com/office/drawing/2014/main" id="{91622166-030C-2CDB-4849-606B06EB26BC}"/>
                </a:ext>
              </a:extLst>
            </p:cNvPr>
            <p:cNvSpPr txBox="1"/>
            <p:nvPr/>
          </p:nvSpPr>
          <p:spPr>
            <a:xfrm>
              <a:off x="2078817" y="4541768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96" name="テキスト ボックス 7">
              <a:extLst>
                <a:ext uri="{FF2B5EF4-FFF2-40B4-BE49-F238E27FC236}">
                  <a16:creationId xmlns:a16="http://schemas.microsoft.com/office/drawing/2014/main" id="{11FE771E-021C-A43A-A7FF-9CF0201F96BC}"/>
                </a:ext>
              </a:extLst>
            </p:cNvPr>
            <p:cNvSpPr txBox="1"/>
            <p:nvPr/>
          </p:nvSpPr>
          <p:spPr>
            <a:xfrm>
              <a:off x="2405639" y="4612457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97" name="テキスト ボックス 7">
              <a:extLst>
                <a:ext uri="{FF2B5EF4-FFF2-40B4-BE49-F238E27FC236}">
                  <a16:creationId xmlns:a16="http://schemas.microsoft.com/office/drawing/2014/main" id="{87E50522-8CFF-0AB8-6CF1-E6B153E9BD0F}"/>
                </a:ext>
              </a:extLst>
            </p:cNvPr>
            <p:cNvSpPr txBox="1"/>
            <p:nvPr/>
          </p:nvSpPr>
          <p:spPr>
            <a:xfrm>
              <a:off x="2729477" y="433731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98" name="テキスト ボックス 7">
              <a:extLst>
                <a:ext uri="{FF2B5EF4-FFF2-40B4-BE49-F238E27FC236}">
                  <a16:creationId xmlns:a16="http://schemas.microsoft.com/office/drawing/2014/main" id="{53C98B89-21CC-77D3-D734-8BCFA07568A3}"/>
                </a:ext>
              </a:extLst>
            </p:cNvPr>
            <p:cNvSpPr txBox="1"/>
            <p:nvPr/>
          </p:nvSpPr>
          <p:spPr>
            <a:xfrm>
              <a:off x="3044394" y="4238230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99" name="テキスト ボックス 7">
              <a:extLst>
                <a:ext uri="{FF2B5EF4-FFF2-40B4-BE49-F238E27FC236}">
                  <a16:creationId xmlns:a16="http://schemas.microsoft.com/office/drawing/2014/main" id="{94C0B9AE-1EC7-0E85-34F2-119CD53BFA3D}"/>
                </a:ext>
              </a:extLst>
            </p:cNvPr>
            <p:cNvSpPr txBox="1"/>
            <p:nvPr/>
          </p:nvSpPr>
          <p:spPr>
            <a:xfrm>
              <a:off x="1888835" y="5212775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100" name="テキスト ボックス 7">
              <a:extLst>
                <a:ext uri="{FF2B5EF4-FFF2-40B4-BE49-F238E27FC236}">
                  <a16:creationId xmlns:a16="http://schemas.microsoft.com/office/drawing/2014/main" id="{D4B74611-D5D1-DE55-9453-BDBE1D4F41EF}"/>
                </a:ext>
              </a:extLst>
            </p:cNvPr>
            <p:cNvSpPr txBox="1"/>
            <p:nvPr/>
          </p:nvSpPr>
          <p:spPr>
            <a:xfrm>
              <a:off x="2211466" y="5218397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101" name="テキスト ボックス 7">
              <a:extLst>
                <a:ext uri="{FF2B5EF4-FFF2-40B4-BE49-F238E27FC236}">
                  <a16:creationId xmlns:a16="http://schemas.microsoft.com/office/drawing/2014/main" id="{E5942BDA-514C-AEB5-C572-17147CB0D547}"/>
                </a:ext>
              </a:extLst>
            </p:cNvPr>
            <p:cNvSpPr txBox="1"/>
            <p:nvPr/>
          </p:nvSpPr>
          <p:spPr>
            <a:xfrm>
              <a:off x="2539990" y="5227524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102" name="テキスト ボックス 7">
              <a:extLst>
                <a:ext uri="{FF2B5EF4-FFF2-40B4-BE49-F238E27FC236}">
                  <a16:creationId xmlns:a16="http://schemas.microsoft.com/office/drawing/2014/main" id="{6684E2F7-50E2-3A3E-AFB6-D0BD4311B1ED}"/>
                </a:ext>
              </a:extLst>
            </p:cNvPr>
            <p:cNvSpPr txBox="1"/>
            <p:nvPr/>
          </p:nvSpPr>
          <p:spPr>
            <a:xfrm>
              <a:off x="2866370" y="5237053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103" name="テキスト ボックス 7">
              <a:extLst>
                <a:ext uri="{FF2B5EF4-FFF2-40B4-BE49-F238E27FC236}">
                  <a16:creationId xmlns:a16="http://schemas.microsoft.com/office/drawing/2014/main" id="{94274DAC-3910-CD76-1492-6DEB79FE63C6}"/>
                </a:ext>
              </a:extLst>
            </p:cNvPr>
            <p:cNvSpPr txBox="1"/>
            <p:nvPr/>
          </p:nvSpPr>
          <p:spPr>
            <a:xfrm>
              <a:off x="3188499" y="5237137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18" name="テキスト ボックス 4">
              <a:extLst>
                <a:ext uri="{FF2B5EF4-FFF2-40B4-BE49-F238E27FC236}">
                  <a16:creationId xmlns:a16="http://schemas.microsoft.com/office/drawing/2014/main" id="{B05C1EAF-C30C-D26A-00CD-F2AB76F3276A}"/>
                </a:ext>
              </a:extLst>
            </p:cNvPr>
            <p:cNvSpPr txBox="1"/>
            <p:nvPr/>
          </p:nvSpPr>
          <p:spPr>
            <a:xfrm>
              <a:off x="1283327" y="1187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20" name="テキスト ボックス 4">
              <a:extLst>
                <a:ext uri="{FF2B5EF4-FFF2-40B4-BE49-F238E27FC236}">
                  <a16:creationId xmlns:a16="http://schemas.microsoft.com/office/drawing/2014/main" id="{2E1584AA-52E6-A0FD-70F4-5FDAF8A3EFD7}"/>
                </a:ext>
              </a:extLst>
            </p:cNvPr>
            <p:cNvSpPr txBox="1"/>
            <p:nvPr/>
          </p:nvSpPr>
          <p:spPr>
            <a:xfrm>
              <a:off x="3459086" y="1187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21" name="テキスト ボックス 4">
              <a:extLst>
                <a:ext uri="{FF2B5EF4-FFF2-40B4-BE49-F238E27FC236}">
                  <a16:creationId xmlns:a16="http://schemas.microsoft.com/office/drawing/2014/main" id="{912229D4-ADA4-23E5-CE2E-256B309C1836}"/>
                </a:ext>
              </a:extLst>
            </p:cNvPr>
            <p:cNvSpPr txBox="1"/>
            <p:nvPr/>
          </p:nvSpPr>
          <p:spPr>
            <a:xfrm>
              <a:off x="5602819" y="11875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sp>
          <p:nvSpPr>
            <p:cNvPr id="32" name="テキスト ボックス 4">
              <a:extLst>
                <a:ext uri="{FF2B5EF4-FFF2-40B4-BE49-F238E27FC236}">
                  <a16:creationId xmlns:a16="http://schemas.microsoft.com/office/drawing/2014/main" id="{3768A870-198A-8295-17B2-336AA6F04959}"/>
                </a:ext>
              </a:extLst>
            </p:cNvPr>
            <p:cNvSpPr txBox="1"/>
            <p:nvPr/>
          </p:nvSpPr>
          <p:spPr>
            <a:xfrm>
              <a:off x="1278518" y="375718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  <p:pic>
          <p:nvPicPr>
            <p:cNvPr id="16" name="Picture 15" descr="A graph of a number of columns&#10;&#10;AI-generated content may be incorrect.">
              <a:extLst>
                <a:ext uri="{FF2B5EF4-FFF2-40B4-BE49-F238E27FC236}">
                  <a16:creationId xmlns:a16="http://schemas.microsoft.com/office/drawing/2014/main" id="{D6BE8FE6-4DEF-D21C-65C9-4B4DCF71ED5B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537107" y="375523"/>
              <a:ext cx="2125683" cy="1700005"/>
            </a:xfrm>
            <a:prstGeom prst="rect">
              <a:avLst/>
            </a:prstGeom>
          </p:spPr>
        </p:pic>
        <p:sp>
          <p:nvSpPr>
            <p:cNvPr id="43" name="テキスト ボックス 7">
              <a:extLst>
                <a:ext uri="{FF2B5EF4-FFF2-40B4-BE49-F238E27FC236}">
                  <a16:creationId xmlns:a16="http://schemas.microsoft.com/office/drawing/2014/main" id="{5DE8BA59-8427-2192-81E2-299CB4182125}"/>
                </a:ext>
              </a:extLst>
            </p:cNvPr>
            <p:cNvSpPr txBox="1"/>
            <p:nvPr/>
          </p:nvSpPr>
          <p:spPr>
            <a:xfrm>
              <a:off x="3986180" y="992060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44" name="テキスト ボックス 7">
              <a:extLst>
                <a:ext uri="{FF2B5EF4-FFF2-40B4-BE49-F238E27FC236}">
                  <a16:creationId xmlns:a16="http://schemas.microsoft.com/office/drawing/2014/main" id="{18E9DF80-B4F3-BC28-CFA8-AC47DEB1B620}"/>
                </a:ext>
              </a:extLst>
            </p:cNvPr>
            <p:cNvSpPr txBox="1"/>
            <p:nvPr/>
          </p:nvSpPr>
          <p:spPr>
            <a:xfrm>
              <a:off x="4300864" y="97443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45" name="テキスト ボックス 7">
              <a:extLst>
                <a:ext uri="{FF2B5EF4-FFF2-40B4-BE49-F238E27FC236}">
                  <a16:creationId xmlns:a16="http://schemas.microsoft.com/office/drawing/2014/main" id="{4852BDBF-68DE-AD59-5B05-129C1A2CB2F7}"/>
                </a:ext>
              </a:extLst>
            </p:cNvPr>
            <p:cNvSpPr txBox="1"/>
            <p:nvPr/>
          </p:nvSpPr>
          <p:spPr>
            <a:xfrm>
              <a:off x="4618194" y="937035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46" name="テキスト ボックス 7">
              <a:extLst>
                <a:ext uri="{FF2B5EF4-FFF2-40B4-BE49-F238E27FC236}">
                  <a16:creationId xmlns:a16="http://schemas.microsoft.com/office/drawing/2014/main" id="{85D7709D-B2BE-B507-19A2-BE32862A9A23}"/>
                </a:ext>
              </a:extLst>
            </p:cNvPr>
            <p:cNvSpPr txBox="1"/>
            <p:nvPr/>
          </p:nvSpPr>
          <p:spPr>
            <a:xfrm>
              <a:off x="4932100" y="970054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47" name="テキスト ボックス 7">
              <a:extLst>
                <a:ext uri="{FF2B5EF4-FFF2-40B4-BE49-F238E27FC236}">
                  <a16:creationId xmlns:a16="http://schemas.microsoft.com/office/drawing/2014/main" id="{DF4ACAAE-E8A1-92B3-5E6C-888188DF586A}"/>
                </a:ext>
              </a:extLst>
            </p:cNvPr>
            <p:cNvSpPr txBox="1"/>
            <p:nvPr/>
          </p:nvSpPr>
          <p:spPr>
            <a:xfrm>
              <a:off x="5250427" y="1064039"/>
              <a:ext cx="200850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/>
                <a:t>a</a:t>
              </a:r>
              <a:endParaRPr lang="zh-CN" altLang="en-US" sz="1000" b="1"/>
            </a:p>
          </p:txBody>
        </p:sp>
        <p:sp>
          <p:nvSpPr>
            <p:cNvPr id="48" name="テキスト ボックス 7">
              <a:extLst>
                <a:ext uri="{FF2B5EF4-FFF2-40B4-BE49-F238E27FC236}">
                  <a16:creationId xmlns:a16="http://schemas.microsoft.com/office/drawing/2014/main" id="{165A40AA-2093-4D75-D0BE-F063D22E3131}"/>
                </a:ext>
              </a:extLst>
            </p:cNvPr>
            <p:cNvSpPr txBox="1"/>
            <p:nvPr/>
          </p:nvSpPr>
          <p:spPr>
            <a:xfrm>
              <a:off x="4117142" y="605390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49" name="テキスト ボックス 7">
              <a:extLst>
                <a:ext uri="{FF2B5EF4-FFF2-40B4-BE49-F238E27FC236}">
                  <a16:creationId xmlns:a16="http://schemas.microsoft.com/office/drawing/2014/main" id="{F344B4FC-29CF-2003-D5F8-4A402CF53159}"/>
                </a:ext>
              </a:extLst>
            </p:cNvPr>
            <p:cNvSpPr txBox="1"/>
            <p:nvPr/>
          </p:nvSpPr>
          <p:spPr>
            <a:xfrm>
              <a:off x="4433361" y="787537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50" name="テキスト ボックス 7">
              <a:extLst>
                <a:ext uri="{FF2B5EF4-FFF2-40B4-BE49-F238E27FC236}">
                  <a16:creationId xmlns:a16="http://schemas.microsoft.com/office/drawing/2014/main" id="{6768FDA9-9F01-93C6-683D-A740694CC50F}"/>
                </a:ext>
              </a:extLst>
            </p:cNvPr>
            <p:cNvSpPr txBox="1"/>
            <p:nvPr/>
          </p:nvSpPr>
          <p:spPr>
            <a:xfrm>
              <a:off x="4751384" y="712643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51" name="テキスト ボックス 7">
              <a:extLst>
                <a:ext uri="{FF2B5EF4-FFF2-40B4-BE49-F238E27FC236}">
                  <a16:creationId xmlns:a16="http://schemas.microsoft.com/office/drawing/2014/main" id="{43D3C77A-5B86-E543-072E-9F2F315ACDFE}"/>
                </a:ext>
              </a:extLst>
            </p:cNvPr>
            <p:cNvSpPr txBox="1"/>
            <p:nvPr/>
          </p:nvSpPr>
          <p:spPr>
            <a:xfrm>
              <a:off x="5062473" y="658603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52" name="テキスト ボックス 7">
              <a:extLst>
                <a:ext uri="{FF2B5EF4-FFF2-40B4-BE49-F238E27FC236}">
                  <a16:creationId xmlns:a16="http://schemas.microsoft.com/office/drawing/2014/main" id="{DBC6A1D1-B70D-738D-4DB7-39F3A081A789}"/>
                </a:ext>
              </a:extLst>
            </p:cNvPr>
            <p:cNvSpPr txBox="1"/>
            <p:nvPr/>
          </p:nvSpPr>
          <p:spPr>
            <a:xfrm>
              <a:off x="5387656" y="809407"/>
              <a:ext cx="219775" cy="1937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000" b="1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a</a:t>
              </a:r>
              <a:r>
                <a:rPr lang="en-US" altLang="zh-CN" sz="1000">
                  <a:solidFill>
                    <a:schemeClr val="bg1">
                      <a:lumMod val="50000"/>
                    </a:schemeClr>
                  </a:solidFill>
                  <a:latin typeface="+mj-lt"/>
                </a:rPr>
                <a:t>'</a:t>
              </a:r>
              <a:endParaRPr lang="zh-CN" altLang="en-US" sz="1000" b="1">
                <a:solidFill>
                  <a:schemeClr val="bg1">
                    <a:lumMod val="50000"/>
                  </a:schemeClr>
                </a:solidFill>
                <a:latin typeface="+mj-lt"/>
              </a:endParaRPr>
            </a:p>
          </p:txBody>
        </p:sp>
        <p:sp>
          <p:nvSpPr>
            <p:cNvPr id="22" name="テキスト ボックス 4">
              <a:extLst>
                <a:ext uri="{FF2B5EF4-FFF2-40B4-BE49-F238E27FC236}">
                  <a16:creationId xmlns:a16="http://schemas.microsoft.com/office/drawing/2014/main" id="{C494F37F-CC94-BFBC-6CBA-ED4F1E2C9247}"/>
                </a:ext>
              </a:extLst>
            </p:cNvPr>
            <p:cNvSpPr txBox="1"/>
            <p:nvPr/>
          </p:nvSpPr>
          <p:spPr>
            <a:xfrm>
              <a:off x="1283327" y="195783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23" name="テキスト ボックス 4">
              <a:extLst>
                <a:ext uri="{FF2B5EF4-FFF2-40B4-BE49-F238E27FC236}">
                  <a16:creationId xmlns:a16="http://schemas.microsoft.com/office/drawing/2014/main" id="{4C78BF46-E024-4610-4E94-363BCCFFCB93}"/>
                </a:ext>
              </a:extLst>
            </p:cNvPr>
            <p:cNvSpPr txBox="1"/>
            <p:nvPr/>
          </p:nvSpPr>
          <p:spPr>
            <a:xfrm>
              <a:off x="3463094" y="1957832"/>
              <a:ext cx="3898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24" name="テキスト ボックス 4">
              <a:extLst>
                <a:ext uri="{FF2B5EF4-FFF2-40B4-BE49-F238E27FC236}">
                  <a16:creationId xmlns:a16="http://schemas.microsoft.com/office/drawing/2014/main" id="{18B7E778-615A-FCCC-A6A0-6F04088943F2}"/>
                </a:ext>
              </a:extLst>
            </p:cNvPr>
            <p:cNvSpPr txBox="1"/>
            <p:nvPr/>
          </p:nvSpPr>
          <p:spPr>
            <a:xfrm>
              <a:off x="5610834" y="1957832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950916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2DD5AEA8-9809-7E1D-5A79-34F5F48A6573}"/>
              </a:ext>
            </a:extLst>
          </p:cNvPr>
          <p:cNvSpPr txBox="1"/>
          <p:nvPr/>
        </p:nvSpPr>
        <p:spPr>
          <a:xfrm>
            <a:off x="114790" y="5549492"/>
            <a:ext cx="891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4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issue-specific accumulation of mineral elements (Mg, P, K, Ca, Fe, Cu, and Zn) in the leave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18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50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Mn for 2 days. Leaves of HE and NHE were dissected into upper epidermis, mesophyll, and lower epidermis. The concentrations of Mg (A), P (B), K (C), Ca (D), Fe (E), Cu (F), and Zn (G) in the leaves were determined by ICP-MS after digestion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between HE and NHE are marked: *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; **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1; ns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gt;0.05, by Student’s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-test. FW, fresh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55" name="グループ化 54">
            <a:extLst>
              <a:ext uri="{FF2B5EF4-FFF2-40B4-BE49-F238E27FC236}">
                <a16:creationId xmlns:a16="http://schemas.microsoft.com/office/drawing/2014/main" id="{46372908-CDE1-D474-5709-595848A9FE90}"/>
              </a:ext>
            </a:extLst>
          </p:cNvPr>
          <p:cNvGrpSpPr>
            <a:grpSpLocks noChangeAspect="1"/>
          </p:cNvGrpSpPr>
          <p:nvPr/>
        </p:nvGrpSpPr>
        <p:grpSpPr>
          <a:xfrm>
            <a:off x="1467435" y="-54490"/>
            <a:ext cx="6164565" cy="5662763"/>
            <a:chOff x="1284652" y="0"/>
            <a:chExt cx="6549569" cy="6016427"/>
          </a:xfrm>
        </p:grpSpPr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B354379E-D363-D1BA-CACA-DAEBFBBCC753}"/>
                </a:ext>
              </a:extLst>
            </p:cNvPr>
            <p:cNvGrpSpPr/>
            <p:nvPr/>
          </p:nvGrpSpPr>
          <p:grpSpPr>
            <a:xfrm>
              <a:off x="1355329" y="232632"/>
              <a:ext cx="2152413" cy="1913368"/>
              <a:chOff x="1358143" y="232632"/>
              <a:chExt cx="2152413" cy="1913368"/>
            </a:xfrm>
          </p:grpSpPr>
          <p:pic>
            <p:nvPicPr>
              <p:cNvPr id="13" name="Picture 12" descr="A graph of a number of different types of blood&#10;&#10;AI-generated content may be incorrect.">
                <a:extLst>
                  <a:ext uri="{FF2B5EF4-FFF2-40B4-BE49-F238E27FC236}">
                    <a16:creationId xmlns:a16="http://schemas.microsoft.com/office/drawing/2014/main" id="{20C88D9E-F4EF-E36D-FA51-996524E236E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358143" y="232632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19" name="文本框 26">
                <a:extLst>
                  <a:ext uri="{FF2B5EF4-FFF2-40B4-BE49-F238E27FC236}">
                    <a16:creationId xmlns:a16="http://schemas.microsoft.com/office/drawing/2014/main" id="{7959CEAB-5591-B44F-0503-2FF445B115AA}"/>
                  </a:ext>
                </a:extLst>
              </p:cNvPr>
              <p:cNvSpPr txBox="1"/>
              <p:nvPr/>
            </p:nvSpPr>
            <p:spPr>
              <a:xfrm>
                <a:off x="1789762" y="313274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26" name="文本框 26">
                <a:extLst>
                  <a:ext uri="{FF2B5EF4-FFF2-40B4-BE49-F238E27FC236}">
                    <a16:creationId xmlns:a16="http://schemas.microsoft.com/office/drawing/2014/main" id="{2B20E1AF-0B2C-688E-5BAB-99FF3914BC87}"/>
                  </a:ext>
                </a:extLst>
              </p:cNvPr>
              <p:cNvSpPr txBox="1"/>
              <p:nvPr/>
            </p:nvSpPr>
            <p:spPr>
              <a:xfrm>
                <a:off x="2324132" y="885821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3" name="文本框 26">
                <a:extLst>
                  <a:ext uri="{FF2B5EF4-FFF2-40B4-BE49-F238E27FC236}">
                    <a16:creationId xmlns:a16="http://schemas.microsoft.com/office/drawing/2014/main" id="{2FDEC03D-FCAA-1B7E-B4F7-4F4B55C11D0A}"/>
                  </a:ext>
                </a:extLst>
              </p:cNvPr>
              <p:cNvSpPr txBox="1"/>
              <p:nvPr/>
            </p:nvSpPr>
            <p:spPr>
              <a:xfrm>
                <a:off x="2863002" y="484132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B8E7908D-C234-60EE-8982-8BB1229D8FA8}"/>
                </a:ext>
              </a:extLst>
            </p:cNvPr>
            <p:cNvGrpSpPr/>
            <p:nvPr/>
          </p:nvGrpSpPr>
          <p:grpSpPr>
            <a:xfrm>
              <a:off x="3508865" y="232632"/>
              <a:ext cx="2152413" cy="1913368"/>
              <a:chOff x="3492585" y="232632"/>
              <a:chExt cx="2152413" cy="1913368"/>
            </a:xfrm>
          </p:grpSpPr>
          <p:pic>
            <p:nvPicPr>
              <p:cNvPr id="17" name="Picture 16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E385F3B5-9F47-8753-F40F-DF5A63E4B2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92585" y="232632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0" name="文本框 26">
                <a:extLst>
                  <a:ext uri="{FF2B5EF4-FFF2-40B4-BE49-F238E27FC236}">
                    <a16:creationId xmlns:a16="http://schemas.microsoft.com/office/drawing/2014/main" id="{75EA06B9-1CB9-91D4-6874-4A999E12DD75}"/>
                  </a:ext>
                </a:extLst>
              </p:cNvPr>
              <p:cNvSpPr txBox="1"/>
              <p:nvPr/>
            </p:nvSpPr>
            <p:spPr>
              <a:xfrm>
                <a:off x="3973524" y="1149417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1C5FB127-8DF3-85C2-F9DD-11E9FD400EED}"/>
                  </a:ext>
                </a:extLst>
              </p:cNvPr>
              <p:cNvSpPr txBox="1"/>
              <p:nvPr/>
            </p:nvSpPr>
            <p:spPr>
              <a:xfrm>
                <a:off x="4487410" y="1109554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4" name="文本框 26">
                <a:extLst>
                  <a:ext uri="{FF2B5EF4-FFF2-40B4-BE49-F238E27FC236}">
                    <a16:creationId xmlns:a16="http://schemas.microsoft.com/office/drawing/2014/main" id="{E492D282-91DE-E52B-0022-30E648FB4F66}"/>
                  </a:ext>
                </a:extLst>
              </p:cNvPr>
              <p:cNvSpPr txBox="1"/>
              <p:nvPr/>
            </p:nvSpPr>
            <p:spPr>
              <a:xfrm>
                <a:off x="5002872" y="1102362"/>
                <a:ext cx="305577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</p:grpSp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FF3F314B-FDC0-5258-14C5-9B889F0F3F9B}"/>
                </a:ext>
              </a:extLst>
            </p:cNvPr>
            <p:cNvGrpSpPr/>
            <p:nvPr/>
          </p:nvGrpSpPr>
          <p:grpSpPr>
            <a:xfrm>
              <a:off x="5681808" y="232632"/>
              <a:ext cx="2152413" cy="1913368"/>
              <a:chOff x="5627028" y="232632"/>
              <a:chExt cx="2152413" cy="1913368"/>
            </a:xfrm>
          </p:grpSpPr>
          <p:pic>
            <p:nvPicPr>
              <p:cNvPr id="11" name="Picture 10" descr="A graph of different types of growth&#10;&#10;AI-generated content may be incorrect.">
                <a:extLst>
                  <a:ext uri="{FF2B5EF4-FFF2-40B4-BE49-F238E27FC236}">
                    <a16:creationId xmlns:a16="http://schemas.microsoft.com/office/drawing/2014/main" id="{A13F1C26-AA03-DEE3-68E8-4652ED751E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627028" y="232632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1" name="文本框 26">
                <a:extLst>
                  <a:ext uri="{FF2B5EF4-FFF2-40B4-BE49-F238E27FC236}">
                    <a16:creationId xmlns:a16="http://schemas.microsoft.com/office/drawing/2014/main" id="{6F2BFAD3-BE10-23A7-B236-D094C1237953}"/>
                  </a:ext>
                </a:extLst>
              </p:cNvPr>
              <p:cNvSpPr txBox="1"/>
              <p:nvPr/>
            </p:nvSpPr>
            <p:spPr>
              <a:xfrm>
                <a:off x="6099209" y="1155043"/>
                <a:ext cx="305577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  <p:sp>
            <p:nvSpPr>
              <p:cNvPr id="28" name="文本框 26">
                <a:extLst>
                  <a:ext uri="{FF2B5EF4-FFF2-40B4-BE49-F238E27FC236}">
                    <a16:creationId xmlns:a16="http://schemas.microsoft.com/office/drawing/2014/main" id="{7EB765FB-04CA-B096-BB37-9B36D85DB72D}"/>
                  </a:ext>
                </a:extLst>
              </p:cNvPr>
              <p:cNvSpPr txBox="1"/>
              <p:nvPr/>
            </p:nvSpPr>
            <p:spPr>
              <a:xfrm>
                <a:off x="6622799" y="1062863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5" name="文本框 26">
                <a:extLst>
                  <a:ext uri="{FF2B5EF4-FFF2-40B4-BE49-F238E27FC236}">
                    <a16:creationId xmlns:a16="http://schemas.microsoft.com/office/drawing/2014/main" id="{32200E3F-AEC8-76DE-73B4-9BE52C4606A7}"/>
                  </a:ext>
                </a:extLst>
              </p:cNvPr>
              <p:cNvSpPr txBox="1"/>
              <p:nvPr/>
            </p:nvSpPr>
            <p:spPr>
              <a:xfrm>
                <a:off x="7144985" y="688227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53" name="グループ化 52">
              <a:extLst>
                <a:ext uri="{FF2B5EF4-FFF2-40B4-BE49-F238E27FC236}">
                  <a16:creationId xmlns:a16="http://schemas.microsoft.com/office/drawing/2014/main" id="{6A17986D-4C64-A876-B52B-A4AF78D5233D}"/>
                </a:ext>
              </a:extLst>
            </p:cNvPr>
            <p:cNvGrpSpPr/>
            <p:nvPr/>
          </p:nvGrpSpPr>
          <p:grpSpPr>
            <a:xfrm>
              <a:off x="1355329" y="2170530"/>
              <a:ext cx="2152413" cy="1913368"/>
              <a:chOff x="1358143" y="2170530"/>
              <a:chExt cx="2152413" cy="1913368"/>
            </a:xfrm>
          </p:grpSpPr>
          <p:pic>
            <p:nvPicPr>
              <p:cNvPr id="5" name="Picture 4" descr="A graph of a number of different types of epidermis&#10;&#10;AI-generated content may be incorrect.">
                <a:extLst>
                  <a:ext uri="{FF2B5EF4-FFF2-40B4-BE49-F238E27FC236}">
                    <a16:creationId xmlns:a16="http://schemas.microsoft.com/office/drawing/2014/main" id="{65FAF42A-FFA0-A33C-A9D9-4656FCE03F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358143" y="2170530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2" name="文本框 26">
                <a:extLst>
                  <a:ext uri="{FF2B5EF4-FFF2-40B4-BE49-F238E27FC236}">
                    <a16:creationId xmlns:a16="http://schemas.microsoft.com/office/drawing/2014/main" id="{AE8CC783-8991-7A73-2403-026CF36BD8D0}"/>
                  </a:ext>
                </a:extLst>
              </p:cNvPr>
              <p:cNvSpPr txBox="1"/>
              <p:nvPr/>
            </p:nvSpPr>
            <p:spPr>
              <a:xfrm>
                <a:off x="1870569" y="2381160"/>
                <a:ext cx="234579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29" name="文本框 26">
                <a:extLst>
                  <a:ext uri="{FF2B5EF4-FFF2-40B4-BE49-F238E27FC236}">
                    <a16:creationId xmlns:a16="http://schemas.microsoft.com/office/drawing/2014/main" id="{DD475C22-FF2A-4657-9F0C-1EC6B7AD69B3}"/>
                  </a:ext>
                </a:extLst>
              </p:cNvPr>
              <p:cNvSpPr txBox="1"/>
              <p:nvPr/>
            </p:nvSpPr>
            <p:spPr>
              <a:xfrm>
                <a:off x="2389349" y="2741929"/>
                <a:ext cx="234579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36" name="文本框 26">
                <a:extLst>
                  <a:ext uri="{FF2B5EF4-FFF2-40B4-BE49-F238E27FC236}">
                    <a16:creationId xmlns:a16="http://schemas.microsoft.com/office/drawing/2014/main" id="{6FED08C9-D262-10A9-0359-33DC188848D4}"/>
                  </a:ext>
                </a:extLst>
              </p:cNvPr>
              <p:cNvSpPr txBox="1"/>
              <p:nvPr/>
            </p:nvSpPr>
            <p:spPr>
              <a:xfrm>
                <a:off x="2874465" y="2605753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763BF225-C5C1-2F30-41A7-BA21ADAE0197}"/>
                </a:ext>
              </a:extLst>
            </p:cNvPr>
            <p:cNvGrpSpPr/>
            <p:nvPr/>
          </p:nvGrpSpPr>
          <p:grpSpPr>
            <a:xfrm>
              <a:off x="3508865" y="2218322"/>
              <a:ext cx="2152413" cy="1913368"/>
              <a:chOff x="3525145" y="2218322"/>
              <a:chExt cx="2152413" cy="1913368"/>
            </a:xfrm>
          </p:grpSpPr>
          <p:pic>
            <p:nvPicPr>
              <p:cNvPr id="9" name="Picture 8" descr="A graph of different types of blood&#10;&#10;AI-generated content may be incorrect.">
                <a:extLst>
                  <a:ext uri="{FF2B5EF4-FFF2-40B4-BE49-F238E27FC236}">
                    <a16:creationId xmlns:a16="http://schemas.microsoft.com/office/drawing/2014/main" id="{EC42EB87-ACDE-A563-B580-9DB401D2302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25145" y="2218322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3" name="文本框 26">
                <a:extLst>
                  <a:ext uri="{FF2B5EF4-FFF2-40B4-BE49-F238E27FC236}">
                    <a16:creationId xmlns:a16="http://schemas.microsoft.com/office/drawing/2014/main" id="{FAAC0F3D-4C9C-B8D9-48BE-49259C92B8C8}"/>
                  </a:ext>
                </a:extLst>
              </p:cNvPr>
              <p:cNvSpPr txBox="1"/>
              <p:nvPr/>
            </p:nvSpPr>
            <p:spPr>
              <a:xfrm>
                <a:off x="3915215" y="2399907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0" name="文本框 26">
                <a:extLst>
                  <a:ext uri="{FF2B5EF4-FFF2-40B4-BE49-F238E27FC236}">
                    <a16:creationId xmlns:a16="http://schemas.microsoft.com/office/drawing/2014/main" id="{20CE1419-36FE-F78B-CEC3-1795182AC2A1}"/>
                  </a:ext>
                </a:extLst>
              </p:cNvPr>
              <p:cNvSpPr txBox="1"/>
              <p:nvPr/>
            </p:nvSpPr>
            <p:spPr>
              <a:xfrm>
                <a:off x="4464781" y="3328024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7" name="文本框 26">
                <a:extLst>
                  <a:ext uri="{FF2B5EF4-FFF2-40B4-BE49-F238E27FC236}">
                    <a16:creationId xmlns:a16="http://schemas.microsoft.com/office/drawing/2014/main" id="{28E4FB74-B4E5-5301-EEB2-5572A590C873}"/>
                  </a:ext>
                </a:extLst>
              </p:cNvPr>
              <p:cNvSpPr txBox="1"/>
              <p:nvPr/>
            </p:nvSpPr>
            <p:spPr>
              <a:xfrm>
                <a:off x="5023254" y="2832467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9E4B20FB-9B01-FC29-36A1-A771C92319EC}"/>
                </a:ext>
              </a:extLst>
            </p:cNvPr>
            <p:cNvGrpSpPr/>
            <p:nvPr/>
          </p:nvGrpSpPr>
          <p:grpSpPr>
            <a:xfrm>
              <a:off x="5681808" y="2218322"/>
              <a:ext cx="2152413" cy="1913368"/>
              <a:chOff x="5659587" y="2218322"/>
              <a:chExt cx="2152413" cy="1913368"/>
            </a:xfrm>
          </p:grpSpPr>
          <p:pic>
            <p:nvPicPr>
              <p:cNvPr id="7" name="Picture 6" descr="A graph of a number of different types of epidermis&#10;&#10;AI-generated content may be incorrect.">
                <a:extLst>
                  <a:ext uri="{FF2B5EF4-FFF2-40B4-BE49-F238E27FC236}">
                    <a16:creationId xmlns:a16="http://schemas.microsoft.com/office/drawing/2014/main" id="{F16475B8-A1F4-DC9C-7E52-53D1B2C40E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659587" y="2218322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4" name="文本框 26">
                <a:extLst>
                  <a:ext uri="{FF2B5EF4-FFF2-40B4-BE49-F238E27FC236}">
                    <a16:creationId xmlns:a16="http://schemas.microsoft.com/office/drawing/2014/main" id="{A2153B20-EB75-9EEE-0AEF-D5FB75719F16}"/>
                  </a:ext>
                </a:extLst>
              </p:cNvPr>
              <p:cNvSpPr txBox="1"/>
              <p:nvPr/>
            </p:nvSpPr>
            <p:spPr>
              <a:xfrm>
                <a:off x="6241856" y="2423545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1" name="文本框 26">
                <a:extLst>
                  <a:ext uri="{FF2B5EF4-FFF2-40B4-BE49-F238E27FC236}">
                    <a16:creationId xmlns:a16="http://schemas.microsoft.com/office/drawing/2014/main" id="{E7E911AD-EF68-920D-3A04-BE1FA7A782DB}"/>
                  </a:ext>
                </a:extLst>
              </p:cNvPr>
              <p:cNvSpPr txBox="1"/>
              <p:nvPr/>
            </p:nvSpPr>
            <p:spPr>
              <a:xfrm>
                <a:off x="6594254" y="3237562"/>
                <a:ext cx="305577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  <p:sp>
            <p:nvSpPr>
              <p:cNvPr id="38" name="文本框 26">
                <a:extLst>
                  <a:ext uri="{FF2B5EF4-FFF2-40B4-BE49-F238E27FC236}">
                    <a16:creationId xmlns:a16="http://schemas.microsoft.com/office/drawing/2014/main" id="{396259ED-76AD-591E-B502-DFC23AB76DC6}"/>
                  </a:ext>
                </a:extLst>
              </p:cNvPr>
              <p:cNvSpPr txBox="1"/>
              <p:nvPr/>
            </p:nvSpPr>
            <p:spPr>
              <a:xfrm>
                <a:off x="7139766" y="3206923"/>
                <a:ext cx="295638" cy="21810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252E37D7-751F-FC71-0F8C-3771FCB9836E}"/>
                </a:ext>
              </a:extLst>
            </p:cNvPr>
            <p:cNvGrpSpPr/>
            <p:nvPr/>
          </p:nvGrpSpPr>
          <p:grpSpPr>
            <a:xfrm>
              <a:off x="1355329" y="4103059"/>
              <a:ext cx="2152413" cy="1913368"/>
              <a:chOff x="1352515" y="4103059"/>
              <a:chExt cx="2152413" cy="1913368"/>
            </a:xfrm>
          </p:grpSpPr>
          <p:pic>
            <p:nvPicPr>
              <p:cNvPr id="3" name="Picture 2" descr="A graph of a graph showing different types of zinc content&#10;&#10;AI-generated content may be incorrect.">
                <a:extLst>
                  <a:ext uri="{FF2B5EF4-FFF2-40B4-BE49-F238E27FC236}">
                    <a16:creationId xmlns:a16="http://schemas.microsoft.com/office/drawing/2014/main" id="{EE706733-81DB-E5EF-1743-1E1D69668FB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352515" y="4103059"/>
                <a:ext cx="2152413" cy="1913368"/>
              </a:xfrm>
              <a:prstGeom prst="rect">
                <a:avLst/>
              </a:prstGeom>
            </p:spPr>
          </p:pic>
          <p:sp>
            <p:nvSpPr>
              <p:cNvPr id="25" name="文本框 26">
                <a:extLst>
                  <a:ext uri="{FF2B5EF4-FFF2-40B4-BE49-F238E27FC236}">
                    <a16:creationId xmlns:a16="http://schemas.microsoft.com/office/drawing/2014/main" id="{4FCDD127-4C42-6423-A02D-A4178CEA70D2}"/>
                  </a:ext>
                </a:extLst>
              </p:cNvPr>
              <p:cNvSpPr txBox="1"/>
              <p:nvPr/>
            </p:nvSpPr>
            <p:spPr>
              <a:xfrm>
                <a:off x="1787919" y="4209491"/>
                <a:ext cx="305577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  <p:sp>
            <p:nvSpPr>
              <p:cNvPr id="32" name="文本框 26">
                <a:extLst>
                  <a:ext uri="{FF2B5EF4-FFF2-40B4-BE49-F238E27FC236}">
                    <a16:creationId xmlns:a16="http://schemas.microsoft.com/office/drawing/2014/main" id="{4DE3205E-3B94-35CF-D3CB-2E98244B57FC}"/>
                  </a:ext>
                </a:extLst>
              </p:cNvPr>
              <p:cNvSpPr txBox="1"/>
              <p:nvPr/>
            </p:nvSpPr>
            <p:spPr>
              <a:xfrm>
                <a:off x="2322454" y="5026015"/>
                <a:ext cx="305577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  <p:sp>
            <p:nvSpPr>
              <p:cNvPr id="39" name="文本框 26">
                <a:extLst>
                  <a:ext uri="{FF2B5EF4-FFF2-40B4-BE49-F238E27FC236}">
                    <a16:creationId xmlns:a16="http://schemas.microsoft.com/office/drawing/2014/main" id="{8D5ABB3F-17BB-07BD-C0A1-3A2FB0E5D87B}"/>
                  </a:ext>
                </a:extLst>
              </p:cNvPr>
              <p:cNvSpPr txBox="1"/>
              <p:nvPr/>
            </p:nvSpPr>
            <p:spPr>
              <a:xfrm>
                <a:off x="2812837" y="4264395"/>
                <a:ext cx="234579" cy="2998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</p:grpSp>
        <p:sp>
          <p:nvSpPr>
            <p:cNvPr id="2" name="テキスト ボックス 4">
              <a:extLst>
                <a:ext uri="{FF2B5EF4-FFF2-40B4-BE49-F238E27FC236}">
                  <a16:creationId xmlns:a16="http://schemas.microsoft.com/office/drawing/2014/main" id="{4D2AF7A5-E4B2-47FB-17EF-BF88DE9F7816}"/>
                </a:ext>
              </a:extLst>
            </p:cNvPr>
            <p:cNvSpPr txBox="1"/>
            <p:nvPr/>
          </p:nvSpPr>
          <p:spPr>
            <a:xfrm>
              <a:off x="1289761" y="0"/>
              <a:ext cx="422714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4" name="テキスト ボックス 4">
              <a:extLst>
                <a:ext uri="{FF2B5EF4-FFF2-40B4-BE49-F238E27FC236}">
                  <a16:creationId xmlns:a16="http://schemas.microsoft.com/office/drawing/2014/main" id="{8E81E31B-BDC5-57A2-591F-4EBEE2911CBE}"/>
                </a:ext>
              </a:extLst>
            </p:cNvPr>
            <p:cNvSpPr txBox="1"/>
            <p:nvPr/>
          </p:nvSpPr>
          <p:spPr>
            <a:xfrm>
              <a:off x="3443517" y="0"/>
              <a:ext cx="422714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6" name="テキスト ボックス 4">
              <a:extLst>
                <a:ext uri="{FF2B5EF4-FFF2-40B4-BE49-F238E27FC236}">
                  <a16:creationId xmlns:a16="http://schemas.microsoft.com/office/drawing/2014/main" id="{4A8D26A8-D8BD-0F13-694D-2404CFEB1298}"/>
                </a:ext>
              </a:extLst>
            </p:cNvPr>
            <p:cNvSpPr txBox="1"/>
            <p:nvPr/>
          </p:nvSpPr>
          <p:spPr>
            <a:xfrm>
              <a:off x="5577354" y="0"/>
              <a:ext cx="422714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sp>
          <p:nvSpPr>
            <p:cNvPr id="8" name="テキスト ボックス 4">
              <a:extLst>
                <a:ext uri="{FF2B5EF4-FFF2-40B4-BE49-F238E27FC236}">
                  <a16:creationId xmlns:a16="http://schemas.microsoft.com/office/drawing/2014/main" id="{DB8DEA8E-4A0B-5B02-680A-7CB662AD4A50}"/>
                </a:ext>
              </a:extLst>
            </p:cNvPr>
            <p:cNvSpPr txBox="1"/>
            <p:nvPr/>
          </p:nvSpPr>
          <p:spPr>
            <a:xfrm>
              <a:off x="1289761" y="1949446"/>
              <a:ext cx="422714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10" name="テキスト ボックス 4">
              <a:extLst>
                <a:ext uri="{FF2B5EF4-FFF2-40B4-BE49-F238E27FC236}">
                  <a16:creationId xmlns:a16="http://schemas.microsoft.com/office/drawing/2014/main" id="{8162D21B-B755-7B11-8AEB-93287BAF5D80}"/>
                </a:ext>
              </a:extLst>
            </p:cNvPr>
            <p:cNvSpPr txBox="1"/>
            <p:nvPr/>
          </p:nvSpPr>
          <p:spPr>
            <a:xfrm>
              <a:off x="3447774" y="1949446"/>
              <a:ext cx="414199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12" name="テキスト ボックス 4">
              <a:extLst>
                <a:ext uri="{FF2B5EF4-FFF2-40B4-BE49-F238E27FC236}">
                  <a16:creationId xmlns:a16="http://schemas.microsoft.com/office/drawing/2014/main" id="{F2E33EFD-6049-8165-C77C-6A246ABB170A}"/>
                </a:ext>
              </a:extLst>
            </p:cNvPr>
            <p:cNvSpPr txBox="1"/>
            <p:nvPr/>
          </p:nvSpPr>
          <p:spPr>
            <a:xfrm>
              <a:off x="5585871" y="1949446"/>
              <a:ext cx="405683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  <p:sp>
          <p:nvSpPr>
            <p:cNvPr id="14" name="テキスト ボックス 4">
              <a:extLst>
                <a:ext uri="{FF2B5EF4-FFF2-40B4-BE49-F238E27FC236}">
                  <a16:creationId xmlns:a16="http://schemas.microsoft.com/office/drawing/2014/main" id="{C69E793E-313C-5665-72D6-9D39A6829233}"/>
                </a:ext>
              </a:extLst>
            </p:cNvPr>
            <p:cNvSpPr txBox="1"/>
            <p:nvPr/>
          </p:nvSpPr>
          <p:spPr>
            <a:xfrm>
              <a:off x="1284652" y="3870126"/>
              <a:ext cx="432933" cy="2942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0104969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84D353F-2AC5-618D-8A63-BC05FB46DD96}"/>
              </a:ext>
            </a:extLst>
          </p:cNvPr>
          <p:cNvSpPr txBox="1"/>
          <p:nvPr/>
        </p:nvSpPr>
        <p:spPr>
          <a:xfrm>
            <a:off x="117000" y="5700491"/>
            <a:ext cx="8910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5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issue-specific distribution of mineral elements (Mg, P, K, Ca, Fe, Cu, and Zn) in the leave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18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50 </a:t>
            </a:r>
            <a:r>
              <a:rPr lang="el-GR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μ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 Mn for 2 days. Leaves of HE and NHE were dissected into upper epidermis, mesophyll, and lower epidermis. The distributions of Mg (A), P (B), K (C), Ca (D), Fe (E), Cu (F), and Zn (G) in the leaves were calculated based on content in each part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between HE and NHE are marked: *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; **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1; ns,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gt;0.05, by Student’s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-tes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85928596-F12A-8FE4-4961-86119D97DD27}"/>
              </a:ext>
            </a:extLst>
          </p:cNvPr>
          <p:cNvGrpSpPr>
            <a:grpSpLocks noChangeAspect="1"/>
          </p:cNvGrpSpPr>
          <p:nvPr/>
        </p:nvGrpSpPr>
        <p:grpSpPr>
          <a:xfrm>
            <a:off x="1465561" y="85725"/>
            <a:ext cx="6166439" cy="5632976"/>
            <a:chOff x="1291559" y="106479"/>
            <a:chExt cx="6412794" cy="5858019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47CCE292-5561-CB07-7541-26FA9D7C494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514532" y="2241193"/>
              <a:ext cx="2082018" cy="1850792"/>
              <a:chOff x="1241909" y="3064155"/>
              <a:chExt cx="2429857" cy="2160000"/>
            </a:xfrm>
          </p:grpSpPr>
          <p:pic>
            <p:nvPicPr>
              <p:cNvPr id="11" name="Picture 10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1C7505F4-43BA-B5D7-CF4F-9741CA2D8CC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241909" y="3064155"/>
                <a:ext cx="2429857" cy="2160000"/>
              </a:xfrm>
              <a:prstGeom prst="rect">
                <a:avLst/>
              </a:prstGeom>
            </p:spPr>
          </p:pic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886593AD-EAC2-F226-CDC9-40B7726D3F6C}"/>
                  </a:ext>
                </a:extLst>
              </p:cNvPr>
              <p:cNvSpPr txBox="1"/>
              <p:nvPr/>
            </p:nvSpPr>
            <p:spPr>
              <a:xfrm>
                <a:off x="1700950" y="4194988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4" name="文本框 26">
                <a:extLst>
                  <a:ext uri="{FF2B5EF4-FFF2-40B4-BE49-F238E27FC236}">
                    <a16:creationId xmlns:a16="http://schemas.microsoft.com/office/drawing/2014/main" id="{AE665D8C-574B-3A38-CC04-B23B6611DD4D}"/>
                  </a:ext>
                </a:extLst>
              </p:cNvPr>
              <p:cNvSpPr txBox="1"/>
              <p:nvPr/>
            </p:nvSpPr>
            <p:spPr>
              <a:xfrm>
                <a:off x="2310749" y="3202699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41" name="文本框 26">
                <a:extLst>
                  <a:ext uri="{FF2B5EF4-FFF2-40B4-BE49-F238E27FC236}">
                    <a16:creationId xmlns:a16="http://schemas.microsoft.com/office/drawing/2014/main" id="{FB91A2CC-BC45-F6C4-625A-1C327A622CA7}"/>
                  </a:ext>
                </a:extLst>
              </p:cNvPr>
              <p:cNvSpPr txBox="1"/>
              <p:nvPr/>
            </p:nvSpPr>
            <p:spPr>
              <a:xfrm>
                <a:off x="2928579" y="4278140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88" name="Group 87">
              <a:extLst>
                <a:ext uri="{FF2B5EF4-FFF2-40B4-BE49-F238E27FC236}">
                  <a16:creationId xmlns:a16="http://schemas.microsoft.com/office/drawing/2014/main" id="{367C89C0-0B7E-0CA1-288A-B3DDF49E4D64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22335" y="2241193"/>
              <a:ext cx="2082018" cy="1850792"/>
              <a:chOff x="3859423" y="3064155"/>
              <a:chExt cx="2429857" cy="2160000"/>
            </a:xfrm>
          </p:grpSpPr>
          <p:pic>
            <p:nvPicPr>
              <p:cNvPr id="10" name="Picture 9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B61B3C81-CBD1-5EC6-F19B-620C38A536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859423" y="3064155"/>
                <a:ext cx="2429857" cy="2160000"/>
              </a:xfrm>
              <a:prstGeom prst="rect">
                <a:avLst/>
              </a:prstGeom>
            </p:spPr>
          </p:pic>
          <p:sp>
            <p:nvSpPr>
              <p:cNvPr id="28" name="文本框 26">
                <a:extLst>
                  <a:ext uri="{FF2B5EF4-FFF2-40B4-BE49-F238E27FC236}">
                    <a16:creationId xmlns:a16="http://schemas.microsoft.com/office/drawing/2014/main" id="{02ECA340-C33F-85BB-4FBF-A21A0E966482}"/>
                  </a:ext>
                </a:extLst>
              </p:cNvPr>
              <p:cNvSpPr txBox="1"/>
              <p:nvPr/>
            </p:nvSpPr>
            <p:spPr>
              <a:xfrm>
                <a:off x="4320708" y="3217842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5" name="文本框 26">
                <a:extLst>
                  <a:ext uri="{FF2B5EF4-FFF2-40B4-BE49-F238E27FC236}">
                    <a16:creationId xmlns:a16="http://schemas.microsoft.com/office/drawing/2014/main" id="{5E13F4E9-D189-6675-3DEF-B67F6F1B26FF}"/>
                  </a:ext>
                </a:extLst>
              </p:cNvPr>
              <p:cNvSpPr txBox="1"/>
              <p:nvPr/>
            </p:nvSpPr>
            <p:spPr>
              <a:xfrm>
                <a:off x="4777398" y="3421060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42" name="文本框 26">
                <a:extLst>
                  <a:ext uri="{FF2B5EF4-FFF2-40B4-BE49-F238E27FC236}">
                    <a16:creationId xmlns:a16="http://schemas.microsoft.com/office/drawing/2014/main" id="{9416594D-FEC1-16C4-4436-14A71614C1AE}"/>
                  </a:ext>
                </a:extLst>
              </p:cNvPr>
              <p:cNvSpPr txBox="1"/>
              <p:nvPr/>
            </p:nvSpPr>
            <p:spPr>
              <a:xfrm>
                <a:off x="5540549" y="4259912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2C92D940-072F-2C8E-5D05-7D3002CDB6A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98573" y="4113706"/>
              <a:ext cx="2082018" cy="1850792"/>
              <a:chOff x="6289280" y="2968521"/>
              <a:chExt cx="2429857" cy="2160000"/>
            </a:xfrm>
          </p:grpSpPr>
          <p:pic>
            <p:nvPicPr>
              <p:cNvPr id="53" name="Picture 52" descr="A graph of different types of epidermis&#10;&#10;AI-generated content may be incorrect.">
                <a:extLst>
                  <a:ext uri="{FF2B5EF4-FFF2-40B4-BE49-F238E27FC236}">
                    <a16:creationId xmlns:a16="http://schemas.microsoft.com/office/drawing/2014/main" id="{4AC955F4-8653-15D0-0CD0-03ED21C2F69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289280" y="2968521"/>
                <a:ext cx="2429857" cy="2160000"/>
              </a:xfrm>
              <a:prstGeom prst="rect">
                <a:avLst/>
              </a:prstGeom>
            </p:spPr>
          </p:pic>
          <p:sp>
            <p:nvSpPr>
              <p:cNvPr id="29" name="文本框 26">
                <a:extLst>
                  <a:ext uri="{FF2B5EF4-FFF2-40B4-BE49-F238E27FC236}">
                    <a16:creationId xmlns:a16="http://schemas.microsoft.com/office/drawing/2014/main" id="{45766127-3E89-9E4C-77B2-52EF921A4CFE}"/>
                  </a:ext>
                </a:extLst>
              </p:cNvPr>
              <p:cNvSpPr txBox="1"/>
              <p:nvPr/>
            </p:nvSpPr>
            <p:spPr>
              <a:xfrm>
                <a:off x="6746901" y="4122199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6" name="文本框 26">
                <a:extLst>
                  <a:ext uri="{FF2B5EF4-FFF2-40B4-BE49-F238E27FC236}">
                    <a16:creationId xmlns:a16="http://schemas.microsoft.com/office/drawing/2014/main" id="{0D12FAEA-0DB9-5949-3C4A-2F4E564BF8C1}"/>
                  </a:ext>
                </a:extLst>
              </p:cNvPr>
              <p:cNvSpPr txBox="1"/>
              <p:nvPr/>
            </p:nvSpPr>
            <p:spPr>
              <a:xfrm>
                <a:off x="7362264" y="3179483"/>
                <a:ext cx="333745" cy="246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43" name="文本框 26">
                <a:extLst>
                  <a:ext uri="{FF2B5EF4-FFF2-40B4-BE49-F238E27FC236}">
                    <a16:creationId xmlns:a16="http://schemas.microsoft.com/office/drawing/2014/main" id="{E959DB5C-52DD-7700-1CD6-FB0AAF8B7CDB}"/>
                  </a:ext>
                </a:extLst>
              </p:cNvPr>
              <p:cNvSpPr txBox="1"/>
              <p:nvPr/>
            </p:nvSpPr>
            <p:spPr>
              <a:xfrm>
                <a:off x="8016476" y="4116307"/>
                <a:ext cx="264816" cy="3385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5134C7FE-72A5-4892-04A5-75BAA49FDE6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514532" y="347935"/>
              <a:ext cx="2082018" cy="1850792"/>
              <a:chOff x="2967913" y="281508"/>
              <a:chExt cx="1619796" cy="1439904"/>
            </a:xfrm>
          </p:grpSpPr>
          <p:pic>
            <p:nvPicPr>
              <p:cNvPr id="52" name="Picture 51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4940B860-9B87-BAFA-3377-EF7CCEF102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967913" y="281508"/>
                <a:ext cx="1619796" cy="1439904"/>
              </a:xfrm>
              <a:prstGeom prst="rect">
                <a:avLst/>
              </a:prstGeom>
            </p:spPr>
          </p:pic>
          <p:sp>
            <p:nvSpPr>
              <p:cNvPr id="22" name="文本框 26">
                <a:extLst>
                  <a:ext uri="{FF2B5EF4-FFF2-40B4-BE49-F238E27FC236}">
                    <a16:creationId xmlns:a16="http://schemas.microsoft.com/office/drawing/2014/main" id="{EBAC1FBD-03F4-F515-A28E-C9F1CD0D86D3}"/>
                  </a:ext>
                </a:extLst>
              </p:cNvPr>
              <p:cNvSpPr txBox="1"/>
              <p:nvPr/>
            </p:nvSpPr>
            <p:spPr>
              <a:xfrm>
                <a:off x="3295662" y="1221296"/>
                <a:ext cx="17653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31" name="文本框 26">
                <a:extLst>
                  <a:ext uri="{FF2B5EF4-FFF2-40B4-BE49-F238E27FC236}">
                    <a16:creationId xmlns:a16="http://schemas.microsoft.com/office/drawing/2014/main" id="{F291916A-4736-CCF8-EE72-EE3E5DAAB503}"/>
                  </a:ext>
                </a:extLst>
              </p:cNvPr>
              <p:cNvSpPr txBox="1"/>
              <p:nvPr/>
            </p:nvSpPr>
            <p:spPr>
              <a:xfrm>
                <a:off x="3675764" y="294068"/>
                <a:ext cx="22996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  <p:sp>
            <p:nvSpPr>
              <p:cNvPr id="38" name="文本框 26">
                <a:extLst>
                  <a:ext uri="{FF2B5EF4-FFF2-40B4-BE49-F238E27FC236}">
                    <a16:creationId xmlns:a16="http://schemas.microsoft.com/office/drawing/2014/main" id="{1C66E24F-E2FF-E9E2-6E47-821ECCAC1DAB}"/>
                  </a:ext>
                </a:extLst>
              </p:cNvPr>
              <p:cNvSpPr txBox="1"/>
              <p:nvPr/>
            </p:nvSpPr>
            <p:spPr>
              <a:xfrm>
                <a:off x="4083717" y="1199354"/>
                <a:ext cx="22996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*</a:t>
                </a:r>
                <a:endParaRPr lang="zh-CN" altLang="en-US" sz="1600" b="1"/>
              </a:p>
            </p:txBody>
          </p:sp>
        </p:grp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5F0B9638-C8D7-0A07-B9F6-C88BA31BD44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5622335" y="347933"/>
              <a:ext cx="2082018" cy="1850792"/>
              <a:chOff x="4572000" y="281508"/>
              <a:chExt cx="1619796" cy="1439904"/>
            </a:xfrm>
          </p:grpSpPr>
          <p:pic>
            <p:nvPicPr>
              <p:cNvPr id="12" name="Picture 11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3C4A485D-7D55-8C69-F44E-C69AB13846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572000" y="281508"/>
                <a:ext cx="1619796" cy="1439904"/>
              </a:xfrm>
              <a:prstGeom prst="rect">
                <a:avLst/>
              </a:prstGeom>
            </p:spPr>
          </p:pic>
          <p:sp>
            <p:nvSpPr>
              <p:cNvPr id="23" name="文本框 26">
                <a:extLst>
                  <a:ext uri="{FF2B5EF4-FFF2-40B4-BE49-F238E27FC236}">
                    <a16:creationId xmlns:a16="http://schemas.microsoft.com/office/drawing/2014/main" id="{B38F02EB-8D3C-FEA4-9732-A15A6007454E}"/>
                  </a:ext>
                </a:extLst>
              </p:cNvPr>
              <p:cNvSpPr txBox="1"/>
              <p:nvPr/>
            </p:nvSpPr>
            <p:spPr>
              <a:xfrm>
                <a:off x="4874390" y="1214167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2" name="文本框 26">
                <a:extLst>
                  <a:ext uri="{FF2B5EF4-FFF2-40B4-BE49-F238E27FC236}">
                    <a16:creationId xmlns:a16="http://schemas.microsoft.com/office/drawing/2014/main" id="{D47883A1-82FF-E371-1F7D-041B025F3937}"/>
                  </a:ext>
                </a:extLst>
              </p:cNvPr>
              <p:cNvSpPr txBox="1"/>
              <p:nvPr/>
            </p:nvSpPr>
            <p:spPr>
              <a:xfrm>
                <a:off x="5307580" y="305210"/>
                <a:ext cx="17653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39" name="文本框 26">
                <a:extLst>
                  <a:ext uri="{FF2B5EF4-FFF2-40B4-BE49-F238E27FC236}">
                    <a16:creationId xmlns:a16="http://schemas.microsoft.com/office/drawing/2014/main" id="{DEFFC85A-E52D-E47D-6899-584DCEB32C37}"/>
                  </a:ext>
                </a:extLst>
              </p:cNvPr>
              <p:cNvSpPr txBox="1"/>
              <p:nvPr/>
            </p:nvSpPr>
            <p:spPr>
              <a:xfrm>
                <a:off x="5698844" y="1113549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0223FB7A-29B7-7BD7-6967-F17F004151D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98573" y="2241193"/>
              <a:ext cx="2082018" cy="1850792"/>
              <a:chOff x="1407251" y="1832069"/>
              <a:chExt cx="1619796" cy="1439904"/>
            </a:xfrm>
          </p:grpSpPr>
          <p:pic>
            <p:nvPicPr>
              <p:cNvPr id="9" name="Picture 8" descr="A graph of a number of patients">
                <a:extLst>
                  <a:ext uri="{FF2B5EF4-FFF2-40B4-BE49-F238E27FC236}">
                    <a16:creationId xmlns:a16="http://schemas.microsoft.com/office/drawing/2014/main" id="{B2AB7953-798B-B44C-452B-EF7CEC52C9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407251" y="1832069"/>
                <a:ext cx="1619796" cy="1439904"/>
              </a:xfrm>
              <a:prstGeom prst="rect">
                <a:avLst/>
              </a:prstGeom>
            </p:spPr>
          </p:pic>
          <p:sp>
            <p:nvSpPr>
              <p:cNvPr id="24" name="文本框 26">
                <a:extLst>
                  <a:ext uri="{FF2B5EF4-FFF2-40B4-BE49-F238E27FC236}">
                    <a16:creationId xmlns:a16="http://schemas.microsoft.com/office/drawing/2014/main" id="{857D95A6-D247-1CAD-F822-5C0821CCD9BC}"/>
                  </a:ext>
                </a:extLst>
              </p:cNvPr>
              <p:cNvSpPr txBox="1"/>
              <p:nvPr/>
            </p:nvSpPr>
            <p:spPr>
              <a:xfrm>
                <a:off x="1730907" y="2728647"/>
                <a:ext cx="17653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33" name="文本框 26">
                <a:extLst>
                  <a:ext uri="{FF2B5EF4-FFF2-40B4-BE49-F238E27FC236}">
                    <a16:creationId xmlns:a16="http://schemas.microsoft.com/office/drawing/2014/main" id="{472A39D7-D04C-91B8-7AC4-612292210E1D}"/>
                  </a:ext>
                </a:extLst>
              </p:cNvPr>
              <p:cNvSpPr txBox="1"/>
              <p:nvPr/>
            </p:nvSpPr>
            <p:spPr>
              <a:xfrm>
                <a:off x="2142831" y="1878181"/>
                <a:ext cx="176532" cy="2256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600" b="1"/>
                  <a:t>*</a:t>
                </a:r>
                <a:endParaRPr lang="zh-CN" altLang="en-US" sz="1600" b="1"/>
              </a:p>
            </p:txBody>
          </p:sp>
          <p:sp>
            <p:nvSpPr>
              <p:cNvPr id="40" name="文本框 26">
                <a:extLst>
                  <a:ext uri="{FF2B5EF4-FFF2-40B4-BE49-F238E27FC236}">
                    <a16:creationId xmlns:a16="http://schemas.microsoft.com/office/drawing/2014/main" id="{1885ED03-51AE-25D6-70A1-572BE38C3670}"/>
                  </a:ext>
                </a:extLst>
              </p:cNvPr>
              <p:cNvSpPr txBox="1"/>
              <p:nvPr/>
            </p:nvSpPr>
            <p:spPr>
              <a:xfrm>
                <a:off x="2535017" y="2736131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sp>
          <p:nvSpPr>
            <p:cNvPr id="2" name="テキスト ボックス 4">
              <a:extLst>
                <a:ext uri="{FF2B5EF4-FFF2-40B4-BE49-F238E27FC236}">
                  <a16:creationId xmlns:a16="http://schemas.microsoft.com/office/drawing/2014/main" id="{23ECA110-D907-7BF6-FAB3-CCE6D5FACF98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296560" y="106479"/>
              <a:ext cx="413761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A)</a:t>
              </a:r>
              <a:endParaRPr lang="zh-CN" altLang="en-US" sz="1200" b="1" dirty="0"/>
            </a:p>
          </p:txBody>
        </p:sp>
        <p:sp>
          <p:nvSpPr>
            <p:cNvPr id="3" name="テキスト ボックス 4">
              <a:extLst>
                <a:ext uri="{FF2B5EF4-FFF2-40B4-BE49-F238E27FC236}">
                  <a16:creationId xmlns:a16="http://schemas.microsoft.com/office/drawing/2014/main" id="{D9E7A4B3-42B1-C5F7-780A-74BE7A261A54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406445" y="106479"/>
              <a:ext cx="413761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B)</a:t>
              </a:r>
              <a:endParaRPr lang="zh-CN" altLang="en-US" sz="1200" b="1" dirty="0"/>
            </a:p>
          </p:txBody>
        </p:sp>
        <p:sp>
          <p:nvSpPr>
            <p:cNvPr id="4" name="テキスト ボックス 4">
              <a:extLst>
                <a:ext uri="{FF2B5EF4-FFF2-40B4-BE49-F238E27FC236}">
                  <a16:creationId xmlns:a16="http://schemas.microsoft.com/office/drawing/2014/main" id="{52AA5CEF-E2B7-64ED-BBEC-7A38BA738E57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14181" y="106479"/>
              <a:ext cx="413761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C)</a:t>
              </a:r>
              <a:endParaRPr lang="zh-CN" altLang="en-US" sz="1200" b="1" dirty="0"/>
            </a:p>
          </p:txBody>
        </p:sp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1995019C-D610-2AFA-58A1-8EA16096CE86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398573" y="347933"/>
              <a:ext cx="2082018" cy="1850792"/>
              <a:chOff x="1363826" y="281508"/>
              <a:chExt cx="1619796" cy="1439904"/>
            </a:xfrm>
          </p:grpSpPr>
          <p:pic>
            <p:nvPicPr>
              <p:cNvPr id="13" name="Picture 12" descr="A graph of a number of patients&#10;&#10;AI-generated content may be incorrect.">
                <a:extLst>
                  <a:ext uri="{FF2B5EF4-FFF2-40B4-BE49-F238E27FC236}">
                    <a16:creationId xmlns:a16="http://schemas.microsoft.com/office/drawing/2014/main" id="{F5CA2C23-6E1E-C0FB-8714-492CB6AF3D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363826" y="281508"/>
                <a:ext cx="1619796" cy="1439904"/>
              </a:xfrm>
              <a:prstGeom prst="rect">
                <a:avLst/>
              </a:prstGeom>
            </p:spPr>
          </p:pic>
          <p:sp>
            <p:nvSpPr>
              <p:cNvPr id="20" name="文本框 26">
                <a:extLst>
                  <a:ext uri="{FF2B5EF4-FFF2-40B4-BE49-F238E27FC236}">
                    <a16:creationId xmlns:a16="http://schemas.microsoft.com/office/drawing/2014/main" id="{4EB3B764-FC1A-B476-886B-C18AD8BDA8FD}"/>
                  </a:ext>
                </a:extLst>
              </p:cNvPr>
              <p:cNvSpPr txBox="1"/>
              <p:nvPr/>
            </p:nvSpPr>
            <p:spPr>
              <a:xfrm>
                <a:off x="1675660" y="1164617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7" name="文本框 26">
                <a:extLst>
                  <a:ext uri="{FF2B5EF4-FFF2-40B4-BE49-F238E27FC236}">
                    <a16:creationId xmlns:a16="http://schemas.microsoft.com/office/drawing/2014/main" id="{35DDB3EA-B130-A130-D00C-9B5484A84DBE}"/>
                  </a:ext>
                </a:extLst>
              </p:cNvPr>
              <p:cNvSpPr txBox="1"/>
              <p:nvPr/>
            </p:nvSpPr>
            <p:spPr>
              <a:xfrm>
                <a:off x="2490849" y="1146876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  <p:sp>
            <p:nvSpPr>
              <p:cNvPr id="30" name="文本框 26">
                <a:extLst>
                  <a:ext uri="{FF2B5EF4-FFF2-40B4-BE49-F238E27FC236}">
                    <a16:creationId xmlns:a16="http://schemas.microsoft.com/office/drawing/2014/main" id="{FDD1F94F-810A-A0C4-4640-007070819080}"/>
                  </a:ext>
                </a:extLst>
              </p:cNvPr>
              <p:cNvSpPr txBox="1"/>
              <p:nvPr/>
            </p:nvSpPr>
            <p:spPr>
              <a:xfrm>
                <a:off x="2082802" y="346793"/>
                <a:ext cx="222482" cy="1641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000" b="1"/>
                  <a:t>ns</a:t>
                </a:r>
                <a:endParaRPr lang="zh-CN" altLang="en-US" sz="1000" b="1"/>
              </a:p>
            </p:txBody>
          </p:sp>
        </p:grp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7B999A9-B1B4-0D5C-9D47-D5BE67169F95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296560" y="2005369"/>
              <a:ext cx="413761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D)</a:t>
              </a:r>
              <a:endParaRPr lang="zh-CN" altLang="en-US" sz="1200" b="1" dirty="0"/>
            </a:p>
          </p:txBody>
        </p:sp>
        <p:sp>
          <p:nvSpPr>
            <p:cNvPr id="6" name="テキスト ボックス 4">
              <a:extLst>
                <a:ext uri="{FF2B5EF4-FFF2-40B4-BE49-F238E27FC236}">
                  <a16:creationId xmlns:a16="http://schemas.microsoft.com/office/drawing/2014/main" id="{E2554957-FB96-68AB-4D80-8C3F643F2843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3410614" y="2005369"/>
              <a:ext cx="405426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E)</a:t>
              </a:r>
              <a:endParaRPr lang="zh-CN" altLang="en-US" sz="1200" b="1" dirty="0"/>
            </a:p>
          </p:txBody>
        </p:sp>
        <p:sp>
          <p:nvSpPr>
            <p:cNvPr id="7" name="テキスト ボックス 4">
              <a:extLst>
                <a:ext uri="{FF2B5EF4-FFF2-40B4-BE49-F238E27FC236}">
                  <a16:creationId xmlns:a16="http://schemas.microsoft.com/office/drawing/2014/main" id="{99649809-F358-DAC5-A667-B4A591433BCD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5522516" y="2005369"/>
              <a:ext cx="397091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F)</a:t>
              </a:r>
              <a:endParaRPr lang="zh-CN" altLang="en-US" sz="1200" b="1" dirty="0"/>
            </a:p>
          </p:txBody>
        </p:sp>
        <p:sp>
          <p:nvSpPr>
            <p:cNvPr id="8" name="テキスト ボックス 4">
              <a:extLst>
                <a:ext uri="{FF2B5EF4-FFF2-40B4-BE49-F238E27FC236}">
                  <a16:creationId xmlns:a16="http://schemas.microsoft.com/office/drawing/2014/main" id="{2CC6FEC1-E896-652A-2C3B-E5D6336E576B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1291559" y="3864381"/>
              <a:ext cx="423763" cy="2880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 dirty="0"/>
                <a:t>(G)</a:t>
              </a:r>
              <a:endParaRPr lang="zh-CN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354616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1E5F03D-16D8-BF5B-49FA-8A1C55928D75}"/>
              </a:ext>
            </a:extLst>
          </p:cNvPr>
          <p:cNvSpPr txBox="1"/>
          <p:nvPr/>
        </p:nvSpPr>
        <p:spPr>
          <a:xfrm>
            <a:off x="117000" y="4750203"/>
            <a:ext cx="8910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6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hanges in shoot biomas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under Mn treatmen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21-d-old)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exposed to 0.5 or 500 μM Mn for 4 days. The shoot biomass of HE and NHE under 0.5 μM Mn treatment was defined as 100%, respectively. Data represent the mean ± SD of three biological replicates (each replicate corresponds to a single plant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Yu Gothic" panose="020B0400000000000000" pitchFamily="34" charset="-128"/>
                <a:cs typeface="Arial" panose="020B0604020202020204" pitchFamily="34" charset="0"/>
              </a:rPr>
              <a:t> with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three individual plants processed in parallel). Significant differences are marked by different letters at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&lt;0.05 using one-way analysis of variance (ANOVA) followed by Tukey’s test. DW, dry weight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298C7AC6-DBF8-3DEF-BE94-FC0EA9ECAE98}"/>
              </a:ext>
            </a:extLst>
          </p:cNvPr>
          <p:cNvGrpSpPr>
            <a:grpSpLocks noChangeAspect="1"/>
          </p:cNvGrpSpPr>
          <p:nvPr/>
        </p:nvGrpSpPr>
        <p:grpSpPr>
          <a:xfrm>
            <a:off x="3132000" y="1149938"/>
            <a:ext cx="2880000" cy="2880000"/>
            <a:chOff x="4731633" y="1664288"/>
            <a:chExt cx="2160000" cy="2160000"/>
          </a:xfrm>
        </p:grpSpPr>
        <p:pic>
          <p:nvPicPr>
            <p:cNvPr id="4" name="Picture 3" descr="A graph of a graph showing the amount of biomass&#10;&#10;AI-generated content may be incorrect.">
              <a:extLst>
                <a:ext uri="{FF2B5EF4-FFF2-40B4-BE49-F238E27FC236}">
                  <a16:creationId xmlns:a16="http://schemas.microsoft.com/office/drawing/2014/main" id="{404DF22B-DE3D-9EEA-1842-11CC5DC230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31633" y="1664288"/>
              <a:ext cx="2160000" cy="2160000"/>
            </a:xfrm>
            <a:prstGeom prst="rect">
              <a:avLst/>
            </a:prstGeom>
          </p:spPr>
        </p:pic>
        <p:sp>
          <p:nvSpPr>
            <p:cNvPr id="79" name="文本框 26">
              <a:extLst>
                <a:ext uri="{FF2B5EF4-FFF2-40B4-BE49-F238E27FC236}">
                  <a16:creationId xmlns:a16="http://schemas.microsoft.com/office/drawing/2014/main" id="{E1DCAE6A-E01F-AB22-230D-F7742A75F259}"/>
                </a:ext>
              </a:extLst>
            </p:cNvPr>
            <p:cNvSpPr txBox="1"/>
            <p:nvPr/>
          </p:nvSpPr>
          <p:spPr>
            <a:xfrm>
              <a:off x="5323274" y="2326986"/>
              <a:ext cx="202220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a</a:t>
              </a:r>
              <a:endParaRPr lang="zh-CN" altLang="en-US" sz="1200" b="1"/>
            </a:p>
          </p:txBody>
        </p:sp>
        <p:sp>
          <p:nvSpPr>
            <p:cNvPr id="80" name="文本框 26">
              <a:extLst>
                <a:ext uri="{FF2B5EF4-FFF2-40B4-BE49-F238E27FC236}">
                  <a16:creationId xmlns:a16="http://schemas.microsoft.com/office/drawing/2014/main" id="{CEB7A46D-13F1-1E7F-F2E2-F5D7516FC3C5}"/>
                </a:ext>
              </a:extLst>
            </p:cNvPr>
            <p:cNvSpPr txBox="1"/>
            <p:nvPr/>
          </p:nvSpPr>
          <p:spPr>
            <a:xfrm>
              <a:off x="5662899" y="2124910"/>
              <a:ext cx="202220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a</a:t>
              </a:r>
              <a:endParaRPr lang="zh-CN" altLang="en-US" sz="1200" b="1"/>
            </a:p>
          </p:txBody>
        </p:sp>
        <p:sp>
          <p:nvSpPr>
            <p:cNvPr id="81" name="文本框 26">
              <a:extLst>
                <a:ext uri="{FF2B5EF4-FFF2-40B4-BE49-F238E27FC236}">
                  <a16:creationId xmlns:a16="http://schemas.microsoft.com/office/drawing/2014/main" id="{F7C19B0C-9258-815F-DD9C-B685F2BDCF2C}"/>
                </a:ext>
              </a:extLst>
            </p:cNvPr>
            <p:cNvSpPr txBox="1"/>
            <p:nvPr/>
          </p:nvSpPr>
          <p:spPr>
            <a:xfrm>
              <a:off x="6099123" y="2030662"/>
              <a:ext cx="202220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a</a:t>
              </a:r>
              <a:endParaRPr lang="zh-CN" altLang="en-US" sz="1200" b="1"/>
            </a:p>
          </p:txBody>
        </p:sp>
        <p:sp>
          <p:nvSpPr>
            <p:cNvPr id="82" name="文本框 26">
              <a:extLst>
                <a:ext uri="{FF2B5EF4-FFF2-40B4-BE49-F238E27FC236}">
                  <a16:creationId xmlns:a16="http://schemas.microsoft.com/office/drawing/2014/main" id="{B639E330-5362-CEBC-1635-5E2B1E5E288E}"/>
                </a:ext>
              </a:extLst>
            </p:cNvPr>
            <p:cNvSpPr txBox="1"/>
            <p:nvPr/>
          </p:nvSpPr>
          <p:spPr>
            <a:xfrm>
              <a:off x="6436919" y="2278239"/>
              <a:ext cx="202220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1200" b="1"/>
                <a:t>a</a:t>
              </a:r>
              <a:endParaRPr lang="zh-CN" altLang="en-US" sz="1200" b="1"/>
            </a:p>
          </p:txBody>
        </p:sp>
      </p:grpSp>
    </p:spTree>
    <p:extLst>
      <p:ext uri="{BB962C8B-B14F-4D97-AF65-F5344CB8AC3E}">
        <p14:creationId xmlns:p14="http://schemas.microsoft.com/office/powerpoint/2010/main" val="19482465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2579D72-C2F3-2410-4C4D-4CFB43ED32A6}"/>
              </a:ext>
            </a:extLst>
          </p:cNvPr>
          <p:cNvSpPr txBox="1"/>
          <p:nvPr/>
        </p:nvSpPr>
        <p:spPr>
          <a:xfrm>
            <a:off x="117000" y="5306885"/>
            <a:ext cx="8910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7.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Comparison of Mn tolerance in the shoots of hyperaccumulating ecotype (HE) and non-hyperaccumulating ecotype (NHE) of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ith prolonged exposure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(A) Leaf phenotype of HE and NHE </a:t>
            </a:r>
            <a:r>
              <a:rPr lang="en-US" altLang="ja-JP" sz="1100" i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at 0.5 and 500 μM Mn. (B, C) Enlarged area of white dashed box in (A) of NHE (B) and HE (C). Scale bar, 2 cm. Seedlings (21-d-old) were exposed to 0.5 or 500 μM Mn for 12 days. The white arrows indicate the symptoms of Mn toxicity.</a:t>
            </a:r>
            <a:endParaRPr lang="ja-JP" altLang="ja-JP" sz="1100" kern="100" dirty="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61FAB31-3008-DE9A-40E2-246A8E0F3249}"/>
              </a:ext>
            </a:extLst>
          </p:cNvPr>
          <p:cNvGrpSpPr>
            <a:grpSpLocks noChangeAspect="1"/>
          </p:cNvGrpSpPr>
          <p:nvPr/>
        </p:nvGrpSpPr>
        <p:grpSpPr>
          <a:xfrm>
            <a:off x="1377289" y="655047"/>
            <a:ext cx="6479999" cy="4144297"/>
            <a:chOff x="4062375" y="1791081"/>
            <a:chExt cx="3227298" cy="2064025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7069E3D5-6B11-A242-5FFF-000F06436023}"/>
                </a:ext>
              </a:extLst>
            </p:cNvPr>
            <p:cNvGrpSpPr/>
            <p:nvPr/>
          </p:nvGrpSpPr>
          <p:grpSpPr>
            <a:xfrm>
              <a:off x="4062375" y="1791081"/>
              <a:ext cx="3227298" cy="2064025"/>
              <a:chOff x="4062375" y="1791081"/>
              <a:chExt cx="3227298" cy="2064025"/>
            </a:xfrm>
          </p:grpSpPr>
          <p:pic>
            <p:nvPicPr>
              <p:cNvPr id="3" name="Picture 2" descr="A group of green plants growing on a black and white checkered surface&#10;&#10;Description automatically generated">
                <a:extLst>
                  <a:ext uri="{FF2B5EF4-FFF2-40B4-BE49-F238E27FC236}">
                    <a16:creationId xmlns:a16="http://schemas.microsoft.com/office/drawing/2014/main" id="{E6D7C8A7-EE6E-2ECE-9795-02A6779E51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screen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6356"/>
                        </a14:imgEffect>
                        <a14:imgEffect>
                          <a14:saturation sat="171000"/>
                        </a14:imgEffect>
                        <a14:imgEffect>
                          <a14:brightnessContrast bright="-15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4336423" y="1791081"/>
                <a:ext cx="1962461" cy="1912239"/>
              </a:xfrm>
              <a:prstGeom prst="rect">
                <a:avLst/>
              </a:prstGeom>
            </p:spPr>
          </p:pic>
          <p:cxnSp>
            <p:nvCxnSpPr>
              <p:cNvPr id="4" name="Straight Connector 3">
                <a:extLst>
                  <a:ext uri="{FF2B5EF4-FFF2-40B4-BE49-F238E27FC236}">
                    <a16:creationId xmlns:a16="http://schemas.microsoft.com/office/drawing/2014/main" id="{A5B565D6-CD70-4249-7FD0-C13EF567F9DA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4356057" y="3515067"/>
                <a:ext cx="295200" cy="0"/>
              </a:xfrm>
              <a:prstGeom prst="line">
                <a:avLst/>
              </a:prstGeom>
              <a:ln w="76200"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" name="Picture 4" descr="A close-up of a plant&#10;&#10;Description automatically generated">
                <a:extLst>
                  <a:ext uri="{FF2B5EF4-FFF2-40B4-BE49-F238E27FC236}">
                    <a16:creationId xmlns:a16="http://schemas.microsoft.com/office/drawing/2014/main" id="{6A4F2FD8-CE2A-9C2D-44C9-799C042A0D3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353171" y="1791081"/>
                <a:ext cx="935828" cy="936000"/>
              </a:xfrm>
              <a:prstGeom prst="rect">
                <a:avLst/>
              </a:prstGeom>
            </p:spPr>
          </p:pic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605CD3A3-E61B-4319-9ADF-2E1C6ABF59DD}"/>
                  </a:ext>
                </a:extLst>
              </p:cNvPr>
              <p:cNvSpPr/>
              <p:nvPr/>
            </p:nvSpPr>
            <p:spPr>
              <a:xfrm>
                <a:off x="5539755" y="2052242"/>
                <a:ext cx="433271" cy="432730"/>
              </a:xfrm>
              <a:prstGeom prst="rect">
                <a:avLst/>
              </a:prstGeom>
              <a:noFill/>
              <a:ln w="19050">
                <a:solidFill>
                  <a:srgbClr val="FFFFFF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6" descr="A close-up of a plant&#10;&#10;Description automatically generated">
                <a:extLst>
                  <a:ext uri="{FF2B5EF4-FFF2-40B4-BE49-F238E27FC236}">
                    <a16:creationId xmlns:a16="http://schemas.microsoft.com/office/drawing/2014/main" id="{EF7F3F97-CEC6-C1C5-F997-FB332A960E5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6353171" y="2767320"/>
                <a:ext cx="936502" cy="936000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7512B90-F3AC-867C-66BA-3ADEA5257219}"/>
                  </a:ext>
                </a:extLst>
              </p:cNvPr>
              <p:cNvSpPr txBox="1"/>
              <p:nvPr/>
            </p:nvSpPr>
            <p:spPr>
              <a:xfrm>
                <a:off x="4635217" y="3705814"/>
                <a:ext cx="501269" cy="1492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0.5 μM Mn</a:t>
                </a:r>
                <a:endParaRPr lang="zh-CN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8D8E224-A05E-8CFD-F209-8874C4845769}"/>
                  </a:ext>
                </a:extLst>
              </p:cNvPr>
              <p:cNvSpPr txBox="1"/>
              <p:nvPr/>
            </p:nvSpPr>
            <p:spPr>
              <a:xfrm>
                <a:off x="5514481" y="3705814"/>
                <a:ext cx="523732" cy="1492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500 μM Mn</a:t>
                </a:r>
                <a:endParaRPr lang="zh-CN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ectangle 31">
                <a:extLst>
                  <a:ext uri="{FF2B5EF4-FFF2-40B4-BE49-F238E27FC236}">
                    <a16:creationId xmlns:a16="http://schemas.microsoft.com/office/drawing/2014/main" id="{7F2C2C2A-C34E-278E-710D-CA0C671D50E5}"/>
                  </a:ext>
                </a:extLst>
              </p:cNvPr>
              <p:cNvSpPr/>
              <p:nvPr/>
            </p:nvSpPr>
            <p:spPr>
              <a:xfrm>
                <a:off x="5589725" y="2974321"/>
                <a:ext cx="433271" cy="432730"/>
              </a:xfrm>
              <a:prstGeom prst="rect">
                <a:avLst/>
              </a:prstGeom>
              <a:noFill/>
              <a:ln w="19050">
                <a:solidFill>
                  <a:srgbClr val="FFFFFF"/>
                </a:solidFill>
                <a:prstDash val="sys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F8BE2A4-CD1C-EBB1-A52A-C97A2A3DDADE}"/>
                  </a:ext>
                </a:extLst>
              </p:cNvPr>
              <p:cNvSpPr txBox="1"/>
              <p:nvPr/>
            </p:nvSpPr>
            <p:spPr>
              <a:xfrm>
                <a:off x="4121989" y="3152185"/>
                <a:ext cx="214434" cy="1492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HE</a:t>
                </a:r>
                <a:endParaRPr lang="zh-CN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C0B45F1-E5FB-9192-4EC5-1FC28B4A7E2E}"/>
                  </a:ext>
                </a:extLst>
              </p:cNvPr>
              <p:cNvSpPr txBox="1"/>
              <p:nvPr/>
            </p:nvSpPr>
            <p:spPr>
              <a:xfrm>
                <a:off x="4062375" y="2276707"/>
                <a:ext cx="274048" cy="14929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zh-CN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NHE</a:t>
                </a:r>
                <a:endParaRPr lang="zh-CN" alt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7">
                <a:extLst>
                  <a:ext uri="{FF2B5EF4-FFF2-40B4-BE49-F238E27FC236}">
                    <a16:creationId xmlns:a16="http://schemas.microsoft.com/office/drawing/2014/main" id="{8ACDE1A8-6181-29B5-0278-8804384EC2BC}"/>
                  </a:ext>
                </a:extLst>
              </p:cNvPr>
              <p:cNvSpPr txBox="1"/>
              <p:nvPr/>
            </p:nvSpPr>
            <p:spPr>
              <a:xfrm>
                <a:off x="4085501" y="1805737"/>
                <a:ext cx="215717" cy="1532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7">
                <a:extLst>
                  <a:ext uri="{FF2B5EF4-FFF2-40B4-BE49-F238E27FC236}">
                    <a16:creationId xmlns:a16="http://schemas.microsoft.com/office/drawing/2014/main" id="{8B1AD08E-0425-5C96-654A-DB475A29349D}"/>
                  </a:ext>
                </a:extLst>
              </p:cNvPr>
              <p:cNvSpPr txBox="1"/>
              <p:nvPr/>
            </p:nvSpPr>
            <p:spPr>
              <a:xfrm>
                <a:off x="6323731" y="1805737"/>
                <a:ext cx="381836" cy="1532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</a:t>
                </a:r>
                <a:endParaRPr lang="zh-CN" altLang="en-US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7">
                <a:extLst>
                  <a:ext uri="{FF2B5EF4-FFF2-40B4-BE49-F238E27FC236}">
                    <a16:creationId xmlns:a16="http://schemas.microsoft.com/office/drawing/2014/main" id="{32AEFE3A-E702-BB9D-8B0A-C1EF1DA17C92}"/>
                  </a:ext>
                </a:extLst>
              </p:cNvPr>
              <p:cNvSpPr txBox="1"/>
              <p:nvPr/>
            </p:nvSpPr>
            <p:spPr>
              <a:xfrm>
                <a:off x="6328540" y="2759391"/>
                <a:ext cx="215717" cy="1532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C)</a:t>
                </a:r>
                <a:endParaRPr lang="zh-CN" altLang="en-US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235C73CD-3336-1B4D-A7B3-FE39A61190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884194" y="3535601"/>
              <a:ext cx="90253" cy="12868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C9E7ABC3-AD74-681B-E573-B5680298DC2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20366" y="2330010"/>
              <a:ext cx="120993" cy="64345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35C5192C-661F-60A5-22F3-873AFC4DDB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1484" y="2468823"/>
              <a:ext cx="92974" cy="10820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B974221A-2386-4835-452D-F6B95A6FAD7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076195" y="2362027"/>
              <a:ext cx="143175" cy="64655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3A9D2AB0-15FB-47CC-EE92-9594FABB7D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701991" y="1920770"/>
              <a:ext cx="141722" cy="33943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4071472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1CA2BD4-D252-654F-BB3B-46156A64F2D3}"/>
              </a:ext>
            </a:extLst>
          </p:cNvPr>
          <p:cNvSpPr txBox="1"/>
          <p:nvPr/>
        </p:nvSpPr>
        <p:spPr>
          <a:xfrm>
            <a:off x="117000" y="4442113"/>
            <a:ext cx="891000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buNone/>
            </a:pPr>
            <a:r>
              <a:rPr lang="en-US" altLang="ja-JP" sz="11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Figure S8. 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mi-quantification of Mn-related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MTPs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expression in the shoots of hyperaccumulating ecotype (HE) and non-hyperaccumulating ecotype (NHE) of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eedlings (21-d-old) of HE and NHE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. alfredii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cultured in a solution with 0.5 μM Mn. The shoots of HE and NHE were collected for RNA extraction. The expression levels of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1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8.2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9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10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, and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MTP11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ere analyzed by semi-quantitative PCR. </a:t>
            </a:r>
            <a:r>
              <a:rPr lang="en-US" altLang="ja-JP" sz="1100" i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SaActin1</a:t>
            </a:r>
            <a:r>
              <a:rPr lang="en-US" altLang="ja-JP" sz="1100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Arial" panose="020B0604020202020204" pitchFamily="34" charset="0"/>
              </a:rPr>
              <a:t> was used as an internal control.</a:t>
            </a:r>
            <a:endParaRPr lang="ja-JP" altLang="ja-JP" sz="1100" kern="100">
              <a:effectLst/>
              <a:latin typeface="Aptos" panose="020B00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60F03238-C980-184C-4620-428CC846A53B}"/>
              </a:ext>
            </a:extLst>
          </p:cNvPr>
          <p:cNvGrpSpPr>
            <a:grpSpLocks noChangeAspect="1"/>
          </p:cNvGrpSpPr>
          <p:nvPr/>
        </p:nvGrpSpPr>
        <p:grpSpPr>
          <a:xfrm>
            <a:off x="3137078" y="1310119"/>
            <a:ext cx="2880000" cy="2523309"/>
            <a:chOff x="4423053" y="1125969"/>
            <a:chExt cx="3068747" cy="2688677"/>
          </a:xfrm>
        </p:grpSpPr>
        <p:pic>
          <p:nvPicPr>
            <p:cNvPr id="2" name="Picture 1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77632397-28DA-F5AA-2836-14BD31C0D7E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hq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2000"/>
                      </a14:imgEffect>
                      <a14:imgEffect>
                        <a14:brightnessContrast bright="-15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5606" y="1753009"/>
              <a:ext cx="1273351" cy="307777"/>
            </a:xfrm>
            <a:prstGeom prst="rect">
              <a:avLst/>
            </a:prstGeom>
          </p:spPr>
        </p:pic>
        <p:pic>
          <p:nvPicPr>
            <p:cNvPr id="3" name="Picture 2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F7E28DBD-0D83-EF5A-E1C4-95B995C53E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2000"/>
                      </a14:imgEffect>
                      <a14:imgEffect>
                        <a14:brightnessContrast bright="-15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5606" y="2102257"/>
              <a:ext cx="1273352" cy="30777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A0F7AB3-3D0E-C714-4605-D7DB7A0682D9}"/>
                </a:ext>
              </a:extLst>
            </p:cNvPr>
            <p:cNvSpPr txBox="1"/>
            <p:nvPr/>
          </p:nvSpPr>
          <p:spPr>
            <a:xfrm>
              <a:off x="4423053" y="1586140"/>
              <a:ext cx="9108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MTP8.1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8B5F1E6-390D-9891-F022-49650288C61D}"/>
                </a:ext>
              </a:extLst>
            </p:cNvPr>
            <p:cNvSpPr txBox="1"/>
            <p:nvPr/>
          </p:nvSpPr>
          <p:spPr>
            <a:xfrm>
              <a:off x="4423053" y="2117403"/>
              <a:ext cx="9108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MTP8.2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 descr="A close-up of a film strip&#10;&#10;Description automatically generated">
              <a:extLst>
                <a:ext uri="{FF2B5EF4-FFF2-40B4-BE49-F238E27FC236}">
                  <a16:creationId xmlns:a16="http://schemas.microsoft.com/office/drawing/2014/main" id="{7A4F5DC0-310E-4762-04DA-6A23F7A5141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12000"/>
                      </a14:imgEffect>
                      <a14:imgEffect>
                        <a14:brightnessContrast bright="-15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5604" y="2459125"/>
              <a:ext cx="1273353" cy="307777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8E91C1B-7BE1-4321-4AE6-A79FA583124E}"/>
                </a:ext>
              </a:extLst>
            </p:cNvPr>
            <p:cNvSpPr txBox="1"/>
            <p:nvPr/>
          </p:nvSpPr>
          <p:spPr>
            <a:xfrm>
              <a:off x="4551293" y="2459125"/>
              <a:ext cx="7825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MTP9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" name="Picture 8" descr="A close-up of a film&#10;&#10;Description automatically generated">
              <a:extLst>
                <a:ext uri="{FF2B5EF4-FFF2-40B4-BE49-F238E27FC236}">
                  <a16:creationId xmlns:a16="http://schemas.microsoft.com/office/drawing/2014/main" id="{1AE84F4C-D64B-CC93-2525-1C48E033603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12000"/>
                      </a14:imgEffect>
                      <a14:imgEffect>
                        <a14:brightnessContrast bright="-15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5604" y="2815993"/>
              <a:ext cx="1273354" cy="307777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AC8779B-C1C2-C8F8-F150-C6B59098023F}"/>
                </a:ext>
              </a:extLst>
            </p:cNvPr>
            <p:cNvSpPr txBox="1"/>
            <p:nvPr/>
          </p:nvSpPr>
          <p:spPr>
            <a:xfrm>
              <a:off x="4466334" y="2828119"/>
              <a:ext cx="867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MTP10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1C8AD14-E0FB-D968-6202-DA32F0B96607}"/>
                </a:ext>
              </a:extLst>
            </p:cNvPr>
            <p:cNvSpPr txBox="1"/>
            <p:nvPr/>
          </p:nvSpPr>
          <p:spPr>
            <a:xfrm>
              <a:off x="4467552" y="3164266"/>
              <a:ext cx="866328" cy="278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MTP11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Picture 11" descr="A close-up of a film&#10;&#10;Description automatically generated">
              <a:extLst>
                <a:ext uri="{FF2B5EF4-FFF2-40B4-BE49-F238E27FC236}">
                  <a16:creationId xmlns:a16="http://schemas.microsoft.com/office/drawing/2014/main" id="{BDF277A8-FE9F-EA14-7EB5-3CCB9A2DF6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12000"/>
                      </a14:imgEffect>
                      <a14:imgEffect>
                        <a14:brightnessContrast bright="-15000" contras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65604" y="3165241"/>
              <a:ext cx="1273354" cy="307777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7F27D76-FE6D-D2C6-CEAE-D28DFE44D142}"/>
                </a:ext>
              </a:extLst>
            </p:cNvPr>
            <p:cNvSpPr txBox="1"/>
            <p:nvPr/>
          </p:nvSpPr>
          <p:spPr>
            <a:xfrm>
              <a:off x="4491981" y="3526068"/>
              <a:ext cx="8418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 i="1">
                  <a:latin typeface="Arial" panose="020B0604020202020204" pitchFamily="34" charset="0"/>
                  <a:cs typeface="Arial" panose="020B0604020202020204" pitchFamily="34" charset="0"/>
                </a:rPr>
                <a:t>SaActin1</a:t>
              </a:r>
              <a:endParaRPr lang="zh-CN" altLang="en-US" sz="1100" b="1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 descr="A black rectangular object with white lines&#10;&#10;Description automatically generated">
              <a:extLst>
                <a:ext uri="{FF2B5EF4-FFF2-40B4-BE49-F238E27FC236}">
                  <a16:creationId xmlns:a16="http://schemas.microsoft.com/office/drawing/2014/main" id="{B562C0CB-3E42-9601-2B58-F864AFBFA8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hq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3000" contrast="33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51072"/>
            <a:stretch/>
          </p:blipFill>
          <p:spPr>
            <a:xfrm>
              <a:off x="5365604" y="3514489"/>
              <a:ext cx="1273354" cy="300157"/>
            </a:xfrm>
            <a:prstGeom prst="rect">
              <a:avLst/>
            </a:prstGeom>
          </p:spPr>
        </p:pic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334266DE-DE3D-D6AB-90BE-4B526EBED8E7}"/>
                </a:ext>
              </a:extLst>
            </p:cNvPr>
            <p:cNvCxnSpPr>
              <a:cxnSpLocks/>
            </p:cNvCxnSpPr>
            <p:nvPr/>
          </p:nvCxnSpPr>
          <p:spPr>
            <a:xfrm>
              <a:off x="6701245" y="1752214"/>
              <a:ext cx="0" cy="171556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79730D8-AC89-E78F-2A07-843116FDE7AE}"/>
                </a:ext>
              </a:extLst>
            </p:cNvPr>
            <p:cNvSpPr txBox="1"/>
            <p:nvPr/>
          </p:nvSpPr>
          <p:spPr>
            <a:xfrm>
              <a:off x="6667535" y="2453728"/>
              <a:ext cx="824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algn="r">
                <a:defRPr sz="1400" i="1"/>
              </a:lvl1pPr>
            </a:lstStyle>
            <a:p>
              <a:pPr algn="l"/>
              <a:r>
                <a:rPr lang="en-US" altLang="zh-CN" sz="1100">
                  <a:latin typeface="Arial" panose="020B0604020202020204" pitchFamily="34" charset="0"/>
                  <a:cs typeface="Arial" panose="020B0604020202020204" pitchFamily="34" charset="0"/>
                </a:rPr>
                <a:t>30 cycles</a:t>
              </a:r>
              <a:endParaRPr lang="zh-CN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0B113A1-C556-0A1F-B3B1-DC1C9C3F0092}"/>
                </a:ext>
              </a:extLst>
            </p:cNvPr>
            <p:cNvSpPr txBox="1"/>
            <p:nvPr/>
          </p:nvSpPr>
          <p:spPr>
            <a:xfrm>
              <a:off x="6667535" y="3526068"/>
              <a:ext cx="824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algn="r">
                <a:defRPr sz="1400" i="1"/>
              </a:lvl1pPr>
            </a:lstStyle>
            <a:p>
              <a:pPr algn="l"/>
              <a:r>
                <a:rPr lang="en-US" altLang="zh-CN" sz="1100">
                  <a:latin typeface="Arial" panose="020B0604020202020204" pitchFamily="34" charset="0"/>
                  <a:cs typeface="Arial" panose="020B0604020202020204" pitchFamily="34" charset="0"/>
                </a:rPr>
                <a:t>24 cycles</a:t>
              </a:r>
              <a:endParaRPr lang="zh-CN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Picture 17" descr="A black and white photo of a strip of light&#10;&#10;Description automatically generated">
              <a:extLst>
                <a:ext uri="{FF2B5EF4-FFF2-40B4-BE49-F238E27FC236}">
                  <a16:creationId xmlns:a16="http://schemas.microsoft.com/office/drawing/2014/main" id="{72BCEA56-5FE1-F977-6F8E-F380685FFDB0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hq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sharpenSoften amount="12000"/>
                      </a14:imgEffect>
                      <a14:imgEffect>
                        <a14:brightnessContrast bright="-15000" contrast="3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359279" y="1387942"/>
              <a:ext cx="1279678" cy="307777"/>
            </a:xfrm>
            <a:prstGeom prst="rect">
              <a:avLst/>
            </a:prstGeom>
          </p:spPr>
        </p:pic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9EA462E-7352-B62F-3847-10F65B3E1E1B}"/>
                </a:ext>
              </a:extLst>
            </p:cNvPr>
            <p:cNvCxnSpPr>
              <a:cxnSpLocks/>
            </p:cNvCxnSpPr>
            <p:nvPr/>
          </p:nvCxnSpPr>
          <p:spPr>
            <a:xfrm>
              <a:off x="5305832" y="1377349"/>
              <a:ext cx="0" cy="6768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FC403F7-3899-3753-4E1B-CDCB6D79EE78}"/>
                </a:ext>
              </a:extLst>
            </p:cNvPr>
            <p:cNvSpPr txBox="1"/>
            <p:nvPr/>
          </p:nvSpPr>
          <p:spPr>
            <a:xfrm>
              <a:off x="6667535" y="1387666"/>
              <a:ext cx="8242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algn="r">
                <a:defRPr sz="1400" i="1"/>
              </a:lvl1pPr>
            </a:lstStyle>
            <a:p>
              <a:pPr algn="l"/>
              <a:r>
                <a:rPr lang="en-US" altLang="zh-CN" sz="1100">
                  <a:latin typeface="Arial" panose="020B0604020202020204" pitchFamily="34" charset="0"/>
                  <a:cs typeface="Arial" panose="020B0604020202020204" pitchFamily="34" charset="0"/>
                </a:rPr>
                <a:t>28 cycles</a:t>
              </a:r>
              <a:endParaRPr lang="zh-CN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879D0B7-788E-51AC-CEC3-70AF414E8308}"/>
                </a:ext>
              </a:extLst>
            </p:cNvPr>
            <p:cNvSpPr txBox="1"/>
            <p:nvPr/>
          </p:nvSpPr>
          <p:spPr>
            <a:xfrm>
              <a:off x="5436297" y="1125969"/>
              <a:ext cx="406860" cy="278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HE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31C0CE9-4348-D10D-8F5D-6656662D0CFB}"/>
                </a:ext>
              </a:extLst>
            </p:cNvPr>
            <p:cNvSpPr txBox="1"/>
            <p:nvPr/>
          </p:nvSpPr>
          <p:spPr>
            <a:xfrm>
              <a:off x="6043387" y="1125969"/>
              <a:ext cx="516176" cy="2787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zh-CN" sz="1100" b="1">
                  <a:latin typeface="Arial" panose="020B0604020202020204" pitchFamily="34" charset="0"/>
                  <a:cs typeface="Arial" panose="020B0604020202020204" pitchFamily="34" charset="0"/>
                </a:rPr>
                <a:t>NHE</a:t>
              </a:r>
              <a:endParaRPr lang="zh-CN" altLang="en-US" sz="11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0413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ユーザー定義 1">
      <a:majorFont>
        <a:latin typeface="Arial"/>
        <a:ea typeface="黑体"/>
        <a:cs typeface=""/>
      </a:majorFont>
      <a:minorFont>
        <a:latin typeface="Arial"/>
        <a:ea typeface="黑体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2945</Words>
  <Application>Microsoft Office PowerPoint</Application>
  <PresentationFormat>全屏显示(4:3)</PresentationFormat>
  <Paragraphs>504</Paragraphs>
  <Slides>17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7</vt:i4>
      </vt:variant>
    </vt:vector>
  </HeadingPairs>
  <TitlesOfParts>
    <vt:vector size="23" baseType="lpstr">
      <vt:lpstr>等线</vt:lpstr>
      <vt:lpstr>Aptos</vt:lpstr>
      <vt:lpstr>Aptos Display</vt:lpstr>
      <vt:lpstr>Arial</vt:lpstr>
      <vt:lpstr>Times New Roman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 Ge</dc:creator>
  <cp:lastModifiedBy>Jun Ge</cp:lastModifiedBy>
  <cp:revision>1</cp:revision>
  <cp:lastPrinted>2025-02-19T06:03:27Z</cp:lastPrinted>
  <dcterms:created xsi:type="dcterms:W3CDTF">2024-03-25T05:02:50Z</dcterms:created>
  <dcterms:modified xsi:type="dcterms:W3CDTF">2025-05-23T00:35:12Z</dcterms:modified>
</cp:coreProperties>
</file>